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Estilo Cl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9" autoAdjust="0"/>
    <p:restoredTop sz="94660"/>
  </p:normalViewPr>
  <p:slideViewPr>
    <p:cSldViewPr snapToGrid="0">
      <p:cViewPr>
        <p:scale>
          <a:sx n="50" d="100"/>
          <a:sy n="50" d="100"/>
        </p:scale>
        <p:origin x="1266" y="11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tilizador\Documents\MEGA\sssssssss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tilizador\Documents\MEGA\ssssssssss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tilizador\Documents\MEGA\sssssssss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tilizador\Documents\MEGA\ssssssssss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lass</a:t>
            </a:r>
          </a:p>
        </c:rich>
      </c:tx>
      <c:layout>
        <c:manualLayout>
          <c:xMode val="edge"/>
          <c:yMode val="edge"/>
          <c:x val="0.3601664237780659"/>
          <c:y val="6.37414567505230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1975074431347974E-2"/>
          <c:y val="0.12405492807107699"/>
          <c:w val="0.68882136679014105"/>
          <c:h val="0.70807465181816198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Class_grafico '!$A$2</c:f>
              <c:strCache>
                <c:ptCount val="1"/>
                <c:pt idx="0">
                  <c:v>Acidobacteria_unclassifi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:$K$2</c:f>
              <c:numCache>
                <c:formatCode>General</c:formatCode>
                <c:ptCount val="10"/>
                <c:pt idx="0">
                  <c:v>1.9618334225075799E-2</c:v>
                </c:pt>
                <c:pt idx="1">
                  <c:v>9.4509025611946001E-3</c:v>
                </c:pt>
                <c:pt idx="2">
                  <c:v>1.30639261452708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47790531553278E-2</c:v>
                </c:pt>
                <c:pt idx="7">
                  <c:v>0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2F-4865-8BA2-EA4FD10F788F}"/>
            </c:ext>
          </c:extLst>
        </c:ser>
        <c:ser>
          <c:idx val="1"/>
          <c:order val="1"/>
          <c:tx>
            <c:strRef>
              <c:f>'Class_grafico '!$A$3</c:f>
              <c:strCache>
                <c:ptCount val="1"/>
                <c:pt idx="0">
                  <c:v>Acidobacteri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:$K$3</c:f>
              <c:numCache>
                <c:formatCode>General</c:formatCode>
                <c:ptCount val="10"/>
                <c:pt idx="0">
                  <c:v>0.80613518815766005</c:v>
                </c:pt>
                <c:pt idx="1">
                  <c:v>1.6208297892448731</c:v>
                </c:pt>
                <c:pt idx="2">
                  <c:v>1.770161992684202</c:v>
                </c:pt>
                <c:pt idx="3">
                  <c:v>1.5563811627673461</c:v>
                </c:pt>
                <c:pt idx="4">
                  <c:v>0</c:v>
                </c:pt>
                <c:pt idx="5">
                  <c:v>3.5542370983991942</c:v>
                </c:pt>
                <c:pt idx="6">
                  <c:v>0.187201339967486</c:v>
                </c:pt>
                <c:pt idx="7">
                  <c:v>0</c:v>
                </c:pt>
                <c:pt idx="8">
                  <c:v>2.85685443165758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62F-4865-8BA2-EA4FD10F788F}"/>
            </c:ext>
          </c:extLst>
        </c:ser>
        <c:ser>
          <c:idx val="2"/>
          <c:order val="2"/>
          <c:tx>
            <c:strRef>
              <c:f>'Class_grafico '!$A$4</c:f>
              <c:strCache>
                <c:ptCount val="1"/>
                <c:pt idx="0">
                  <c:v>Blastocatellia_(Subgroup_4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:$K$4</c:f>
              <c:numCache>
                <c:formatCode>General</c:formatCode>
                <c:ptCount val="10"/>
                <c:pt idx="0">
                  <c:v>4.5354021758516136</c:v>
                </c:pt>
                <c:pt idx="1">
                  <c:v>5.1507418958510538</c:v>
                </c:pt>
                <c:pt idx="2">
                  <c:v>12.74603727573594</c:v>
                </c:pt>
                <c:pt idx="3">
                  <c:v>4.8549051109549142</c:v>
                </c:pt>
                <c:pt idx="4">
                  <c:v>0</c:v>
                </c:pt>
                <c:pt idx="5">
                  <c:v>6.1905294973693046</c:v>
                </c:pt>
                <c:pt idx="6">
                  <c:v>9.3600669983743001E-2</c:v>
                </c:pt>
                <c:pt idx="7">
                  <c:v>1.1763321962122099E-2</c:v>
                </c:pt>
                <c:pt idx="8">
                  <c:v>10.740965071673729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62F-4865-8BA2-EA4FD10F788F}"/>
            </c:ext>
          </c:extLst>
        </c:ser>
        <c:ser>
          <c:idx val="3"/>
          <c:order val="3"/>
          <c:tx>
            <c:strRef>
              <c:f>'Class_grafico '!$A$5</c:f>
              <c:strCache>
                <c:ptCount val="1"/>
                <c:pt idx="0">
                  <c:v>Holophaga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:$K$5</c:f>
              <c:numCache>
                <c:formatCode>General</c:formatCode>
                <c:ptCount val="10"/>
                <c:pt idx="0">
                  <c:v>1.42678794364187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5074141583329230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62F-4865-8BA2-EA4FD10F788F}"/>
            </c:ext>
          </c:extLst>
        </c:ser>
        <c:ser>
          <c:idx val="4"/>
          <c:order val="4"/>
          <c:tx>
            <c:strRef>
              <c:f>'Class_grafico '!$A$6</c:f>
              <c:strCache>
                <c:ptCount val="1"/>
                <c:pt idx="0">
                  <c:v>Subgroup_11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:$K$6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62F-4865-8BA2-EA4FD10F788F}"/>
            </c:ext>
          </c:extLst>
        </c:ser>
        <c:ser>
          <c:idx val="5"/>
          <c:order val="5"/>
          <c:tx>
            <c:strRef>
              <c:f>'Class_grafico '!$A$7</c:f>
              <c:strCache>
                <c:ptCount val="1"/>
                <c:pt idx="0">
                  <c:v>Subgroup_17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:$K$7</c:f>
              <c:numCache>
                <c:formatCode>General</c:formatCode>
                <c:ptCount val="10"/>
                <c:pt idx="0">
                  <c:v>0.1480292491528449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62F-4865-8BA2-EA4FD10F788F}"/>
            </c:ext>
          </c:extLst>
        </c:ser>
        <c:ser>
          <c:idx val="6"/>
          <c:order val="6"/>
          <c:tx>
            <c:strRef>
              <c:f>'Class_grafico '!$A$8</c:f>
              <c:strCache>
                <c:ptCount val="1"/>
                <c:pt idx="0">
                  <c:v>Subgroup_6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:$K$8</c:f>
              <c:numCache>
                <c:formatCode>General</c:formatCode>
                <c:ptCount val="10"/>
                <c:pt idx="0">
                  <c:v>0.65453896914571097</c:v>
                </c:pt>
                <c:pt idx="1">
                  <c:v>0.39221245628957602</c:v>
                </c:pt>
                <c:pt idx="2">
                  <c:v>1.0168089183069151</c:v>
                </c:pt>
                <c:pt idx="3">
                  <c:v>0.49703785520634602</c:v>
                </c:pt>
                <c:pt idx="4">
                  <c:v>0</c:v>
                </c:pt>
                <c:pt idx="5">
                  <c:v>0.50375013993059503</c:v>
                </c:pt>
                <c:pt idx="6">
                  <c:v>0.443371594659836</c:v>
                </c:pt>
                <c:pt idx="7">
                  <c:v>0</c:v>
                </c:pt>
                <c:pt idx="8">
                  <c:v>0.4071606433811160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62F-4865-8BA2-EA4FD10F788F}"/>
            </c:ext>
          </c:extLst>
        </c:ser>
        <c:ser>
          <c:idx val="7"/>
          <c:order val="7"/>
          <c:tx>
            <c:strRef>
              <c:f>'Class_grafico '!$A$9</c:f>
              <c:strCache>
                <c:ptCount val="1"/>
                <c:pt idx="0">
                  <c:v>Thermoanaerobaculi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9:$K$9</c:f>
              <c:numCache>
                <c:formatCode>General</c:formatCode>
                <c:ptCount val="10"/>
                <c:pt idx="0">
                  <c:v>0.1444622792937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9180566439046199</c:v>
                </c:pt>
                <c:pt idx="6">
                  <c:v>4.4337159465983503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62F-4865-8BA2-EA4FD10F788F}"/>
            </c:ext>
          </c:extLst>
        </c:ser>
        <c:ser>
          <c:idx val="8"/>
          <c:order val="8"/>
          <c:tx>
            <c:strRef>
              <c:f>'Class_grafico '!$A$10</c:f>
              <c:strCache>
                <c:ptCount val="1"/>
                <c:pt idx="0">
                  <c:v>0319-7L14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0:$K$10</c:f>
              <c:numCache>
                <c:formatCode>General</c:formatCode>
                <c:ptCount val="10"/>
                <c:pt idx="0">
                  <c:v>11.883360085607279</c:v>
                </c:pt>
                <c:pt idx="1">
                  <c:v>0</c:v>
                </c:pt>
                <c:pt idx="2">
                  <c:v>2.395053126632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24139120153702201</c:v>
                </c:pt>
                <c:pt idx="7">
                  <c:v>0</c:v>
                </c:pt>
                <c:pt idx="8">
                  <c:v>8.0759135877246202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62F-4865-8BA2-EA4FD10F788F}"/>
            </c:ext>
          </c:extLst>
        </c:ser>
        <c:ser>
          <c:idx val="9"/>
          <c:order val="9"/>
          <c:tx>
            <c:strRef>
              <c:f>'Class_grafico '!$A$11</c:f>
              <c:strCache>
                <c:ptCount val="1"/>
                <c:pt idx="0">
                  <c:v>Acidimicrobiia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1:$K$11</c:f>
              <c:numCache>
                <c:formatCode>General</c:formatCode>
                <c:ptCount val="10"/>
                <c:pt idx="0">
                  <c:v>3.77207062600321</c:v>
                </c:pt>
                <c:pt idx="1">
                  <c:v>2.603723655609111</c:v>
                </c:pt>
                <c:pt idx="2">
                  <c:v>3.8168437554433021</c:v>
                </c:pt>
                <c:pt idx="3">
                  <c:v>2.6408273923084651</c:v>
                </c:pt>
                <c:pt idx="4">
                  <c:v>5.42829225925524E-3</c:v>
                </c:pt>
                <c:pt idx="5">
                  <c:v>2.4963618045449452</c:v>
                </c:pt>
                <c:pt idx="6">
                  <c:v>11.80353712005518</c:v>
                </c:pt>
                <c:pt idx="7">
                  <c:v>2.6781163000431332</c:v>
                </c:pt>
                <c:pt idx="8">
                  <c:v>3.3111245709670909</c:v>
                </c:pt>
                <c:pt idx="9">
                  <c:v>1.45945762481756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662F-4865-8BA2-EA4FD10F788F}"/>
            </c:ext>
          </c:extLst>
        </c:ser>
        <c:ser>
          <c:idx val="10"/>
          <c:order val="10"/>
          <c:tx>
            <c:strRef>
              <c:f>'Class_grafico '!$A$12</c:f>
              <c:strCache>
                <c:ptCount val="1"/>
                <c:pt idx="0">
                  <c:v>Actinobacteri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2:$K$12</c:f>
              <c:numCache>
                <c:formatCode>General</c:formatCode>
                <c:ptCount val="10"/>
                <c:pt idx="0">
                  <c:v>30.180131977884791</c:v>
                </c:pt>
                <c:pt idx="1">
                  <c:v>16.4303941026368</c:v>
                </c:pt>
                <c:pt idx="2">
                  <c:v>7.376763630029612</c:v>
                </c:pt>
                <c:pt idx="3">
                  <c:v>14.81072396826991</c:v>
                </c:pt>
                <c:pt idx="4">
                  <c:v>0.10585169905547701</c:v>
                </c:pt>
                <c:pt idx="5">
                  <c:v>1.511250419791784</c:v>
                </c:pt>
                <c:pt idx="6">
                  <c:v>50.677373269619203</c:v>
                </c:pt>
                <c:pt idx="7">
                  <c:v>24.177547739481628</c:v>
                </c:pt>
                <c:pt idx="8">
                  <c:v>11.42068779864055</c:v>
                </c:pt>
                <c:pt idx="9">
                  <c:v>7.58917964905135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662F-4865-8BA2-EA4FD10F788F}"/>
            </c:ext>
          </c:extLst>
        </c:ser>
        <c:ser>
          <c:idx val="11"/>
          <c:order val="11"/>
          <c:tx>
            <c:strRef>
              <c:f>'Class_grafico '!$A$13</c:f>
              <c:strCache>
                <c:ptCount val="1"/>
                <c:pt idx="0">
                  <c:v>Actinobacteria_unclassified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3:$K$13</c:f>
              <c:numCache>
                <c:formatCode>General</c:formatCode>
                <c:ptCount val="10"/>
                <c:pt idx="0">
                  <c:v>0.112359550561798</c:v>
                </c:pt>
                <c:pt idx="1">
                  <c:v>6.1430866647764898E-2</c:v>
                </c:pt>
                <c:pt idx="2">
                  <c:v>1.74185681936945E-2</c:v>
                </c:pt>
                <c:pt idx="3">
                  <c:v>6.5267597148308099E-2</c:v>
                </c:pt>
                <c:pt idx="4">
                  <c:v>0.12756486809249801</c:v>
                </c:pt>
                <c:pt idx="5">
                  <c:v>1.11944475540132E-2</c:v>
                </c:pt>
                <c:pt idx="6">
                  <c:v>0.13793782944972699</c:v>
                </c:pt>
                <c:pt idx="7">
                  <c:v>6.2737717131317899E-2</c:v>
                </c:pt>
                <c:pt idx="8">
                  <c:v>3.0284675953967301E-2</c:v>
                </c:pt>
                <c:pt idx="9">
                  <c:v>4.41231374944845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662F-4865-8BA2-EA4FD10F788F}"/>
            </c:ext>
          </c:extLst>
        </c:ser>
        <c:ser>
          <c:idx val="12"/>
          <c:order val="12"/>
          <c:tx>
            <c:strRef>
              <c:f>'Class_grafico '!$A$14</c:f>
              <c:strCache>
                <c:ptCount val="1"/>
                <c:pt idx="0">
                  <c:v>MB-A2-108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4:$K$14</c:f>
              <c:numCache>
                <c:formatCode>General</c:formatCode>
                <c:ptCount val="10"/>
                <c:pt idx="0">
                  <c:v>1.60513643659710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14779053155327801</c:v>
                </c:pt>
                <c:pt idx="7">
                  <c:v>0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662F-4865-8BA2-EA4FD10F788F}"/>
            </c:ext>
          </c:extLst>
        </c:ser>
        <c:ser>
          <c:idx val="13"/>
          <c:order val="13"/>
          <c:tx>
            <c:strRef>
              <c:f>'Class_grafico '!$A$15</c:f>
              <c:strCache>
                <c:ptCount val="1"/>
                <c:pt idx="0">
                  <c:v>Nitriliruptori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5:$K$15</c:f>
              <c:numCache>
                <c:formatCode>General</c:formatCode>
                <c:ptCount val="10"/>
                <c:pt idx="0">
                  <c:v>0.20153379703941501</c:v>
                </c:pt>
                <c:pt idx="1">
                  <c:v>2.117002173707589</c:v>
                </c:pt>
                <c:pt idx="2">
                  <c:v>0.30264762236544202</c:v>
                </c:pt>
                <c:pt idx="3">
                  <c:v>2.219098303042474</c:v>
                </c:pt>
                <c:pt idx="4">
                  <c:v>0.119422429703615</c:v>
                </c:pt>
                <c:pt idx="5">
                  <c:v>6.1569461547072699E-2</c:v>
                </c:pt>
                <c:pt idx="6">
                  <c:v>1.517316123946993</c:v>
                </c:pt>
                <c:pt idx="7">
                  <c:v>2.536956436497666</c:v>
                </c:pt>
                <c:pt idx="8">
                  <c:v>0.23554747964196801</c:v>
                </c:pt>
                <c:pt idx="9">
                  <c:v>0.49553677493805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662F-4865-8BA2-EA4FD10F788F}"/>
            </c:ext>
          </c:extLst>
        </c:ser>
        <c:ser>
          <c:idx val="14"/>
          <c:order val="14"/>
          <c:tx>
            <c:strRef>
              <c:f>'Class_grafico '!$A$16</c:f>
              <c:strCache>
                <c:ptCount val="1"/>
                <c:pt idx="0">
                  <c:v>Rubrobacteri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6:$K$16</c:f>
              <c:numCache>
                <c:formatCode>General</c:formatCode>
                <c:ptCount val="10"/>
                <c:pt idx="0">
                  <c:v>0.422685928303906</c:v>
                </c:pt>
                <c:pt idx="1">
                  <c:v>12.271996975711181</c:v>
                </c:pt>
                <c:pt idx="2">
                  <c:v>3.8669221390001729</c:v>
                </c:pt>
                <c:pt idx="3">
                  <c:v>13.56059845366001</c:v>
                </c:pt>
                <c:pt idx="4">
                  <c:v>65.326783194007149</c:v>
                </c:pt>
                <c:pt idx="5">
                  <c:v>0.29105563640434301</c:v>
                </c:pt>
                <c:pt idx="6">
                  <c:v>11.315828365929359</c:v>
                </c:pt>
                <c:pt idx="7">
                  <c:v>34.431243383131402</c:v>
                </c:pt>
                <c:pt idx="8">
                  <c:v>24.816609462278759</c:v>
                </c:pt>
                <c:pt idx="9">
                  <c:v>26.531581984183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662F-4865-8BA2-EA4FD10F788F}"/>
            </c:ext>
          </c:extLst>
        </c:ser>
        <c:ser>
          <c:idx val="15"/>
          <c:order val="15"/>
          <c:tx>
            <c:strRef>
              <c:f>'Class_grafico '!$A$17</c:f>
              <c:strCache>
                <c:ptCount val="1"/>
                <c:pt idx="0">
                  <c:v>Thermoleophili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7:$K$17</c:f>
              <c:numCache>
                <c:formatCode>General</c:formatCode>
                <c:ptCount val="10"/>
                <c:pt idx="0">
                  <c:v>0.82397003745318398</c:v>
                </c:pt>
                <c:pt idx="1">
                  <c:v>0.73244494849258102</c:v>
                </c:pt>
                <c:pt idx="2">
                  <c:v>1.7788712767810491</c:v>
                </c:pt>
                <c:pt idx="3">
                  <c:v>0.61753188071091503</c:v>
                </c:pt>
                <c:pt idx="4">
                  <c:v>2.71414612962762E-3</c:v>
                </c:pt>
                <c:pt idx="5">
                  <c:v>0.59890294413970702</c:v>
                </c:pt>
                <c:pt idx="6">
                  <c:v>0.52711956254002701</c:v>
                </c:pt>
                <c:pt idx="7">
                  <c:v>0</c:v>
                </c:pt>
                <c:pt idx="8">
                  <c:v>1.907934585099939</c:v>
                </c:pt>
                <c:pt idx="9">
                  <c:v>0.41407867494824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662F-4865-8BA2-EA4FD10F788F}"/>
            </c:ext>
          </c:extLst>
        </c:ser>
        <c:ser>
          <c:idx val="16"/>
          <c:order val="16"/>
          <c:tx>
            <c:strRef>
              <c:f>'Class_grafico '!$A$18</c:f>
              <c:strCache>
                <c:ptCount val="1"/>
                <c:pt idx="0">
                  <c:v>Fimbriimonadia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8:$K$18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0474459923278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662F-4865-8BA2-EA4FD10F788F}"/>
            </c:ext>
          </c:extLst>
        </c:ser>
        <c:ser>
          <c:idx val="17"/>
          <c:order val="17"/>
          <c:tx>
            <c:strRef>
              <c:f>'Class_grafico '!$A$19</c:f>
              <c:strCache>
                <c:ptCount val="1"/>
                <c:pt idx="0">
                  <c:v>BRC1_cl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19:$K$19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1.4176353841791899E-2</c:v>
                </c:pt>
                <c:pt idx="2">
                  <c:v>1.52412471694827E-2</c:v>
                </c:pt>
                <c:pt idx="3">
                  <c:v>5.0205843960236998E-3</c:v>
                </c:pt>
                <c:pt idx="4">
                  <c:v>0</c:v>
                </c:pt>
                <c:pt idx="5">
                  <c:v>5.5972237770066102E-3</c:v>
                </c:pt>
                <c:pt idx="6">
                  <c:v>1.47790531553278E-2</c:v>
                </c:pt>
                <c:pt idx="7">
                  <c:v>3.1368858565658901E-2</c:v>
                </c:pt>
                <c:pt idx="8">
                  <c:v>0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662F-4865-8BA2-EA4FD10F788F}"/>
            </c:ext>
          </c:extLst>
        </c:ser>
        <c:ser>
          <c:idx val="18"/>
          <c:order val="18"/>
          <c:tx>
            <c:strRef>
              <c:f>'Class_grafico '!$A$20</c:f>
              <c:strCache>
                <c:ptCount val="1"/>
                <c:pt idx="0">
                  <c:v>Bacteria_unclassified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0:$K$20</c:f>
              <c:numCache>
                <c:formatCode>General</c:formatCode>
                <c:ptCount val="10"/>
                <c:pt idx="0">
                  <c:v>0.28357410379882297</c:v>
                </c:pt>
                <c:pt idx="1">
                  <c:v>0.18901805122389201</c:v>
                </c:pt>
                <c:pt idx="2">
                  <c:v>0.12410729838007301</c:v>
                </c:pt>
                <c:pt idx="3">
                  <c:v>0.15563811627673499</c:v>
                </c:pt>
                <c:pt idx="4">
                  <c:v>8.1424383888828597E-2</c:v>
                </c:pt>
                <c:pt idx="5">
                  <c:v>0.82838911899697698</c:v>
                </c:pt>
                <c:pt idx="6">
                  <c:v>0.29558106310655702</c:v>
                </c:pt>
                <c:pt idx="7">
                  <c:v>3.1368858565658901E-2</c:v>
                </c:pt>
                <c:pt idx="8">
                  <c:v>0.121138703815869</c:v>
                </c:pt>
                <c:pt idx="9">
                  <c:v>6.109357499236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662F-4865-8BA2-EA4FD10F788F}"/>
            </c:ext>
          </c:extLst>
        </c:ser>
        <c:ser>
          <c:idx val="19"/>
          <c:order val="19"/>
          <c:tx>
            <c:strRef>
              <c:f>'Class_grafico '!$A$21</c:f>
              <c:strCache>
                <c:ptCount val="1"/>
                <c:pt idx="0">
                  <c:v>Bacteroidetes_unclassified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1:$K$21</c:f>
              <c:numCache>
                <c:formatCode>General</c:formatCode>
                <c:ptCount val="10"/>
                <c:pt idx="0">
                  <c:v>1.0700909577314101E-2</c:v>
                </c:pt>
                <c:pt idx="1">
                  <c:v>4.7254512805973E-3</c:v>
                </c:pt>
                <c:pt idx="2">
                  <c:v>2.1773210242118099E-3</c:v>
                </c:pt>
                <c:pt idx="3">
                  <c:v>5.0205843960236998E-3</c:v>
                </c:pt>
                <c:pt idx="4">
                  <c:v>2.71414612962762E-3</c:v>
                </c:pt>
                <c:pt idx="5">
                  <c:v>5.5972237770066102E-3</c:v>
                </c:pt>
                <c:pt idx="6">
                  <c:v>0</c:v>
                </c:pt>
                <c:pt idx="7">
                  <c:v>0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662F-4865-8BA2-EA4FD10F788F}"/>
            </c:ext>
          </c:extLst>
        </c:ser>
        <c:ser>
          <c:idx val="20"/>
          <c:order val="20"/>
          <c:tx>
            <c:strRef>
              <c:f>'Class_grafico '!$A$22</c:f>
              <c:strCache>
                <c:ptCount val="1"/>
                <c:pt idx="0">
                  <c:v>Bacteroidia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2:$K$22</c:f>
              <c:numCache>
                <c:formatCode>General</c:formatCode>
                <c:ptCount val="10"/>
                <c:pt idx="0">
                  <c:v>0.49224184055644699</c:v>
                </c:pt>
                <c:pt idx="1">
                  <c:v>3.1849541631225788</c:v>
                </c:pt>
                <c:pt idx="2">
                  <c:v>2.3863438425361441</c:v>
                </c:pt>
                <c:pt idx="3">
                  <c:v>3.5294708304046591</c:v>
                </c:pt>
                <c:pt idx="4">
                  <c:v>4.3046357615894033</c:v>
                </c:pt>
                <c:pt idx="5">
                  <c:v>6.0394044553901276</c:v>
                </c:pt>
                <c:pt idx="6">
                  <c:v>1.073944529287157</c:v>
                </c:pt>
                <c:pt idx="7">
                  <c:v>1.278280986550602</c:v>
                </c:pt>
                <c:pt idx="8">
                  <c:v>6.9890302173766736</c:v>
                </c:pt>
                <c:pt idx="9">
                  <c:v>11.689237348538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662F-4865-8BA2-EA4FD10F788F}"/>
            </c:ext>
          </c:extLst>
        </c:ser>
        <c:ser>
          <c:idx val="21"/>
          <c:order val="21"/>
          <c:tx>
            <c:strRef>
              <c:f>'Class_grafico '!$A$23</c:f>
              <c:strCache>
                <c:ptCount val="1"/>
                <c:pt idx="0">
                  <c:v>Ignavibacteria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3:$K$23</c:f>
              <c:numCache>
                <c:formatCode>General</c:formatCode>
                <c:ptCount val="10"/>
                <c:pt idx="0">
                  <c:v>0.278223649010166</c:v>
                </c:pt>
                <c:pt idx="1">
                  <c:v>3.3078158964181099E-2</c:v>
                </c:pt>
                <c:pt idx="2">
                  <c:v>5.2255704581083397E-2</c:v>
                </c:pt>
                <c:pt idx="3">
                  <c:v>3.0123506376142199E-2</c:v>
                </c:pt>
                <c:pt idx="4">
                  <c:v>0</c:v>
                </c:pt>
                <c:pt idx="5">
                  <c:v>0.82279189521997098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662F-4865-8BA2-EA4FD10F788F}"/>
            </c:ext>
          </c:extLst>
        </c:ser>
        <c:ser>
          <c:idx val="22"/>
          <c:order val="22"/>
          <c:tx>
            <c:strRef>
              <c:f>'Class_grafico '!$A$24</c:f>
              <c:strCache>
                <c:ptCount val="1"/>
                <c:pt idx="0">
                  <c:v>Rhodothermia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4:$K$24</c:f>
              <c:numCache>
                <c:formatCode>General</c:formatCode>
                <c:ptCount val="10"/>
                <c:pt idx="0">
                  <c:v>0.29784198323524202</c:v>
                </c:pt>
                <c:pt idx="1">
                  <c:v>7.29137132596163</c:v>
                </c:pt>
                <c:pt idx="2">
                  <c:v>0.33530743772861898</c:v>
                </c:pt>
                <c:pt idx="3">
                  <c:v>7.1744151019178624</c:v>
                </c:pt>
                <c:pt idx="4">
                  <c:v>28.53110411464554</c:v>
                </c:pt>
                <c:pt idx="5">
                  <c:v>0.190305608418225</c:v>
                </c:pt>
                <c:pt idx="6">
                  <c:v>0.315286467313661</c:v>
                </c:pt>
                <c:pt idx="7">
                  <c:v>3.5289965886366299E-2</c:v>
                </c:pt>
                <c:pt idx="8">
                  <c:v>2.0257083249209229</c:v>
                </c:pt>
                <c:pt idx="9">
                  <c:v>17.340393035332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662F-4865-8BA2-EA4FD10F788F}"/>
            </c:ext>
          </c:extLst>
        </c:ser>
        <c:ser>
          <c:idx val="23"/>
          <c:order val="23"/>
          <c:tx>
            <c:strRef>
              <c:f>'Class_grafico '!$A$25</c:f>
              <c:strCache>
                <c:ptCount val="1"/>
                <c:pt idx="0">
                  <c:v>Chlamydiae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5:$K$25</c:f>
              <c:numCache>
                <c:formatCode>General</c:formatCode>
                <c:ptCount val="10"/>
                <c:pt idx="0">
                  <c:v>7.1339397182093797E-2</c:v>
                </c:pt>
                <c:pt idx="1">
                  <c:v>0</c:v>
                </c:pt>
                <c:pt idx="2">
                  <c:v>8.7092840968472397E-3</c:v>
                </c:pt>
                <c:pt idx="3">
                  <c:v>0</c:v>
                </c:pt>
                <c:pt idx="4">
                  <c:v>0</c:v>
                </c:pt>
                <c:pt idx="5">
                  <c:v>0.38061121683644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662F-4865-8BA2-EA4FD10F788F}"/>
            </c:ext>
          </c:extLst>
        </c:ser>
        <c:ser>
          <c:idx val="24"/>
          <c:order val="24"/>
          <c:tx>
            <c:strRef>
              <c:f>'Class_grafico '!$A$26</c:f>
              <c:strCache>
                <c:ptCount val="1"/>
                <c:pt idx="0">
                  <c:v>Anaerolinea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6:$K$26</c:f>
              <c:numCache>
                <c:formatCode>General</c:formatCode>
                <c:ptCount val="10"/>
                <c:pt idx="0">
                  <c:v>0.61351881576600698</c:v>
                </c:pt>
                <c:pt idx="1">
                  <c:v>1.181362820149324</c:v>
                </c:pt>
                <c:pt idx="2">
                  <c:v>1.567671137432503</c:v>
                </c:pt>
                <c:pt idx="3">
                  <c:v>1.0041168792047399</c:v>
                </c:pt>
                <c:pt idx="4">
                  <c:v>0</c:v>
                </c:pt>
                <c:pt idx="5">
                  <c:v>3.2184036717787978</c:v>
                </c:pt>
                <c:pt idx="6">
                  <c:v>0.25124390364057297</c:v>
                </c:pt>
                <c:pt idx="7">
                  <c:v>0</c:v>
                </c:pt>
                <c:pt idx="8">
                  <c:v>1.5007739417188239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662F-4865-8BA2-EA4FD10F788F}"/>
            </c:ext>
          </c:extLst>
        </c:ser>
        <c:ser>
          <c:idx val="25"/>
          <c:order val="25"/>
          <c:tx>
            <c:strRef>
              <c:f>'Class_grafico '!$A$27</c:f>
              <c:strCache>
                <c:ptCount val="1"/>
                <c:pt idx="0">
                  <c:v>Chloroflexi_unclassified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7:$K$27</c:f>
              <c:numCache>
                <c:formatCode>General</c:formatCode>
                <c:ptCount val="10"/>
                <c:pt idx="0">
                  <c:v>2.1401819154628101E-2</c:v>
                </c:pt>
                <c:pt idx="1">
                  <c:v>4.7254512805973E-3</c:v>
                </c:pt>
                <c:pt idx="2">
                  <c:v>8.7092840968472404E-2</c:v>
                </c:pt>
                <c:pt idx="3">
                  <c:v>2.5102921980118501E-2</c:v>
                </c:pt>
                <c:pt idx="4">
                  <c:v>0</c:v>
                </c:pt>
                <c:pt idx="5">
                  <c:v>5.5972237770066102E-3</c:v>
                </c:pt>
                <c:pt idx="6">
                  <c:v>2.4631755258879801E-2</c:v>
                </c:pt>
                <c:pt idx="7">
                  <c:v>0</c:v>
                </c:pt>
                <c:pt idx="8">
                  <c:v>2.018978396931149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662F-4865-8BA2-EA4FD10F788F}"/>
            </c:ext>
          </c:extLst>
        </c:ser>
        <c:ser>
          <c:idx val="26"/>
          <c:order val="26"/>
          <c:tx>
            <c:strRef>
              <c:f>'Class_grafico '!$A$28</c:f>
              <c:strCache>
                <c:ptCount val="1"/>
                <c:pt idx="0">
                  <c:v>Chloroflexia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8:$K$28</c:f>
              <c:numCache>
                <c:formatCode>General</c:formatCode>
                <c:ptCount val="10"/>
                <c:pt idx="0">
                  <c:v>0.99518459069020904</c:v>
                </c:pt>
                <c:pt idx="1">
                  <c:v>6.6061808902750201</c:v>
                </c:pt>
                <c:pt idx="2">
                  <c:v>6.3991464901585102</c:v>
                </c:pt>
                <c:pt idx="3">
                  <c:v>6.9936740636610102</c:v>
                </c:pt>
                <c:pt idx="4">
                  <c:v>0</c:v>
                </c:pt>
                <c:pt idx="5">
                  <c:v>0.59330572036270002</c:v>
                </c:pt>
                <c:pt idx="6">
                  <c:v>4.5273166165820946</c:v>
                </c:pt>
                <c:pt idx="7">
                  <c:v>1.6703917186213391</c:v>
                </c:pt>
                <c:pt idx="8">
                  <c:v>4.9263072885120129</c:v>
                </c:pt>
                <c:pt idx="9">
                  <c:v>4.78905746190137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662F-4865-8BA2-EA4FD10F788F}"/>
            </c:ext>
          </c:extLst>
        </c:ser>
        <c:ser>
          <c:idx val="27"/>
          <c:order val="27"/>
          <c:tx>
            <c:strRef>
              <c:f>'Class_grafico '!$A$29</c:f>
              <c:strCache>
                <c:ptCount val="1"/>
                <c:pt idx="0">
                  <c:v>Dehalococcoidia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29:$K$29</c:f>
              <c:numCache>
                <c:formatCode>General</c:formatCode>
                <c:ptCount val="10"/>
                <c:pt idx="0">
                  <c:v>6.5988942393436806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7986118885032999E-2</c:v>
                </c:pt>
                <c:pt idx="6">
                  <c:v>0.221685797329918</c:v>
                </c:pt>
                <c:pt idx="7">
                  <c:v>0</c:v>
                </c:pt>
                <c:pt idx="8">
                  <c:v>1.00948919846558E-2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662F-4865-8BA2-EA4FD10F788F}"/>
            </c:ext>
          </c:extLst>
        </c:ser>
        <c:ser>
          <c:idx val="28"/>
          <c:order val="28"/>
          <c:tx>
            <c:strRef>
              <c:f>'Class_grafico '!$A$30</c:f>
              <c:strCache>
                <c:ptCount val="1"/>
                <c:pt idx="0">
                  <c:v>Gitt-GS-136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0:$K$30</c:f>
              <c:numCache>
                <c:formatCode>General</c:formatCode>
                <c:ptCount val="10"/>
                <c:pt idx="0">
                  <c:v>5.1721062957017998E-2</c:v>
                </c:pt>
                <c:pt idx="1">
                  <c:v>9.4509025611946001E-3</c:v>
                </c:pt>
                <c:pt idx="2">
                  <c:v>2.39505312663299E-2</c:v>
                </c:pt>
                <c:pt idx="3">
                  <c:v>5.0205843960237001E-2</c:v>
                </c:pt>
                <c:pt idx="4">
                  <c:v>0</c:v>
                </c:pt>
                <c:pt idx="5">
                  <c:v>0.106347251763125</c:v>
                </c:pt>
                <c:pt idx="6">
                  <c:v>0.408887137297404</c:v>
                </c:pt>
                <c:pt idx="7">
                  <c:v>0</c:v>
                </c:pt>
                <c:pt idx="8">
                  <c:v>7.7394171882360904E-2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662F-4865-8BA2-EA4FD10F788F}"/>
            </c:ext>
          </c:extLst>
        </c:ser>
        <c:ser>
          <c:idx val="29"/>
          <c:order val="29"/>
          <c:tx>
            <c:strRef>
              <c:f>'Class_grafico '!$A$31</c:f>
              <c:strCache>
                <c:ptCount val="1"/>
                <c:pt idx="0">
                  <c:v>JG30-KF-CM66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1:$K$31</c:f>
              <c:numCache>
                <c:formatCode>General</c:formatCode>
                <c:ptCount val="10"/>
                <c:pt idx="0">
                  <c:v>9.8091671125379004E-2</c:v>
                </c:pt>
                <c:pt idx="1">
                  <c:v>0.10395992817314099</c:v>
                </c:pt>
                <c:pt idx="2">
                  <c:v>0.26127852290541698</c:v>
                </c:pt>
                <c:pt idx="3">
                  <c:v>8.0329350336379196E-2</c:v>
                </c:pt>
                <c:pt idx="4">
                  <c:v>0</c:v>
                </c:pt>
                <c:pt idx="5">
                  <c:v>0.21269450352625099</c:v>
                </c:pt>
                <c:pt idx="6">
                  <c:v>0.113306074190847</c:v>
                </c:pt>
                <c:pt idx="7">
                  <c:v>0</c:v>
                </c:pt>
                <c:pt idx="8">
                  <c:v>0.16488323574937799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662F-4865-8BA2-EA4FD10F788F}"/>
            </c:ext>
          </c:extLst>
        </c:ser>
        <c:ser>
          <c:idx val="30"/>
          <c:order val="30"/>
          <c:tx>
            <c:strRef>
              <c:f>'Class_grafico '!$A$32</c:f>
              <c:strCache>
                <c:ptCount val="1"/>
                <c:pt idx="0">
                  <c:v>KD4-96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2:$K$32</c:f>
              <c:numCache>
                <c:formatCode>General</c:formatCode>
                <c:ptCount val="10"/>
                <c:pt idx="0">
                  <c:v>0.16943106830747301</c:v>
                </c:pt>
                <c:pt idx="1">
                  <c:v>0</c:v>
                </c:pt>
                <c:pt idx="2">
                  <c:v>4.3546420484236199E-3</c:v>
                </c:pt>
                <c:pt idx="3">
                  <c:v>1.00411687920474E-2</c:v>
                </c:pt>
                <c:pt idx="4">
                  <c:v>0</c:v>
                </c:pt>
                <c:pt idx="5">
                  <c:v>0.12313892309414499</c:v>
                </c:pt>
                <c:pt idx="6">
                  <c:v>1.97054042071037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662F-4865-8BA2-EA4FD10F788F}"/>
            </c:ext>
          </c:extLst>
        </c:ser>
        <c:ser>
          <c:idx val="31"/>
          <c:order val="31"/>
          <c:tx>
            <c:strRef>
              <c:f>'Class_grafico '!$A$33</c:f>
              <c:strCache>
                <c:ptCount val="1"/>
                <c:pt idx="0">
                  <c:v>N9D0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3:$K$3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.0205843960236998E-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662F-4865-8BA2-EA4FD10F788F}"/>
            </c:ext>
          </c:extLst>
        </c:ser>
        <c:ser>
          <c:idx val="32"/>
          <c:order val="32"/>
          <c:tx>
            <c:strRef>
              <c:f>'Class_grafico '!$A$34</c:f>
              <c:strCache>
                <c:ptCount val="1"/>
                <c:pt idx="0">
                  <c:v>OLB14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4:$K$34</c:f>
              <c:numCache>
                <c:formatCode>General</c:formatCode>
                <c:ptCount val="10"/>
                <c:pt idx="0">
                  <c:v>0.12841091492776899</c:v>
                </c:pt>
                <c:pt idx="1">
                  <c:v>3.3078158964181099E-2</c:v>
                </c:pt>
                <c:pt idx="2">
                  <c:v>8.7092840968472397E-3</c:v>
                </c:pt>
                <c:pt idx="3">
                  <c:v>1.5061753188071099E-2</c:v>
                </c:pt>
                <c:pt idx="4">
                  <c:v>0</c:v>
                </c:pt>
                <c:pt idx="5">
                  <c:v>0.173513937087205</c:v>
                </c:pt>
                <c:pt idx="6">
                  <c:v>3.9410808414207597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662F-4865-8BA2-EA4FD10F788F}"/>
            </c:ext>
          </c:extLst>
        </c:ser>
        <c:ser>
          <c:idx val="33"/>
          <c:order val="33"/>
          <c:tx>
            <c:strRef>
              <c:f>'Class_grafico '!$A$35</c:f>
              <c:strCache>
                <c:ptCount val="1"/>
                <c:pt idx="0">
                  <c:v>P2-11E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5:$K$35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662F-4865-8BA2-EA4FD10F788F}"/>
            </c:ext>
          </c:extLst>
        </c:ser>
        <c:ser>
          <c:idx val="34"/>
          <c:order val="34"/>
          <c:tx>
            <c:strRef>
              <c:f>'Class_grafico '!$A$36</c:f>
              <c:strCache>
                <c:ptCount val="1"/>
                <c:pt idx="0">
                  <c:v>TK10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6:$K$36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4.7254512805973E-3</c:v>
                </c:pt>
                <c:pt idx="2">
                  <c:v>0.10886605121059099</c:v>
                </c:pt>
                <c:pt idx="3">
                  <c:v>1.5061753188071099E-2</c:v>
                </c:pt>
                <c:pt idx="4">
                  <c:v>0</c:v>
                </c:pt>
                <c:pt idx="5">
                  <c:v>0</c:v>
                </c:pt>
                <c:pt idx="6">
                  <c:v>1.47790531553278E-2</c:v>
                </c:pt>
                <c:pt idx="7">
                  <c:v>0</c:v>
                </c:pt>
                <c:pt idx="8">
                  <c:v>1.345985597954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662F-4865-8BA2-EA4FD10F788F}"/>
            </c:ext>
          </c:extLst>
        </c:ser>
        <c:ser>
          <c:idx val="35"/>
          <c:order val="35"/>
          <c:tx>
            <c:strRef>
              <c:f>'Class_grafico '!$A$37</c:f>
              <c:strCache>
                <c:ptCount val="1"/>
                <c:pt idx="0">
                  <c:v>Melainabacteria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7:$K$37</c:f>
              <c:numCache>
                <c:formatCode>General</c:formatCode>
                <c:ptCount val="10"/>
                <c:pt idx="0">
                  <c:v>0</c:v>
                </c:pt>
                <c:pt idx="1">
                  <c:v>0.108685379453738</c:v>
                </c:pt>
                <c:pt idx="2">
                  <c:v>1.0886605121059E-2</c:v>
                </c:pt>
                <c:pt idx="3">
                  <c:v>0.105432272316498</c:v>
                </c:pt>
                <c:pt idx="4">
                  <c:v>0</c:v>
                </c:pt>
                <c:pt idx="5">
                  <c:v>1.186611440725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3-662F-4865-8BA2-EA4FD10F788F}"/>
            </c:ext>
          </c:extLst>
        </c:ser>
        <c:ser>
          <c:idx val="36"/>
          <c:order val="36"/>
          <c:tx>
            <c:strRef>
              <c:f>'Class_grafico '!$A$38</c:f>
              <c:strCache>
                <c:ptCount val="1"/>
                <c:pt idx="0">
                  <c:v>Oxyphotobacteria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8:$K$38</c:f>
              <c:numCache>
                <c:formatCode>General</c:formatCode>
                <c:ptCount val="10"/>
                <c:pt idx="0">
                  <c:v>7.9703941501694313</c:v>
                </c:pt>
                <c:pt idx="1">
                  <c:v>12.47519138077686</c:v>
                </c:pt>
                <c:pt idx="2">
                  <c:v>26.6221041630378</c:v>
                </c:pt>
                <c:pt idx="3">
                  <c:v>13.113766442413899</c:v>
                </c:pt>
                <c:pt idx="4">
                  <c:v>1.0856584518510499E-2</c:v>
                </c:pt>
                <c:pt idx="5">
                  <c:v>7.1028769730213801</c:v>
                </c:pt>
                <c:pt idx="6">
                  <c:v>0.187201339967486</c:v>
                </c:pt>
                <c:pt idx="7">
                  <c:v>7.9833745049602012</c:v>
                </c:pt>
                <c:pt idx="8">
                  <c:v>6.3934315902819797E-2</c:v>
                </c:pt>
                <c:pt idx="9">
                  <c:v>1.7717136747785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662F-4865-8BA2-EA4FD10F788F}"/>
            </c:ext>
          </c:extLst>
        </c:ser>
        <c:ser>
          <c:idx val="37"/>
          <c:order val="37"/>
          <c:tx>
            <c:strRef>
              <c:f>'Class_grafico '!$A$39</c:f>
              <c:strCache>
                <c:ptCount val="1"/>
                <c:pt idx="0">
                  <c:v>Sericytochromatia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39:$K$3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4.35464204842361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5-662F-4865-8BA2-EA4FD10F788F}"/>
            </c:ext>
          </c:extLst>
        </c:ser>
        <c:ser>
          <c:idx val="38"/>
          <c:order val="38"/>
          <c:tx>
            <c:strRef>
              <c:f>'Class_grafico '!$A$40</c:f>
              <c:strCache>
                <c:ptCount val="1"/>
                <c:pt idx="0">
                  <c:v>Dadabacteriia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0:$K$40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662F-4865-8BA2-EA4FD10F788F}"/>
            </c:ext>
          </c:extLst>
        </c:ser>
        <c:ser>
          <c:idx val="39"/>
          <c:order val="39"/>
          <c:tx>
            <c:strRef>
              <c:f>'Class_grafico '!$A$41</c:f>
              <c:strCache>
                <c:ptCount val="1"/>
                <c:pt idx="0">
                  <c:v>Deinococci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1:$K$41</c:f>
              <c:numCache>
                <c:formatCode>General</c:formatCode>
                <c:ptCount val="10"/>
                <c:pt idx="0">
                  <c:v>8.0256821829855496E-2</c:v>
                </c:pt>
                <c:pt idx="1">
                  <c:v>3.78036102447784E-2</c:v>
                </c:pt>
                <c:pt idx="2">
                  <c:v>0.30482494338965399</c:v>
                </c:pt>
                <c:pt idx="3">
                  <c:v>8.0329350336379196E-2</c:v>
                </c:pt>
                <c:pt idx="4">
                  <c:v>0</c:v>
                </c:pt>
                <c:pt idx="5">
                  <c:v>2.7986118885032999E-2</c:v>
                </c:pt>
                <c:pt idx="6">
                  <c:v>0.24631755258879701</c:v>
                </c:pt>
                <c:pt idx="7">
                  <c:v>1.1763321962122099E-2</c:v>
                </c:pt>
                <c:pt idx="8">
                  <c:v>9.0854027861901901E-2</c:v>
                </c:pt>
                <c:pt idx="9">
                  <c:v>0.45820181244272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662F-4865-8BA2-EA4FD10F788F}"/>
            </c:ext>
          </c:extLst>
        </c:ser>
        <c:ser>
          <c:idx val="40"/>
          <c:order val="40"/>
          <c:tx>
            <c:strRef>
              <c:f>'Class_grafico '!$A$42</c:f>
              <c:strCache>
                <c:ptCount val="1"/>
                <c:pt idx="0">
                  <c:v>Babeliae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2:$K$42</c:f>
              <c:numCache>
                <c:formatCode>General</c:formatCode>
                <c:ptCount val="10"/>
                <c:pt idx="0">
                  <c:v>5.35045478865704E-2</c:v>
                </c:pt>
                <c:pt idx="1">
                  <c:v>9.4509025611946001E-3</c:v>
                </c:pt>
                <c:pt idx="2">
                  <c:v>0</c:v>
                </c:pt>
                <c:pt idx="3">
                  <c:v>3.0123506376142199E-2</c:v>
                </c:pt>
                <c:pt idx="4">
                  <c:v>0</c:v>
                </c:pt>
                <c:pt idx="5">
                  <c:v>4.4777790216052799E-2</c:v>
                </c:pt>
                <c:pt idx="6">
                  <c:v>3.4484457362431602E-2</c:v>
                </c:pt>
                <c:pt idx="7">
                  <c:v>0</c:v>
                </c:pt>
                <c:pt idx="8">
                  <c:v>0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662F-4865-8BA2-EA4FD10F788F}"/>
            </c:ext>
          </c:extLst>
        </c:ser>
        <c:ser>
          <c:idx val="41"/>
          <c:order val="41"/>
          <c:tx>
            <c:strRef>
              <c:f>'Class_grafico '!$A$43</c:f>
              <c:strCache>
                <c:ptCount val="1"/>
                <c:pt idx="0">
                  <c:v>Elusimicrobia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3:$K$43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9-662F-4865-8BA2-EA4FD10F788F}"/>
            </c:ext>
          </c:extLst>
        </c:ser>
        <c:ser>
          <c:idx val="42"/>
          <c:order val="42"/>
          <c:tx>
            <c:strRef>
              <c:f>'Class_grafico '!$A$44</c:f>
              <c:strCache>
                <c:ptCount val="1"/>
                <c:pt idx="0">
                  <c:v>Elusimicrobia_unclassified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4:$K$44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A-662F-4865-8BA2-EA4FD10F788F}"/>
            </c:ext>
          </c:extLst>
        </c:ser>
        <c:ser>
          <c:idx val="43"/>
          <c:order val="43"/>
          <c:tx>
            <c:strRef>
              <c:f>'Class_grafico '!$A$45</c:f>
              <c:strCache>
                <c:ptCount val="1"/>
                <c:pt idx="0">
                  <c:v>Lineage_IIa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5:$K$45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1.89018051223892E-2</c:v>
                </c:pt>
                <c:pt idx="2">
                  <c:v>8.9270161992684199E-2</c:v>
                </c:pt>
                <c:pt idx="3">
                  <c:v>2.5102921980118501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B-662F-4865-8BA2-EA4FD10F788F}"/>
            </c:ext>
          </c:extLst>
        </c:ser>
        <c:ser>
          <c:idx val="44"/>
          <c:order val="44"/>
          <c:tx>
            <c:strRef>
              <c:f>'Class_grafico '!$A$46</c:f>
              <c:strCache>
                <c:ptCount val="1"/>
                <c:pt idx="0">
                  <c:v>Lineage_IIb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6:$K$46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C-662F-4865-8BA2-EA4FD10F788F}"/>
            </c:ext>
          </c:extLst>
        </c:ser>
        <c:ser>
          <c:idx val="45"/>
          <c:order val="45"/>
          <c:tx>
            <c:strRef>
              <c:f>'Class_grafico '!$A$47</c:f>
              <c:strCache>
                <c:ptCount val="1"/>
                <c:pt idx="0">
                  <c:v>Lineage_IIc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7:$K$47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D-662F-4865-8BA2-EA4FD10F788F}"/>
            </c:ext>
          </c:extLst>
        </c:ser>
        <c:ser>
          <c:idx val="46"/>
          <c:order val="46"/>
          <c:tx>
            <c:strRef>
              <c:f>'Class_grafico '!$A$48</c:f>
              <c:strCache>
                <c:ptCount val="1"/>
                <c:pt idx="0">
                  <c:v>Campylobacteria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8:$K$4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5.42829225925524E-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E-662F-4865-8BA2-EA4FD10F788F}"/>
            </c:ext>
          </c:extLst>
        </c:ser>
        <c:ser>
          <c:idx val="47"/>
          <c:order val="47"/>
          <c:tx>
            <c:strRef>
              <c:f>'Class_grafico '!$A$49</c:f>
              <c:strCache>
                <c:ptCount val="1"/>
                <c:pt idx="0">
                  <c:v>FBP_cl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49:$K$4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.395053126632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6.0569351907934603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F-662F-4865-8BA2-EA4FD10F788F}"/>
            </c:ext>
          </c:extLst>
        </c:ser>
        <c:ser>
          <c:idx val="48"/>
          <c:order val="48"/>
          <c:tx>
            <c:strRef>
              <c:f>'Class_grafico '!$A$50</c:f>
              <c:strCache>
                <c:ptCount val="1"/>
                <c:pt idx="0">
                  <c:v>FCPU426_cl</c:v>
                </c:pt>
              </c:strCache>
            </c:strRef>
          </c:tx>
          <c:spPr>
            <a:solidFill>
              <a:schemeClr val="accent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0:$K$5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0-662F-4865-8BA2-EA4FD10F788F}"/>
            </c:ext>
          </c:extLst>
        </c:ser>
        <c:ser>
          <c:idx val="49"/>
          <c:order val="49"/>
          <c:tx>
            <c:strRef>
              <c:f>'Class_grafico '!$A$51</c:f>
              <c:strCache>
                <c:ptCount val="1"/>
                <c:pt idx="0">
                  <c:v>Bacilli</c:v>
                </c:pt>
              </c:strCache>
            </c:strRef>
          </c:tx>
          <c:spPr>
            <a:solidFill>
              <a:schemeClr val="accent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1:$K$51</c:f>
              <c:numCache>
                <c:formatCode>General</c:formatCode>
                <c:ptCount val="10"/>
                <c:pt idx="0">
                  <c:v>1.9618334225075799E-2</c:v>
                </c:pt>
                <c:pt idx="1">
                  <c:v>1.89018051223892E-2</c:v>
                </c:pt>
                <c:pt idx="2">
                  <c:v>0</c:v>
                </c:pt>
                <c:pt idx="3">
                  <c:v>1.5061753188071099E-2</c:v>
                </c:pt>
                <c:pt idx="4">
                  <c:v>5.6997068722180001E-2</c:v>
                </c:pt>
                <c:pt idx="5">
                  <c:v>0.55972237770066002</c:v>
                </c:pt>
                <c:pt idx="6">
                  <c:v>1.9705404207103799E-2</c:v>
                </c:pt>
                <c:pt idx="7">
                  <c:v>2.74477512449516E-2</c:v>
                </c:pt>
                <c:pt idx="8">
                  <c:v>1.6824819974426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1-662F-4865-8BA2-EA4FD10F788F}"/>
            </c:ext>
          </c:extLst>
        </c:ser>
        <c:ser>
          <c:idx val="50"/>
          <c:order val="50"/>
          <c:tx>
            <c:strRef>
              <c:f>'Class_grafico '!$A$52</c:f>
              <c:strCache>
                <c:ptCount val="1"/>
                <c:pt idx="0">
                  <c:v>Clostridia</c:v>
                </c:pt>
              </c:strCache>
            </c:strRef>
          </c:tx>
          <c:spPr>
            <a:solidFill>
              <a:schemeClr val="accent3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2:$K$52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9.4509025611946001E-3</c:v>
                </c:pt>
                <c:pt idx="2">
                  <c:v>0</c:v>
                </c:pt>
                <c:pt idx="3">
                  <c:v>1.5061753188071099E-2</c:v>
                </c:pt>
                <c:pt idx="4">
                  <c:v>2.1713169037020998E-2</c:v>
                </c:pt>
                <c:pt idx="5">
                  <c:v>1.6791671331019799E-2</c:v>
                </c:pt>
                <c:pt idx="6">
                  <c:v>3.4484457362431602E-2</c:v>
                </c:pt>
                <c:pt idx="7">
                  <c:v>7.8422146414147392E-3</c:v>
                </c:pt>
                <c:pt idx="8">
                  <c:v>1.3459855979541E-2</c:v>
                </c:pt>
                <c:pt idx="9">
                  <c:v>1.69704374978787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2-662F-4865-8BA2-EA4FD10F788F}"/>
            </c:ext>
          </c:extLst>
        </c:ser>
        <c:ser>
          <c:idx val="51"/>
          <c:order val="51"/>
          <c:tx>
            <c:strRef>
              <c:f>'Class_grafico '!$A$53</c:f>
              <c:strCache>
                <c:ptCount val="1"/>
                <c:pt idx="0">
                  <c:v>Firmicutes_unclassified</c:v>
                </c:pt>
              </c:strCache>
            </c:strRef>
          </c:tx>
          <c:spPr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3:$K$5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.17732102421180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4.9263510517759497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3-662F-4865-8BA2-EA4FD10F788F}"/>
            </c:ext>
          </c:extLst>
        </c:ser>
        <c:ser>
          <c:idx val="52"/>
          <c:order val="52"/>
          <c:tx>
            <c:strRef>
              <c:f>'Class_grafico '!$A$54</c:f>
              <c:strCache>
                <c:ptCount val="1"/>
                <c:pt idx="0">
                  <c:v>Limnochordia</c:v>
                </c:pt>
              </c:strCache>
            </c:strRef>
          </c:tx>
          <c:spPr>
            <a:solidFill>
              <a:schemeClr val="accent5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4:$K$54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97054042071037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4-662F-4865-8BA2-EA4FD10F788F}"/>
            </c:ext>
          </c:extLst>
        </c:ser>
        <c:ser>
          <c:idx val="53"/>
          <c:order val="53"/>
          <c:tx>
            <c:strRef>
              <c:f>'Class_grafico '!$A$55</c:f>
              <c:strCache>
                <c:ptCount val="1"/>
                <c:pt idx="0">
                  <c:v>GAL15_cl</c:v>
                </c:pt>
              </c:strCache>
            </c:strRef>
          </c:tx>
          <c:spPr>
            <a:solidFill>
              <a:schemeClr val="accent6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5:$K$55</c:f>
              <c:numCache>
                <c:formatCode>General</c:formatCode>
                <c:ptCount val="10"/>
                <c:pt idx="0">
                  <c:v>1.248439450686640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5-662F-4865-8BA2-EA4FD10F788F}"/>
            </c:ext>
          </c:extLst>
        </c:ser>
        <c:ser>
          <c:idx val="54"/>
          <c:order val="54"/>
          <c:tx>
            <c:strRef>
              <c:f>'Class_grafico '!$A$56</c:f>
              <c:strCache>
                <c:ptCount val="1"/>
                <c:pt idx="0">
                  <c:v>AKAU4049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6:$K$56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6-662F-4865-8BA2-EA4FD10F788F}"/>
            </c:ext>
          </c:extLst>
        </c:ser>
        <c:ser>
          <c:idx val="55"/>
          <c:order val="55"/>
          <c:tx>
            <c:strRef>
              <c:f>'Class_grafico '!$A$57</c:f>
              <c:strCache>
                <c:ptCount val="1"/>
                <c:pt idx="0">
                  <c:v>BD2-11_terrestrial_group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7:$K$57</c:f>
              <c:numCache>
                <c:formatCode>General</c:formatCode>
                <c:ptCount val="10"/>
                <c:pt idx="0">
                  <c:v>5.1721062957017998E-2</c:v>
                </c:pt>
                <c:pt idx="1">
                  <c:v>6.6156317928362199E-2</c:v>
                </c:pt>
                <c:pt idx="2">
                  <c:v>0</c:v>
                </c:pt>
                <c:pt idx="3">
                  <c:v>3.0123506376142199E-2</c:v>
                </c:pt>
                <c:pt idx="4">
                  <c:v>0</c:v>
                </c:pt>
                <c:pt idx="5">
                  <c:v>2.2388895108026399E-2</c:v>
                </c:pt>
                <c:pt idx="6">
                  <c:v>0.226612148381694</c:v>
                </c:pt>
                <c:pt idx="7">
                  <c:v>0</c:v>
                </c:pt>
                <c:pt idx="8">
                  <c:v>6.7299279897705096E-3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7-662F-4865-8BA2-EA4FD10F788F}"/>
            </c:ext>
          </c:extLst>
        </c:ser>
        <c:ser>
          <c:idx val="56"/>
          <c:order val="56"/>
          <c:tx>
            <c:strRef>
              <c:f>'Class_grafico '!$A$58</c:f>
              <c:strCache>
                <c:ptCount val="1"/>
                <c:pt idx="0">
                  <c:v>Gemmatimonadete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8:$K$58</c:f>
              <c:numCache>
                <c:formatCode>General</c:formatCode>
                <c:ptCount val="10"/>
                <c:pt idx="0">
                  <c:v>1.970750847155341</c:v>
                </c:pt>
                <c:pt idx="1">
                  <c:v>0.60013231263585698</c:v>
                </c:pt>
                <c:pt idx="2">
                  <c:v>0.58134471346455296</c:v>
                </c:pt>
                <c:pt idx="3">
                  <c:v>0.587408374334773</c:v>
                </c:pt>
                <c:pt idx="4">
                  <c:v>0</c:v>
                </c:pt>
                <c:pt idx="5">
                  <c:v>0.86756968543602397</c:v>
                </c:pt>
                <c:pt idx="6">
                  <c:v>0.44829794571161102</c:v>
                </c:pt>
                <c:pt idx="7">
                  <c:v>1.1763321962122099E-2</c:v>
                </c:pt>
                <c:pt idx="8">
                  <c:v>0.86479574668551096</c:v>
                </c:pt>
                <c:pt idx="9">
                  <c:v>3.7334962495333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662F-4865-8BA2-EA4FD10F788F}"/>
            </c:ext>
          </c:extLst>
        </c:ser>
        <c:ser>
          <c:idx val="57"/>
          <c:order val="57"/>
          <c:tx>
            <c:strRef>
              <c:f>'Class_grafico '!$A$59</c:f>
              <c:strCache>
                <c:ptCount val="1"/>
                <c:pt idx="0">
                  <c:v>Gemmatimonadetes_unclassified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59:$K$59</c:f>
              <c:numCache>
                <c:formatCode>General</c:formatCode>
                <c:ptCount val="10"/>
                <c:pt idx="0">
                  <c:v>1.6051364365971099E-2</c:v>
                </c:pt>
                <c:pt idx="1">
                  <c:v>0.20791985634628099</c:v>
                </c:pt>
                <c:pt idx="2">
                  <c:v>0</c:v>
                </c:pt>
                <c:pt idx="3">
                  <c:v>0.12551460990059199</c:v>
                </c:pt>
                <c:pt idx="4">
                  <c:v>0</c:v>
                </c:pt>
                <c:pt idx="5">
                  <c:v>0.190305608418225</c:v>
                </c:pt>
                <c:pt idx="6">
                  <c:v>0.30050741415833299</c:v>
                </c:pt>
                <c:pt idx="7">
                  <c:v>0</c:v>
                </c:pt>
                <c:pt idx="8">
                  <c:v>3.3649639948852499E-2</c:v>
                </c:pt>
                <c:pt idx="9">
                  <c:v>0.13576349998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9-662F-4865-8BA2-EA4FD10F788F}"/>
            </c:ext>
          </c:extLst>
        </c:ser>
        <c:ser>
          <c:idx val="58"/>
          <c:order val="58"/>
          <c:tx>
            <c:strRef>
              <c:f>'Class_grafico '!$A$60</c:f>
              <c:strCache>
                <c:ptCount val="1"/>
                <c:pt idx="0">
                  <c:v>Longimicrobi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0:$K$60</c:f>
              <c:numCache>
                <c:formatCode>General</c:formatCode>
                <c:ptCount val="10"/>
                <c:pt idx="0">
                  <c:v>4.2803638309256299E-2</c:v>
                </c:pt>
                <c:pt idx="1">
                  <c:v>1.4034590303373971</c:v>
                </c:pt>
                <c:pt idx="2">
                  <c:v>0.15894443476746201</c:v>
                </c:pt>
                <c:pt idx="3">
                  <c:v>1.611607591123607</c:v>
                </c:pt>
                <c:pt idx="4">
                  <c:v>0</c:v>
                </c:pt>
                <c:pt idx="5">
                  <c:v>0.31344453151237001</c:v>
                </c:pt>
                <c:pt idx="6">
                  <c:v>0.25124390364057297</c:v>
                </c:pt>
                <c:pt idx="7">
                  <c:v>0</c:v>
                </c:pt>
                <c:pt idx="8">
                  <c:v>0.215357695672656</c:v>
                </c:pt>
                <c:pt idx="9">
                  <c:v>0.556630349930421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A-662F-4865-8BA2-EA4FD10F788F}"/>
            </c:ext>
          </c:extLst>
        </c:ser>
        <c:ser>
          <c:idx val="59"/>
          <c:order val="59"/>
          <c:tx>
            <c:strRef>
              <c:f>'Class_grafico '!$A$61</c:f>
              <c:strCache>
                <c:ptCount val="1"/>
                <c:pt idx="0">
                  <c:v>PAUC43f_marine_benthic_group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1:$K$6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5061753188071099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B-662F-4865-8BA2-EA4FD10F788F}"/>
            </c:ext>
          </c:extLst>
        </c:ser>
        <c:ser>
          <c:idx val="60"/>
          <c:order val="60"/>
          <c:tx>
            <c:strRef>
              <c:f>'Class_grafico '!$A$62</c:f>
              <c:strCache>
                <c:ptCount val="1"/>
                <c:pt idx="0">
                  <c:v>S0134_terrestrial_group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2:$K$62</c:f>
              <c:numCache>
                <c:formatCode>General</c:formatCode>
                <c:ptCount val="10"/>
                <c:pt idx="0">
                  <c:v>0.422685928303906</c:v>
                </c:pt>
                <c:pt idx="1">
                  <c:v>6.6156317928362199E-2</c:v>
                </c:pt>
                <c:pt idx="2">
                  <c:v>8.0560877895837005E-2</c:v>
                </c:pt>
                <c:pt idx="3">
                  <c:v>9.5391103524450196E-2</c:v>
                </c:pt>
                <c:pt idx="4">
                  <c:v>0</c:v>
                </c:pt>
                <c:pt idx="5">
                  <c:v>5.0375013993059402E-2</c:v>
                </c:pt>
                <c:pt idx="6">
                  <c:v>0.85718508300901497</c:v>
                </c:pt>
                <c:pt idx="7">
                  <c:v>0</c:v>
                </c:pt>
                <c:pt idx="8">
                  <c:v>2.3554747964196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C-662F-4865-8BA2-EA4FD10F788F}"/>
            </c:ext>
          </c:extLst>
        </c:ser>
        <c:ser>
          <c:idx val="61"/>
          <c:order val="61"/>
          <c:tx>
            <c:strRef>
              <c:f>'Class_grafico '!$A$63</c:f>
              <c:strCache>
                <c:ptCount val="1"/>
                <c:pt idx="0">
                  <c:v>Hydrogenedenti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3:$K$6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6791671331019799E-2</c:v>
                </c:pt>
                <c:pt idx="6">
                  <c:v>4.9263510517759497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D-662F-4865-8BA2-EA4FD10F788F}"/>
            </c:ext>
          </c:extLst>
        </c:ser>
        <c:ser>
          <c:idx val="62"/>
          <c:order val="62"/>
          <c:tx>
            <c:strRef>
              <c:f>'Class_grafico '!$A$64</c:f>
              <c:strCache>
                <c:ptCount val="1"/>
                <c:pt idx="0">
                  <c:v>Latescibacteri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4:$K$64</c:f>
              <c:numCache>
                <c:formatCode>General</c:formatCode>
                <c:ptCount val="10"/>
                <c:pt idx="0">
                  <c:v>1.15391474942036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E-662F-4865-8BA2-EA4FD10F788F}"/>
            </c:ext>
          </c:extLst>
        </c:ser>
        <c:ser>
          <c:idx val="63"/>
          <c:order val="63"/>
          <c:tx>
            <c:strRef>
              <c:f>'Class_grafico '!$A$65</c:f>
              <c:strCache>
                <c:ptCount val="1"/>
                <c:pt idx="0">
                  <c:v>Latescibacteria_cl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5:$K$65</c:f>
              <c:numCache>
                <c:formatCode>General</c:formatCode>
                <c:ptCount val="10"/>
                <c:pt idx="0">
                  <c:v>0.17121455323702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F-662F-4865-8BA2-EA4FD10F788F}"/>
            </c:ext>
          </c:extLst>
        </c:ser>
        <c:ser>
          <c:idx val="64"/>
          <c:order val="64"/>
          <c:tx>
            <c:strRef>
              <c:f>'Class_grafico '!$A$66</c:f>
              <c:strCache>
                <c:ptCount val="1"/>
                <c:pt idx="0">
                  <c:v>Nitrospir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6:$K$66</c:f>
              <c:numCache>
                <c:formatCode>General</c:formatCode>
                <c:ptCount val="10"/>
                <c:pt idx="0">
                  <c:v>1.3429641519529161</c:v>
                </c:pt>
                <c:pt idx="1">
                  <c:v>3.3078158964181099E-2</c:v>
                </c:pt>
                <c:pt idx="2">
                  <c:v>0.137171224525344</c:v>
                </c:pt>
                <c:pt idx="3">
                  <c:v>1.00411687920474E-2</c:v>
                </c:pt>
                <c:pt idx="4">
                  <c:v>0</c:v>
                </c:pt>
                <c:pt idx="5">
                  <c:v>0.64368073435576001</c:v>
                </c:pt>
                <c:pt idx="6">
                  <c:v>0.162569584708606</c:v>
                </c:pt>
                <c:pt idx="7">
                  <c:v>0</c:v>
                </c:pt>
                <c:pt idx="8">
                  <c:v>3.0284675953967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0-662F-4865-8BA2-EA4FD10F788F}"/>
            </c:ext>
          </c:extLst>
        </c:ser>
        <c:ser>
          <c:idx val="65"/>
          <c:order val="65"/>
          <c:tx>
            <c:strRef>
              <c:f>'Class_grafico '!$A$67</c:f>
              <c:strCache>
                <c:ptCount val="1"/>
                <c:pt idx="0">
                  <c:v>ABY1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7:$K$67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2388895108026399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1-662F-4865-8BA2-EA4FD10F788F}"/>
            </c:ext>
          </c:extLst>
        </c:ser>
        <c:ser>
          <c:idx val="66"/>
          <c:order val="66"/>
          <c:tx>
            <c:strRef>
              <c:f>'Class_grafico '!$A$68</c:f>
              <c:strCache>
                <c:ptCount val="1"/>
                <c:pt idx="0">
                  <c:v>Gracilibacteria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8:$K$6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2-662F-4865-8BA2-EA4FD10F788F}"/>
            </c:ext>
          </c:extLst>
        </c:ser>
        <c:ser>
          <c:idx val="67"/>
          <c:order val="67"/>
          <c:tx>
            <c:strRef>
              <c:f>'Class_grafico '!$A$69</c:f>
              <c:strCache>
                <c:ptCount val="1"/>
                <c:pt idx="0">
                  <c:v>Microgenomati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69:$K$69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3-662F-4865-8BA2-EA4FD10F788F}"/>
            </c:ext>
          </c:extLst>
        </c:ser>
        <c:ser>
          <c:idx val="68"/>
          <c:order val="68"/>
          <c:tx>
            <c:strRef>
              <c:f>'Class_grafico '!$A$70</c:f>
              <c:strCache>
                <c:ptCount val="1"/>
                <c:pt idx="0">
                  <c:v>Parcubacteri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0:$K$70</c:f>
              <c:numCache>
                <c:formatCode>General</c:formatCode>
                <c:ptCount val="10"/>
                <c:pt idx="0">
                  <c:v>8.5607276618512598E-2</c:v>
                </c:pt>
                <c:pt idx="1">
                  <c:v>0</c:v>
                </c:pt>
                <c:pt idx="2">
                  <c:v>6.5319630726354298E-3</c:v>
                </c:pt>
                <c:pt idx="3">
                  <c:v>0</c:v>
                </c:pt>
                <c:pt idx="4">
                  <c:v>0</c:v>
                </c:pt>
                <c:pt idx="5">
                  <c:v>8.9555580432105694E-2</c:v>
                </c:pt>
                <c:pt idx="6">
                  <c:v>0</c:v>
                </c:pt>
                <c:pt idx="7">
                  <c:v>0</c:v>
                </c:pt>
                <c:pt idx="8">
                  <c:v>2.6919711959082E-2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4-662F-4865-8BA2-EA4FD10F788F}"/>
            </c:ext>
          </c:extLst>
        </c:ser>
        <c:ser>
          <c:idx val="69"/>
          <c:order val="69"/>
          <c:tx>
            <c:strRef>
              <c:f>'Class_grafico '!$A$71</c:f>
              <c:strCache>
                <c:ptCount val="1"/>
                <c:pt idx="0">
                  <c:v>Saccharimonadi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1:$K$71</c:f>
              <c:numCache>
                <c:formatCode>General</c:formatCode>
                <c:ptCount val="10"/>
                <c:pt idx="0">
                  <c:v>0.28714107365792801</c:v>
                </c:pt>
                <c:pt idx="1">
                  <c:v>0.283527076835838</c:v>
                </c:pt>
                <c:pt idx="2">
                  <c:v>0.363612611043372</c:v>
                </c:pt>
                <c:pt idx="3">
                  <c:v>0.25604980419720902</c:v>
                </c:pt>
                <c:pt idx="4">
                  <c:v>0</c:v>
                </c:pt>
                <c:pt idx="5">
                  <c:v>1.6008060002238891</c:v>
                </c:pt>
                <c:pt idx="6">
                  <c:v>9.8527021035518993E-3</c:v>
                </c:pt>
                <c:pt idx="7">
                  <c:v>5.8816609810610501E-2</c:v>
                </c:pt>
                <c:pt idx="8">
                  <c:v>0.29611683154990198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5-662F-4865-8BA2-EA4FD10F788F}"/>
            </c:ext>
          </c:extLst>
        </c:ser>
        <c:ser>
          <c:idx val="70"/>
          <c:order val="70"/>
          <c:tx>
            <c:strRef>
              <c:f>'Class_grafico '!$A$72</c:f>
              <c:strCache>
                <c:ptCount val="1"/>
                <c:pt idx="0">
                  <c:v>BD7-11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2:$K$72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6-662F-4865-8BA2-EA4FD10F788F}"/>
            </c:ext>
          </c:extLst>
        </c:ser>
        <c:ser>
          <c:idx val="71"/>
          <c:order val="71"/>
          <c:tx>
            <c:strRef>
              <c:f>'Class_grafico '!$A$73</c:f>
              <c:strCache>
                <c:ptCount val="1"/>
                <c:pt idx="0">
                  <c:v>OM190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3:$K$73</c:f>
              <c:numCache>
                <c:formatCode>General</c:formatCode>
                <c:ptCount val="10"/>
                <c:pt idx="0">
                  <c:v>0.224719101123596</c:v>
                </c:pt>
                <c:pt idx="1">
                  <c:v>4.7254512805973E-3</c:v>
                </c:pt>
                <c:pt idx="2">
                  <c:v>8.7092840968472397E-3</c:v>
                </c:pt>
                <c:pt idx="3">
                  <c:v>0</c:v>
                </c:pt>
                <c:pt idx="4">
                  <c:v>0</c:v>
                </c:pt>
                <c:pt idx="5">
                  <c:v>0.184708384641218</c:v>
                </c:pt>
                <c:pt idx="6">
                  <c:v>7.38952657766391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7-662F-4865-8BA2-EA4FD10F788F}"/>
            </c:ext>
          </c:extLst>
        </c:ser>
        <c:ser>
          <c:idx val="72"/>
          <c:order val="72"/>
          <c:tx>
            <c:strRef>
              <c:f>'Class_grafico '!$A$74</c:f>
              <c:strCache>
                <c:ptCount val="1"/>
                <c:pt idx="0">
                  <c:v>Phycisphaerae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4:$K$74</c:f>
              <c:numCache>
                <c:formatCode>General</c:formatCode>
                <c:ptCount val="10"/>
                <c:pt idx="0">
                  <c:v>1.282325664348136</c:v>
                </c:pt>
                <c:pt idx="1">
                  <c:v>0.425290615253757</c:v>
                </c:pt>
                <c:pt idx="2">
                  <c:v>0.52908900888346999</c:v>
                </c:pt>
                <c:pt idx="3">
                  <c:v>0.51712019279044097</c:v>
                </c:pt>
                <c:pt idx="4">
                  <c:v>0</c:v>
                </c:pt>
                <c:pt idx="5">
                  <c:v>1.332139258927572</c:v>
                </c:pt>
                <c:pt idx="6">
                  <c:v>9.3600669983743001E-2</c:v>
                </c:pt>
                <c:pt idx="7">
                  <c:v>2.3526643924244198E-2</c:v>
                </c:pt>
                <c:pt idx="8">
                  <c:v>1.2955111380308231</c:v>
                </c:pt>
                <c:pt idx="9">
                  <c:v>0.298679699962665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8-662F-4865-8BA2-EA4FD10F788F}"/>
            </c:ext>
          </c:extLst>
        </c:ser>
        <c:ser>
          <c:idx val="73"/>
          <c:order val="73"/>
          <c:tx>
            <c:strRef>
              <c:f>'Class_grafico '!$A$75</c:f>
              <c:strCache>
                <c:ptCount val="1"/>
                <c:pt idx="0">
                  <c:v>Pla3_lineage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5:$K$75</c:f>
              <c:numCache>
                <c:formatCode>General</c:formatCode>
                <c:ptCount val="10"/>
                <c:pt idx="0">
                  <c:v>2.67522739432852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9-662F-4865-8BA2-EA4FD10F788F}"/>
            </c:ext>
          </c:extLst>
        </c:ser>
        <c:ser>
          <c:idx val="74"/>
          <c:order val="74"/>
          <c:tx>
            <c:strRef>
              <c:f>'Class_grafico '!$A$76</c:f>
              <c:strCache>
                <c:ptCount val="1"/>
                <c:pt idx="0">
                  <c:v>Pla4_lineage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6:$K$76</c:f>
              <c:numCache>
                <c:formatCode>General</c:formatCode>
                <c:ptCount val="10"/>
                <c:pt idx="0">
                  <c:v>3.031924380238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A-662F-4865-8BA2-EA4FD10F788F}"/>
            </c:ext>
          </c:extLst>
        </c:ser>
        <c:ser>
          <c:idx val="75"/>
          <c:order val="75"/>
          <c:tx>
            <c:strRef>
              <c:f>'Class_grafico '!$A$77</c:f>
              <c:strCache>
                <c:ptCount val="1"/>
                <c:pt idx="0">
                  <c:v>Planctomycetacia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7:$K$77</c:f>
              <c:numCache>
                <c:formatCode>General</c:formatCode>
                <c:ptCount val="10"/>
                <c:pt idx="0">
                  <c:v>1.812020688425183</c:v>
                </c:pt>
                <c:pt idx="1">
                  <c:v>0.84585577922691602</c:v>
                </c:pt>
                <c:pt idx="2">
                  <c:v>0.99939035011321997</c:v>
                </c:pt>
                <c:pt idx="3">
                  <c:v>0.93884928205643203</c:v>
                </c:pt>
                <c:pt idx="4">
                  <c:v>0</c:v>
                </c:pt>
                <c:pt idx="5">
                  <c:v>1.53363931489981</c:v>
                </c:pt>
                <c:pt idx="6">
                  <c:v>0.91137494457855095</c:v>
                </c:pt>
                <c:pt idx="7">
                  <c:v>0</c:v>
                </c:pt>
                <c:pt idx="8">
                  <c:v>0.79076653879803505</c:v>
                </c:pt>
                <c:pt idx="9">
                  <c:v>0.27831517496521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B-662F-4865-8BA2-EA4FD10F788F}"/>
            </c:ext>
          </c:extLst>
        </c:ser>
        <c:ser>
          <c:idx val="76"/>
          <c:order val="76"/>
          <c:tx>
            <c:strRef>
              <c:f>'Class_grafico '!$A$78</c:f>
              <c:strCache>
                <c:ptCount val="1"/>
                <c:pt idx="0">
                  <c:v>Planctomycetes_unclassified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8:$K$78</c:f>
              <c:numCache>
                <c:formatCode>General</c:formatCode>
                <c:ptCount val="10"/>
                <c:pt idx="0">
                  <c:v>5.7071517745675003E-2</c:v>
                </c:pt>
                <c:pt idx="1">
                  <c:v>4.7254512805973E-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5.5972237770066102E-3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C-662F-4865-8BA2-EA4FD10F788F}"/>
            </c:ext>
          </c:extLst>
        </c:ser>
        <c:ser>
          <c:idx val="77"/>
          <c:order val="77"/>
          <c:tx>
            <c:strRef>
              <c:f>'Class_grafico '!$A$79</c:f>
              <c:strCache>
                <c:ptCount val="1"/>
                <c:pt idx="0">
                  <c:v>vadinHA49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79:$K$7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2294861748572709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D-662F-4865-8BA2-EA4FD10F788F}"/>
            </c:ext>
          </c:extLst>
        </c:ser>
        <c:ser>
          <c:idx val="78"/>
          <c:order val="78"/>
          <c:tx>
            <c:strRef>
              <c:f>'Class_grafico '!$A$80</c:f>
              <c:strCache>
                <c:ptCount val="1"/>
                <c:pt idx="0">
                  <c:v>Alphaproteobacteria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0:$K$80</c:f>
              <c:numCache>
                <c:formatCode>General</c:formatCode>
                <c:ptCount val="10"/>
                <c:pt idx="0">
                  <c:v>12.215088282504009</c:v>
                </c:pt>
                <c:pt idx="1">
                  <c:v>12.47991683205746</c:v>
                </c:pt>
                <c:pt idx="2">
                  <c:v>15.855251698310401</c:v>
                </c:pt>
                <c:pt idx="3">
                  <c:v>11.77327040867557</c:v>
                </c:pt>
                <c:pt idx="4">
                  <c:v>0.17099120616654001</c:v>
                </c:pt>
                <c:pt idx="5">
                  <c:v>22.94861748572707</c:v>
                </c:pt>
                <c:pt idx="6">
                  <c:v>5.5322922311443916</c:v>
                </c:pt>
                <c:pt idx="7">
                  <c:v>20.268203740736379</c:v>
                </c:pt>
                <c:pt idx="8">
                  <c:v>18.201090248334339</c:v>
                </c:pt>
                <c:pt idx="9">
                  <c:v>22.750568509656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E-662F-4865-8BA2-EA4FD10F788F}"/>
            </c:ext>
          </c:extLst>
        </c:ser>
        <c:ser>
          <c:idx val="79"/>
          <c:order val="79"/>
          <c:tx>
            <c:strRef>
              <c:f>'Class_grafico '!$A$81</c:f>
              <c:strCache>
                <c:ptCount val="1"/>
                <c:pt idx="0">
                  <c:v>Deltaproteobacteria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1:$K$81</c:f>
              <c:numCache>
                <c:formatCode>General</c:formatCode>
                <c:ptCount val="10"/>
                <c:pt idx="0">
                  <c:v>0.83110397717139295</c:v>
                </c:pt>
                <c:pt idx="1">
                  <c:v>0.84113032794631903</c:v>
                </c:pt>
                <c:pt idx="2">
                  <c:v>2.4451315101898632</c:v>
                </c:pt>
                <c:pt idx="3">
                  <c:v>0.65769655587910403</c:v>
                </c:pt>
                <c:pt idx="4">
                  <c:v>0</c:v>
                </c:pt>
                <c:pt idx="5">
                  <c:v>2.664278517855144</c:v>
                </c:pt>
                <c:pt idx="6">
                  <c:v>7.3895265776639199E-2</c:v>
                </c:pt>
                <c:pt idx="7">
                  <c:v>1.96055366035368E-2</c:v>
                </c:pt>
                <c:pt idx="8">
                  <c:v>0.40379567938623101</c:v>
                </c:pt>
                <c:pt idx="9">
                  <c:v>2.375861249703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F-662F-4865-8BA2-EA4FD10F788F}"/>
            </c:ext>
          </c:extLst>
        </c:ser>
        <c:ser>
          <c:idx val="80"/>
          <c:order val="80"/>
          <c:tx>
            <c:strRef>
              <c:f>'Class_grafico '!$A$82</c:f>
              <c:strCache>
                <c:ptCount val="1"/>
                <c:pt idx="0">
                  <c:v>Gammaproteobacteria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2:$K$82</c:f>
              <c:numCache>
                <c:formatCode>General</c:formatCode>
                <c:ptCount val="10"/>
                <c:pt idx="0">
                  <c:v>11.804886748706981</c:v>
                </c:pt>
                <c:pt idx="1">
                  <c:v>9.5406861355259451</c:v>
                </c:pt>
                <c:pt idx="2">
                  <c:v>6.4905939731754048</c:v>
                </c:pt>
                <c:pt idx="3">
                  <c:v>9.8102219098303021</c:v>
                </c:pt>
                <c:pt idx="4">
                  <c:v>1.1263706437954619</c:v>
                </c:pt>
                <c:pt idx="5">
                  <c:v>28.926452479570131</c:v>
                </c:pt>
                <c:pt idx="6">
                  <c:v>5.3795753485393369</c:v>
                </c:pt>
                <c:pt idx="7">
                  <c:v>4.6308277457554006</c:v>
                </c:pt>
                <c:pt idx="8">
                  <c:v>5.1551248401642082</c:v>
                </c:pt>
                <c:pt idx="9">
                  <c:v>3.1327427621084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0-662F-4865-8BA2-EA4FD10F788F}"/>
            </c:ext>
          </c:extLst>
        </c:ser>
        <c:ser>
          <c:idx val="81"/>
          <c:order val="81"/>
          <c:tx>
            <c:strRef>
              <c:f>'Class_grafico '!$A$83</c:f>
              <c:strCache>
                <c:ptCount val="1"/>
                <c:pt idx="0">
                  <c:v>Proteobacteria_unclassified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3:$K$83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3.4837136387389001E-2</c:v>
                </c:pt>
                <c:pt idx="3">
                  <c:v>0</c:v>
                </c:pt>
                <c:pt idx="4">
                  <c:v>0</c:v>
                </c:pt>
                <c:pt idx="5">
                  <c:v>2.2388895108026399E-2</c:v>
                </c:pt>
                <c:pt idx="6">
                  <c:v>1.47790531553278E-2</c:v>
                </c:pt>
                <c:pt idx="7">
                  <c:v>0</c:v>
                </c:pt>
                <c:pt idx="8">
                  <c:v>0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1-662F-4865-8BA2-EA4FD10F788F}"/>
            </c:ext>
          </c:extLst>
        </c:ser>
        <c:ser>
          <c:idx val="82"/>
          <c:order val="82"/>
          <c:tx>
            <c:strRef>
              <c:f>'Class_grafico '!$A$84</c:f>
              <c:strCache>
                <c:ptCount val="1"/>
                <c:pt idx="0">
                  <c:v>NC10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4:$K$84</c:f>
              <c:numCache>
                <c:formatCode>General</c:formatCode>
                <c:ptCount val="10"/>
                <c:pt idx="0">
                  <c:v>4.28036383092562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4631755258879801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2-662F-4865-8BA2-EA4FD10F788F}"/>
            </c:ext>
          </c:extLst>
        </c:ser>
        <c:ser>
          <c:idx val="83"/>
          <c:order val="83"/>
          <c:tx>
            <c:strRef>
              <c:f>'Class_grafico '!$A$85</c:f>
              <c:strCache>
                <c:ptCount val="1"/>
                <c:pt idx="0">
                  <c:v>Verrucomicrobia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5:$K$85</c:f>
              <c:numCache>
                <c:formatCode>General</c:formatCode>
                <c:ptCount val="10"/>
                <c:pt idx="0">
                  <c:v>0.50115926520420895</c:v>
                </c:pt>
                <c:pt idx="1">
                  <c:v>0.467819676779132</c:v>
                </c:pt>
                <c:pt idx="2">
                  <c:v>1.1256749695175059</c:v>
                </c:pt>
                <c:pt idx="3">
                  <c:v>0.26609097298925599</c:v>
                </c:pt>
                <c:pt idx="4">
                  <c:v>0</c:v>
                </c:pt>
                <c:pt idx="5">
                  <c:v>0.86756968543602397</c:v>
                </c:pt>
                <c:pt idx="6">
                  <c:v>0.108379723139071</c:v>
                </c:pt>
                <c:pt idx="7">
                  <c:v>1.1763321962122099E-2</c:v>
                </c:pt>
                <c:pt idx="8">
                  <c:v>0.67972272696682201</c:v>
                </c:pt>
                <c:pt idx="9">
                  <c:v>2.375861249703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3-662F-4865-8BA2-EA4FD10F788F}"/>
            </c:ext>
          </c:extLst>
        </c:ser>
        <c:ser>
          <c:idx val="84"/>
          <c:order val="84"/>
          <c:tx>
            <c:strRef>
              <c:f>'Class_grafico '!$A$86</c:f>
              <c:strCache>
                <c:ptCount val="1"/>
                <c:pt idx="0">
                  <c:v>WPS-2_cl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6:$K$8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1.088660512105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4-662F-4865-8BA2-EA4FD10F788F}"/>
            </c:ext>
          </c:extLst>
        </c:ser>
        <c:ser>
          <c:idx val="85"/>
          <c:order val="85"/>
          <c:tx>
            <c:strRef>
              <c:f>'Class_grafico '!$A$87</c:f>
              <c:strCache>
                <c:ptCount val="1"/>
                <c:pt idx="0">
                  <c:v>WS2_cl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7:$K$87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16231948953319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5-662F-4865-8BA2-EA4FD10F788F}"/>
            </c:ext>
          </c:extLst>
        </c:ser>
        <c:ser>
          <c:idx val="86"/>
          <c:order val="86"/>
          <c:tx>
            <c:strRef>
              <c:f>'Class_grafico '!$A$88</c:f>
              <c:strCache>
                <c:ptCount val="1"/>
                <c:pt idx="0">
                  <c:v>Zixibacteria_cl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8:$K$88</c:f>
              <c:numCache>
                <c:formatCode>General</c:formatCode>
                <c:ptCount val="10"/>
                <c:pt idx="0">
                  <c:v>7.3122882111646206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6-662F-4865-8BA2-EA4FD10F788F}"/>
            </c:ext>
          </c:extLst>
        </c:ser>
        <c:ser>
          <c:idx val="87"/>
          <c:order val="87"/>
          <c:tx>
            <c:strRef>
              <c:f>'Class_grafico '!$A$89</c:f>
              <c:strCache>
                <c:ptCount val="1"/>
                <c:pt idx="0">
                  <c:v>unknown_unclassified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ass_grafico '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'Class_grafico '!$B$89:$K$89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7-662F-4865-8BA2-EA4FD10F78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00182848"/>
        <c:axId val="-2100186080"/>
      </c:barChart>
      <c:catAx>
        <c:axId val="-21001828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2100186080"/>
        <c:crosses val="autoZero"/>
        <c:auto val="1"/>
        <c:lblAlgn val="ctr"/>
        <c:lblOffset val="100"/>
        <c:noMultiLvlLbl val="0"/>
      </c:catAx>
      <c:valAx>
        <c:axId val="-2100186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001828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4131288690630304"/>
          <c:y val="1.49736566613465E-2"/>
          <c:w val="0.25868711309369702"/>
          <c:h val="0.982970167314442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Order </a:t>
            </a:r>
          </a:p>
        </c:rich>
      </c:tx>
      <c:layout>
        <c:manualLayout>
          <c:xMode val="edge"/>
          <c:yMode val="edge"/>
          <c:x val="0.34869126542972312"/>
          <c:y val="8.47031966008197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0755043545440595E-2"/>
          <c:y val="0.14470828133339408"/>
          <c:w val="0.63911247393612003"/>
          <c:h val="0.6992063084984430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ordem_grafico!$A$3</c:f>
              <c:strCache>
                <c:ptCount val="1"/>
                <c:pt idx="0">
                  <c:v>Acidobacteria_unclassifi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:$K$3</c:f>
              <c:numCache>
                <c:formatCode>General</c:formatCode>
                <c:ptCount val="10"/>
                <c:pt idx="0">
                  <c:v>1.9618334225075799E-2</c:v>
                </c:pt>
                <c:pt idx="1">
                  <c:v>9.4509025611946001E-3</c:v>
                </c:pt>
                <c:pt idx="2">
                  <c:v>1.30639261452708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47790531553278E-2</c:v>
                </c:pt>
                <c:pt idx="7">
                  <c:v>0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D7-40C8-B743-8BEFE0D4F8BA}"/>
            </c:ext>
          </c:extLst>
        </c:ser>
        <c:ser>
          <c:idx val="1"/>
          <c:order val="1"/>
          <c:tx>
            <c:strRef>
              <c:f>ordem_grafico!$A$4</c:f>
              <c:strCache>
                <c:ptCount val="1"/>
                <c:pt idx="0">
                  <c:v>Solibacteral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:$K$4</c:f>
              <c:numCache>
                <c:formatCode>General</c:formatCode>
                <c:ptCount val="10"/>
                <c:pt idx="0">
                  <c:v>0.74014624576422305</c:v>
                </c:pt>
                <c:pt idx="1">
                  <c:v>1.6208297892448731</c:v>
                </c:pt>
                <c:pt idx="2">
                  <c:v>1.770161992684202</c:v>
                </c:pt>
                <c:pt idx="3">
                  <c:v>1.5563811627673461</c:v>
                </c:pt>
                <c:pt idx="4">
                  <c:v>0</c:v>
                </c:pt>
                <c:pt idx="5">
                  <c:v>3.5542370983991942</c:v>
                </c:pt>
                <c:pt idx="6">
                  <c:v>0.187201339967486</c:v>
                </c:pt>
                <c:pt idx="7">
                  <c:v>0</c:v>
                </c:pt>
                <c:pt idx="8">
                  <c:v>2.85685443165758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D7-40C8-B743-8BEFE0D4F8BA}"/>
            </c:ext>
          </c:extLst>
        </c:ser>
        <c:ser>
          <c:idx val="2"/>
          <c:order val="2"/>
          <c:tx>
            <c:strRef>
              <c:f>ordem_grafico!$A$5</c:f>
              <c:strCache>
                <c:ptCount val="1"/>
                <c:pt idx="0">
                  <c:v>Subgroup_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:$K$5</c:f>
              <c:numCache>
                <c:formatCode>General</c:formatCode>
                <c:ptCount val="10"/>
                <c:pt idx="0">
                  <c:v>6.5988942393436806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7D7-40C8-B743-8BEFE0D4F8BA}"/>
            </c:ext>
          </c:extLst>
        </c:ser>
        <c:ser>
          <c:idx val="3"/>
          <c:order val="3"/>
          <c:tx>
            <c:strRef>
              <c:f>ordem_grafico!$A$6</c:f>
              <c:strCache>
                <c:ptCount val="1"/>
                <c:pt idx="0">
                  <c:v>nov/24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:$K$6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4.35464204842361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7D7-40C8-B743-8BEFE0D4F8BA}"/>
            </c:ext>
          </c:extLst>
        </c:ser>
        <c:ser>
          <c:idx val="4"/>
          <c:order val="4"/>
          <c:tx>
            <c:strRef>
              <c:f>ordem_grafico!$A$7</c:f>
              <c:strCache>
                <c:ptCount val="1"/>
                <c:pt idx="0">
                  <c:v>Blastocatellale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:$K$7</c:f>
              <c:numCache>
                <c:formatCode>General</c:formatCode>
                <c:ptCount val="10"/>
                <c:pt idx="0">
                  <c:v>4.5229177813447476</c:v>
                </c:pt>
                <c:pt idx="1">
                  <c:v>5.1460164445704546</c:v>
                </c:pt>
                <c:pt idx="2">
                  <c:v>12.61539801428323</c:v>
                </c:pt>
                <c:pt idx="3">
                  <c:v>4.8448639421628679</c:v>
                </c:pt>
                <c:pt idx="4">
                  <c:v>0</c:v>
                </c:pt>
                <c:pt idx="5">
                  <c:v>6.1905294973693046</c:v>
                </c:pt>
                <c:pt idx="6">
                  <c:v>9.3600669983743001E-2</c:v>
                </c:pt>
                <c:pt idx="7">
                  <c:v>1.1763321962122099E-2</c:v>
                </c:pt>
                <c:pt idx="8">
                  <c:v>9.334410121811695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7D7-40C8-B743-8BEFE0D4F8BA}"/>
            </c:ext>
          </c:extLst>
        </c:ser>
        <c:ser>
          <c:idx val="5"/>
          <c:order val="5"/>
          <c:tx>
            <c:strRef>
              <c:f>ordem_grafico!$A$8</c:f>
              <c:strCache>
                <c:ptCount val="1"/>
                <c:pt idx="0">
                  <c:v>Blastocatellia_(Subgroup_4)_unclassifie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:$K$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.17732102421180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3744531933508302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97D7-40C8-B743-8BEFE0D4F8BA}"/>
            </c:ext>
          </c:extLst>
        </c:ser>
        <c:ser>
          <c:idx val="6"/>
          <c:order val="6"/>
          <c:tx>
            <c:strRef>
              <c:f>ordem_grafico!$A$9</c:f>
              <c:strCache>
                <c:ptCount val="1"/>
                <c:pt idx="0">
                  <c:v>Pyrinomonadales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:$K$9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4.7254512805973E-3</c:v>
                </c:pt>
                <c:pt idx="2">
                  <c:v>0.12410729838007301</c:v>
                </c:pt>
                <c:pt idx="3">
                  <c:v>1.00411687920474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362810417928528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7D7-40C8-B743-8BEFE0D4F8BA}"/>
            </c:ext>
          </c:extLst>
        </c:ser>
        <c:ser>
          <c:idx val="7"/>
          <c:order val="7"/>
          <c:tx>
            <c:strRef>
              <c:f>ordem_grafico!$A$10</c:f>
              <c:strCache>
                <c:ptCount val="1"/>
                <c:pt idx="0">
                  <c:v>Subgroup_7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:$K$10</c:f>
              <c:numCache>
                <c:formatCode>General</c:formatCode>
                <c:ptCount val="10"/>
                <c:pt idx="0">
                  <c:v>1.42678794364187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5074141583329230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97D7-40C8-B743-8BEFE0D4F8BA}"/>
            </c:ext>
          </c:extLst>
        </c:ser>
        <c:ser>
          <c:idx val="8"/>
          <c:order val="8"/>
          <c:tx>
            <c:strRef>
              <c:f>ordem_grafico!$A$11</c:f>
              <c:strCache>
                <c:ptCount val="1"/>
                <c:pt idx="0">
                  <c:v>Subgroup_11_or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:$K$11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7D7-40C8-B743-8BEFE0D4F8BA}"/>
            </c:ext>
          </c:extLst>
        </c:ser>
        <c:ser>
          <c:idx val="9"/>
          <c:order val="9"/>
          <c:tx>
            <c:strRef>
              <c:f>ordem_grafico!$A$12</c:f>
              <c:strCache>
                <c:ptCount val="1"/>
                <c:pt idx="0">
                  <c:v>Subgroup_17_or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:$K$12</c:f>
              <c:numCache>
                <c:formatCode>General</c:formatCode>
                <c:ptCount val="10"/>
                <c:pt idx="0">
                  <c:v>0.1480292491528449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97D7-40C8-B743-8BEFE0D4F8BA}"/>
            </c:ext>
          </c:extLst>
        </c:ser>
        <c:ser>
          <c:idx val="10"/>
          <c:order val="10"/>
          <c:tx>
            <c:strRef>
              <c:f>ordem_grafico!$A$13</c:f>
              <c:strCache>
                <c:ptCount val="1"/>
                <c:pt idx="0">
                  <c:v>Subgroup_6_or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:$K$13</c:f>
              <c:numCache>
                <c:formatCode>General</c:formatCode>
                <c:ptCount val="10"/>
                <c:pt idx="0">
                  <c:v>0.62957018013197796</c:v>
                </c:pt>
                <c:pt idx="1">
                  <c:v>0.36385974860599202</c:v>
                </c:pt>
                <c:pt idx="2">
                  <c:v>0.98197178191952605</c:v>
                </c:pt>
                <c:pt idx="3">
                  <c:v>0.48197610201827501</c:v>
                </c:pt>
                <c:pt idx="4">
                  <c:v>0</c:v>
                </c:pt>
                <c:pt idx="5">
                  <c:v>0.47016679726855498</c:v>
                </c:pt>
                <c:pt idx="6">
                  <c:v>0.40396078624562798</c:v>
                </c:pt>
                <c:pt idx="7">
                  <c:v>0</c:v>
                </c:pt>
                <c:pt idx="8">
                  <c:v>0.37014603943737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97D7-40C8-B743-8BEFE0D4F8BA}"/>
            </c:ext>
          </c:extLst>
        </c:ser>
        <c:ser>
          <c:idx val="11"/>
          <c:order val="11"/>
          <c:tx>
            <c:strRef>
              <c:f>ordem_grafico!$A$14</c:f>
              <c:strCache>
                <c:ptCount val="1"/>
                <c:pt idx="0">
                  <c:v>Subgroup_6_unclassified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:$K$14</c:f>
              <c:numCache>
                <c:formatCode>General</c:formatCode>
                <c:ptCount val="10"/>
                <c:pt idx="0">
                  <c:v>1.7834849295523501E-2</c:v>
                </c:pt>
                <c:pt idx="1">
                  <c:v>1.4176353841791899E-2</c:v>
                </c:pt>
                <c:pt idx="2">
                  <c:v>2.1773210242118101E-2</c:v>
                </c:pt>
                <c:pt idx="3">
                  <c:v>5.0205843960236998E-3</c:v>
                </c:pt>
                <c:pt idx="4">
                  <c:v>0</c:v>
                </c:pt>
                <c:pt idx="5">
                  <c:v>1.6791671331019799E-2</c:v>
                </c:pt>
                <c:pt idx="6">
                  <c:v>9.8527021035518993E-3</c:v>
                </c:pt>
                <c:pt idx="7">
                  <c:v>0</c:v>
                </c:pt>
                <c:pt idx="8">
                  <c:v>2.018978396931149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97D7-40C8-B743-8BEFE0D4F8BA}"/>
            </c:ext>
          </c:extLst>
        </c:ser>
        <c:ser>
          <c:idx val="12"/>
          <c:order val="12"/>
          <c:tx>
            <c:strRef>
              <c:f>ordem_grafico!$A$15</c:f>
              <c:strCache>
                <c:ptCount val="1"/>
                <c:pt idx="0">
                  <c:v>Unknown_Order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:$K$15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1.4176353841791899E-2</c:v>
                </c:pt>
                <c:pt idx="2">
                  <c:v>1.3063926145270899E-2</c:v>
                </c:pt>
                <c:pt idx="3">
                  <c:v>1.00411687920474E-2</c:v>
                </c:pt>
                <c:pt idx="4">
                  <c:v>0</c:v>
                </c:pt>
                <c:pt idx="5">
                  <c:v>1.6791671331019799E-2</c:v>
                </c:pt>
                <c:pt idx="6">
                  <c:v>2.95581063106557E-2</c:v>
                </c:pt>
                <c:pt idx="7">
                  <c:v>0</c:v>
                </c:pt>
                <c:pt idx="8">
                  <c:v>1.6824819974426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97D7-40C8-B743-8BEFE0D4F8BA}"/>
            </c:ext>
          </c:extLst>
        </c:ser>
        <c:ser>
          <c:idx val="13"/>
          <c:order val="13"/>
          <c:tx>
            <c:strRef>
              <c:f>ordem_grafico!$A$16</c:f>
              <c:strCache>
                <c:ptCount val="1"/>
                <c:pt idx="0">
                  <c:v>Thermoanaerobaculales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:$K$16</c:f>
              <c:numCache>
                <c:formatCode>General</c:formatCode>
                <c:ptCount val="10"/>
                <c:pt idx="0">
                  <c:v>0.1444622792937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9180566439046199</c:v>
                </c:pt>
                <c:pt idx="6">
                  <c:v>4.4337159465983503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97D7-40C8-B743-8BEFE0D4F8BA}"/>
            </c:ext>
          </c:extLst>
        </c:ser>
        <c:ser>
          <c:idx val="14"/>
          <c:order val="14"/>
          <c:tx>
            <c:strRef>
              <c:f>ordem_grafico!$A$17</c:f>
              <c:strCache>
                <c:ptCount val="1"/>
                <c:pt idx="0">
                  <c:v>0319-7L14_or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:$K$17</c:f>
              <c:numCache>
                <c:formatCode>General</c:formatCode>
                <c:ptCount val="10"/>
                <c:pt idx="0">
                  <c:v>11.883360085607279</c:v>
                </c:pt>
                <c:pt idx="1">
                  <c:v>0</c:v>
                </c:pt>
                <c:pt idx="2">
                  <c:v>2.395053126632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24139120153702201</c:v>
                </c:pt>
                <c:pt idx="7">
                  <c:v>0</c:v>
                </c:pt>
                <c:pt idx="8">
                  <c:v>8.0759135877246202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97D7-40C8-B743-8BEFE0D4F8BA}"/>
            </c:ext>
          </c:extLst>
        </c:ser>
        <c:ser>
          <c:idx val="15"/>
          <c:order val="15"/>
          <c:tx>
            <c:strRef>
              <c:f>ordem_grafico!$A$18</c:f>
              <c:strCache>
                <c:ptCount val="1"/>
                <c:pt idx="0">
                  <c:v>Acidimicrobiia_unclassified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:$K$18</c:f>
              <c:numCache>
                <c:formatCode>General</c:formatCode>
                <c:ptCount val="10"/>
                <c:pt idx="0">
                  <c:v>1.403602639557695</c:v>
                </c:pt>
                <c:pt idx="1">
                  <c:v>0.155939892259711</c:v>
                </c:pt>
                <c:pt idx="2">
                  <c:v>0.13281658247691999</c:v>
                </c:pt>
                <c:pt idx="3">
                  <c:v>0.22592629782106599</c:v>
                </c:pt>
                <c:pt idx="4">
                  <c:v>0</c:v>
                </c:pt>
                <c:pt idx="5">
                  <c:v>2.2388895108026399E-2</c:v>
                </c:pt>
                <c:pt idx="6">
                  <c:v>0.56160401990245801</c:v>
                </c:pt>
                <c:pt idx="7">
                  <c:v>2.3526643924244198E-2</c:v>
                </c:pt>
                <c:pt idx="8">
                  <c:v>0.275927047580591</c:v>
                </c:pt>
                <c:pt idx="9">
                  <c:v>5.09113124936360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97D7-40C8-B743-8BEFE0D4F8BA}"/>
            </c:ext>
          </c:extLst>
        </c:ser>
        <c:ser>
          <c:idx val="16"/>
          <c:order val="16"/>
          <c:tx>
            <c:strRef>
              <c:f>ordem_grafico!$A$19</c:f>
              <c:strCache>
                <c:ptCount val="1"/>
                <c:pt idx="0">
                  <c:v>Actinomarinales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:$K$19</c:f>
              <c:numCache>
                <c:formatCode>General</c:formatCode>
                <c:ptCount val="10"/>
                <c:pt idx="0">
                  <c:v>0.38523274478330699</c:v>
                </c:pt>
                <c:pt idx="1">
                  <c:v>8.5058123050751305E-2</c:v>
                </c:pt>
                <c:pt idx="2">
                  <c:v>0</c:v>
                </c:pt>
                <c:pt idx="3">
                  <c:v>0.115473441108545</c:v>
                </c:pt>
                <c:pt idx="4">
                  <c:v>0</c:v>
                </c:pt>
                <c:pt idx="5">
                  <c:v>0.29665286018135001</c:v>
                </c:pt>
                <c:pt idx="6">
                  <c:v>8.6112616385043577</c:v>
                </c:pt>
                <c:pt idx="7">
                  <c:v>1.1763321962122099E-2</c:v>
                </c:pt>
                <c:pt idx="8">
                  <c:v>4.3744531933508302E-2</c:v>
                </c:pt>
                <c:pt idx="9">
                  <c:v>7.8064012490242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97D7-40C8-B743-8BEFE0D4F8BA}"/>
            </c:ext>
          </c:extLst>
        </c:ser>
        <c:ser>
          <c:idx val="17"/>
          <c:order val="17"/>
          <c:tx>
            <c:strRef>
              <c:f>ordem_grafico!$A$20</c:f>
              <c:strCache>
                <c:ptCount val="1"/>
                <c:pt idx="0">
                  <c:v>IMCC26256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:$K$20</c:f>
              <c:numCache>
                <c:formatCode>General</c:formatCode>
                <c:ptCount val="10"/>
                <c:pt idx="0">
                  <c:v>0.26217228464419501</c:v>
                </c:pt>
                <c:pt idx="1">
                  <c:v>0</c:v>
                </c:pt>
                <c:pt idx="2">
                  <c:v>2.1773210242118099E-3</c:v>
                </c:pt>
                <c:pt idx="3">
                  <c:v>0</c:v>
                </c:pt>
                <c:pt idx="4">
                  <c:v>0</c:v>
                </c:pt>
                <c:pt idx="5">
                  <c:v>9.5152804209112304E-2</c:v>
                </c:pt>
                <c:pt idx="6">
                  <c:v>0.29065471205478099</c:v>
                </c:pt>
                <c:pt idx="7">
                  <c:v>0</c:v>
                </c:pt>
                <c:pt idx="8">
                  <c:v>6.7299279897705096E-3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97D7-40C8-B743-8BEFE0D4F8BA}"/>
            </c:ext>
          </c:extLst>
        </c:ser>
        <c:ser>
          <c:idx val="18"/>
          <c:order val="18"/>
          <c:tx>
            <c:strRef>
              <c:f>ordem_grafico!$A$21</c:f>
              <c:strCache>
                <c:ptCount val="1"/>
                <c:pt idx="0">
                  <c:v>Microtrichales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:$K$21</c:f>
              <c:numCache>
                <c:formatCode>General</c:formatCode>
                <c:ptCount val="10"/>
                <c:pt idx="0">
                  <c:v>1.6746923488496519</c:v>
                </c:pt>
                <c:pt idx="1">
                  <c:v>1.8051223891881669</c:v>
                </c:pt>
                <c:pt idx="2">
                  <c:v>3.0504267549207449</c:v>
                </c:pt>
                <c:pt idx="3">
                  <c:v>1.747163369816247</c:v>
                </c:pt>
                <c:pt idx="4">
                  <c:v>5.42829225925524E-3</c:v>
                </c:pt>
                <c:pt idx="5">
                  <c:v>2.082167245046457</c:v>
                </c:pt>
                <c:pt idx="6">
                  <c:v>1.58135868762008</c:v>
                </c:pt>
                <c:pt idx="7">
                  <c:v>2.258557816727444</c:v>
                </c:pt>
                <c:pt idx="8">
                  <c:v>2.8804091796217781</c:v>
                </c:pt>
                <c:pt idx="9">
                  <c:v>1.2218714998472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97D7-40C8-B743-8BEFE0D4F8BA}"/>
            </c:ext>
          </c:extLst>
        </c:ser>
        <c:ser>
          <c:idx val="19"/>
          <c:order val="19"/>
          <c:tx>
            <c:strRef>
              <c:f>ordem_grafico!$A$22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:$K$22</c:f>
              <c:numCache>
                <c:formatCode>General</c:formatCode>
                <c:ptCount val="10"/>
                <c:pt idx="0">
                  <c:v>4.6370608168360999E-2</c:v>
                </c:pt>
                <c:pt idx="1">
                  <c:v>0.55760325111048104</c:v>
                </c:pt>
                <c:pt idx="2">
                  <c:v>0.63142309702142496</c:v>
                </c:pt>
                <c:pt idx="3">
                  <c:v>0.55226428356260704</c:v>
                </c:pt>
                <c:pt idx="4">
                  <c:v>0</c:v>
                </c:pt>
                <c:pt idx="5">
                  <c:v>0</c:v>
                </c:pt>
                <c:pt idx="6">
                  <c:v>0.75865806197349595</c:v>
                </c:pt>
                <c:pt idx="7">
                  <c:v>0.384268517429322</c:v>
                </c:pt>
                <c:pt idx="8">
                  <c:v>0.10431388384144299</c:v>
                </c:pt>
                <c:pt idx="9">
                  <c:v>0.1052167124868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97D7-40C8-B743-8BEFE0D4F8BA}"/>
            </c:ext>
          </c:extLst>
        </c:ser>
        <c:ser>
          <c:idx val="20"/>
          <c:order val="20"/>
          <c:tx>
            <c:strRef>
              <c:f>ordem_grafico!$A$23</c:f>
              <c:strCache>
                <c:ptCount val="1"/>
                <c:pt idx="0">
                  <c:v>Actinobacteria_unclassified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3:$K$23</c:f>
              <c:numCache>
                <c:formatCode>General</c:formatCode>
                <c:ptCount val="10"/>
                <c:pt idx="0">
                  <c:v>1.0344212591403601</c:v>
                </c:pt>
                <c:pt idx="1">
                  <c:v>0.37803610244778402</c:v>
                </c:pt>
                <c:pt idx="2">
                  <c:v>7.1851593798989699E-2</c:v>
                </c:pt>
                <c:pt idx="3">
                  <c:v>0.34642032332563499</c:v>
                </c:pt>
                <c:pt idx="4">
                  <c:v>0</c:v>
                </c:pt>
                <c:pt idx="5">
                  <c:v>0.53733348259263403</c:v>
                </c:pt>
                <c:pt idx="6">
                  <c:v>0.95078575299275803</c:v>
                </c:pt>
                <c:pt idx="7">
                  <c:v>0.431321805277811</c:v>
                </c:pt>
                <c:pt idx="8">
                  <c:v>0.13123359580052499</c:v>
                </c:pt>
                <c:pt idx="9">
                  <c:v>6.109357499236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97D7-40C8-B743-8BEFE0D4F8BA}"/>
            </c:ext>
          </c:extLst>
        </c:ser>
        <c:ser>
          <c:idx val="21"/>
          <c:order val="21"/>
          <c:tx>
            <c:strRef>
              <c:f>ordem_grafico!$A$24</c:f>
              <c:strCache>
                <c:ptCount val="1"/>
                <c:pt idx="0">
                  <c:v>Corynebacteriales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4:$K$24</c:f>
              <c:numCache>
                <c:formatCode>General</c:formatCode>
                <c:ptCount val="10"/>
                <c:pt idx="0">
                  <c:v>0.87212413055109705</c:v>
                </c:pt>
                <c:pt idx="1">
                  <c:v>0.13231263585672401</c:v>
                </c:pt>
                <c:pt idx="2">
                  <c:v>6.0964988677930702E-2</c:v>
                </c:pt>
                <c:pt idx="3">
                  <c:v>0.26609097298925599</c:v>
                </c:pt>
                <c:pt idx="4">
                  <c:v>2.71414612962762E-2</c:v>
                </c:pt>
                <c:pt idx="5">
                  <c:v>7.8361132878092501E-2</c:v>
                </c:pt>
                <c:pt idx="6">
                  <c:v>2.4631755258879801E-2</c:v>
                </c:pt>
                <c:pt idx="7">
                  <c:v>1.96055366035368E-2</c:v>
                </c:pt>
                <c:pt idx="8">
                  <c:v>6.7299279897705096E-3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97D7-40C8-B743-8BEFE0D4F8BA}"/>
            </c:ext>
          </c:extLst>
        </c:ser>
        <c:ser>
          <c:idx val="22"/>
          <c:order val="22"/>
          <c:tx>
            <c:strRef>
              <c:f>ordem_grafico!$A$25</c:f>
              <c:strCache>
                <c:ptCount val="1"/>
                <c:pt idx="0">
                  <c:v>Frankiales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5:$K$25</c:f>
              <c:numCache>
                <c:formatCode>General</c:formatCode>
                <c:ptCount val="10"/>
                <c:pt idx="0">
                  <c:v>0.139111824505083</c:v>
                </c:pt>
                <c:pt idx="1">
                  <c:v>6.6156317928362199E-2</c:v>
                </c:pt>
                <c:pt idx="2">
                  <c:v>0.38103117923706697</c:v>
                </c:pt>
                <c:pt idx="3">
                  <c:v>0.140576363088664</c:v>
                </c:pt>
                <c:pt idx="4">
                  <c:v>0</c:v>
                </c:pt>
                <c:pt idx="5">
                  <c:v>0.29665286018135001</c:v>
                </c:pt>
                <c:pt idx="6">
                  <c:v>7.3895265776639199E-2</c:v>
                </c:pt>
                <c:pt idx="7">
                  <c:v>1.7880249382425599</c:v>
                </c:pt>
                <c:pt idx="8">
                  <c:v>0.23554747964196801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97D7-40C8-B743-8BEFE0D4F8BA}"/>
            </c:ext>
          </c:extLst>
        </c:ser>
        <c:ser>
          <c:idx val="23"/>
          <c:order val="23"/>
          <c:tx>
            <c:strRef>
              <c:f>ordem_grafico!$A$26</c:f>
              <c:strCache>
                <c:ptCount val="1"/>
                <c:pt idx="0">
                  <c:v>Glycomycetales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6:$K$2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9.8527021035518993E-3</c:v>
                </c:pt>
                <c:pt idx="7">
                  <c:v>6.6658824452025298E-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97D7-40C8-B743-8BEFE0D4F8BA}"/>
            </c:ext>
          </c:extLst>
        </c:ser>
        <c:ser>
          <c:idx val="24"/>
          <c:order val="24"/>
          <c:tx>
            <c:strRef>
              <c:f>ordem_grafico!$A$27</c:f>
              <c:strCache>
                <c:ptCount val="1"/>
                <c:pt idx="0">
                  <c:v>Kineosporiale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7:$K$27</c:f>
              <c:numCache>
                <c:formatCode>General</c:formatCode>
                <c:ptCount val="10"/>
                <c:pt idx="0">
                  <c:v>9.2741216336721902E-2</c:v>
                </c:pt>
                <c:pt idx="1">
                  <c:v>0.77969946129855405</c:v>
                </c:pt>
                <c:pt idx="2">
                  <c:v>0.93407071938686603</c:v>
                </c:pt>
                <c:pt idx="3">
                  <c:v>0.78321116577969596</c:v>
                </c:pt>
                <c:pt idx="4">
                  <c:v>0</c:v>
                </c:pt>
                <c:pt idx="5">
                  <c:v>2.7986118885032999E-2</c:v>
                </c:pt>
                <c:pt idx="6">
                  <c:v>0.11823242524262299</c:v>
                </c:pt>
                <c:pt idx="7">
                  <c:v>0.529349488295495</c:v>
                </c:pt>
                <c:pt idx="8">
                  <c:v>0.43744531933508302</c:v>
                </c:pt>
                <c:pt idx="9">
                  <c:v>2.03645249974543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97D7-40C8-B743-8BEFE0D4F8BA}"/>
            </c:ext>
          </c:extLst>
        </c:ser>
        <c:ser>
          <c:idx val="25"/>
          <c:order val="25"/>
          <c:tx>
            <c:strRef>
              <c:f>ordem_grafico!$A$28</c:f>
              <c:strCache>
                <c:ptCount val="1"/>
                <c:pt idx="0">
                  <c:v>Micrococcal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8:$K$28</c:f>
              <c:numCache>
                <c:formatCode>General</c:formatCode>
                <c:ptCount val="10"/>
                <c:pt idx="0">
                  <c:v>3.5669698591046899E-2</c:v>
                </c:pt>
                <c:pt idx="1">
                  <c:v>0.87420848691050002</c:v>
                </c:pt>
                <c:pt idx="2">
                  <c:v>2.1773210242118101E-2</c:v>
                </c:pt>
                <c:pt idx="3">
                  <c:v>0.71292298423536504</c:v>
                </c:pt>
                <c:pt idx="4">
                  <c:v>5.9711214851807602E-2</c:v>
                </c:pt>
                <c:pt idx="5">
                  <c:v>0.145527818202172</c:v>
                </c:pt>
                <c:pt idx="6">
                  <c:v>0.54682496674712999</c:v>
                </c:pt>
                <c:pt idx="7">
                  <c:v>14.4767282280516</c:v>
                </c:pt>
                <c:pt idx="8">
                  <c:v>3.0284675953967301E-2</c:v>
                </c:pt>
                <c:pt idx="9">
                  <c:v>1.0148321623731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97D7-40C8-B743-8BEFE0D4F8BA}"/>
            </c:ext>
          </c:extLst>
        </c:ser>
        <c:ser>
          <c:idx val="26"/>
          <c:order val="26"/>
          <c:tx>
            <c:strRef>
              <c:f>ordem_grafico!$A$29</c:f>
              <c:strCache>
                <c:ptCount val="1"/>
                <c:pt idx="0">
                  <c:v>Micromonosporales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9:$K$29</c:f>
              <c:numCache>
                <c:formatCode>General</c:formatCode>
                <c:ptCount val="10"/>
                <c:pt idx="0">
                  <c:v>2.31853040841805E-2</c:v>
                </c:pt>
                <c:pt idx="1">
                  <c:v>0</c:v>
                </c:pt>
                <c:pt idx="2">
                  <c:v>0</c:v>
                </c:pt>
                <c:pt idx="3">
                  <c:v>2.5102921980118501E-2</c:v>
                </c:pt>
                <c:pt idx="4">
                  <c:v>0</c:v>
                </c:pt>
                <c:pt idx="5">
                  <c:v>0</c:v>
                </c:pt>
                <c:pt idx="6">
                  <c:v>0.83255332775013502</c:v>
                </c:pt>
                <c:pt idx="7">
                  <c:v>0.8038270007450100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97D7-40C8-B743-8BEFE0D4F8BA}"/>
            </c:ext>
          </c:extLst>
        </c:ser>
        <c:ser>
          <c:idx val="27"/>
          <c:order val="27"/>
          <c:tx>
            <c:strRef>
              <c:f>ordem_grafico!$A$30</c:f>
              <c:strCache>
                <c:ptCount val="1"/>
                <c:pt idx="0">
                  <c:v>Propionibacteriale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0:$K$30</c:f>
              <c:numCache>
                <c:formatCode>General</c:formatCode>
                <c:ptCount val="10"/>
                <c:pt idx="0">
                  <c:v>0.103442125914036</c:v>
                </c:pt>
                <c:pt idx="1">
                  <c:v>3.8465173424061998</c:v>
                </c:pt>
                <c:pt idx="2">
                  <c:v>3.113569064622888</c:v>
                </c:pt>
                <c:pt idx="3">
                  <c:v>3.5344914148006832</c:v>
                </c:pt>
                <c:pt idx="4">
                  <c:v>1.35707306481381E-2</c:v>
                </c:pt>
                <c:pt idx="5">
                  <c:v>2.2388895108026399E-2</c:v>
                </c:pt>
                <c:pt idx="6">
                  <c:v>1.221735060840436</c:v>
                </c:pt>
                <c:pt idx="7">
                  <c:v>0.59600831274751997</c:v>
                </c:pt>
                <c:pt idx="8">
                  <c:v>7.4197456087219864</c:v>
                </c:pt>
                <c:pt idx="9">
                  <c:v>0.851915962393510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97D7-40C8-B743-8BEFE0D4F8BA}"/>
            </c:ext>
          </c:extLst>
        </c:ser>
        <c:ser>
          <c:idx val="28"/>
          <c:order val="28"/>
          <c:tx>
            <c:strRef>
              <c:f>ordem_grafico!$A$31</c:f>
              <c:strCache>
                <c:ptCount val="1"/>
                <c:pt idx="0">
                  <c:v>Pseudonocardiales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1:$K$31</c:f>
              <c:numCache>
                <c:formatCode>General</c:formatCode>
                <c:ptCount val="10"/>
                <c:pt idx="0">
                  <c:v>27.856251114678081</c:v>
                </c:pt>
                <c:pt idx="1">
                  <c:v>10.353463755788679</c:v>
                </c:pt>
                <c:pt idx="2">
                  <c:v>2.7630203797247872</c:v>
                </c:pt>
                <c:pt idx="3">
                  <c:v>9.0019078220704873</c:v>
                </c:pt>
                <c:pt idx="4">
                  <c:v>5.42829225925524E-3</c:v>
                </c:pt>
                <c:pt idx="5">
                  <c:v>0.40300011194447599</c:v>
                </c:pt>
                <c:pt idx="6">
                  <c:v>46.726439726094881</c:v>
                </c:pt>
                <c:pt idx="7">
                  <c:v>5.4660236050660709</c:v>
                </c:pt>
                <c:pt idx="8">
                  <c:v>3.1597011911972541</c:v>
                </c:pt>
                <c:pt idx="9">
                  <c:v>5.62739707429657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97D7-40C8-B743-8BEFE0D4F8BA}"/>
            </c:ext>
          </c:extLst>
        </c:ser>
        <c:ser>
          <c:idx val="29"/>
          <c:order val="29"/>
          <c:tx>
            <c:strRef>
              <c:f>ordem_grafico!$A$32</c:f>
              <c:strCache>
                <c:ptCount val="1"/>
                <c:pt idx="0">
                  <c:v>Streptomycetales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2:$K$32</c:f>
              <c:numCache>
                <c:formatCode>General</c:formatCode>
                <c:ptCount val="10"/>
                <c:pt idx="0">
                  <c:v>2.31853040841805E-2</c:v>
                </c:pt>
                <c:pt idx="1">
                  <c:v>0</c:v>
                </c:pt>
                <c:pt idx="2">
                  <c:v>3.04824943389652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128085127346175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97D7-40C8-B743-8BEFE0D4F8BA}"/>
            </c:ext>
          </c:extLst>
        </c:ser>
        <c:ser>
          <c:idx val="30"/>
          <c:order val="30"/>
          <c:tx>
            <c:strRef>
              <c:f>ordem_grafico!$A$33</c:f>
              <c:strCache>
                <c:ptCount val="1"/>
                <c:pt idx="0">
                  <c:v>Streptosporangiales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3:$K$3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4.4337159465983503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97D7-40C8-B743-8BEFE0D4F8BA}"/>
            </c:ext>
          </c:extLst>
        </c:ser>
        <c:ser>
          <c:idx val="31"/>
          <c:order val="31"/>
          <c:tx>
            <c:strRef>
              <c:f>ordem_grafico!$A$34</c:f>
              <c:strCache>
                <c:ptCount val="1"/>
                <c:pt idx="0">
                  <c:v>Actinobacteria_unclassified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4:$K$34</c:f>
              <c:numCache>
                <c:formatCode>General</c:formatCode>
                <c:ptCount val="10"/>
                <c:pt idx="0">
                  <c:v>0.112359550561798</c:v>
                </c:pt>
                <c:pt idx="1">
                  <c:v>6.1430866647764898E-2</c:v>
                </c:pt>
                <c:pt idx="2">
                  <c:v>1.74185681936945E-2</c:v>
                </c:pt>
                <c:pt idx="3">
                  <c:v>6.5267597148308099E-2</c:v>
                </c:pt>
                <c:pt idx="4">
                  <c:v>0.12756486809249801</c:v>
                </c:pt>
                <c:pt idx="5">
                  <c:v>1.11944475540132E-2</c:v>
                </c:pt>
                <c:pt idx="6">
                  <c:v>0.13793782944972699</c:v>
                </c:pt>
                <c:pt idx="7">
                  <c:v>6.2737717131317899E-2</c:v>
                </c:pt>
                <c:pt idx="8">
                  <c:v>3.0284675953967301E-2</c:v>
                </c:pt>
                <c:pt idx="9">
                  <c:v>4.41231374944845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97D7-40C8-B743-8BEFE0D4F8BA}"/>
            </c:ext>
          </c:extLst>
        </c:ser>
        <c:ser>
          <c:idx val="32"/>
          <c:order val="32"/>
          <c:tx>
            <c:strRef>
              <c:f>ordem_grafico!$A$35</c:f>
              <c:strCache>
                <c:ptCount val="1"/>
                <c:pt idx="0">
                  <c:v>MB-A2-108_or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5:$K$35</c:f>
              <c:numCache>
                <c:formatCode>General</c:formatCode>
                <c:ptCount val="10"/>
                <c:pt idx="0">
                  <c:v>1.60513643659710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14779053155327801</c:v>
                </c:pt>
                <c:pt idx="7">
                  <c:v>0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97D7-40C8-B743-8BEFE0D4F8BA}"/>
            </c:ext>
          </c:extLst>
        </c:ser>
        <c:ser>
          <c:idx val="33"/>
          <c:order val="33"/>
          <c:tx>
            <c:strRef>
              <c:f>ordem_grafico!$A$36</c:f>
              <c:strCache>
                <c:ptCount val="1"/>
                <c:pt idx="0">
                  <c:v>Euzebyales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6:$K$36</c:f>
              <c:numCache>
                <c:formatCode>General</c:formatCode>
                <c:ptCount val="10"/>
                <c:pt idx="0">
                  <c:v>0.13732833957553101</c:v>
                </c:pt>
                <c:pt idx="1">
                  <c:v>0.43001606653435398</c:v>
                </c:pt>
                <c:pt idx="2">
                  <c:v>0.29176101724438303</c:v>
                </c:pt>
                <c:pt idx="3">
                  <c:v>0.57234662114670098</c:v>
                </c:pt>
                <c:pt idx="4">
                  <c:v>0</c:v>
                </c:pt>
                <c:pt idx="5">
                  <c:v>3.9180566439046202E-2</c:v>
                </c:pt>
                <c:pt idx="6">
                  <c:v>1.0788708803389331</c:v>
                </c:pt>
                <c:pt idx="7">
                  <c:v>1.2351488060228211</c:v>
                </c:pt>
                <c:pt idx="8">
                  <c:v>0.21872265966754201</c:v>
                </c:pt>
                <c:pt idx="9">
                  <c:v>0.224009774971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97D7-40C8-B743-8BEFE0D4F8BA}"/>
            </c:ext>
          </c:extLst>
        </c:ser>
        <c:ser>
          <c:idx val="34"/>
          <c:order val="34"/>
          <c:tx>
            <c:strRef>
              <c:f>ordem_grafico!$A$37</c:f>
              <c:strCache>
                <c:ptCount val="1"/>
                <c:pt idx="0">
                  <c:v>Nitriliruptorales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7:$K$37</c:f>
              <c:numCache>
                <c:formatCode>General</c:formatCode>
                <c:ptCount val="10"/>
                <c:pt idx="0">
                  <c:v>6.4205457463884397E-2</c:v>
                </c:pt>
                <c:pt idx="1">
                  <c:v>1.686986107173235</c:v>
                </c:pt>
                <c:pt idx="2">
                  <c:v>1.0886605121059E-2</c:v>
                </c:pt>
                <c:pt idx="3">
                  <c:v>1.646751681895773</c:v>
                </c:pt>
                <c:pt idx="4">
                  <c:v>0.119422429703615</c:v>
                </c:pt>
                <c:pt idx="5">
                  <c:v>2.2388895108026399E-2</c:v>
                </c:pt>
                <c:pt idx="6">
                  <c:v>0.43351889255628401</c:v>
                </c:pt>
                <c:pt idx="7">
                  <c:v>1.278280986550602</c:v>
                </c:pt>
                <c:pt idx="8">
                  <c:v>1.6824819974426301E-2</c:v>
                </c:pt>
                <c:pt idx="9">
                  <c:v>0.26473882496690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97D7-40C8-B743-8BEFE0D4F8BA}"/>
            </c:ext>
          </c:extLst>
        </c:ser>
        <c:ser>
          <c:idx val="35"/>
          <c:order val="35"/>
          <c:tx>
            <c:strRef>
              <c:f>ordem_grafico!$A$38</c:f>
              <c:strCache>
                <c:ptCount val="1"/>
                <c:pt idx="0">
                  <c:v>Nitriliruptoria_unclassified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8:$K$3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4.9263510517759497E-3</c:v>
                </c:pt>
                <c:pt idx="7">
                  <c:v>2.3526643924244198E-2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3-97D7-40C8-B743-8BEFE0D4F8BA}"/>
            </c:ext>
          </c:extLst>
        </c:ser>
        <c:ser>
          <c:idx val="36"/>
          <c:order val="36"/>
          <c:tx>
            <c:strRef>
              <c:f>ordem_grafico!$A$39</c:f>
              <c:strCache>
                <c:ptCount val="1"/>
                <c:pt idx="0">
                  <c:v>Rubrobacterales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39:$K$39</c:f>
              <c:numCache>
                <c:formatCode>General</c:formatCode>
                <c:ptCount val="10"/>
                <c:pt idx="0">
                  <c:v>0.422685928303906</c:v>
                </c:pt>
                <c:pt idx="1">
                  <c:v>12.271996975711181</c:v>
                </c:pt>
                <c:pt idx="2">
                  <c:v>3.8669221390001729</c:v>
                </c:pt>
                <c:pt idx="3">
                  <c:v>13.56059845366001</c:v>
                </c:pt>
                <c:pt idx="4">
                  <c:v>65.326783194007149</c:v>
                </c:pt>
                <c:pt idx="5">
                  <c:v>0.29105563640434301</c:v>
                </c:pt>
                <c:pt idx="6">
                  <c:v>11.315828365929359</c:v>
                </c:pt>
                <c:pt idx="7">
                  <c:v>34.431243383131402</c:v>
                </c:pt>
                <c:pt idx="8">
                  <c:v>24.816609462278759</c:v>
                </c:pt>
                <c:pt idx="9">
                  <c:v>26.531581984183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97D7-40C8-B743-8BEFE0D4F8BA}"/>
            </c:ext>
          </c:extLst>
        </c:ser>
        <c:ser>
          <c:idx val="37"/>
          <c:order val="37"/>
          <c:tx>
            <c:strRef>
              <c:f>ordem_grafico!$A$40</c:f>
              <c:strCache>
                <c:ptCount val="1"/>
                <c:pt idx="0">
                  <c:v>Gaiellales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0:$K$40</c:f>
              <c:numCache>
                <c:formatCode>General</c:formatCode>
                <c:ptCount val="10"/>
                <c:pt idx="0">
                  <c:v>0.31567683253076501</c:v>
                </c:pt>
                <c:pt idx="1">
                  <c:v>2.8352707683583799E-2</c:v>
                </c:pt>
                <c:pt idx="2">
                  <c:v>3.2659815363177198E-2</c:v>
                </c:pt>
                <c:pt idx="3">
                  <c:v>2.5102921980118501E-2</c:v>
                </c:pt>
                <c:pt idx="4">
                  <c:v>2.71414612962762E-3</c:v>
                </c:pt>
                <c:pt idx="5">
                  <c:v>0.41419455949848899</c:v>
                </c:pt>
                <c:pt idx="6">
                  <c:v>6.8968914724863301E-2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5-97D7-40C8-B743-8BEFE0D4F8BA}"/>
            </c:ext>
          </c:extLst>
        </c:ser>
        <c:ser>
          <c:idx val="38"/>
          <c:order val="38"/>
          <c:tx>
            <c:strRef>
              <c:f>ordem_grafico!$A$41</c:f>
              <c:strCache>
                <c:ptCount val="1"/>
                <c:pt idx="0">
                  <c:v>Solirubrobacterales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1:$K$41</c:f>
              <c:numCache>
                <c:formatCode>General</c:formatCode>
                <c:ptCount val="10"/>
                <c:pt idx="0">
                  <c:v>0.50650971999286598</c:v>
                </c:pt>
                <c:pt idx="1">
                  <c:v>0.69464133824780305</c:v>
                </c:pt>
                <c:pt idx="2">
                  <c:v>1.728792893224177</c:v>
                </c:pt>
                <c:pt idx="3">
                  <c:v>0.587408374334773</c:v>
                </c:pt>
                <c:pt idx="4">
                  <c:v>0</c:v>
                </c:pt>
                <c:pt idx="5">
                  <c:v>0.162319489533192</c:v>
                </c:pt>
                <c:pt idx="6">
                  <c:v>0.44829794571161102</c:v>
                </c:pt>
                <c:pt idx="7">
                  <c:v>0</c:v>
                </c:pt>
                <c:pt idx="8">
                  <c:v>1.897839693115283</c:v>
                </c:pt>
                <c:pt idx="9">
                  <c:v>0.410684587448664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97D7-40C8-B743-8BEFE0D4F8BA}"/>
            </c:ext>
          </c:extLst>
        </c:ser>
        <c:ser>
          <c:idx val="39"/>
          <c:order val="39"/>
          <c:tx>
            <c:strRef>
              <c:f>ordem_grafico!$A$42</c:f>
              <c:strCache>
                <c:ptCount val="1"/>
                <c:pt idx="0">
                  <c:v>Thermoleophilia_unclassified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2:$K$42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9.4509025611946001E-3</c:v>
                </c:pt>
                <c:pt idx="2">
                  <c:v>1.74185681936945E-2</c:v>
                </c:pt>
                <c:pt idx="3">
                  <c:v>5.0205843960236998E-3</c:v>
                </c:pt>
                <c:pt idx="4">
                  <c:v>0</c:v>
                </c:pt>
                <c:pt idx="5">
                  <c:v>1.11944475540132E-2</c:v>
                </c:pt>
                <c:pt idx="6">
                  <c:v>9.8527021035518993E-3</c:v>
                </c:pt>
                <c:pt idx="7">
                  <c:v>0</c:v>
                </c:pt>
                <c:pt idx="8">
                  <c:v>3.36496399488525E-3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97D7-40C8-B743-8BEFE0D4F8BA}"/>
            </c:ext>
          </c:extLst>
        </c:ser>
        <c:ser>
          <c:idx val="40"/>
          <c:order val="40"/>
          <c:tx>
            <c:strRef>
              <c:f>ordem_grafico!$A$43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3:$K$4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97D7-40C8-B743-8BEFE0D4F8BA}"/>
            </c:ext>
          </c:extLst>
        </c:ser>
        <c:ser>
          <c:idx val="41"/>
          <c:order val="41"/>
          <c:tx>
            <c:strRef>
              <c:f>ordem_grafico!$A$44</c:f>
              <c:strCache>
                <c:ptCount val="1"/>
                <c:pt idx="0">
                  <c:v>Fimbriimonadales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4:$K$44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0474459923278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9-97D7-40C8-B743-8BEFE0D4F8BA}"/>
            </c:ext>
          </c:extLst>
        </c:ser>
        <c:ser>
          <c:idx val="42"/>
          <c:order val="42"/>
          <c:tx>
            <c:strRef>
              <c:f>ordem_grafico!$A$45</c:f>
              <c:strCache>
                <c:ptCount val="1"/>
                <c:pt idx="0">
                  <c:v>BRC1_or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5:$K$45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1.4176353841791899E-2</c:v>
                </c:pt>
                <c:pt idx="2">
                  <c:v>1.52412471694827E-2</c:v>
                </c:pt>
                <c:pt idx="3">
                  <c:v>5.0205843960236998E-3</c:v>
                </c:pt>
                <c:pt idx="4">
                  <c:v>0</c:v>
                </c:pt>
                <c:pt idx="5">
                  <c:v>5.5972237770066102E-3</c:v>
                </c:pt>
                <c:pt idx="6">
                  <c:v>1.47790531553278E-2</c:v>
                </c:pt>
                <c:pt idx="7">
                  <c:v>3.1368858565658901E-2</c:v>
                </c:pt>
                <c:pt idx="8">
                  <c:v>0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A-97D7-40C8-B743-8BEFE0D4F8BA}"/>
            </c:ext>
          </c:extLst>
        </c:ser>
        <c:ser>
          <c:idx val="43"/>
          <c:order val="43"/>
          <c:tx>
            <c:strRef>
              <c:f>ordem_grafico!$A$46</c:f>
              <c:strCache>
                <c:ptCount val="1"/>
                <c:pt idx="0">
                  <c:v>Bacteria_unclassified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6:$K$46</c:f>
              <c:numCache>
                <c:formatCode>General</c:formatCode>
                <c:ptCount val="10"/>
                <c:pt idx="0">
                  <c:v>0.28357410379882297</c:v>
                </c:pt>
                <c:pt idx="1">
                  <c:v>0.18901805122389201</c:v>
                </c:pt>
                <c:pt idx="2">
                  <c:v>0.12410729838007301</c:v>
                </c:pt>
                <c:pt idx="3">
                  <c:v>0.15563811627673499</c:v>
                </c:pt>
                <c:pt idx="4">
                  <c:v>8.1424383888828597E-2</c:v>
                </c:pt>
                <c:pt idx="5">
                  <c:v>0.82838911899697698</c:v>
                </c:pt>
                <c:pt idx="6">
                  <c:v>0.29558106310655702</c:v>
                </c:pt>
                <c:pt idx="7">
                  <c:v>3.1368858565658901E-2</c:v>
                </c:pt>
                <c:pt idx="8">
                  <c:v>0.121138703815869</c:v>
                </c:pt>
                <c:pt idx="9">
                  <c:v>6.109357499236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B-97D7-40C8-B743-8BEFE0D4F8BA}"/>
            </c:ext>
          </c:extLst>
        </c:ser>
        <c:ser>
          <c:idx val="44"/>
          <c:order val="44"/>
          <c:tx>
            <c:strRef>
              <c:f>ordem_grafico!$A$47</c:f>
              <c:strCache>
                <c:ptCount val="1"/>
                <c:pt idx="0">
                  <c:v>Bacteroidetes_unclassified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7:$K$47</c:f>
              <c:numCache>
                <c:formatCode>General</c:formatCode>
                <c:ptCount val="10"/>
                <c:pt idx="0">
                  <c:v>1.0700909577314101E-2</c:v>
                </c:pt>
                <c:pt idx="1">
                  <c:v>4.7254512805973E-3</c:v>
                </c:pt>
                <c:pt idx="2">
                  <c:v>2.1773210242118099E-3</c:v>
                </c:pt>
                <c:pt idx="3">
                  <c:v>5.0205843960236998E-3</c:v>
                </c:pt>
                <c:pt idx="4">
                  <c:v>2.71414612962762E-3</c:v>
                </c:pt>
                <c:pt idx="5">
                  <c:v>5.5972237770066102E-3</c:v>
                </c:pt>
                <c:pt idx="6">
                  <c:v>0</c:v>
                </c:pt>
                <c:pt idx="7">
                  <c:v>0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C-97D7-40C8-B743-8BEFE0D4F8BA}"/>
            </c:ext>
          </c:extLst>
        </c:ser>
        <c:ser>
          <c:idx val="45"/>
          <c:order val="45"/>
          <c:tx>
            <c:strRef>
              <c:f>ordem_grafico!$A$48</c:f>
              <c:strCache>
                <c:ptCount val="1"/>
                <c:pt idx="0">
                  <c:v>Bacteroidales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8:$K$4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.4427315166648599E-2</c:v>
                </c:pt>
                <c:pt idx="5">
                  <c:v>5.5972237770066102E-3</c:v>
                </c:pt>
                <c:pt idx="6">
                  <c:v>0</c:v>
                </c:pt>
                <c:pt idx="7">
                  <c:v>7.8422146414147392E-3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D-97D7-40C8-B743-8BEFE0D4F8BA}"/>
            </c:ext>
          </c:extLst>
        </c:ser>
        <c:ser>
          <c:idx val="46"/>
          <c:order val="46"/>
          <c:tx>
            <c:strRef>
              <c:f>ordem_grafico!$A$49</c:f>
              <c:strCache>
                <c:ptCount val="1"/>
                <c:pt idx="0">
                  <c:v>Bacteroidia_unclassified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49:$K$49</c:f>
              <c:numCache>
                <c:formatCode>General</c:formatCode>
                <c:ptCount val="10"/>
                <c:pt idx="0">
                  <c:v>1.7834849295523501E-2</c:v>
                </c:pt>
                <c:pt idx="1">
                  <c:v>9.4509025611946001E-3</c:v>
                </c:pt>
                <c:pt idx="2">
                  <c:v>0</c:v>
                </c:pt>
                <c:pt idx="3">
                  <c:v>1.5061753188071099E-2</c:v>
                </c:pt>
                <c:pt idx="4">
                  <c:v>0</c:v>
                </c:pt>
                <c:pt idx="5">
                  <c:v>8.3958356655099098E-2</c:v>
                </c:pt>
                <c:pt idx="6">
                  <c:v>0</c:v>
                </c:pt>
                <c:pt idx="7">
                  <c:v>0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E-97D7-40C8-B743-8BEFE0D4F8BA}"/>
            </c:ext>
          </c:extLst>
        </c:ser>
        <c:ser>
          <c:idx val="47"/>
          <c:order val="47"/>
          <c:tx>
            <c:strRef>
              <c:f>ordem_grafico!$A$50</c:f>
              <c:strCache>
                <c:ptCount val="1"/>
                <c:pt idx="0">
                  <c:v>Chitinophagales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0:$K$50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.496172384462716</c:v>
                </c:pt>
                <c:pt idx="2">
                  <c:v>1.3172792196481451</c:v>
                </c:pt>
                <c:pt idx="3">
                  <c:v>0.486996686414299</c:v>
                </c:pt>
                <c:pt idx="4">
                  <c:v>0</c:v>
                </c:pt>
                <c:pt idx="5">
                  <c:v>3.8900705250195902</c:v>
                </c:pt>
                <c:pt idx="6">
                  <c:v>0</c:v>
                </c:pt>
                <c:pt idx="7">
                  <c:v>0</c:v>
                </c:pt>
                <c:pt idx="8">
                  <c:v>5.8651322430849966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F-97D7-40C8-B743-8BEFE0D4F8BA}"/>
            </c:ext>
          </c:extLst>
        </c:ser>
        <c:ser>
          <c:idx val="48"/>
          <c:order val="48"/>
          <c:tx>
            <c:strRef>
              <c:f>ordem_grafico!$A$51</c:f>
              <c:strCache>
                <c:ptCount val="1"/>
                <c:pt idx="0">
                  <c:v>Cytophagales</c:v>
                </c:pt>
              </c:strCache>
            </c:strRef>
          </c:tx>
          <c:spPr>
            <a:solidFill>
              <a:schemeClr val="accent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1:$K$51</c:f>
              <c:numCache>
                <c:formatCode>General</c:formatCode>
                <c:ptCount val="10"/>
                <c:pt idx="0">
                  <c:v>0.461922596754058</c:v>
                </c:pt>
                <c:pt idx="1">
                  <c:v>2.0602967583404221</c:v>
                </c:pt>
                <c:pt idx="2">
                  <c:v>0.966730534750044</c:v>
                </c:pt>
                <c:pt idx="3">
                  <c:v>2.3195099909629482</c:v>
                </c:pt>
                <c:pt idx="4">
                  <c:v>0</c:v>
                </c:pt>
                <c:pt idx="5">
                  <c:v>1.0746669651852681</c:v>
                </c:pt>
                <c:pt idx="6">
                  <c:v>0.60594117936844205</c:v>
                </c:pt>
                <c:pt idx="7">
                  <c:v>1.2547543426263581</c:v>
                </c:pt>
                <c:pt idx="8">
                  <c:v>1.1104381183121339</c:v>
                </c:pt>
                <c:pt idx="9">
                  <c:v>10.314631911210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0-97D7-40C8-B743-8BEFE0D4F8BA}"/>
            </c:ext>
          </c:extLst>
        </c:ser>
        <c:ser>
          <c:idx val="49"/>
          <c:order val="49"/>
          <c:tx>
            <c:strRef>
              <c:f>ordem_grafico!$A$52</c:f>
              <c:strCache>
                <c:ptCount val="1"/>
                <c:pt idx="0">
                  <c:v>Flavobacteriales</c:v>
                </c:pt>
              </c:strCache>
            </c:strRef>
          </c:tx>
          <c:spPr>
            <a:solidFill>
              <a:schemeClr val="accent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2:$K$52</c:f>
              <c:numCache>
                <c:formatCode>General</c:formatCode>
                <c:ptCount val="10"/>
                <c:pt idx="0">
                  <c:v>0</c:v>
                </c:pt>
                <c:pt idx="1">
                  <c:v>0.61903411775824602</c:v>
                </c:pt>
                <c:pt idx="2">
                  <c:v>6.5319630726354298E-3</c:v>
                </c:pt>
                <c:pt idx="3">
                  <c:v>0.707902399839341</c:v>
                </c:pt>
                <c:pt idx="4">
                  <c:v>4.2802084464227557</c:v>
                </c:pt>
                <c:pt idx="5">
                  <c:v>0.83958356655099098</c:v>
                </c:pt>
                <c:pt idx="6">
                  <c:v>0.46800334991871501</c:v>
                </c:pt>
                <c:pt idx="7">
                  <c:v>1.5684429282829499E-2</c:v>
                </c:pt>
                <c:pt idx="8">
                  <c:v>0</c:v>
                </c:pt>
                <c:pt idx="9">
                  <c:v>1.3203000373349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1-97D7-40C8-B743-8BEFE0D4F8BA}"/>
            </c:ext>
          </c:extLst>
        </c:ser>
        <c:ser>
          <c:idx val="50"/>
          <c:order val="50"/>
          <c:tx>
            <c:strRef>
              <c:f>ordem_grafico!$A$53</c:f>
              <c:strCache>
                <c:ptCount val="1"/>
                <c:pt idx="0">
                  <c:v>Sphingobacteriales</c:v>
                </c:pt>
              </c:strCache>
            </c:strRef>
          </c:tx>
          <c:spPr>
            <a:solidFill>
              <a:schemeClr val="accent3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3:$K$53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</c:v>
                </c:pt>
                <c:pt idx="2">
                  <c:v>9.5802125065319599E-2</c:v>
                </c:pt>
                <c:pt idx="3">
                  <c:v>0</c:v>
                </c:pt>
                <c:pt idx="4">
                  <c:v>0</c:v>
                </c:pt>
                <c:pt idx="5">
                  <c:v>0.145527818202172</c:v>
                </c:pt>
                <c:pt idx="6">
                  <c:v>0</c:v>
                </c:pt>
                <c:pt idx="7">
                  <c:v>0</c:v>
                </c:pt>
                <c:pt idx="8">
                  <c:v>1.00948919846558E-2</c:v>
                </c:pt>
                <c:pt idx="9">
                  <c:v>5.43053999932118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2-97D7-40C8-B743-8BEFE0D4F8BA}"/>
            </c:ext>
          </c:extLst>
        </c:ser>
        <c:ser>
          <c:idx val="51"/>
          <c:order val="51"/>
          <c:tx>
            <c:strRef>
              <c:f>ordem_grafico!$A$54</c:f>
              <c:strCache>
                <c:ptCount val="1"/>
                <c:pt idx="0">
                  <c:v>Ignavibacteria_unclassified</c:v>
                </c:pt>
              </c:strCache>
            </c:strRef>
          </c:tx>
          <c:spPr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4:$K$54</c:f>
              <c:numCache>
                <c:formatCode>General</c:formatCode>
                <c:ptCount val="10"/>
                <c:pt idx="0">
                  <c:v>3.388621366149460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3-97D7-40C8-B743-8BEFE0D4F8BA}"/>
            </c:ext>
          </c:extLst>
        </c:ser>
        <c:ser>
          <c:idx val="52"/>
          <c:order val="52"/>
          <c:tx>
            <c:strRef>
              <c:f>ordem_grafico!$A$55</c:f>
              <c:strCache>
                <c:ptCount val="1"/>
                <c:pt idx="0">
                  <c:v>Kryptoniales</c:v>
                </c:pt>
              </c:strCache>
            </c:strRef>
          </c:tx>
          <c:spPr>
            <a:solidFill>
              <a:schemeClr val="accent5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5:$K$55</c:f>
              <c:numCache>
                <c:formatCode>General</c:formatCode>
                <c:ptCount val="10"/>
                <c:pt idx="0">
                  <c:v>0.23898698056001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4-97D7-40C8-B743-8BEFE0D4F8BA}"/>
            </c:ext>
          </c:extLst>
        </c:ser>
        <c:ser>
          <c:idx val="53"/>
          <c:order val="53"/>
          <c:tx>
            <c:strRef>
              <c:f>ordem_grafico!$A$56</c:f>
              <c:strCache>
                <c:ptCount val="1"/>
                <c:pt idx="0">
                  <c:v>OPB56</c:v>
                </c:pt>
              </c:strCache>
            </c:strRef>
          </c:tx>
          <c:spPr>
            <a:solidFill>
              <a:schemeClr val="accent6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6:$K$56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3.3078158964181099E-2</c:v>
                </c:pt>
                <c:pt idx="2">
                  <c:v>5.2255704581083397E-2</c:v>
                </c:pt>
                <c:pt idx="3">
                  <c:v>3.0123506376142199E-2</c:v>
                </c:pt>
                <c:pt idx="4">
                  <c:v>0</c:v>
                </c:pt>
                <c:pt idx="5">
                  <c:v>0.12313892309414499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5-97D7-40C8-B743-8BEFE0D4F8BA}"/>
            </c:ext>
          </c:extLst>
        </c:ser>
        <c:ser>
          <c:idx val="54"/>
          <c:order val="54"/>
          <c:tx>
            <c:strRef>
              <c:f>ordem_grafico!$A$57</c:f>
              <c:strCache>
                <c:ptCount val="1"/>
                <c:pt idx="0">
                  <c:v>SJA-28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7:$K$57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69965297212582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6-97D7-40C8-B743-8BEFE0D4F8BA}"/>
            </c:ext>
          </c:extLst>
        </c:ser>
        <c:ser>
          <c:idx val="55"/>
          <c:order val="55"/>
          <c:tx>
            <c:strRef>
              <c:f>ordem_grafico!$A$58</c:f>
              <c:strCache>
                <c:ptCount val="1"/>
                <c:pt idx="0">
                  <c:v>Balneolal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8:$K$58</c:f>
              <c:numCache>
                <c:formatCode>General</c:formatCode>
                <c:ptCount val="10"/>
                <c:pt idx="0">
                  <c:v>1.7834849295523501E-2</c:v>
                </c:pt>
                <c:pt idx="1">
                  <c:v>6.8708061619884697</c:v>
                </c:pt>
                <c:pt idx="2">
                  <c:v>0</c:v>
                </c:pt>
                <c:pt idx="3">
                  <c:v>6.8380359473842756</c:v>
                </c:pt>
                <c:pt idx="4">
                  <c:v>28.53110411464554</c:v>
                </c:pt>
                <c:pt idx="5">
                  <c:v>0</c:v>
                </c:pt>
                <c:pt idx="6">
                  <c:v>0.315286467313661</c:v>
                </c:pt>
                <c:pt idx="7">
                  <c:v>3.5289965886366299E-2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7-97D7-40C8-B743-8BEFE0D4F8BA}"/>
            </c:ext>
          </c:extLst>
        </c:ser>
        <c:ser>
          <c:idx val="56"/>
          <c:order val="56"/>
          <c:tx>
            <c:strRef>
              <c:f>ordem_grafico!$A$59</c:f>
              <c:strCache>
                <c:ptCount val="1"/>
                <c:pt idx="0">
                  <c:v>Rhodothermale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59:$K$59</c:f>
              <c:numCache>
                <c:formatCode>General</c:formatCode>
                <c:ptCount val="10"/>
                <c:pt idx="0">
                  <c:v>0.27465667915106101</c:v>
                </c:pt>
                <c:pt idx="1">
                  <c:v>0.42056516397315902</c:v>
                </c:pt>
                <c:pt idx="2">
                  <c:v>0.33530743772861898</c:v>
                </c:pt>
                <c:pt idx="3">
                  <c:v>0.33637915453358802</c:v>
                </c:pt>
                <c:pt idx="4">
                  <c:v>0</c:v>
                </c:pt>
                <c:pt idx="5">
                  <c:v>0.190305608418225</c:v>
                </c:pt>
                <c:pt idx="6">
                  <c:v>0</c:v>
                </c:pt>
                <c:pt idx="7">
                  <c:v>0</c:v>
                </c:pt>
                <c:pt idx="8">
                  <c:v>2.018978396931153</c:v>
                </c:pt>
                <c:pt idx="9">
                  <c:v>17.333604860333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97D7-40C8-B743-8BEFE0D4F8BA}"/>
            </c:ext>
          </c:extLst>
        </c:ser>
        <c:ser>
          <c:idx val="57"/>
          <c:order val="57"/>
          <c:tx>
            <c:strRef>
              <c:f>ordem_grafico!$A$60</c:f>
              <c:strCache>
                <c:ptCount val="1"/>
                <c:pt idx="0">
                  <c:v>Rhodothermia_unclassified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0:$K$60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9-97D7-40C8-B743-8BEFE0D4F8BA}"/>
            </c:ext>
          </c:extLst>
        </c:ser>
        <c:ser>
          <c:idx val="58"/>
          <c:order val="58"/>
          <c:tx>
            <c:strRef>
              <c:f>ordem_grafico!$A$61</c:f>
              <c:strCache>
                <c:ptCount val="1"/>
                <c:pt idx="0">
                  <c:v>Chlamydiale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1:$K$61</c:f>
              <c:numCache>
                <c:formatCode>General</c:formatCode>
                <c:ptCount val="10"/>
                <c:pt idx="0">
                  <c:v>7.1339397182093797E-2</c:v>
                </c:pt>
                <c:pt idx="1">
                  <c:v>0</c:v>
                </c:pt>
                <c:pt idx="2">
                  <c:v>8.7092840968472397E-3</c:v>
                </c:pt>
                <c:pt idx="3">
                  <c:v>0</c:v>
                </c:pt>
                <c:pt idx="4">
                  <c:v>0</c:v>
                </c:pt>
                <c:pt idx="5">
                  <c:v>0.38061121683644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A-97D7-40C8-B743-8BEFE0D4F8BA}"/>
            </c:ext>
          </c:extLst>
        </c:ser>
        <c:ser>
          <c:idx val="59"/>
          <c:order val="59"/>
          <c:tx>
            <c:strRef>
              <c:f>ordem_grafico!$A$62</c:f>
              <c:strCache>
                <c:ptCount val="1"/>
                <c:pt idx="0">
                  <c:v>Anaerolineae_unclassifie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2:$K$62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4.9263510517759497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B-97D7-40C8-B743-8BEFE0D4F8BA}"/>
            </c:ext>
          </c:extLst>
        </c:ser>
        <c:ser>
          <c:idx val="60"/>
          <c:order val="60"/>
          <c:tx>
            <c:strRef>
              <c:f>ordem_grafico!$A$63</c:f>
              <c:strCache>
                <c:ptCount val="1"/>
                <c:pt idx="0">
                  <c:v>Anaerolineales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3:$K$63</c:f>
              <c:numCache>
                <c:formatCode>General</c:formatCode>
                <c:ptCount val="10"/>
                <c:pt idx="0">
                  <c:v>4.8154093097913298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97054042071037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C-97D7-40C8-B743-8BEFE0D4F8BA}"/>
            </c:ext>
          </c:extLst>
        </c:ser>
        <c:ser>
          <c:idx val="61"/>
          <c:order val="61"/>
          <c:tx>
            <c:strRef>
              <c:f>ordem_grafico!$A$64</c:f>
              <c:strCache>
                <c:ptCount val="1"/>
                <c:pt idx="0">
                  <c:v>Ardenticatenale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4:$K$64</c:f>
              <c:numCache>
                <c:formatCode>General</c:formatCode>
                <c:ptCount val="10"/>
                <c:pt idx="0">
                  <c:v>6.2421972534332099E-2</c:v>
                </c:pt>
                <c:pt idx="1">
                  <c:v>0.14648898969851601</c:v>
                </c:pt>
                <c:pt idx="2">
                  <c:v>0.99068106601637296</c:v>
                </c:pt>
                <c:pt idx="3">
                  <c:v>0.160658700672758</c:v>
                </c:pt>
                <c:pt idx="4">
                  <c:v>0</c:v>
                </c:pt>
                <c:pt idx="5">
                  <c:v>0.156722265756185</c:v>
                </c:pt>
                <c:pt idx="6">
                  <c:v>3.4484457362431602E-2</c:v>
                </c:pt>
                <c:pt idx="7">
                  <c:v>0</c:v>
                </c:pt>
                <c:pt idx="8">
                  <c:v>1.376270273908069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D-97D7-40C8-B743-8BEFE0D4F8BA}"/>
            </c:ext>
          </c:extLst>
        </c:ser>
        <c:ser>
          <c:idx val="62"/>
          <c:order val="62"/>
          <c:tx>
            <c:strRef>
              <c:f>ordem_grafico!$A$65</c:f>
              <c:strCache>
                <c:ptCount val="1"/>
                <c:pt idx="0">
                  <c:v>Caldilineales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5:$K$65</c:f>
              <c:numCache>
                <c:formatCode>General</c:formatCode>
                <c:ptCount val="10"/>
                <c:pt idx="0">
                  <c:v>0.17656500802568201</c:v>
                </c:pt>
                <c:pt idx="1">
                  <c:v>0.91673754843587596</c:v>
                </c:pt>
                <c:pt idx="2">
                  <c:v>0.52908900888346999</c:v>
                </c:pt>
                <c:pt idx="3">
                  <c:v>0.81835525655186303</c:v>
                </c:pt>
                <c:pt idx="4">
                  <c:v>0</c:v>
                </c:pt>
                <c:pt idx="5">
                  <c:v>0.21269450352625099</c:v>
                </c:pt>
                <c:pt idx="6">
                  <c:v>7.3895265776639199E-2</c:v>
                </c:pt>
                <c:pt idx="7">
                  <c:v>0</c:v>
                </c:pt>
                <c:pt idx="8">
                  <c:v>0.114408775826099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E-97D7-40C8-B743-8BEFE0D4F8BA}"/>
            </c:ext>
          </c:extLst>
        </c:ser>
        <c:ser>
          <c:idx val="63"/>
          <c:order val="63"/>
          <c:tx>
            <c:strRef>
              <c:f>ordem_grafico!$A$66</c:f>
              <c:strCache>
                <c:ptCount val="1"/>
                <c:pt idx="0">
                  <c:v>RBG-13-54-9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6:$K$6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919847755513264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F-97D7-40C8-B743-8BEFE0D4F8BA}"/>
            </c:ext>
          </c:extLst>
        </c:ser>
        <c:ser>
          <c:idx val="64"/>
          <c:order val="64"/>
          <c:tx>
            <c:strRef>
              <c:f>ordem_grafico!$A$67</c:f>
              <c:strCache>
                <c:ptCount val="1"/>
                <c:pt idx="0">
                  <c:v>SBR1031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7:$K$67</c:f>
              <c:numCache>
                <c:formatCode>General</c:formatCode>
                <c:ptCount val="10"/>
                <c:pt idx="0">
                  <c:v>0.32281077224897498</c:v>
                </c:pt>
                <c:pt idx="1">
                  <c:v>0.118136282014932</c:v>
                </c:pt>
                <c:pt idx="2">
                  <c:v>4.7901062532659799E-2</c:v>
                </c:pt>
                <c:pt idx="3">
                  <c:v>2.5102921980118501E-2</c:v>
                </c:pt>
                <c:pt idx="4">
                  <c:v>0</c:v>
                </c:pt>
                <c:pt idx="5">
                  <c:v>0.91794469942908297</c:v>
                </c:pt>
                <c:pt idx="6">
                  <c:v>0.11823242524262299</c:v>
                </c:pt>
                <c:pt idx="7">
                  <c:v>0</c:v>
                </c:pt>
                <c:pt idx="8">
                  <c:v>1.0094891984655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0-97D7-40C8-B743-8BEFE0D4F8BA}"/>
            </c:ext>
          </c:extLst>
        </c:ser>
        <c:ser>
          <c:idx val="65"/>
          <c:order val="65"/>
          <c:tx>
            <c:strRef>
              <c:f>ordem_grafico!$A$68</c:f>
              <c:strCache>
                <c:ptCount val="1"/>
                <c:pt idx="0">
                  <c:v>Chloroflexi_unclassified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8:$K$68</c:f>
              <c:numCache>
                <c:formatCode>General</c:formatCode>
                <c:ptCount val="10"/>
                <c:pt idx="0">
                  <c:v>2.1401819154628101E-2</c:v>
                </c:pt>
                <c:pt idx="1">
                  <c:v>4.7254512805973E-3</c:v>
                </c:pt>
                <c:pt idx="2">
                  <c:v>8.7092840968472404E-2</c:v>
                </c:pt>
                <c:pt idx="3">
                  <c:v>2.5102921980118501E-2</c:v>
                </c:pt>
                <c:pt idx="4">
                  <c:v>0</c:v>
                </c:pt>
                <c:pt idx="5">
                  <c:v>5.5972237770066102E-3</c:v>
                </c:pt>
                <c:pt idx="6">
                  <c:v>2.4631755258879801E-2</c:v>
                </c:pt>
                <c:pt idx="7">
                  <c:v>0</c:v>
                </c:pt>
                <c:pt idx="8">
                  <c:v>2.018978396931149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1-97D7-40C8-B743-8BEFE0D4F8BA}"/>
            </c:ext>
          </c:extLst>
        </c:ser>
        <c:ser>
          <c:idx val="66"/>
          <c:order val="66"/>
          <c:tx>
            <c:strRef>
              <c:f>ordem_grafico!$A$69</c:f>
              <c:strCache>
                <c:ptCount val="1"/>
                <c:pt idx="0">
                  <c:v>Chloroflexale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69:$K$69</c:f>
              <c:numCache>
                <c:formatCode>General</c:formatCode>
                <c:ptCount val="10"/>
                <c:pt idx="0">
                  <c:v>0</c:v>
                </c:pt>
                <c:pt idx="1">
                  <c:v>1.4176353841791899E-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2-97D7-40C8-B743-8BEFE0D4F8BA}"/>
            </c:ext>
          </c:extLst>
        </c:ser>
        <c:ser>
          <c:idx val="67"/>
          <c:order val="67"/>
          <c:tx>
            <c:strRef>
              <c:f>ordem_grafico!$A$70</c:f>
              <c:strCache>
                <c:ptCount val="1"/>
                <c:pt idx="0">
                  <c:v>Chloroflexia_unclassified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0:$K$70</c:f>
              <c:numCache>
                <c:formatCode>General</c:formatCode>
                <c:ptCount val="10"/>
                <c:pt idx="0">
                  <c:v>1.7834849295523501E-2</c:v>
                </c:pt>
                <c:pt idx="1">
                  <c:v>0</c:v>
                </c:pt>
                <c:pt idx="2">
                  <c:v>2.39505312663299E-2</c:v>
                </c:pt>
                <c:pt idx="3">
                  <c:v>5.0205843960236998E-3</c:v>
                </c:pt>
                <c:pt idx="4">
                  <c:v>0</c:v>
                </c:pt>
                <c:pt idx="5">
                  <c:v>1.11944475540132E-2</c:v>
                </c:pt>
                <c:pt idx="6">
                  <c:v>5.4189861569535397E-2</c:v>
                </c:pt>
                <c:pt idx="7">
                  <c:v>0</c:v>
                </c:pt>
                <c:pt idx="8">
                  <c:v>1.00948919846558E-2</c:v>
                </c:pt>
                <c:pt idx="9">
                  <c:v>1.69704374978787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3-97D7-40C8-B743-8BEFE0D4F8BA}"/>
            </c:ext>
          </c:extLst>
        </c:ser>
        <c:ser>
          <c:idx val="68"/>
          <c:order val="68"/>
          <c:tx>
            <c:strRef>
              <c:f>ordem_grafico!$A$71</c:f>
              <c:strCache>
                <c:ptCount val="1"/>
                <c:pt idx="0">
                  <c:v>Kallotenuales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1:$K$71</c:f>
              <c:numCache>
                <c:formatCode>General</c:formatCode>
                <c:ptCount val="10"/>
                <c:pt idx="0">
                  <c:v>0</c:v>
                </c:pt>
                <c:pt idx="1">
                  <c:v>0.255174369152254</c:v>
                </c:pt>
                <c:pt idx="2">
                  <c:v>0.61618184985194202</c:v>
                </c:pt>
                <c:pt idx="3">
                  <c:v>0.2460086354051609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30621172353455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4-97D7-40C8-B743-8BEFE0D4F8BA}"/>
            </c:ext>
          </c:extLst>
        </c:ser>
        <c:ser>
          <c:idx val="69"/>
          <c:order val="69"/>
          <c:tx>
            <c:strRef>
              <c:f>ordem_grafico!$A$72</c:f>
              <c:strCache>
                <c:ptCount val="1"/>
                <c:pt idx="0">
                  <c:v>Thermomicrobiales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2:$K$72</c:f>
              <c:numCache>
                <c:formatCode>General</c:formatCode>
                <c:ptCount val="10"/>
                <c:pt idx="0">
                  <c:v>0.977349741394685</c:v>
                </c:pt>
                <c:pt idx="1">
                  <c:v>6.3368301672809757</c:v>
                </c:pt>
                <c:pt idx="2">
                  <c:v>5.7590141090402369</c:v>
                </c:pt>
                <c:pt idx="3">
                  <c:v>6.742644843859825</c:v>
                </c:pt>
                <c:pt idx="4">
                  <c:v>0</c:v>
                </c:pt>
                <c:pt idx="5">
                  <c:v>0.58211127280868702</c:v>
                </c:pt>
                <c:pt idx="6">
                  <c:v>4.4731267550125633</c:v>
                </c:pt>
                <c:pt idx="7">
                  <c:v>1.6703917186213391</c:v>
                </c:pt>
                <c:pt idx="8">
                  <c:v>4.6032707450030301</c:v>
                </c:pt>
                <c:pt idx="9">
                  <c:v>4.772087024403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5-97D7-40C8-B743-8BEFE0D4F8BA}"/>
            </c:ext>
          </c:extLst>
        </c:ser>
        <c:ser>
          <c:idx val="70"/>
          <c:order val="70"/>
          <c:tx>
            <c:strRef>
              <c:f>ordem_grafico!$A$73</c:f>
              <c:strCache>
                <c:ptCount val="1"/>
                <c:pt idx="0">
                  <c:v>Dehalococcoidia_unclassified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3:$K$73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4.9263510517759497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6-97D7-40C8-B743-8BEFE0D4F8BA}"/>
            </c:ext>
          </c:extLst>
        </c:ser>
        <c:ser>
          <c:idx val="71"/>
          <c:order val="71"/>
          <c:tx>
            <c:strRef>
              <c:f>ordem_grafico!$A$74</c:f>
              <c:strCache>
                <c:ptCount val="1"/>
                <c:pt idx="0">
                  <c:v>S085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4:$K$74</c:f>
              <c:numCache>
                <c:formatCode>General</c:formatCode>
                <c:ptCount val="10"/>
                <c:pt idx="0">
                  <c:v>4.1020153379703897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7986118885032999E-2</c:v>
                </c:pt>
                <c:pt idx="6">
                  <c:v>1.47790531553278E-2</c:v>
                </c:pt>
                <c:pt idx="7">
                  <c:v>0</c:v>
                </c:pt>
                <c:pt idx="8">
                  <c:v>1.0094891984655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7-97D7-40C8-B743-8BEFE0D4F8BA}"/>
            </c:ext>
          </c:extLst>
        </c:ser>
        <c:ser>
          <c:idx val="72"/>
          <c:order val="72"/>
          <c:tx>
            <c:strRef>
              <c:f>ordem_grafico!$A$75</c:f>
              <c:strCache>
                <c:ptCount val="1"/>
                <c:pt idx="0">
                  <c:v>SAR202_clade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5:$K$75</c:f>
              <c:numCache>
                <c:formatCode>General</c:formatCode>
                <c:ptCount val="10"/>
                <c:pt idx="0">
                  <c:v>2.31853040841805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20198039312281399</c:v>
                </c:pt>
                <c:pt idx="7">
                  <c:v>0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8-97D7-40C8-B743-8BEFE0D4F8BA}"/>
            </c:ext>
          </c:extLst>
        </c:ser>
        <c:ser>
          <c:idx val="73"/>
          <c:order val="73"/>
          <c:tx>
            <c:strRef>
              <c:f>ordem_grafico!$A$76</c:f>
              <c:strCache>
                <c:ptCount val="1"/>
                <c:pt idx="0">
                  <c:v>Gitt-GS-136_or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6:$K$76</c:f>
              <c:numCache>
                <c:formatCode>General</c:formatCode>
                <c:ptCount val="10"/>
                <c:pt idx="0">
                  <c:v>5.1721062957017998E-2</c:v>
                </c:pt>
                <c:pt idx="1">
                  <c:v>9.4509025611946001E-3</c:v>
                </c:pt>
                <c:pt idx="2">
                  <c:v>2.39505312663299E-2</c:v>
                </c:pt>
                <c:pt idx="3">
                  <c:v>5.0205843960237001E-2</c:v>
                </c:pt>
                <c:pt idx="4">
                  <c:v>0</c:v>
                </c:pt>
                <c:pt idx="5">
                  <c:v>0.106347251763125</c:v>
                </c:pt>
                <c:pt idx="6">
                  <c:v>0.408887137297404</c:v>
                </c:pt>
                <c:pt idx="7">
                  <c:v>0</c:v>
                </c:pt>
                <c:pt idx="8">
                  <c:v>7.7394171882360904E-2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9-97D7-40C8-B743-8BEFE0D4F8BA}"/>
            </c:ext>
          </c:extLst>
        </c:ser>
        <c:ser>
          <c:idx val="74"/>
          <c:order val="74"/>
          <c:tx>
            <c:strRef>
              <c:f>ordem_grafico!$A$77</c:f>
              <c:strCache>
                <c:ptCount val="1"/>
                <c:pt idx="0">
                  <c:v>JG30-KF-CM66_or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7:$K$77</c:f>
              <c:numCache>
                <c:formatCode>General</c:formatCode>
                <c:ptCount val="10"/>
                <c:pt idx="0">
                  <c:v>9.8091671125379004E-2</c:v>
                </c:pt>
                <c:pt idx="1">
                  <c:v>0.10395992817314099</c:v>
                </c:pt>
                <c:pt idx="2">
                  <c:v>0.26127852290541698</c:v>
                </c:pt>
                <c:pt idx="3">
                  <c:v>8.0329350336379196E-2</c:v>
                </c:pt>
                <c:pt idx="4">
                  <c:v>0</c:v>
                </c:pt>
                <c:pt idx="5">
                  <c:v>0.21269450352625099</c:v>
                </c:pt>
                <c:pt idx="6">
                  <c:v>0.113306074190847</c:v>
                </c:pt>
                <c:pt idx="7">
                  <c:v>0</c:v>
                </c:pt>
                <c:pt idx="8">
                  <c:v>0.16488323574937799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A-97D7-40C8-B743-8BEFE0D4F8BA}"/>
            </c:ext>
          </c:extLst>
        </c:ser>
        <c:ser>
          <c:idx val="75"/>
          <c:order val="75"/>
          <c:tx>
            <c:strRef>
              <c:f>ordem_grafico!$A$78</c:f>
              <c:strCache>
                <c:ptCount val="1"/>
                <c:pt idx="0">
                  <c:v>KD4-96_or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8:$K$78</c:f>
              <c:numCache>
                <c:formatCode>General</c:formatCode>
                <c:ptCount val="10"/>
                <c:pt idx="0">
                  <c:v>0.16943106830747301</c:v>
                </c:pt>
                <c:pt idx="1">
                  <c:v>0</c:v>
                </c:pt>
                <c:pt idx="2">
                  <c:v>4.3546420484236199E-3</c:v>
                </c:pt>
                <c:pt idx="3">
                  <c:v>1.00411687920474E-2</c:v>
                </c:pt>
                <c:pt idx="4">
                  <c:v>0</c:v>
                </c:pt>
                <c:pt idx="5">
                  <c:v>0.12313892309414499</c:v>
                </c:pt>
                <c:pt idx="6">
                  <c:v>1.97054042071037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B-97D7-40C8-B743-8BEFE0D4F8BA}"/>
            </c:ext>
          </c:extLst>
        </c:ser>
        <c:ser>
          <c:idx val="76"/>
          <c:order val="76"/>
          <c:tx>
            <c:strRef>
              <c:f>ordem_grafico!$A$79</c:f>
              <c:strCache>
                <c:ptCount val="1"/>
                <c:pt idx="0">
                  <c:v>N9D0_or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79:$K$7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.0205843960236998E-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C-97D7-40C8-B743-8BEFE0D4F8BA}"/>
            </c:ext>
          </c:extLst>
        </c:ser>
        <c:ser>
          <c:idx val="77"/>
          <c:order val="77"/>
          <c:tx>
            <c:strRef>
              <c:f>ordem_grafico!$A$80</c:f>
              <c:strCache>
                <c:ptCount val="1"/>
                <c:pt idx="0">
                  <c:v>OLB14_or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0:$K$80</c:f>
              <c:numCache>
                <c:formatCode>General</c:formatCode>
                <c:ptCount val="10"/>
                <c:pt idx="0">
                  <c:v>0.12841091492776899</c:v>
                </c:pt>
                <c:pt idx="1">
                  <c:v>3.3078158964181099E-2</c:v>
                </c:pt>
                <c:pt idx="2">
                  <c:v>8.7092840968472397E-3</c:v>
                </c:pt>
                <c:pt idx="3">
                  <c:v>1.5061753188071099E-2</c:v>
                </c:pt>
                <c:pt idx="4">
                  <c:v>0</c:v>
                </c:pt>
                <c:pt idx="5">
                  <c:v>0.173513937087205</c:v>
                </c:pt>
                <c:pt idx="6">
                  <c:v>3.9410808414207597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D-97D7-40C8-B743-8BEFE0D4F8BA}"/>
            </c:ext>
          </c:extLst>
        </c:ser>
        <c:ser>
          <c:idx val="78"/>
          <c:order val="78"/>
          <c:tx>
            <c:strRef>
              <c:f>ordem_grafico!$A$81</c:f>
              <c:strCache>
                <c:ptCount val="1"/>
                <c:pt idx="0">
                  <c:v>P2-11E_or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1:$K$81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E-97D7-40C8-B743-8BEFE0D4F8BA}"/>
            </c:ext>
          </c:extLst>
        </c:ser>
        <c:ser>
          <c:idx val="79"/>
          <c:order val="79"/>
          <c:tx>
            <c:strRef>
              <c:f>ordem_grafico!$A$82</c:f>
              <c:strCache>
                <c:ptCount val="1"/>
                <c:pt idx="0">
                  <c:v>TK10_or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2:$K$82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4.7254512805973E-3</c:v>
                </c:pt>
                <c:pt idx="2">
                  <c:v>0.10886605121059099</c:v>
                </c:pt>
                <c:pt idx="3">
                  <c:v>1.5061753188071099E-2</c:v>
                </c:pt>
                <c:pt idx="4">
                  <c:v>0</c:v>
                </c:pt>
                <c:pt idx="5">
                  <c:v>0</c:v>
                </c:pt>
                <c:pt idx="6">
                  <c:v>1.47790531553278E-2</c:v>
                </c:pt>
                <c:pt idx="7">
                  <c:v>0</c:v>
                </c:pt>
                <c:pt idx="8">
                  <c:v>1.345985597954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F-97D7-40C8-B743-8BEFE0D4F8BA}"/>
            </c:ext>
          </c:extLst>
        </c:ser>
        <c:ser>
          <c:idx val="80"/>
          <c:order val="80"/>
          <c:tx>
            <c:strRef>
              <c:f>ordem_grafico!$A$83</c:f>
              <c:strCache>
                <c:ptCount val="1"/>
                <c:pt idx="0">
                  <c:v>Obscuribacterales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3:$K$8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3623642673234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0-97D7-40C8-B743-8BEFE0D4F8BA}"/>
            </c:ext>
          </c:extLst>
        </c:ser>
        <c:ser>
          <c:idx val="81"/>
          <c:order val="81"/>
          <c:tx>
            <c:strRef>
              <c:f>ordem_grafico!$A$84</c:f>
              <c:strCache>
                <c:ptCount val="1"/>
                <c:pt idx="0">
                  <c:v>Vampirovibrionale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4:$K$84</c:f>
              <c:numCache>
                <c:formatCode>General</c:formatCode>
                <c:ptCount val="10"/>
                <c:pt idx="0">
                  <c:v>0</c:v>
                </c:pt>
                <c:pt idx="1">
                  <c:v>0.108685379453738</c:v>
                </c:pt>
                <c:pt idx="2">
                  <c:v>1.0886605121059E-2</c:v>
                </c:pt>
                <c:pt idx="3">
                  <c:v>0.105432272316498</c:v>
                </c:pt>
                <c:pt idx="4">
                  <c:v>0</c:v>
                </c:pt>
                <c:pt idx="5">
                  <c:v>5.037501399305940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1-97D7-40C8-B743-8BEFE0D4F8BA}"/>
            </c:ext>
          </c:extLst>
        </c:ser>
        <c:ser>
          <c:idx val="82"/>
          <c:order val="82"/>
          <c:tx>
            <c:strRef>
              <c:f>ordem_grafico!$A$85</c:f>
              <c:strCache>
                <c:ptCount val="1"/>
                <c:pt idx="0">
                  <c:v>Chloroplast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5:$K$85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.76079765617616502</c:v>
                </c:pt>
                <c:pt idx="2">
                  <c:v>2.1773210242118099E-3</c:v>
                </c:pt>
                <c:pt idx="3">
                  <c:v>0.7781905813836730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94890797161118301</c:v>
                </c:pt>
                <c:pt idx="8">
                  <c:v>1.6824819974426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2-97D7-40C8-B743-8BEFE0D4F8BA}"/>
            </c:ext>
          </c:extLst>
        </c:ser>
        <c:ser>
          <c:idx val="83"/>
          <c:order val="83"/>
          <c:tx>
            <c:strRef>
              <c:f>ordem_grafico!$A$86</c:f>
              <c:strCache>
                <c:ptCount val="1"/>
                <c:pt idx="0">
                  <c:v>Leptolyngbyales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6:$K$8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1.9595889217906299E-2</c:v>
                </c:pt>
                <c:pt idx="3">
                  <c:v>0</c:v>
                </c:pt>
                <c:pt idx="4">
                  <c:v>0</c:v>
                </c:pt>
                <c:pt idx="5">
                  <c:v>3.873278853688570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3-97D7-40C8-B743-8BEFE0D4F8BA}"/>
            </c:ext>
          </c:extLst>
        </c:ser>
        <c:ser>
          <c:idx val="84"/>
          <c:order val="84"/>
          <c:tx>
            <c:strRef>
              <c:f>ordem_grafico!$A$87</c:f>
              <c:strCache>
                <c:ptCount val="1"/>
                <c:pt idx="0">
                  <c:v>Nostocales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7:$K$87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3.4448539835554288</c:v>
                </c:pt>
                <c:pt idx="2">
                  <c:v>1.3368751088660511</c:v>
                </c:pt>
                <c:pt idx="3">
                  <c:v>4.4181142685008519</c:v>
                </c:pt>
                <c:pt idx="4">
                  <c:v>0</c:v>
                </c:pt>
                <c:pt idx="5">
                  <c:v>3.0784730773536331</c:v>
                </c:pt>
                <c:pt idx="6">
                  <c:v>0.187201339967486</c:v>
                </c:pt>
                <c:pt idx="7">
                  <c:v>7.8422146414147392E-3</c:v>
                </c:pt>
                <c:pt idx="8">
                  <c:v>4.3744531933508302E-2</c:v>
                </c:pt>
                <c:pt idx="9">
                  <c:v>1.7717136747785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4-97D7-40C8-B743-8BEFE0D4F8BA}"/>
            </c:ext>
          </c:extLst>
        </c:ser>
        <c:ser>
          <c:idx val="85"/>
          <c:order val="85"/>
          <c:tx>
            <c:strRef>
              <c:f>ordem_grafico!$A$88</c:f>
              <c:strCache>
                <c:ptCount val="1"/>
                <c:pt idx="0">
                  <c:v>Oxyphotobacteria_Incertae_Sedi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8:$K$8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6.5319630726354298E-3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5-97D7-40C8-B743-8BEFE0D4F8BA}"/>
            </c:ext>
          </c:extLst>
        </c:ser>
        <c:ser>
          <c:idx val="86"/>
          <c:order val="86"/>
          <c:tx>
            <c:strRef>
              <c:f>ordem_grafico!$A$89</c:f>
              <c:strCache>
                <c:ptCount val="1"/>
                <c:pt idx="0">
                  <c:v>Oxyphotobacteria_unclassified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89:$K$89</c:f>
              <c:numCache>
                <c:formatCode>General</c:formatCode>
                <c:ptCount val="10"/>
                <c:pt idx="0">
                  <c:v>7.9632602104512218</c:v>
                </c:pt>
                <c:pt idx="1">
                  <c:v>8.19865797183631</c:v>
                </c:pt>
                <c:pt idx="2">
                  <c:v>0.21773210242118099</c:v>
                </c:pt>
                <c:pt idx="3">
                  <c:v>7.8873380861532283</c:v>
                </c:pt>
                <c:pt idx="4">
                  <c:v>1.0856584518510499E-2</c:v>
                </c:pt>
                <c:pt idx="5">
                  <c:v>0.12873614687115201</c:v>
                </c:pt>
                <c:pt idx="6">
                  <c:v>0</c:v>
                </c:pt>
                <c:pt idx="7">
                  <c:v>4.2112692624397132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6-97D7-40C8-B743-8BEFE0D4F8BA}"/>
            </c:ext>
          </c:extLst>
        </c:ser>
        <c:ser>
          <c:idx val="87"/>
          <c:order val="87"/>
          <c:tx>
            <c:strRef>
              <c:f>ordem_grafico!$A$90</c:f>
              <c:strCache>
                <c:ptCount val="1"/>
                <c:pt idx="0">
                  <c:v>Phormidesmiales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0:$K$9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.2038975806767830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7-97D7-40C8-B743-8BEFE0D4F8BA}"/>
            </c:ext>
          </c:extLst>
        </c:ser>
        <c:ser>
          <c:idx val="88"/>
          <c:order val="88"/>
          <c:tx>
            <c:strRef>
              <c:f>ordem_grafico!$A$91</c:f>
              <c:strCache>
                <c:ptCount val="1"/>
                <c:pt idx="0">
                  <c:v>Thermosynechococcales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1:$K$9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.17732102421180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2.611457475591107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8-97D7-40C8-B743-8BEFE0D4F8BA}"/>
            </c:ext>
          </c:extLst>
        </c:ser>
        <c:ser>
          <c:idx val="89"/>
          <c:order val="89"/>
          <c:tx>
            <c:strRef>
              <c:f>ordem_grafico!$A$92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2:$K$92</c:f>
              <c:numCache>
                <c:formatCode>General</c:formatCode>
                <c:ptCount val="10"/>
                <c:pt idx="0">
                  <c:v>0</c:v>
                </c:pt>
                <c:pt idx="1">
                  <c:v>7.08817692089595E-2</c:v>
                </c:pt>
                <c:pt idx="2">
                  <c:v>25.037014457411601</c:v>
                </c:pt>
                <c:pt idx="3">
                  <c:v>3.0123506376142199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9-97D7-40C8-B743-8BEFE0D4F8BA}"/>
            </c:ext>
          </c:extLst>
        </c:ser>
        <c:ser>
          <c:idx val="90"/>
          <c:order val="90"/>
          <c:tx>
            <c:strRef>
              <c:f>ordem_grafico!$A$93</c:f>
              <c:strCache>
                <c:ptCount val="1"/>
                <c:pt idx="0">
                  <c:v>Sericytochromatia_or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3:$K$9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4.35464204842361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A-97D7-40C8-B743-8BEFE0D4F8BA}"/>
            </c:ext>
          </c:extLst>
        </c:ser>
        <c:ser>
          <c:idx val="91"/>
          <c:order val="91"/>
          <c:tx>
            <c:strRef>
              <c:f>ordem_grafico!$A$94</c:f>
              <c:strCache>
                <c:ptCount val="1"/>
                <c:pt idx="0">
                  <c:v>Dadabacteriales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4:$K$94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B-97D7-40C8-B743-8BEFE0D4F8BA}"/>
            </c:ext>
          </c:extLst>
        </c:ser>
        <c:ser>
          <c:idx val="92"/>
          <c:order val="92"/>
          <c:tx>
            <c:strRef>
              <c:f>ordem_grafico!$A$95</c:f>
              <c:strCache>
                <c:ptCount val="1"/>
                <c:pt idx="0">
                  <c:v>Deinococcales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5:$K$95</c:f>
              <c:numCache>
                <c:formatCode>General</c:formatCode>
                <c:ptCount val="10"/>
                <c:pt idx="0">
                  <c:v>7.8473336900303198E-2</c:v>
                </c:pt>
                <c:pt idx="1">
                  <c:v>3.78036102447784E-2</c:v>
                </c:pt>
                <c:pt idx="2">
                  <c:v>0.30482494338965399</c:v>
                </c:pt>
                <c:pt idx="3">
                  <c:v>8.0329350336379196E-2</c:v>
                </c:pt>
                <c:pt idx="4">
                  <c:v>0</c:v>
                </c:pt>
                <c:pt idx="5">
                  <c:v>2.7986118885032999E-2</c:v>
                </c:pt>
                <c:pt idx="6">
                  <c:v>0.24631755258879701</c:v>
                </c:pt>
                <c:pt idx="7">
                  <c:v>1.1763321962122099E-2</c:v>
                </c:pt>
                <c:pt idx="8">
                  <c:v>9.0854027861901901E-2</c:v>
                </c:pt>
                <c:pt idx="9">
                  <c:v>0.45820181244272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C-97D7-40C8-B743-8BEFE0D4F8BA}"/>
            </c:ext>
          </c:extLst>
        </c:ser>
        <c:ser>
          <c:idx val="93"/>
          <c:order val="93"/>
          <c:tx>
            <c:strRef>
              <c:f>ordem_grafico!$A$96</c:f>
              <c:strCache>
                <c:ptCount val="1"/>
                <c:pt idx="0">
                  <c:v>Deinococci_unclassified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6:$K$96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D-97D7-40C8-B743-8BEFE0D4F8BA}"/>
            </c:ext>
          </c:extLst>
        </c:ser>
        <c:ser>
          <c:idx val="94"/>
          <c:order val="94"/>
          <c:tx>
            <c:strRef>
              <c:f>ordem_grafico!$A$97</c:f>
              <c:strCache>
                <c:ptCount val="1"/>
                <c:pt idx="0">
                  <c:v>Babeliales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7:$K$97</c:f>
              <c:numCache>
                <c:formatCode>General</c:formatCode>
                <c:ptCount val="10"/>
                <c:pt idx="0">
                  <c:v>5.35045478865704E-2</c:v>
                </c:pt>
                <c:pt idx="1">
                  <c:v>9.4509025611946001E-3</c:v>
                </c:pt>
                <c:pt idx="2">
                  <c:v>0</c:v>
                </c:pt>
                <c:pt idx="3">
                  <c:v>3.0123506376142199E-2</c:v>
                </c:pt>
                <c:pt idx="4">
                  <c:v>0</c:v>
                </c:pt>
                <c:pt idx="5">
                  <c:v>4.4777790216052799E-2</c:v>
                </c:pt>
                <c:pt idx="6">
                  <c:v>3.4484457362431602E-2</c:v>
                </c:pt>
                <c:pt idx="7">
                  <c:v>0</c:v>
                </c:pt>
                <c:pt idx="8">
                  <c:v>0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E-97D7-40C8-B743-8BEFE0D4F8BA}"/>
            </c:ext>
          </c:extLst>
        </c:ser>
        <c:ser>
          <c:idx val="95"/>
          <c:order val="95"/>
          <c:tx>
            <c:strRef>
              <c:f>ordem_grafico!$A$98</c:f>
              <c:strCache>
                <c:ptCount val="1"/>
                <c:pt idx="0">
                  <c:v>Lineage_IV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8:$K$98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F-97D7-40C8-B743-8BEFE0D4F8BA}"/>
            </c:ext>
          </c:extLst>
        </c:ser>
        <c:ser>
          <c:idx val="96"/>
          <c:order val="96"/>
          <c:tx>
            <c:strRef>
              <c:f>ordem_grafico!$A$99</c:f>
              <c:strCache>
                <c:ptCount val="1"/>
                <c:pt idx="0">
                  <c:v>Elusimicrobia_unclassified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99:$K$99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0-97D7-40C8-B743-8BEFE0D4F8BA}"/>
            </c:ext>
          </c:extLst>
        </c:ser>
        <c:ser>
          <c:idx val="97"/>
          <c:order val="97"/>
          <c:tx>
            <c:strRef>
              <c:f>ordem_grafico!$A$100</c:f>
              <c:strCache>
                <c:ptCount val="1"/>
                <c:pt idx="0">
                  <c:v>Lineage_IIa_or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0:$K$100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1.89018051223892E-2</c:v>
                </c:pt>
                <c:pt idx="2">
                  <c:v>8.9270161992684199E-2</c:v>
                </c:pt>
                <c:pt idx="3">
                  <c:v>2.5102921980118501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1-97D7-40C8-B743-8BEFE0D4F8BA}"/>
            </c:ext>
          </c:extLst>
        </c:ser>
        <c:ser>
          <c:idx val="98"/>
          <c:order val="98"/>
          <c:tx>
            <c:strRef>
              <c:f>ordem_grafico!$A$101</c:f>
              <c:strCache>
                <c:ptCount val="1"/>
                <c:pt idx="0">
                  <c:v>Lineage_IIb_or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1:$K$101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2-97D7-40C8-B743-8BEFE0D4F8BA}"/>
            </c:ext>
          </c:extLst>
        </c:ser>
        <c:ser>
          <c:idx val="99"/>
          <c:order val="99"/>
          <c:tx>
            <c:strRef>
              <c:f>ordem_grafico!$A$102</c:f>
              <c:strCache>
                <c:ptCount val="1"/>
                <c:pt idx="0">
                  <c:v>Lineage_IIc_or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2:$K$102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3-97D7-40C8-B743-8BEFE0D4F8BA}"/>
            </c:ext>
          </c:extLst>
        </c:ser>
        <c:ser>
          <c:idx val="100"/>
          <c:order val="100"/>
          <c:tx>
            <c:strRef>
              <c:f>ordem_grafico!$A$103</c:f>
              <c:strCache>
                <c:ptCount val="1"/>
                <c:pt idx="0">
                  <c:v>Campylobacterales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3:$K$10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5.42829225925524E-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4-97D7-40C8-B743-8BEFE0D4F8BA}"/>
            </c:ext>
          </c:extLst>
        </c:ser>
        <c:ser>
          <c:idx val="101"/>
          <c:order val="101"/>
          <c:tx>
            <c:strRef>
              <c:f>ordem_grafico!$A$104</c:f>
              <c:strCache>
                <c:ptCount val="1"/>
                <c:pt idx="0">
                  <c:v>FBP_or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4:$K$104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.395053126632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6.0569351907934603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5-97D7-40C8-B743-8BEFE0D4F8BA}"/>
            </c:ext>
          </c:extLst>
        </c:ser>
        <c:ser>
          <c:idx val="102"/>
          <c:order val="102"/>
          <c:tx>
            <c:strRef>
              <c:f>ordem_grafico!$A$105</c:f>
              <c:strCache>
                <c:ptCount val="1"/>
                <c:pt idx="0">
                  <c:v>FCPU426_or</c:v>
                </c:pt>
              </c:strCache>
            </c:strRef>
          </c:tx>
          <c:spPr>
            <a:solidFill>
              <a:schemeClr val="accent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5:$K$105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6-97D7-40C8-B743-8BEFE0D4F8BA}"/>
            </c:ext>
          </c:extLst>
        </c:ser>
        <c:ser>
          <c:idx val="103"/>
          <c:order val="103"/>
          <c:tx>
            <c:strRef>
              <c:f>ordem_grafico!$A$106</c:f>
              <c:strCache>
                <c:ptCount val="1"/>
                <c:pt idx="0">
                  <c:v>Bacillales</c:v>
                </c:pt>
              </c:strCache>
            </c:strRef>
          </c:tx>
          <c:spPr>
            <a:solidFill>
              <a:schemeClr val="accent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6:$K$106</c:f>
              <c:numCache>
                <c:formatCode>General</c:formatCode>
                <c:ptCount val="10"/>
                <c:pt idx="0">
                  <c:v>1.9618334225075799E-2</c:v>
                </c:pt>
                <c:pt idx="1">
                  <c:v>1.89018051223892E-2</c:v>
                </c:pt>
                <c:pt idx="2">
                  <c:v>0</c:v>
                </c:pt>
                <c:pt idx="3">
                  <c:v>1.5061753188071099E-2</c:v>
                </c:pt>
                <c:pt idx="4">
                  <c:v>4.3426338074041899E-2</c:v>
                </c:pt>
                <c:pt idx="5">
                  <c:v>0.55972237770066002</c:v>
                </c:pt>
                <c:pt idx="6">
                  <c:v>1.9705404207103799E-2</c:v>
                </c:pt>
                <c:pt idx="7">
                  <c:v>1.1763321962122099E-2</c:v>
                </c:pt>
                <c:pt idx="8">
                  <c:v>1.6824819974426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7-97D7-40C8-B743-8BEFE0D4F8BA}"/>
            </c:ext>
          </c:extLst>
        </c:ser>
        <c:ser>
          <c:idx val="104"/>
          <c:order val="104"/>
          <c:tx>
            <c:strRef>
              <c:f>ordem_grafico!$A$107</c:f>
              <c:strCache>
                <c:ptCount val="1"/>
                <c:pt idx="0">
                  <c:v>Lactobacillales</c:v>
                </c:pt>
              </c:strCache>
            </c:strRef>
          </c:tx>
          <c:spPr>
            <a:solidFill>
              <a:schemeClr val="accent3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7:$K$107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35707306481381E-2</c:v>
                </c:pt>
                <c:pt idx="5">
                  <c:v>0</c:v>
                </c:pt>
                <c:pt idx="6">
                  <c:v>0</c:v>
                </c:pt>
                <c:pt idx="7">
                  <c:v>1.5684429282829499E-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8-97D7-40C8-B743-8BEFE0D4F8BA}"/>
            </c:ext>
          </c:extLst>
        </c:ser>
        <c:ser>
          <c:idx val="105"/>
          <c:order val="105"/>
          <c:tx>
            <c:strRef>
              <c:f>ordem_grafico!$A$108</c:f>
              <c:strCache>
                <c:ptCount val="1"/>
                <c:pt idx="0">
                  <c:v>Clostridiales</c:v>
                </c:pt>
              </c:strCache>
            </c:strRef>
          </c:tx>
          <c:spPr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8:$K$108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9.4509025611946001E-3</c:v>
                </c:pt>
                <c:pt idx="2">
                  <c:v>0</c:v>
                </c:pt>
                <c:pt idx="3">
                  <c:v>1.5061753188071099E-2</c:v>
                </c:pt>
                <c:pt idx="4">
                  <c:v>2.1713169037020998E-2</c:v>
                </c:pt>
                <c:pt idx="5">
                  <c:v>1.6791671331019799E-2</c:v>
                </c:pt>
                <c:pt idx="6">
                  <c:v>3.4484457362431602E-2</c:v>
                </c:pt>
                <c:pt idx="7">
                  <c:v>7.8422146414147392E-3</c:v>
                </c:pt>
                <c:pt idx="8">
                  <c:v>1.3459855979541E-2</c:v>
                </c:pt>
                <c:pt idx="9">
                  <c:v>1.69704374978787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9-97D7-40C8-B743-8BEFE0D4F8BA}"/>
            </c:ext>
          </c:extLst>
        </c:ser>
        <c:ser>
          <c:idx val="106"/>
          <c:order val="106"/>
          <c:tx>
            <c:strRef>
              <c:f>ordem_grafico!$A$109</c:f>
              <c:strCache>
                <c:ptCount val="1"/>
                <c:pt idx="0">
                  <c:v>Firmicutes_unclassified</c:v>
                </c:pt>
              </c:strCache>
            </c:strRef>
          </c:tx>
          <c:spPr>
            <a:solidFill>
              <a:schemeClr val="accent5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09:$K$10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.17732102421180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4.9263510517759497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A-97D7-40C8-B743-8BEFE0D4F8BA}"/>
            </c:ext>
          </c:extLst>
        </c:ser>
        <c:ser>
          <c:idx val="107"/>
          <c:order val="107"/>
          <c:tx>
            <c:strRef>
              <c:f>ordem_grafico!$A$110</c:f>
              <c:strCache>
                <c:ptCount val="1"/>
                <c:pt idx="0">
                  <c:v>Limnochordales</c:v>
                </c:pt>
              </c:strCache>
            </c:strRef>
          </c:tx>
          <c:spPr>
            <a:solidFill>
              <a:schemeClr val="accent6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0:$K$11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97054042071037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B-97D7-40C8-B743-8BEFE0D4F8BA}"/>
            </c:ext>
          </c:extLst>
        </c:ser>
        <c:ser>
          <c:idx val="108"/>
          <c:order val="108"/>
          <c:tx>
            <c:strRef>
              <c:f>ordem_grafico!$A$111</c:f>
              <c:strCache>
                <c:ptCount val="1"/>
                <c:pt idx="0">
                  <c:v>GAL15_o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1:$K$111</c:f>
              <c:numCache>
                <c:formatCode>General</c:formatCode>
                <c:ptCount val="10"/>
                <c:pt idx="0">
                  <c:v>1.248439450686640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C-97D7-40C8-B743-8BEFE0D4F8BA}"/>
            </c:ext>
          </c:extLst>
        </c:ser>
        <c:ser>
          <c:idx val="109"/>
          <c:order val="109"/>
          <c:tx>
            <c:strRef>
              <c:f>ordem_grafico!$A$112</c:f>
              <c:strCache>
                <c:ptCount val="1"/>
                <c:pt idx="0">
                  <c:v>AKAU4049_o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2:$K$112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D-97D7-40C8-B743-8BEFE0D4F8BA}"/>
            </c:ext>
          </c:extLst>
        </c:ser>
        <c:ser>
          <c:idx val="110"/>
          <c:order val="110"/>
          <c:tx>
            <c:strRef>
              <c:f>ordem_grafico!$A$113</c:f>
              <c:strCache>
                <c:ptCount val="1"/>
                <c:pt idx="0">
                  <c:v>BD2-11_terrestrial_group_o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3:$K$113</c:f>
              <c:numCache>
                <c:formatCode>General</c:formatCode>
                <c:ptCount val="10"/>
                <c:pt idx="0">
                  <c:v>5.1721062957017998E-2</c:v>
                </c:pt>
                <c:pt idx="1">
                  <c:v>6.6156317928362199E-2</c:v>
                </c:pt>
                <c:pt idx="2">
                  <c:v>0</c:v>
                </c:pt>
                <c:pt idx="3">
                  <c:v>3.0123506376142199E-2</c:v>
                </c:pt>
                <c:pt idx="4">
                  <c:v>0</c:v>
                </c:pt>
                <c:pt idx="5">
                  <c:v>2.2388895108026399E-2</c:v>
                </c:pt>
                <c:pt idx="6">
                  <c:v>0.226612148381694</c:v>
                </c:pt>
                <c:pt idx="7">
                  <c:v>0</c:v>
                </c:pt>
                <c:pt idx="8">
                  <c:v>6.7299279897705096E-3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E-97D7-40C8-B743-8BEFE0D4F8BA}"/>
            </c:ext>
          </c:extLst>
        </c:ser>
        <c:ser>
          <c:idx val="111"/>
          <c:order val="111"/>
          <c:tx>
            <c:strRef>
              <c:f>ordem_grafico!$A$114</c:f>
              <c:strCache>
                <c:ptCount val="1"/>
                <c:pt idx="0">
                  <c:v>Gemmatimonadale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4:$K$114</c:f>
              <c:numCache>
                <c:formatCode>General</c:formatCode>
                <c:ptCount val="10"/>
                <c:pt idx="0">
                  <c:v>1.970750847155341</c:v>
                </c:pt>
                <c:pt idx="1">
                  <c:v>0.60013231263585698</c:v>
                </c:pt>
                <c:pt idx="2">
                  <c:v>0.58134471346455296</c:v>
                </c:pt>
                <c:pt idx="3">
                  <c:v>0.587408374334773</c:v>
                </c:pt>
                <c:pt idx="4">
                  <c:v>0</c:v>
                </c:pt>
                <c:pt idx="5">
                  <c:v>0.86756968543602397</c:v>
                </c:pt>
                <c:pt idx="6">
                  <c:v>0.44829794571161102</c:v>
                </c:pt>
                <c:pt idx="7">
                  <c:v>1.1763321962122099E-2</c:v>
                </c:pt>
                <c:pt idx="8">
                  <c:v>0.86479574668551096</c:v>
                </c:pt>
                <c:pt idx="9">
                  <c:v>3.7334962495333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F-97D7-40C8-B743-8BEFE0D4F8BA}"/>
            </c:ext>
          </c:extLst>
        </c:ser>
        <c:ser>
          <c:idx val="112"/>
          <c:order val="112"/>
          <c:tx>
            <c:strRef>
              <c:f>ordem_grafico!$A$115</c:f>
              <c:strCache>
                <c:ptCount val="1"/>
                <c:pt idx="0">
                  <c:v>Gemmatimonadetes_unclassifie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5:$K$115</c:f>
              <c:numCache>
                <c:formatCode>General</c:formatCode>
                <c:ptCount val="10"/>
                <c:pt idx="0">
                  <c:v>1.6051364365971099E-2</c:v>
                </c:pt>
                <c:pt idx="1">
                  <c:v>0.20791985634628099</c:v>
                </c:pt>
                <c:pt idx="2">
                  <c:v>0</c:v>
                </c:pt>
                <c:pt idx="3">
                  <c:v>0.12551460990059199</c:v>
                </c:pt>
                <c:pt idx="4">
                  <c:v>0</c:v>
                </c:pt>
                <c:pt idx="5">
                  <c:v>0.190305608418225</c:v>
                </c:pt>
                <c:pt idx="6">
                  <c:v>0.30050741415833299</c:v>
                </c:pt>
                <c:pt idx="7">
                  <c:v>0</c:v>
                </c:pt>
                <c:pt idx="8">
                  <c:v>3.3649639948852499E-2</c:v>
                </c:pt>
                <c:pt idx="9">
                  <c:v>0.13576349998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0-97D7-40C8-B743-8BEFE0D4F8BA}"/>
            </c:ext>
          </c:extLst>
        </c:ser>
        <c:ser>
          <c:idx val="113"/>
          <c:order val="113"/>
          <c:tx>
            <c:strRef>
              <c:f>ordem_grafico!$A$116</c:f>
              <c:strCache>
                <c:ptCount val="1"/>
                <c:pt idx="0">
                  <c:v>Longimicrobiale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6:$K$116</c:f>
              <c:numCache>
                <c:formatCode>General</c:formatCode>
                <c:ptCount val="10"/>
                <c:pt idx="0">
                  <c:v>4.2803638309256299E-2</c:v>
                </c:pt>
                <c:pt idx="1">
                  <c:v>1.4034590303373971</c:v>
                </c:pt>
                <c:pt idx="2">
                  <c:v>0.15894443476746201</c:v>
                </c:pt>
                <c:pt idx="3">
                  <c:v>1.611607591123607</c:v>
                </c:pt>
                <c:pt idx="4">
                  <c:v>0</c:v>
                </c:pt>
                <c:pt idx="5">
                  <c:v>0.31344453151237001</c:v>
                </c:pt>
                <c:pt idx="6">
                  <c:v>0.25124390364057297</c:v>
                </c:pt>
                <c:pt idx="7">
                  <c:v>0</c:v>
                </c:pt>
                <c:pt idx="8">
                  <c:v>0.215357695672656</c:v>
                </c:pt>
                <c:pt idx="9">
                  <c:v>0.556630349930421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1-97D7-40C8-B743-8BEFE0D4F8BA}"/>
            </c:ext>
          </c:extLst>
        </c:ser>
        <c:ser>
          <c:idx val="114"/>
          <c:order val="114"/>
          <c:tx>
            <c:strRef>
              <c:f>ordem_grafico!$A$117</c:f>
              <c:strCache>
                <c:ptCount val="1"/>
                <c:pt idx="0">
                  <c:v>PAUC43f_marine_benthic_group_or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7:$K$117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5061753188071099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2-97D7-40C8-B743-8BEFE0D4F8BA}"/>
            </c:ext>
          </c:extLst>
        </c:ser>
        <c:ser>
          <c:idx val="115"/>
          <c:order val="115"/>
          <c:tx>
            <c:strRef>
              <c:f>ordem_grafico!$A$118</c:f>
              <c:strCache>
                <c:ptCount val="1"/>
                <c:pt idx="0">
                  <c:v>S0134_terrestrial_group_or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8:$K$118</c:f>
              <c:numCache>
                <c:formatCode>General</c:formatCode>
                <c:ptCount val="10"/>
                <c:pt idx="0">
                  <c:v>0.422685928303906</c:v>
                </c:pt>
                <c:pt idx="1">
                  <c:v>6.6156317928362199E-2</c:v>
                </c:pt>
                <c:pt idx="2">
                  <c:v>8.0560877895837005E-2</c:v>
                </c:pt>
                <c:pt idx="3">
                  <c:v>9.5391103524450196E-2</c:v>
                </c:pt>
                <c:pt idx="4">
                  <c:v>0</c:v>
                </c:pt>
                <c:pt idx="5">
                  <c:v>5.0375013993059402E-2</c:v>
                </c:pt>
                <c:pt idx="6">
                  <c:v>0.85718508300901497</c:v>
                </c:pt>
                <c:pt idx="7">
                  <c:v>0</c:v>
                </c:pt>
                <c:pt idx="8">
                  <c:v>2.3554747964196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3-97D7-40C8-B743-8BEFE0D4F8BA}"/>
            </c:ext>
          </c:extLst>
        </c:ser>
        <c:ser>
          <c:idx val="116"/>
          <c:order val="116"/>
          <c:tx>
            <c:strRef>
              <c:f>ordem_grafico!$A$119</c:f>
              <c:strCache>
                <c:ptCount val="1"/>
                <c:pt idx="0">
                  <c:v>Hydrogenedentiales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19:$K$11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6791671331019799E-2</c:v>
                </c:pt>
                <c:pt idx="6">
                  <c:v>4.9263510517759497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4-97D7-40C8-B743-8BEFE0D4F8BA}"/>
            </c:ext>
          </c:extLst>
        </c:ser>
        <c:ser>
          <c:idx val="117"/>
          <c:order val="117"/>
          <c:tx>
            <c:strRef>
              <c:f>ordem_grafico!$A$120</c:f>
              <c:strCache>
                <c:ptCount val="1"/>
                <c:pt idx="0">
                  <c:v>Latescibacterale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0:$K$120</c:f>
              <c:numCache>
                <c:formatCode>General</c:formatCode>
                <c:ptCount val="10"/>
                <c:pt idx="0">
                  <c:v>1.15391474942036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5-97D7-40C8-B743-8BEFE0D4F8BA}"/>
            </c:ext>
          </c:extLst>
        </c:ser>
        <c:ser>
          <c:idx val="118"/>
          <c:order val="118"/>
          <c:tx>
            <c:strRef>
              <c:f>ordem_grafico!$A$121</c:f>
              <c:strCache>
                <c:ptCount val="1"/>
                <c:pt idx="0">
                  <c:v>Latescibacteria_or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1:$K$121</c:f>
              <c:numCache>
                <c:formatCode>General</c:formatCode>
                <c:ptCount val="10"/>
                <c:pt idx="0">
                  <c:v>0.17121455323702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6-97D7-40C8-B743-8BEFE0D4F8BA}"/>
            </c:ext>
          </c:extLst>
        </c:ser>
        <c:ser>
          <c:idx val="119"/>
          <c:order val="119"/>
          <c:tx>
            <c:strRef>
              <c:f>ordem_grafico!$A$122</c:f>
              <c:strCache>
                <c:ptCount val="1"/>
                <c:pt idx="0">
                  <c:v>Nitrospirale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2:$K$122</c:f>
              <c:numCache>
                <c:formatCode>General</c:formatCode>
                <c:ptCount val="10"/>
                <c:pt idx="0">
                  <c:v>1.3429641519529161</c:v>
                </c:pt>
                <c:pt idx="1">
                  <c:v>3.3078158964181099E-2</c:v>
                </c:pt>
                <c:pt idx="2">
                  <c:v>0.137171224525344</c:v>
                </c:pt>
                <c:pt idx="3">
                  <c:v>1.00411687920474E-2</c:v>
                </c:pt>
                <c:pt idx="4">
                  <c:v>0</c:v>
                </c:pt>
                <c:pt idx="5">
                  <c:v>0.64368073435576001</c:v>
                </c:pt>
                <c:pt idx="6">
                  <c:v>0.162569584708606</c:v>
                </c:pt>
                <c:pt idx="7">
                  <c:v>0</c:v>
                </c:pt>
                <c:pt idx="8">
                  <c:v>3.0284675953967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7-97D7-40C8-B743-8BEFE0D4F8BA}"/>
            </c:ext>
          </c:extLst>
        </c:ser>
        <c:ser>
          <c:idx val="120"/>
          <c:order val="120"/>
          <c:tx>
            <c:strRef>
              <c:f>ordem_grafico!$A$123</c:f>
              <c:strCache>
                <c:ptCount val="1"/>
                <c:pt idx="0">
                  <c:v>Candidatus_Magasanikbacteria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3:$K$123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2388895108026399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8-97D7-40C8-B743-8BEFE0D4F8BA}"/>
            </c:ext>
          </c:extLst>
        </c:ser>
        <c:ser>
          <c:idx val="121"/>
          <c:order val="121"/>
          <c:tx>
            <c:strRef>
              <c:f>ordem_grafico!$A$124</c:f>
              <c:strCache>
                <c:ptCount val="1"/>
                <c:pt idx="0">
                  <c:v>Gracilibacteria_or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4:$K$124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9-97D7-40C8-B743-8BEFE0D4F8BA}"/>
            </c:ext>
          </c:extLst>
        </c:ser>
        <c:ser>
          <c:idx val="122"/>
          <c:order val="122"/>
          <c:tx>
            <c:strRef>
              <c:f>ordem_grafico!$A$125</c:f>
              <c:strCache>
                <c:ptCount val="1"/>
                <c:pt idx="0">
                  <c:v>Candidatus_Pacebacteri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5:$K$125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A-97D7-40C8-B743-8BEFE0D4F8BA}"/>
            </c:ext>
          </c:extLst>
        </c:ser>
        <c:ser>
          <c:idx val="123"/>
          <c:order val="123"/>
          <c:tx>
            <c:strRef>
              <c:f>ordem_grafico!$A$126</c:f>
              <c:strCache>
                <c:ptCount val="1"/>
                <c:pt idx="0">
                  <c:v>Candidatus_Campbellbacteri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6:$K$12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7.2763909101085905E-2</c:v>
                </c:pt>
                <c:pt idx="6">
                  <c:v>0</c:v>
                </c:pt>
                <c:pt idx="7">
                  <c:v>0</c:v>
                </c:pt>
                <c:pt idx="8">
                  <c:v>1.345985597954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B-97D7-40C8-B743-8BEFE0D4F8BA}"/>
            </c:ext>
          </c:extLst>
        </c:ser>
        <c:ser>
          <c:idx val="124"/>
          <c:order val="124"/>
          <c:tx>
            <c:strRef>
              <c:f>ordem_grafico!$A$127</c:f>
              <c:strCache>
                <c:ptCount val="1"/>
                <c:pt idx="0">
                  <c:v>Candidatus_Jorgensenbacteria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7:$K$127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C-97D7-40C8-B743-8BEFE0D4F8BA}"/>
            </c:ext>
          </c:extLst>
        </c:ser>
        <c:ser>
          <c:idx val="125"/>
          <c:order val="125"/>
          <c:tx>
            <c:strRef>
              <c:f>ordem_grafico!$A$128</c:f>
              <c:strCache>
                <c:ptCount val="1"/>
                <c:pt idx="0">
                  <c:v>Candidatus_Kaiserbacteria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8:$K$128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5.5972237770066102E-3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D-97D7-40C8-B743-8BEFE0D4F8BA}"/>
            </c:ext>
          </c:extLst>
        </c:ser>
        <c:ser>
          <c:idx val="126"/>
          <c:order val="126"/>
          <c:tx>
            <c:strRef>
              <c:f>ordem_grafico!$A$129</c:f>
              <c:strCache>
                <c:ptCount val="1"/>
                <c:pt idx="0">
                  <c:v>Candidatus_Liptonbacteria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29:$K$129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E-97D7-40C8-B743-8BEFE0D4F8BA}"/>
            </c:ext>
          </c:extLst>
        </c:ser>
        <c:ser>
          <c:idx val="127"/>
          <c:order val="127"/>
          <c:tx>
            <c:strRef>
              <c:f>ordem_grafico!$A$130</c:f>
              <c:strCache>
                <c:ptCount val="1"/>
                <c:pt idx="0">
                  <c:v>Candidatus_Nomurabacteria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0:$K$130</c:f>
              <c:numCache>
                <c:formatCode>General</c:formatCode>
                <c:ptCount val="10"/>
                <c:pt idx="0">
                  <c:v>1.7834849295523501E-2</c:v>
                </c:pt>
                <c:pt idx="1">
                  <c:v>0</c:v>
                </c:pt>
                <c:pt idx="2">
                  <c:v>2.17732102421180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F-97D7-40C8-B743-8BEFE0D4F8BA}"/>
            </c:ext>
          </c:extLst>
        </c:ser>
        <c:ser>
          <c:idx val="128"/>
          <c:order val="128"/>
          <c:tx>
            <c:strRef>
              <c:f>ordem_grafico!$A$131</c:f>
              <c:strCache>
                <c:ptCount val="1"/>
                <c:pt idx="0">
                  <c:v>Candidatus_Yanofskybacteria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1:$K$13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0-97D7-40C8-B743-8BEFE0D4F8BA}"/>
            </c:ext>
          </c:extLst>
        </c:ser>
        <c:ser>
          <c:idx val="129"/>
          <c:order val="129"/>
          <c:tx>
            <c:strRef>
              <c:f>ordem_grafico!$A$132</c:f>
              <c:strCache>
                <c:ptCount val="1"/>
                <c:pt idx="0">
                  <c:v>Candidatus_Zambryskibacteria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2:$K$132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1-97D7-40C8-B743-8BEFE0D4F8BA}"/>
            </c:ext>
          </c:extLst>
        </c:ser>
        <c:ser>
          <c:idx val="130"/>
          <c:order val="130"/>
          <c:tx>
            <c:strRef>
              <c:f>ordem_grafico!$A$133</c:f>
              <c:strCache>
                <c:ptCount val="1"/>
                <c:pt idx="0">
                  <c:v>GWA2-38-13b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3:$K$133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2-97D7-40C8-B743-8BEFE0D4F8BA}"/>
            </c:ext>
          </c:extLst>
        </c:ser>
        <c:ser>
          <c:idx val="131"/>
          <c:order val="131"/>
          <c:tx>
            <c:strRef>
              <c:f>ordem_grafico!$A$134</c:f>
              <c:strCache>
                <c:ptCount val="1"/>
                <c:pt idx="0">
                  <c:v>Parcubacteria_or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4:$K$134</c:f>
              <c:numCache>
                <c:formatCode>General</c:formatCode>
                <c:ptCount val="10"/>
                <c:pt idx="0">
                  <c:v>1.070090957731410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3-97D7-40C8-B743-8BEFE0D4F8BA}"/>
            </c:ext>
          </c:extLst>
        </c:ser>
        <c:ser>
          <c:idx val="132"/>
          <c:order val="132"/>
          <c:tx>
            <c:strRef>
              <c:f>ordem_grafico!$A$135</c:f>
              <c:strCache>
                <c:ptCount val="1"/>
                <c:pt idx="0">
                  <c:v>Parcubacteria_unclassified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5:$K$135</c:f>
              <c:numCache>
                <c:formatCode>General</c:formatCode>
                <c:ptCount val="10"/>
                <c:pt idx="0">
                  <c:v>3.9236668450151599E-2</c:v>
                </c:pt>
                <c:pt idx="1">
                  <c:v>0</c:v>
                </c:pt>
                <c:pt idx="2">
                  <c:v>4.35464204842361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3459855979541E-2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4-97D7-40C8-B743-8BEFE0D4F8BA}"/>
            </c:ext>
          </c:extLst>
        </c:ser>
        <c:ser>
          <c:idx val="133"/>
          <c:order val="133"/>
          <c:tx>
            <c:strRef>
              <c:f>ordem_grafico!$A$136</c:f>
              <c:strCache>
                <c:ptCount val="1"/>
                <c:pt idx="0">
                  <c:v>Saccharimonadal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6:$K$136</c:f>
              <c:numCache>
                <c:formatCode>General</c:formatCode>
                <c:ptCount val="10"/>
                <c:pt idx="0">
                  <c:v>0.28714107365792801</c:v>
                </c:pt>
                <c:pt idx="1">
                  <c:v>0.283527076835838</c:v>
                </c:pt>
                <c:pt idx="2">
                  <c:v>0.363612611043372</c:v>
                </c:pt>
                <c:pt idx="3">
                  <c:v>0.25604980419720902</c:v>
                </c:pt>
                <c:pt idx="4">
                  <c:v>0</c:v>
                </c:pt>
                <c:pt idx="5">
                  <c:v>1.6008060002238891</c:v>
                </c:pt>
                <c:pt idx="6">
                  <c:v>9.8527021035518993E-3</c:v>
                </c:pt>
                <c:pt idx="7">
                  <c:v>5.8816609810610501E-2</c:v>
                </c:pt>
                <c:pt idx="8">
                  <c:v>0.29611683154990198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5-97D7-40C8-B743-8BEFE0D4F8BA}"/>
            </c:ext>
          </c:extLst>
        </c:ser>
        <c:ser>
          <c:idx val="134"/>
          <c:order val="134"/>
          <c:tx>
            <c:strRef>
              <c:f>ordem_grafico!$A$137</c:f>
              <c:strCache>
                <c:ptCount val="1"/>
                <c:pt idx="0">
                  <c:v>BD7-11_or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7:$K$137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6-97D7-40C8-B743-8BEFE0D4F8BA}"/>
            </c:ext>
          </c:extLst>
        </c:ser>
        <c:ser>
          <c:idx val="135"/>
          <c:order val="135"/>
          <c:tx>
            <c:strRef>
              <c:f>ordem_grafico!$A$138</c:f>
              <c:strCache>
                <c:ptCount val="1"/>
                <c:pt idx="0">
                  <c:v>OM190_or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8:$K$138</c:f>
              <c:numCache>
                <c:formatCode>General</c:formatCode>
                <c:ptCount val="10"/>
                <c:pt idx="0">
                  <c:v>0.224719101123596</c:v>
                </c:pt>
                <c:pt idx="1">
                  <c:v>4.7254512805973E-3</c:v>
                </c:pt>
                <c:pt idx="2">
                  <c:v>8.7092840968472397E-3</c:v>
                </c:pt>
                <c:pt idx="3">
                  <c:v>0</c:v>
                </c:pt>
                <c:pt idx="4">
                  <c:v>0</c:v>
                </c:pt>
                <c:pt idx="5">
                  <c:v>0.184708384641218</c:v>
                </c:pt>
                <c:pt idx="6">
                  <c:v>7.38952657766391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7-97D7-40C8-B743-8BEFE0D4F8BA}"/>
            </c:ext>
          </c:extLst>
        </c:ser>
        <c:ser>
          <c:idx val="136"/>
          <c:order val="136"/>
          <c:tx>
            <c:strRef>
              <c:f>ordem_grafico!$A$139</c:f>
              <c:strCache>
                <c:ptCount val="1"/>
                <c:pt idx="0">
                  <c:v>C86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39:$K$13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583342662039599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8-97D7-40C8-B743-8BEFE0D4F8BA}"/>
            </c:ext>
          </c:extLst>
        </c:ser>
        <c:ser>
          <c:idx val="137"/>
          <c:order val="137"/>
          <c:tx>
            <c:strRef>
              <c:f>ordem_grafico!$A$140</c:f>
              <c:strCache>
                <c:ptCount val="1"/>
                <c:pt idx="0">
                  <c:v>CCM11a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0:$K$140</c:f>
              <c:numCache>
                <c:formatCode>General</c:formatCode>
                <c:ptCount val="10"/>
                <c:pt idx="0">
                  <c:v>0.6420545746388439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9-97D7-40C8-B743-8BEFE0D4F8BA}"/>
            </c:ext>
          </c:extLst>
        </c:ser>
        <c:ser>
          <c:idx val="138"/>
          <c:order val="138"/>
          <c:tx>
            <c:strRef>
              <c:f>ordem_grafico!$A$141</c:f>
              <c:strCache>
                <c:ptCount val="1"/>
                <c:pt idx="0">
                  <c:v>Phycisphaerae_unclassified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1:$K$141</c:f>
              <c:numCache>
                <c:formatCode>General</c:formatCode>
                <c:ptCount val="10"/>
                <c:pt idx="0">
                  <c:v>0</c:v>
                </c:pt>
                <c:pt idx="1">
                  <c:v>0.13231263585672401</c:v>
                </c:pt>
                <c:pt idx="2">
                  <c:v>0</c:v>
                </c:pt>
                <c:pt idx="3">
                  <c:v>0.12551460990059199</c:v>
                </c:pt>
                <c:pt idx="4">
                  <c:v>0</c:v>
                </c:pt>
                <c:pt idx="5">
                  <c:v>5.5972237770066102E-3</c:v>
                </c:pt>
                <c:pt idx="6">
                  <c:v>9.8527021035518993E-3</c:v>
                </c:pt>
                <c:pt idx="7">
                  <c:v>0</c:v>
                </c:pt>
                <c:pt idx="8">
                  <c:v>3.7014603943737803E-2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A-97D7-40C8-B743-8BEFE0D4F8BA}"/>
            </c:ext>
          </c:extLst>
        </c:ser>
        <c:ser>
          <c:idx val="139"/>
          <c:order val="139"/>
          <c:tx>
            <c:strRef>
              <c:f>ordem_grafico!$A$142</c:f>
              <c:strCache>
                <c:ptCount val="1"/>
                <c:pt idx="0">
                  <c:v>Phycisphaerale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2:$K$142</c:f>
              <c:numCache>
                <c:formatCode>General</c:formatCode>
                <c:ptCount val="10"/>
                <c:pt idx="0">
                  <c:v>0.32459425717852702</c:v>
                </c:pt>
                <c:pt idx="1">
                  <c:v>0.15121444097911399</c:v>
                </c:pt>
                <c:pt idx="2">
                  <c:v>4.13690994600244E-2</c:v>
                </c:pt>
                <c:pt idx="3">
                  <c:v>0.25604980419720902</c:v>
                </c:pt>
                <c:pt idx="4">
                  <c:v>0</c:v>
                </c:pt>
                <c:pt idx="5">
                  <c:v>0.48136124482256798</c:v>
                </c:pt>
                <c:pt idx="6">
                  <c:v>3.9410808414207597E-2</c:v>
                </c:pt>
                <c:pt idx="7">
                  <c:v>0</c:v>
                </c:pt>
                <c:pt idx="8">
                  <c:v>1.6824819974426301E-2</c:v>
                </c:pt>
                <c:pt idx="9">
                  <c:v>9.1640362488544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B-97D7-40C8-B743-8BEFE0D4F8BA}"/>
            </c:ext>
          </c:extLst>
        </c:ser>
        <c:ser>
          <c:idx val="140"/>
          <c:order val="140"/>
          <c:tx>
            <c:strRef>
              <c:f>ordem_grafico!$A$143</c:f>
              <c:strCache>
                <c:ptCount val="1"/>
                <c:pt idx="0">
                  <c:v>Tepidisphaerales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3:$K$143</c:f>
              <c:numCache>
                <c:formatCode>General</c:formatCode>
                <c:ptCount val="10"/>
                <c:pt idx="0">
                  <c:v>0.31567683253076501</c:v>
                </c:pt>
                <c:pt idx="1">
                  <c:v>0.141763538417919</c:v>
                </c:pt>
                <c:pt idx="2">
                  <c:v>0.48771990942344501</c:v>
                </c:pt>
                <c:pt idx="3">
                  <c:v>0.13555577869263999</c:v>
                </c:pt>
                <c:pt idx="4">
                  <c:v>0</c:v>
                </c:pt>
                <c:pt idx="5">
                  <c:v>0.80040300011194399</c:v>
                </c:pt>
                <c:pt idx="6">
                  <c:v>4.4337159465983503E-2</c:v>
                </c:pt>
                <c:pt idx="7">
                  <c:v>2.3526643924244198E-2</c:v>
                </c:pt>
                <c:pt idx="8">
                  <c:v>1.241671714112659</c:v>
                </c:pt>
                <c:pt idx="9">
                  <c:v>0.20025116247496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C-97D7-40C8-B743-8BEFE0D4F8BA}"/>
            </c:ext>
          </c:extLst>
        </c:ser>
        <c:ser>
          <c:idx val="141"/>
          <c:order val="141"/>
          <c:tx>
            <c:strRef>
              <c:f>ordem_grafico!$A$144</c:f>
              <c:strCache>
                <c:ptCount val="1"/>
                <c:pt idx="0">
                  <c:v>Pla3_lineage_or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4:$K$144</c:f>
              <c:numCache>
                <c:formatCode>General</c:formatCode>
                <c:ptCount val="10"/>
                <c:pt idx="0">
                  <c:v>2.67522739432852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D-97D7-40C8-B743-8BEFE0D4F8BA}"/>
            </c:ext>
          </c:extLst>
        </c:ser>
        <c:ser>
          <c:idx val="142"/>
          <c:order val="142"/>
          <c:tx>
            <c:strRef>
              <c:f>ordem_grafico!$A$145</c:f>
              <c:strCache>
                <c:ptCount val="1"/>
                <c:pt idx="0">
                  <c:v>Pla4_lineage_or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5:$K$145</c:f>
              <c:numCache>
                <c:formatCode>General</c:formatCode>
                <c:ptCount val="10"/>
                <c:pt idx="0">
                  <c:v>3.031924380238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E-97D7-40C8-B743-8BEFE0D4F8BA}"/>
            </c:ext>
          </c:extLst>
        </c:ser>
        <c:ser>
          <c:idx val="143"/>
          <c:order val="143"/>
          <c:tx>
            <c:strRef>
              <c:f>ordem_grafico!$A$146</c:f>
              <c:strCache>
                <c:ptCount val="1"/>
                <c:pt idx="0">
                  <c:v>Gemmatales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6:$K$146</c:f>
              <c:numCache>
                <c:formatCode>General</c:formatCode>
                <c:ptCount val="10"/>
                <c:pt idx="0">
                  <c:v>0.50115926520420895</c:v>
                </c:pt>
                <c:pt idx="1">
                  <c:v>0.50089783574331403</c:v>
                </c:pt>
                <c:pt idx="2">
                  <c:v>0.618359170876154</c:v>
                </c:pt>
                <c:pt idx="3">
                  <c:v>0.59242895873079604</c:v>
                </c:pt>
                <c:pt idx="4">
                  <c:v>0</c:v>
                </c:pt>
                <c:pt idx="5">
                  <c:v>1.0522780700772421</c:v>
                </c:pt>
                <c:pt idx="6">
                  <c:v>1.9705404207103799E-2</c:v>
                </c:pt>
                <c:pt idx="7">
                  <c:v>0</c:v>
                </c:pt>
                <c:pt idx="8">
                  <c:v>0.52493438320209995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F-97D7-40C8-B743-8BEFE0D4F8BA}"/>
            </c:ext>
          </c:extLst>
        </c:ser>
        <c:ser>
          <c:idx val="144"/>
          <c:order val="144"/>
          <c:tx>
            <c:strRef>
              <c:f>ordem_grafico!$A$147</c:f>
              <c:strCache>
                <c:ptCount val="1"/>
                <c:pt idx="0">
                  <c:v>Isosphaerales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7:$K$147</c:f>
              <c:numCache>
                <c:formatCode>General</c:formatCode>
                <c:ptCount val="10"/>
                <c:pt idx="0">
                  <c:v>6.0638487604779703E-2</c:v>
                </c:pt>
                <c:pt idx="1">
                  <c:v>5.1979964086570303E-2</c:v>
                </c:pt>
                <c:pt idx="2">
                  <c:v>4.3546420484236202E-2</c:v>
                </c:pt>
                <c:pt idx="3">
                  <c:v>4.0164675168189598E-2</c:v>
                </c:pt>
                <c:pt idx="4">
                  <c:v>0</c:v>
                </c:pt>
                <c:pt idx="5">
                  <c:v>3.9180566439046202E-2</c:v>
                </c:pt>
                <c:pt idx="6">
                  <c:v>9.3600669983743001E-2</c:v>
                </c:pt>
                <c:pt idx="7">
                  <c:v>0</c:v>
                </c:pt>
                <c:pt idx="8">
                  <c:v>7.0664243892590406E-2</c:v>
                </c:pt>
                <c:pt idx="9">
                  <c:v>7.8064012490242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0-97D7-40C8-B743-8BEFE0D4F8BA}"/>
            </c:ext>
          </c:extLst>
        </c:ser>
        <c:ser>
          <c:idx val="145"/>
          <c:order val="145"/>
          <c:tx>
            <c:strRef>
              <c:f>ordem_grafico!$A$148</c:f>
              <c:strCache>
                <c:ptCount val="1"/>
                <c:pt idx="0">
                  <c:v>Pirellulales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8:$K$148</c:f>
              <c:numCache>
                <c:formatCode>General</c:formatCode>
                <c:ptCount val="10"/>
                <c:pt idx="0">
                  <c:v>0.75619761013019504</c:v>
                </c:pt>
                <c:pt idx="1">
                  <c:v>5.1979964086570303E-2</c:v>
                </c:pt>
                <c:pt idx="2">
                  <c:v>0.10015676711374299</c:v>
                </c:pt>
                <c:pt idx="3">
                  <c:v>9.5391103524450196E-2</c:v>
                </c:pt>
                <c:pt idx="4">
                  <c:v>0</c:v>
                </c:pt>
                <c:pt idx="5">
                  <c:v>0.363819545505429</c:v>
                </c:pt>
                <c:pt idx="6">
                  <c:v>0.30543376521010901</c:v>
                </c:pt>
                <c:pt idx="7">
                  <c:v>0</c:v>
                </c:pt>
                <c:pt idx="8">
                  <c:v>0.16488323574937799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1-97D7-40C8-B743-8BEFE0D4F8BA}"/>
            </c:ext>
          </c:extLst>
        </c:ser>
        <c:ser>
          <c:idx val="146"/>
          <c:order val="146"/>
          <c:tx>
            <c:strRef>
              <c:f>ordem_grafico!$A$149</c:f>
              <c:strCache>
                <c:ptCount val="1"/>
                <c:pt idx="0">
                  <c:v>Planctomycetales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49:$K$149</c:f>
              <c:numCache>
                <c:formatCode>General</c:formatCode>
                <c:ptCount val="10"/>
                <c:pt idx="0">
                  <c:v>0.44765471731763901</c:v>
                </c:pt>
                <c:pt idx="1">
                  <c:v>0.240998015310462</c:v>
                </c:pt>
                <c:pt idx="2">
                  <c:v>0.23297334959066399</c:v>
                </c:pt>
                <c:pt idx="3">
                  <c:v>0.210864544632995</c:v>
                </c:pt>
                <c:pt idx="4">
                  <c:v>0</c:v>
                </c:pt>
                <c:pt idx="5">
                  <c:v>6.1569461547072699E-2</c:v>
                </c:pt>
                <c:pt idx="6">
                  <c:v>0.49263510517759501</c:v>
                </c:pt>
                <c:pt idx="7">
                  <c:v>0</c:v>
                </c:pt>
                <c:pt idx="8">
                  <c:v>3.0284675953967301E-2</c:v>
                </c:pt>
                <c:pt idx="9">
                  <c:v>0.19006889997624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2-97D7-40C8-B743-8BEFE0D4F8BA}"/>
            </c:ext>
          </c:extLst>
        </c:ser>
        <c:ser>
          <c:idx val="147"/>
          <c:order val="147"/>
          <c:tx>
            <c:strRef>
              <c:f>ordem_grafico!$A$150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0:$K$150</c:f>
              <c:numCache>
                <c:formatCode>General</c:formatCode>
                <c:ptCount val="10"/>
                <c:pt idx="0">
                  <c:v>4.6370608168360999E-2</c:v>
                </c:pt>
                <c:pt idx="1">
                  <c:v>0</c:v>
                </c:pt>
                <c:pt idx="2">
                  <c:v>4.3546420484236199E-3</c:v>
                </c:pt>
                <c:pt idx="3">
                  <c:v>0</c:v>
                </c:pt>
                <c:pt idx="4">
                  <c:v>0</c:v>
                </c:pt>
                <c:pt idx="5">
                  <c:v>1.6791671331019799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3-97D7-40C8-B743-8BEFE0D4F8BA}"/>
            </c:ext>
          </c:extLst>
        </c:ser>
        <c:ser>
          <c:idx val="148"/>
          <c:order val="148"/>
          <c:tx>
            <c:strRef>
              <c:f>ordem_grafico!$A$151</c:f>
              <c:strCache>
                <c:ptCount val="1"/>
                <c:pt idx="0">
                  <c:v>Planctomycetes_unclassified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1:$K$151</c:f>
              <c:numCache>
                <c:formatCode>General</c:formatCode>
                <c:ptCount val="10"/>
                <c:pt idx="0">
                  <c:v>5.7071517745675003E-2</c:v>
                </c:pt>
                <c:pt idx="1">
                  <c:v>4.7254512805973E-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5.5972237770066102E-3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4-97D7-40C8-B743-8BEFE0D4F8BA}"/>
            </c:ext>
          </c:extLst>
        </c:ser>
        <c:ser>
          <c:idx val="149"/>
          <c:order val="149"/>
          <c:tx>
            <c:strRef>
              <c:f>ordem_grafico!$A$152</c:f>
              <c:strCache>
                <c:ptCount val="1"/>
                <c:pt idx="0">
                  <c:v>vadinHA49_or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2:$K$152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2294861748572709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5-97D7-40C8-B743-8BEFE0D4F8BA}"/>
            </c:ext>
          </c:extLst>
        </c:ser>
        <c:ser>
          <c:idx val="150"/>
          <c:order val="150"/>
          <c:tx>
            <c:strRef>
              <c:f>ordem_grafico!$A$153</c:f>
              <c:strCache>
                <c:ptCount val="1"/>
                <c:pt idx="0">
                  <c:v>Acetobacterales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3:$K$153</c:f>
              <c:numCache>
                <c:formatCode>General</c:formatCode>
                <c:ptCount val="10"/>
                <c:pt idx="0">
                  <c:v>0.20153379703941501</c:v>
                </c:pt>
                <c:pt idx="1">
                  <c:v>3.3078158964181099E-2</c:v>
                </c:pt>
                <c:pt idx="2">
                  <c:v>0.17854032398536801</c:v>
                </c:pt>
                <c:pt idx="3">
                  <c:v>2.0082337584094799E-2</c:v>
                </c:pt>
                <c:pt idx="4">
                  <c:v>0</c:v>
                </c:pt>
                <c:pt idx="5">
                  <c:v>1.998208888391358</c:v>
                </c:pt>
                <c:pt idx="6">
                  <c:v>1.9705404207103799E-2</c:v>
                </c:pt>
                <c:pt idx="7">
                  <c:v>0</c:v>
                </c:pt>
                <c:pt idx="8">
                  <c:v>1.0094891984655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6-97D7-40C8-B743-8BEFE0D4F8BA}"/>
            </c:ext>
          </c:extLst>
        </c:ser>
        <c:ser>
          <c:idx val="151"/>
          <c:order val="151"/>
          <c:tx>
            <c:strRef>
              <c:f>ordem_grafico!$A$154</c:f>
              <c:strCache>
                <c:ptCount val="1"/>
                <c:pt idx="0">
                  <c:v>Alphaproteobacteria_Incertae_Sedis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4:$K$154</c:f>
              <c:numCache>
                <c:formatCode>General</c:formatCode>
                <c:ptCount val="10"/>
                <c:pt idx="0">
                  <c:v>0</c:v>
                </c:pt>
                <c:pt idx="1">
                  <c:v>3.78036102447784E-2</c:v>
                </c:pt>
                <c:pt idx="2">
                  <c:v>0</c:v>
                </c:pt>
                <c:pt idx="3">
                  <c:v>4.51852595642133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7-97D7-40C8-B743-8BEFE0D4F8BA}"/>
            </c:ext>
          </c:extLst>
        </c:ser>
        <c:ser>
          <c:idx val="152"/>
          <c:order val="152"/>
          <c:tx>
            <c:strRef>
              <c:f>ordem_grafico!$A$155</c:f>
              <c:strCache>
                <c:ptCount val="1"/>
                <c:pt idx="0">
                  <c:v>Alphaproteobacteria_unclassified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5:$K$155</c:f>
              <c:numCache>
                <c:formatCode>General</c:formatCode>
                <c:ptCount val="10"/>
                <c:pt idx="0">
                  <c:v>0.99875156054931302</c:v>
                </c:pt>
                <c:pt idx="1">
                  <c:v>0.18901805122389201</c:v>
                </c:pt>
                <c:pt idx="2">
                  <c:v>0.69674272774777901</c:v>
                </c:pt>
                <c:pt idx="3">
                  <c:v>0.130535194296616</c:v>
                </c:pt>
                <c:pt idx="4">
                  <c:v>5.42829225925524E-3</c:v>
                </c:pt>
                <c:pt idx="5">
                  <c:v>1.113847531624315</c:v>
                </c:pt>
                <c:pt idx="6">
                  <c:v>0.408887137297404</c:v>
                </c:pt>
                <c:pt idx="7">
                  <c:v>8.6264361055562094E-2</c:v>
                </c:pt>
                <c:pt idx="8">
                  <c:v>0.37351100343226301</c:v>
                </c:pt>
                <c:pt idx="9">
                  <c:v>4.7517224994060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8-97D7-40C8-B743-8BEFE0D4F8BA}"/>
            </c:ext>
          </c:extLst>
        </c:ser>
        <c:ser>
          <c:idx val="153"/>
          <c:order val="153"/>
          <c:tx>
            <c:strRef>
              <c:f>ordem_grafico!$A$156</c:f>
              <c:strCache>
                <c:ptCount val="1"/>
                <c:pt idx="0">
                  <c:v>Azospirillales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6:$K$156</c:f>
              <c:numCache>
                <c:formatCode>General</c:formatCode>
                <c:ptCount val="10"/>
                <c:pt idx="0">
                  <c:v>2.31853040841805E-2</c:v>
                </c:pt>
                <c:pt idx="1">
                  <c:v>0.127587184576127</c:v>
                </c:pt>
                <c:pt idx="2">
                  <c:v>6.53196307263543E-2</c:v>
                </c:pt>
                <c:pt idx="3">
                  <c:v>0.1455969474846869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9-97D7-40C8-B743-8BEFE0D4F8BA}"/>
            </c:ext>
          </c:extLst>
        </c:ser>
        <c:ser>
          <c:idx val="154"/>
          <c:order val="154"/>
          <c:tx>
            <c:strRef>
              <c:f>ordem_grafico!$A$157</c:f>
              <c:strCache>
                <c:ptCount val="1"/>
                <c:pt idx="0">
                  <c:v>Caedibacterales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7:$K$157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.17732102421180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A-97D7-40C8-B743-8BEFE0D4F8BA}"/>
            </c:ext>
          </c:extLst>
        </c:ser>
        <c:ser>
          <c:idx val="155"/>
          <c:order val="155"/>
          <c:tx>
            <c:strRef>
              <c:f>ordem_grafico!$A$158</c:f>
              <c:strCache>
                <c:ptCount val="1"/>
                <c:pt idx="0">
                  <c:v>Caulobacterales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8:$K$158</c:f>
              <c:numCache>
                <c:formatCode>General</c:formatCode>
                <c:ptCount val="10"/>
                <c:pt idx="0">
                  <c:v>0.66702336365257697</c:v>
                </c:pt>
                <c:pt idx="1">
                  <c:v>0.54342689726868898</c:v>
                </c:pt>
                <c:pt idx="2">
                  <c:v>0.33966207977704199</c:v>
                </c:pt>
                <c:pt idx="3">
                  <c:v>0.47695551762225102</c:v>
                </c:pt>
                <c:pt idx="4">
                  <c:v>0</c:v>
                </c:pt>
                <c:pt idx="5">
                  <c:v>1.8358893988581659</c:v>
                </c:pt>
                <c:pt idx="6">
                  <c:v>0.18227498891571001</c:v>
                </c:pt>
                <c:pt idx="7">
                  <c:v>0</c:v>
                </c:pt>
                <c:pt idx="8">
                  <c:v>0.72010229490544397</c:v>
                </c:pt>
                <c:pt idx="9">
                  <c:v>0.70257611241217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B-97D7-40C8-B743-8BEFE0D4F8BA}"/>
            </c:ext>
          </c:extLst>
        </c:ser>
        <c:ser>
          <c:idx val="156"/>
          <c:order val="156"/>
          <c:tx>
            <c:strRef>
              <c:f>ordem_grafico!$A$159</c:f>
              <c:strCache>
                <c:ptCount val="1"/>
                <c:pt idx="0">
                  <c:v>Dongiales</c:v>
                </c:pt>
              </c:strCache>
            </c:strRef>
          </c:tx>
          <c:spPr>
            <a:solidFill>
              <a:schemeClr val="accent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59:$K$159</c:f>
              <c:numCache>
                <c:formatCode>General</c:formatCode>
                <c:ptCount val="10"/>
                <c:pt idx="0">
                  <c:v>3.468878187979310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C-97D7-40C8-B743-8BEFE0D4F8BA}"/>
            </c:ext>
          </c:extLst>
        </c:ser>
        <c:ser>
          <c:idx val="157"/>
          <c:order val="157"/>
          <c:tx>
            <c:strRef>
              <c:f>ordem_grafico!$A$160</c:f>
              <c:strCache>
                <c:ptCount val="1"/>
                <c:pt idx="0">
                  <c:v>Elsterales</c:v>
                </c:pt>
              </c:strCache>
            </c:strRef>
          </c:tx>
          <c:spPr>
            <a:solidFill>
              <a:schemeClr val="accent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0:$K$160</c:f>
              <c:numCache>
                <c:formatCode>General</c:formatCode>
                <c:ptCount val="10"/>
                <c:pt idx="0">
                  <c:v>4.4587123238808597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7986118885032999E-2</c:v>
                </c:pt>
                <c:pt idx="6">
                  <c:v>3.9410808414207597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D-97D7-40C8-B743-8BEFE0D4F8BA}"/>
            </c:ext>
          </c:extLst>
        </c:ser>
        <c:ser>
          <c:idx val="158"/>
          <c:order val="158"/>
          <c:tx>
            <c:strRef>
              <c:f>ordem_grafico!$A$161</c:f>
              <c:strCache>
                <c:ptCount val="1"/>
                <c:pt idx="0">
                  <c:v>Holosporales</c:v>
                </c:pt>
              </c:strCache>
            </c:strRef>
          </c:tx>
          <c:spPr>
            <a:solidFill>
              <a:schemeClr val="accent3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1:$K$16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10075002798611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E-97D7-40C8-B743-8BEFE0D4F8BA}"/>
            </c:ext>
          </c:extLst>
        </c:ser>
        <c:ser>
          <c:idx val="159"/>
          <c:order val="159"/>
          <c:tx>
            <c:strRef>
              <c:f>ordem_grafico!$A$162</c:f>
              <c:strCache>
                <c:ptCount val="1"/>
                <c:pt idx="0">
                  <c:v>Micavibrionales</c:v>
                </c:pt>
              </c:strCache>
            </c:strRef>
          </c:tx>
          <c:spPr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2:$K$162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F-97D7-40C8-B743-8BEFE0D4F8BA}"/>
            </c:ext>
          </c:extLst>
        </c:ser>
        <c:ser>
          <c:idx val="160"/>
          <c:order val="160"/>
          <c:tx>
            <c:strRef>
              <c:f>ordem_grafico!$A$163</c:f>
              <c:strCache>
                <c:ptCount val="1"/>
                <c:pt idx="0">
                  <c:v>Paracaedibacterales</c:v>
                </c:pt>
              </c:strCache>
            </c:strRef>
          </c:tx>
          <c:spPr>
            <a:solidFill>
              <a:schemeClr val="accent5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3:$K$16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00411687920474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824819974426301E-2</c:v>
                </c:pt>
                <c:pt idx="9">
                  <c:v>2.375861249703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0-97D7-40C8-B743-8BEFE0D4F8BA}"/>
            </c:ext>
          </c:extLst>
        </c:ser>
        <c:ser>
          <c:idx val="161"/>
          <c:order val="161"/>
          <c:tx>
            <c:strRef>
              <c:f>ordem_grafico!$A$164</c:f>
              <c:strCache>
                <c:ptCount val="1"/>
                <c:pt idx="0">
                  <c:v>Parvibaculales</c:v>
                </c:pt>
              </c:strCache>
            </c:strRef>
          </c:tx>
          <c:spPr>
            <a:solidFill>
              <a:schemeClr val="accent6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4:$K$164</c:f>
              <c:numCache>
                <c:formatCode>General</c:formatCode>
                <c:ptCount val="10"/>
                <c:pt idx="0">
                  <c:v>2.67522739432852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5.0375013993059402E-2</c:v>
                </c:pt>
                <c:pt idx="6">
                  <c:v>0</c:v>
                </c:pt>
                <c:pt idx="7">
                  <c:v>3.5289965886366299E-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1-97D7-40C8-B743-8BEFE0D4F8BA}"/>
            </c:ext>
          </c:extLst>
        </c:ser>
        <c:ser>
          <c:idx val="162"/>
          <c:order val="162"/>
          <c:tx>
            <c:strRef>
              <c:f>ordem_grafico!$A$165</c:f>
              <c:strCache>
                <c:ptCount val="1"/>
                <c:pt idx="0">
                  <c:v>Puniceispirillal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5:$K$165</c:f>
              <c:numCache>
                <c:formatCode>General</c:formatCode>
                <c:ptCount val="10"/>
                <c:pt idx="0">
                  <c:v>0.13376136971642599</c:v>
                </c:pt>
                <c:pt idx="1">
                  <c:v>1.039599281731405</c:v>
                </c:pt>
                <c:pt idx="2">
                  <c:v>0.139348545549556</c:v>
                </c:pt>
                <c:pt idx="3">
                  <c:v>1.0241992167888341</c:v>
                </c:pt>
                <c:pt idx="4">
                  <c:v>0</c:v>
                </c:pt>
                <c:pt idx="5">
                  <c:v>0.167916713310198</c:v>
                </c:pt>
                <c:pt idx="6">
                  <c:v>0.280802009951229</c:v>
                </c:pt>
                <c:pt idx="7">
                  <c:v>0.10194879033839201</c:v>
                </c:pt>
                <c:pt idx="8">
                  <c:v>0.18843798371357401</c:v>
                </c:pt>
                <c:pt idx="9">
                  <c:v>8.145809998981770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2-97D7-40C8-B743-8BEFE0D4F8BA}"/>
            </c:ext>
          </c:extLst>
        </c:ser>
        <c:ser>
          <c:idx val="163"/>
          <c:order val="163"/>
          <c:tx>
            <c:strRef>
              <c:f>ordem_grafico!$A$166</c:f>
              <c:strCache>
                <c:ptCount val="1"/>
                <c:pt idx="0">
                  <c:v>Reyranellal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6:$K$166</c:f>
              <c:numCache>
                <c:formatCode>General</c:formatCode>
                <c:ptCount val="10"/>
                <c:pt idx="0">
                  <c:v>0.1872659176029959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75002798611888499</c:v>
                </c:pt>
                <c:pt idx="6">
                  <c:v>1.47790531553278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3-97D7-40C8-B743-8BEFE0D4F8BA}"/>
            </c:ext>
          </c:extLst>
        </c:ser>
        <c:ser>
          <c:idx val="164"/>
          <c:order val="164"/>
          <c:tx>
            <c:strRef>
              <c:f>ordem_grafico!$A$167</c:f>
              <c:strCache>
                <c:ptCount val="1"/>
                <c:pt idx="0">
                  <c:v>Rhizobiale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7:$K$167</c:f>
              <c:numCache>
                <c:formatCode>General</c:formatCode>
                <c:ptCount val="10"/>
                <c:pt idx="0">
                  <c:v>3.9646869983948632</c:v>
                </c:pt>
                <c:pt idx="1">
                  <c:v>2.036669501937435</c:v>
                </c:pt>
                <c:pt idx="2">
                  <c:v>1.3172792196481451</c:v>
                </c:pt>
                <c:pt idx="3">
                  <c:v>1.9831308364293601</c:v>
                </c:pt>
                <c:pt idx="4">
                  <c:v>0</c:v>
                </c:pt>
                <c:pt idx="5">
                  <c:v>2.0094033359453709</c:v>
                </c:pt>
                <c:pt idx="6">
                  <c:v>2.596187004285925</c:v>
                </c:pt>
                <c:pt idx="7">
                  <c:v>8.2539309100890108</c:v>
                </c:pt>
                <c:pt idx="8">
                  <c:v>1.0902483343428231</c:v>
                </c:pt>
                <c:pt idx="9">
                  <c:v>4.15436309948070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4-97D7-40C8-B743-8BEFE0D4F8BA}"/>
            </c:ext>
          </c:extLst>
        </c:ser>
        <c:ser>
          <c:idx val="165"/>
          <c:order val="165"/>
          <c:tx>
            <c:strRef>
              <c:f>ordem_grafico!$A$168</c:f>
              <c:strCache>
                <c:ptCount val="1"/>
                <c:pt idx="0">
                  <c:v>Rhodobacterale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8:$K$168</c:f>
              <c:numCache>
                <c:formatCode>General</c:formatCode>
                <c:ptCount val="10"/>
                <c:pt idx="0">
                  <c:v>0.13554485464597801</c:v>
                </c:pt>
                <c:pt idx="1">
                  <c:v>2.0083167942538509</c:v>
                </c:pt>
                <c:pt idx="2">
                  <c:v>5.8765894443476752</c:v>
                </c:pt>
                <c:pt idx="3">
                  <c:v>1.932924992469123</c:v>
                </c:pt>
                <c:pt idx="4">
                  <c:v>0.165562913907285</c:v>
                </c:pt>
                <c:pt idx="5">
                  <c:v>1.50005597223777</c:v>
                </c:pt>
                <c:pt idx="6">
                  <c:v>0.108379723139071</c:v>
                </c:pt>
                <c:pt idx="7">
                  <c:v>0.57640277614398305</c:v>
                </c:pt>
                <c:pt idx="8">
                  <c:v>4.1288108217242057</c:v>
                </c:pt>
                <c:pt idx="9">
                  <c:v>0.48196042493975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5-97D7-40C8-B743-8BEFE0D4F8BA}"/>
            </c:ext>
          </c:extLst>
        </c:ser>
        <c:ser>
          <c:idx val="166"/>
          <c:order val="166"/>
          <c:tx>
            <c:strRef>
              <c:f>ordem_grafico!$A$169</c:f>
              <c:strCache>
                <c:ptCount val="1"/>
                <c:pt idx="0">
                  <c:v>Rhodospirillale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69:$K$169</c:f>
              <c:numCache>
                <c:formatCode>General</c:formatCode>
                <c:ptCount val="10"/>
                <c:pt idx="0">
                  <c:v>9.0957731407169604E-2</c:v>
                </c:pt>
                <c:pt idx="1">
                  <c:v>2.8352707683583799E-2</c:v>
                </c:pt>
                <c:pt idx="2">
                  <c:v>0</c:v>
                </c:pt>
                <c:pt idx="3">
                  <c:v>2.0082337584094799E-2</c:v>
                </c:pt>
                <c:pt idx="4">
                  <c:v>0</c:v>
                </c:pt>
                <c:pt idx="5">
                  <c:v>0.111944475540132</c:v>
                </c:pt>
                <c:pt idx="6">
                  <c:v>9.8527021035518993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6-97D7-40C8-B743-8BEFE0D4F8BA}"/>
            </c:ext>
          </c:extLst>
        </c:ser>
        <c:ser>
          <c:idx val="167"/>
          <c:order val="167"/>
          <c:tx>
            <c:strRef>
              <c:f>ordem_grafico!$A$170</c:f>
              <c:strCache>
                <c:ptCount val="1"/>
                <c:pt idx="0">
                  <c:v>Rhodovibrionale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0:$K$170</c:f>
              <c:numCache>
                <c:formatCode>General</c:formatCode>
                <c:ptCount val="10"/>
                <c:pt idx="0">
                  <c:v>8.2040306759407905E-2</c:v>
                </c:pt>
                <c:pt idx="1">
                  <c:v>1.606653435403081</c:v>
                </c:pt>
                <c:pt idx="2">
                  <c:v>0</c:v>
                </c:pt>
                <c:pt idx="3">
                  <c:v>1.4559694748468719</c:v>
                </c:pt>
                <c:pt idx="4">
                  <c:v>0</c:v>
                </c:pt>
                <c:pt idx="5">
                  <c:v>5.5972237770066102E-2</c:v>
                </c:pt>
                <c:pt idx="6">
                  <c:v>0.11823242524262299</c:v>
                </c:pt>
                <c:pt idx="7">
                  <c:v>0.65090381523742302</c:v>
                </c:pt>
                <c:pt idx="8">
                  <c:v>1.00948919846558E-2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7-97D7-40C8-B743-8BEFE0D4F8BA}"/>
            </c:ext>
          </c:extLst>
        </c:ser>
        <c:ser>
          <c:idx val="168"/>
          <c:order val="168"/>
          <c:tx>
            <c:strRef>
              <c:f>ordem_grafico!$A$171</c:f>
              <c:strCache>
                <c:ptCount val="1"/>
                <c:pt idx="0">
                  <c:v>Rickettsiales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1:$K$171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5.1979964086570303E-2</c:v>
                </c:pt>
                <c:pt idx="2">
                  <c:v>3.0482494338965299E-2</c:v>
                </c:pt>
                <c:pt idx="3">
                  <c:v>5.0205843960237001E-2</c:v>
                </c:pt>
                <c:pt idx="4">
                  <c:v>0</c:v>
                </c:pt>
                <c:pt idx="5">
                  <c:v>0.30784730773536301</c:v>
                </c:pt>
                <c:pt idx="6">
                  <c:v>0</c:v>
                </c:pt>
                <c:pt idx="7">
                  <c:v>0</c:v>
                </c:pt>
                <c:pt idx="8">
                  <c:v>1.3459855979541E-2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8-97D7-40C8-B743-8BEFE0D4F8BA}"/>
            </c:ext>
          </c:extLst>
        </c:ser>
        <c:ser>
          <c:idx val="169"/>
          <c:order val="169"/>
          <c:tx>
            <c:strRef>
              <c:f>ordem_grafico!$A$172</c:f>
              <c:strCache>
                <c:ptCount val="1"/>
                <c:pt idx="0">
                  <c:v>Sneathiellale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2:$K$172</c:f>
              <c:numCache>
                <c:formatCode>General</c:formatCode>
                <c:ptCount val="10"/>
                <c:pt idx="0">
                  <c:v>1.070090957731410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1287361468711520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9-97D7-40C8-B743-8BEFE0D4F8BA}"/>
            </c:ext>
          </c:extLst>
        </c:ser>
        <c:ser>
          <c:idx val="170"/>
          <c:order val="170"/>
          <c:tx>
            <c:strRef>
              <c:f>ordem_grafico!$A$173</c:f>
              <c:strCache>
                <c:ptCount val="1"/>
                <c:pt idx="0">
                  <c:v>Sphingomonadales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3:$K$173</c:f>
              <c:numCache>
                <c:formatCode>General</c:formatCode>
                <c:ptCount val="10"/>
                <c:pt idx="0">
                  <c:v>1.350098091671126</c:v>
                </c:pt>
                <c:pt idx="1">
                  <c:v>4.5600604857763916</c:v>
                </c:pt>
                <c:pt idx="2">
                  <c:v>7.1089531440515588</c:v>
                </c:pt>
                <c:pt idx="3">
                  <c:v>4.2223114770559276</c:v>
                </c:pt>
                <c:pt idx="4">
                  <c:v>0</c:v>
                </c:pt>
                <c:pt idx="5">
                  <c:v>11.42953095264749</c:v>
                </c:pt>
                <c:pt idx="6">
                  <c:v>0.59608847726489</c:v>
                </c:pt>
                <c:pt idx="7">
                  <c:v>10.563463121985651</c:v>
                </c:pt>
                <c:pt idx="8">
                  <c:v>11.38030823070193</c:v>
                </c:pt>
                <c:pt idx="9">
                  <c:v>16.2882259104639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A-97D7-40C8-B743-8BEFE0D4F8BA}"/>
            </c:ext>
          </c:extLst>
        </c:ser>
        <c:ser>
          <c:idx val="171"/>
          <c:order val="171"/>
          <c:tx>
            <c:strRef>
              <c:f>ordem_grafico!$A$174</c:f>
              <c:strCache>
                <c:ptCount val="1"/>
                <c:pt idx="0">
                  <c:v>Thalassobaculale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4:$K$174</c:f>
              <c:numCache>
                <c:formatCode>General</c:formatCode>
                <c:ptCount val="10"/>
                <c:pt idx="0">
                  <c:v>0.24077046548956699</c:v>
                </c:pt>
                <c:pt idx="1">
                  <c:v>8.9783574331348606E-2</c:v>
                </c:pt>
                <c:pt idx="2">
                  <c:v>4.3546420484236199E-3</c:v>
                </c:pt>
                <c:pt idx="3">
                  <c:v>0.115473441108545</c:v>
                </c:pt>
                <c:pt idx="4">
                  <c:v>0</c:v>
                </c:pt>
                <c:pt idx="5">
                  <c:v>5.5972237770066102E-3</c:v>
                </c:pt>
                <c:pt idx="6">
                  <c:v>0</c:v>
                </c:pt>
                <c:pt idx="7">
                  <c:v>0</c:v>
                </c:pt>
                <c:pt idx="8">
                  <c:v>2.018978396931149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B-97D7-40C8-B743-8BEFE0D4F8BA}"/>
            </c:ext>
          </c:extLst>
        </c:ser>
        <c:ser>
          <c:idx val="172"/>
          <c:order val="172"/>
          <c:tx>
            <c:strRef>
              <c:f>ordem_grafico!$A$175</c:f>
              <c:strCache>
                <c:ptCount val="1"/>
                <c:pt idx="0">
                  <c:v>Tistrellales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5:$K$175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.127587184576127</c:v>
                </c:pt>
                <c:pt idx="2">
                  <c:v>8.7092840968472404E-2</c:v>
                </c:pt>
                <c:pt idx="3">
                  <c:v>0.12551460990059199</c:v>
                </c:pt>
                <c:pt idx="4">
                  <c:v>0</c:v>
                </c:pt>
                <c:pt idx="5">
                  <c:v>0.99630583230717595</c:v>
                </c:pt>
                <c:pt idx="6">
                  <c:v>7.3895265776639199E-2</c:v>
                </c:pt>
                <c:pt idx="7">
                  <c:v>0</c:v>
                </c:pt>
                <c:pt idx="8">
                  <c:v>0.242277407631738</c:v>
                </c:pt>
                <c:pt idx="9">
                  <c:v>0.94695041238163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C-97D7-40C8-B743-8BEFE0D4F8BA}"/>
            </c:ext>
          </c:extLst>
        </c:ser>
        <c:ser>
          <c:idx val="173"/>
          <c:order val="173"/>
          <c:tx>
            <c:strRef>
              <c:f>ordem_grafico!$A$176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6:$K$176</c:f>
              <c:numCache>
                <c:formatCode>General</c:formatCode>
                <c:ptCount val="10"/>
                <c:pt idx="0">
                  <c:v>0.57963260210451195</c:v>
                </c:pt>
                <c:pt idx="1">
                  <c:v>0</c:v>
                </c:pt>
                <c:pt idx="2">
                  <c:v>8.7092840968472397E-3</c:v>
                </c:pt>
                <c:pt idx="3">
                  <c:v>1.5061753188071099E-2</c:v>
                </c:pt>
                <c:pt idx="4">
                  <c:v>0</c:v>
                </c:pt>
                <c:pt idx="5">
                  <c:v>0.34702787417441</c:v>
                </c:pt>
                <c:pt idx="6">
                  <c:v>1.083797231390708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D-97D7-40C8-B743-8BEFE0D4F8BA}"/>
            </c:ext>
          </c:extLst>
        </c:ser>
        <c:ser>
          <c:idx val="174"/>
          <c:order val="174"/>
          <c:tx>
            <c:strRef>
              <c:f>ordem_grafico!$A$177</c:f>
              <c:strCache>
                <c:ptCount val="1"/>
                <c:pt idx="0">
                  <c:v>Bdellovibrionale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7:$K$177</c:f>
              <c:numCache>
                <c:formatCode>General</c:formatCode>
                <c:ptCount val="10"/>
                <c:pt idx="0">
                  <c:v>2.1401819154628101E-2</c:v>
                </c:pt>
                <c:pt idx="1">
                  <c:v>8.0332671770154004E-2</c:v>
                </c:pt>
                <c:pt idx="2">
                  <c:v>6.53196307263543E-2</c:v>
                </c:pt>
                <c:pt idx="3">
                  <c:v>4.51852595642133E-2</c:v>
                </c:pt>
                <c:pt idx="4">
                  <c:v>0</c:v>
                </c:pt>
                <c:pt idx="5">
                  <c:v>0.53733348259263403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E-97D7-40C8-B743-8BEFE0D4F8BA}"/>
            </c:ext>
          </c:extLst>
        </c:ser>
        <c:ser>
          <c:idx val="175"/>
          <c:order val="175"/>
          <c:tx>
            <c:strRef>
              <c:f>ordem_grafico!$A$178</c:f>
              <c:strCache>
                <c:ptCount val="1"/>
                <c:pt idx="0">
                  <c:v>Bradymonadales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8:$K$17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F-97D7-40C8-B743-8BEFE0D4F8BA}"/>
            </c:ext>
          </c:extLst>
        </c:ser>
        <c:ser>
          <c:idx val="176"/>
          <c:order val="176"/>
          <c:tx>
            <c:strRef>
              <c:f>ordem_grafico!$A$179</c:f>
              <c:strCache>
                <c:ptCount val="1"/>
                <c:pt idx="0">
                  <c:v>Deltaproteobacteria_unclassified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79:$K$179</c:f>
              <c:numCache>
                <c:formatCode>General</c:formatCode>
                <c:ptCount val="10"/>
                <c:pt idx="0">
                  <c:v>0.17299803816657799</c:v>
                </c:pt>
                <c:pt idx="1">
                  <c:v>0</c:v>
                </c:pt>
                <c:pt idx="2">
                  <c:v>0.12628461940428501</c:v>
                </c:pt>
                <c:pt idx="3">
                  <c:v>5.0205843960236998E-3</c:v>
                </c:pt>
                <c:pt idx="4">
                  <c:v>0</c:v>
                </c:pt>
                <c:pt idx="5">
                  <c:v>2.2388895108026399E-2</c:v>
                </c:pt>
                <c:pt idx="6">
                  <c:v>4.9263510517759497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0-97D7-40C8-B743-8BEFE0D4F8BA}"/>
            </c:ext>
          </c:extLst>
        </c:ser>
        <c:ser>
          <c:idx val="177"/>
          <c:order val="177"/>
          <c:tx>
            <c:strRef>
              <c:f>ordem_grafico!$A$180</c:f>
              <c:strCache>
                <c:ptCount val="1"/>
                <c:pt idx="0">
                  <c:v>Desulfarculales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0:$K$180</c:f>
              <c:numCache>
                <c:formatCode>General</c:formatCode>
                <c:ptCount val="10"/>
                <c:pt idx="0">
                  <c:v>8.2040306759407905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733236314787865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1-97D7-40C8-B743-8BEFE0D4F8BA}"/>
            </c:ext>
          </c:extLst>
        </c:ser>
        <c:ser>
          <c:idx val="178"/>
          <c:order val="178"/>
          <c:tx>
            <c:strRef>
              <c:f>ordem_grafico!$A$181</c:f>
              <c:strCache>
                <c:ptCount val="1"/>
                <c:pt idx="0">
                  <c:v>Desulfovibrionales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1:$K$18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2-97D7-40C8-B743-8BEFE0D4F8BA}"/>
            </c:ext>
          </c:extLst>
        </c:ser>
        <c:ser>
          <c:idx val="179"/>
          <c:order val="179"/>
          <c:tx>
            <c:strRef>
              <c:f>ordem_grafico!$A$182</c:f>
              <c:strCache>
                <c:ptCount val="1"/>
                <c:pt idx="0">
                  <c:v>MBNT15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2:$K$182</c:f>
              <c:numCache>
                <c:formatCode>General</c:formatCode>
                <c:ptCount val="10"/>
                <c:pt idx="0">
                  <c:v>5.35045478865704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167916713310198</c:v>
                </c:pt>
                <c:pt idx="6">
                  <c:v>1.97054042071037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3-97D7-40C8-B743-8BEFE0D4F8BA}"/>
            </c:ext>
          </c:extLst>
        </c:ser>
        <c:ser>
          <c:idx val="180"/>
          <c:order val="180"/>
          <c:tx>
            <c:strRef>
              <c:f>ordem_grafico!$A$183</c:f>
              <c:strCache>
                <c:ptCount val="1"/>
                <c:pt idx="0">
                  <c:v>Myxococcales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3:$K$183</c:f>
              <c:numCache>
                <c:formatCode>General</c:formatCode>
                <c:ptCount val="10"/>
                <c:pt idx="0">
                  <c:v>0.32281077224897498</c:v>
                </c:pt>
                <c:pt idx="1">
                  <c:v>0.22209621018807299</c:v>
                </c:pt>
                <c:pt idx="2">
                  <c:v>1.4740463333913949</c:v>
                </c:pt>
                <c:pt idx="3">
                  <c:v>0.15563811627673499</c:v>
                </c:pt>
                <c:pt idx="4">
                  <c:v>0</c:v>
                </c:pt>
                <c:pt idx="5">
                  <c:v>0.85077801410500398</c:v>
                </c:pt>
                <c:pt idx="6">
                  <c:v>4.9263510517759498E-2</c:v>
                </c:pt>
                <c:pt idx="7">
                  <c:v>1.96055366035368E-2</c:v>
                </c:pt>
                <c:pt idx="8">
                  <c:v>0.1716131637391480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4-97D7-40C8-B743-8BEFE0D4F8BA}"/>
            </c:ext>
          </c:extLst>
        </c:ser>
        <c:ser>
          <c:idx val="181"/>
          <c:order val="181"/>
          <c:tx>
            <c:strRef>
              <c:f>ordem_grafico!$A$184</c:f>
              <c:strCache>
                <c:ptCount val="1"/>
                <c:pt idx="0">
                  <c:v>NB1-j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4:$K$184</c:f>
              <c:numCache>
                <c:formatCode>General</c:formatCode>
                <c:ptCount val="10"/>
                <c:pt idx="0">
                  <c:v>0.10879258070269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8.3958356655099098E-2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5-97D7-40C8-B743-8BEFE0D4F8BA}"/>
            </c:ext>
          </c:extLst>
        </c:ser>
        <c:ser>
          <c:idx val="182"/>
          <c:order val="182"/>
          <c:tx>
            <c:strRef>
              <c:f>ordem_grafico!$A$185</c:f>
              <c:strCache>
                <c:ptCount val="1"/>
                <c:pt idx="0">
                  <c:v>Oligoflexales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5:$K$185</c:f>
              <c:numCache>
                <c:formatCode>General</c:formatCode>
                <c:ptCount val="10"/>
                <c:pt idx="0">
                  <c:v>0</c:v>
                </c:pt>
                <c:pt idx="1">
                  <c:v>0.538701445988092</c:v>
                </c:pt>
                <c:pt idx="2">
                  <c:v>0.77948092666782798</c:v>
                </c:pt>
                <c:pt idx="3">
                  <c:v>0.45185259564213298</c:v>
                </c:pt>
                <c:pt idx="4">
                  <c:v>0</c:v>
                </c:pt>
                <c:pt idx="5">
                  <c:v>0.21829172730325799</c:v>
                </c:pt>
                <c:pt idx="6">
                  <c:v>0</c:v>
                </c:pt>
                <c:pt idx="7">
                  <c:v>0</c:v>
                </c:pt>
                <c:pt idx="8">
                  <c:v>0.20526280368800101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6-97D7-40C8-B743-8BEFE0D4F8BA}"/>
            </c:ext>
          </c:extLst>
        </c:ser>
        <c:ser>
          <c:idx val="183"/>
          <c:order val="183"/>
          <c:tx>
            <c:strRef>
              <c:f>ordem_grafico!$A$186</c:f>
              <c:strCache>
                <c:ptCount val="1"/>
                <c:pt idx="0">
                  <c:v>PB19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6:$K$18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.018978396931149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7-97D7-40C8-B743-8BEFE0D4F8BA}"/>
            </c:ext>
          </c:extLst>
        </c:ser>
        <c:ser>
          <c:idx val="184"/>
          <c:order val="184"/>
          <c:tx>
            <c:strRef>
              <c:f>ordem_grafico!$A$187</c:f>
              <c:strCache>
                <c:ptCount val="1"/>
                <c:pt idx="0">
                  <c:v>RCP2-54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7:$K$187</c:f>
              <c:numCache>
                <c:formatCode>General</c:formatCode>
                <c:ptCount val="10"/>
                <c:pt idx="0">
                  <c:v>2.496878901373280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8-97D7-40C8-B743-8BEFE0D4F8BA}"/>
            </c:ext>
          </c:extLst>
        </c:ser>
        <c:ser>
          <c:idx val="185"/>
          <c:order val="185"/>
          <c:tx>
            <c:strRef>
              <c:f>ordem_grafico!$A$188</c:f>
              <c:strCache>
                <c:ptCount val="1"/>
                <c:pt idx="0">
                  <c:v>SAR324_clade(Marine_group_B)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8:$K$188</c:f>
              <c:numCache>
                <c:formatCode>General</c:formatCode>
                <c:ptCount val="10"/>
                <c:pt idx="0">
                  <c:v>4.4587123238808597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5.037501399305940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9-97D7-40C8-B743-8BEFE0D4F8BA}"/>
            </c:ext>
          </c:extLst>
        </c:ser>
        <c:ser>
          <c:idx val="186"/>
          <c:order val="186"/>
          <c:tx>
            <c:strRef>
              <c:f>ordem_grafico!$A$189</c:f>
              <c:strCache>
                <c:ptCount val="1"/>
                <c:pt idx="0">
                  <c:v>Acidiferrobacterale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89:$K$189</c:f>
              <c:numCache>
                <c:formatCode>General</c:formatCode>
                <c:ptCount val="10"/>
                <c:pt idx="0">
                  <c:v>9.9875156054931302E-2</c:v>
                </c:pt>
                <c:pt idx="1">
                  <c:v>1.89018051223892E-2</c:v>
                </c:pt>
                <c:pt idx="2">
                  <c:v>2.39505312663299E-2</c:v>
                </c:pt>
                <c:pt idx="3">
                  <c:v>5.0205843960237001E-2</c:v>
                </c:pt>
                <c:pt idx="4">
                  <c:v>0</c:v>
                </c:pt>
                <c:pt idx="5">
                  <c:v>0</c:v>
                </c:pt>
                <c:pt idx="6">
                  <c:v>9.8527021035518993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A-97D7-40C8-B743-8BEFE0D4F8BA}"/>
            </c:ext>
          </c:extLst>
        </c:ser>
        <c:ser>
          <c:idx val="187"/>
          <c:order val="187"/>
          <c:tx>
            <c:strRef>
              <c:f>ordem_grafico!$A$190</c:f>
              <c:strCache>
                <c:ptCount val="1"/>
                <c:pt idx="0">
                  <c:v>Acidithiobacillal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0:$K$190</c:f>
              <c:numCache>
                <c:formatCode>General</c:formatCode>
                <c:ptCount val="10"/>
                <c:pt idx="0">
                  <c:v>2.8535758872837502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8.8674318931967103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B-97D7-40C8-B743-8BEFE0D4F8BA}"/>
            </c:ext>
          </c:extLst>
        </c:ser>
        <c:ser>
          <c:idx val="188"/>
          <c:order val="188"/>
          <c:tx>
            <c:strRef>
              <c:f>ordem_grafico!$A$191</c:f>
              <c:strCache>
                <c:ptCount val="1"/>
                <c:pt idx="0">
                  <c:v>Alteromonadales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1:$K$19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2.3526643924244198E-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C-97D7-40C8-B743-8BEFE0D4F8BA}"/>
            </c:ext>
          </c:extLst>
        </c:ser>
        <c:ser>
          <c:idx val="189"/>
          <c:order val="189"/>
          <c:tx>
            <c:strRef>
              <c:f>ordem_grafico!$A$192</c:f>
              <c:strCache>
                <c:ptCount val="1"/>
                <c:pt idx="0">
                  <c:v>Betaproteobacteriale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2:$K$192</c:f>
              <c:numCache>
                <c:formatCode>General</c:formatCode>
                <c:ptCount val="10"/>
                <c:pt idx="0">
                  <c:v>2.5361155698234348</c:v>
                </c:pt>
                <c:pt idx="1">
                  <c:v>1.2097155278329079</c:v>
                </c:pt>
                <c:pt idx="2">
                  <c:v>0.87963769378157097</c:v>
                </c:pt>
                <c:pt idx="3">
                  <c:v>1.1547344110854501</c:v>
                </c:pt>
                <c:pt idx="4">
                  <c:v>0</c:v>
                </c:pt>
                <c:pt idx="5">
                  <c:v>17.530504869584689</c:v>
                </c:pt>
                <c:pt idx="6">
                  <c:v>0.46307699886693898</c:v>
                </c:pt>
                <c:pt idx="7">
                  <c:v>7.8422146414147392E-3</c:v>
                </c:pt>
                <c:pt idx="8">
                  <c:v>2.5708324920923351</c:v>
                </c:pt>
                <c:pt idx="9">
                  <c:v>1.69704374978787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D-97D7-40C8-B743-8BEFE0D4F8BA}"/>
            </c:ext>
          </c:extLst>
        </c:ser>
        <c:ser>
          <c:idx val="190"/>
          <c:order val="190"/>
          <c:tx>
            <c:strRef>
              <c:f>ordem_grafico!$A$193</c:f>
              <c:strCache>
                <c:ptCount val="1"/>
                <c:pt idx="0">
                  <c:v>CCD24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3:$K$193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E-97D7-40C8-B743-8BEFE0D4F8BA}"/>
            </c:ext>
          </c:extLst>
        </c:ser>
        <c:ser>
          <c:idx val="191"/>
          <c:order val="191"/>
          <c:tx>
            <c:strRef>
              <c:f>ordem_grafico!$A$194</c:f>
              <c:strCache>
                <c:ptCount val="1"/>
                <c:pt idx="0">
                  <c:v>CCM19a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4:$K$194</c:f>
              <c:numCache>
                <c:formatCode>General</c:formatCode>
                <c:ptCount val="10"/>
                <c:pt idx="0">
                  <c:v>0.2193686463349379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97581999328333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BF-97D7-40C8-B743-8BEFE0D4F8BA}"/>
            </c:ext>
          </c:extLst>
        </c:ser>
        <c:ser>
          <c:idx val="192"/>
          <c:order val="192"/>
          <c:tx>
            <c:strRef>
              <c:f>ordem_grafico!$A$195</c:f>
              <c:strCache>
                <c:ptCount val="1"/>
                <c:pt idx="0">
                  <c:v>Cellvibrionales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5:$K$195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0-97D7-40C8-B743-8BEFE0D4F8BA}"/>
            </c:ext>
          </c:extLst>
        </c:ser>
        <c:ser>
          <c:idx val="193"/>
          <c:order val="193"/>
          <c:tx>
            <c:strRef>
              <c:f>ordem_grafico!$A$196</c:f>
              <c:strCache>
                <c:ptCount val="1"/>
                <c:pt idx="0">
                  <c:v>Competibacterale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6:$K$196</c:f>
              <c:numCache>
                <c:formatCode>General</c:formatCode>
                <c:ptCount val="10"/>
                <c:pt idx="0">
                  <c:v>0</c:v>
                </c:pt>
                <c:pt idx="1">
                  <c:v>8.0332671770154004E-2</c:v>
                </c:pt>
                <c:pt idx="2">
                  <c:v>0</c:v>
                </c:pt>
                <c:pt idx="3">
                  <c:v>8.0329350336379196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1-97D7-40C8-B743-8BEFE0D4F8BA}"/>
            </c:ext>
          </c:extLst>
        </c:ser>
        <c:ser>
          <c:idx val="194"/>
          <c:order val="194"/>
          <c:tx>
            <c:strRef>
              <c:f>ordem_grafico!$A$197</c:f>
              <c:strCache>
                <c:ptCount val="1"/>
                <c:pt idx="0">
                  <c:v>Coxiellales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7:$K$197</c:f>
              <c:numCache>
                <c:formatCode>General</c:formatCode>
                <c:ptCount val="10"/>
                <c:pt idx="0">
                  <c:v>2.140181915462810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7986118885032999E-2</c:v>
                </c:pt>
                <c:pt idx="6">
                  <c:v>1.97054042071037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2-97D7-40C8-B743-8BEFE0D4F8BA}"/>
            </c:ext>
          </c:extLst>
        </c:ser>
        <c:ser>
          <c:idx val="195"/>
          <c:order val="195"/>
          <c:tx>
            <c:strRef>
              <c:f>ordem_grafico!$A$198</c:f>
              <c:strCache>
                <c:ptCount val="1"/>
                <c:pt idx="0">
                  <c:v>Diplorickettsiales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8:$K$198</c:f>
              <c:numCache>
                <c:formatCode>General</c:formatCode>
                <c:ptCount val="10"/>
                <c:pt idx="0">
                  <c:v>1.9618334225075799E-2</c:v>
                </c:pt>
                <c:pt idx="1">
                  <c:v>0</c:v>
                </c:pt>
                <c:pt idx="2">
                  <c:v>4.3546420484236199E-3</c:v>
                </c:pt>
                <c:pt idx="3">
                  <c:v>0</c:v>
                </c:pt>
                <c:pt idx="4">
                  <c:v>6.7853653240690495E-2</c:v>
                </c:pt>
                <c:pt idx="5">
                  <c:v>0.179111160864211</c:v>
                </c:pt>
                <c:pt idx="6">
                  <c:v>1.97054042071037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3-97D7-40C8-B743-8BEFE0D4F8BA}"/>
            </c:ext>
          </c:extLst>
        </c:ser>
        <c:ser>
          <c:idx val="196"/>
          <c:order val="196"/>
          <c:tx>
            <c:strRef>
              <c:f>ordem_grafico!$A$199</c:f>
              <c:strCache>
                <c:ptCount val="1"/>
                <c:pt idx="0">
                  <c:v>EV818SWSAP88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199:$K$19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8.7092840968472397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4-97D7-40C8-B743-8BEFE0D4F8BA}"/>
            </c:ext>
          </c:extLst>
        </c:ser>
        <c:ser>
          <c:idx val="197"/>
          <c:order val="197"/>
          <c:tx>
            <c:strRef>
              <c:f>ordem_grafico!$A$200</c:f>
              <c:strCache>
                <c:ptCount val="1"/>
                <c:pt idx="0">
                  <c:v>Ectothiorhodospirales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0:$K$200</c:f>
              <c:numCache>
                <c:formatCode>General</c:formatCode>
                <c:ptCount val="10"/>
                <c:pt idx="0">
                  <c:v>2.67522739432852E-2</c:v>
                </c:pt>
                <c:pt idx="1">
                  <c:v>7.08817692089595E-2</c:v>
                </c:pt>
                <c:pt idx="2">
                  <c:v>0</c:v>
                </c:pt>
                <c:pt idx="3">
                  <c:v>1.5061753188071099E-2</c:v>
                </c:pt>
                <c:pt idx="4">
                  <c:v>0</c:v>
                </c:pt>
                <c:pt idx="5">
                  <c:v>0</c:v>
                </c:pt>
                <c:pt idx="6">
                  <c:v>2.4631755258879801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5-97D7-40C8-B743-8BEFE0D4F8BA}"/>
            </c:ext>
          </c:extLst>
        </c:ser>
        <c:ser>
          <c:idx val="198"/>
          <c:order val="198"/>
          <c:tx>
            <c:strRef>
              <c:f>ordem_grafico!$A$201</c:f>
              <c:strCache>
                <c:ptCount val="1"/>
                <c:pt idx="0">
                  <c:v>Ga0077536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1:$K$201</c:f>
              <c:numCache>
                <c:formatCode>General</c:formatCode>
                <c:ptCount val="10"/>
                <c:pt idx="0">
                  <c:v>3.92366684501515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7.2763909101085905E-2</c:v>
                </c:pt>
                <c:pt idx="6">
                  <c:v>1.47790531553278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6-97D7-40C8-B743-8BEFE0D4F8BA}"/>
            </c:ext>
          </c:extLst>
        </c:ser>
        <c:ser>
          <c:idx val="199"/>
          <c:order val="199"/>
          <c:tx>
            <c:strRef>
              <c:f>ordem_grafico!$A$202</c:f>
              <c:strCache>
                <c:ptCount val="1"/>
                <c:pt idx="0">
                  <c:v>Gammaproteobacteria_Incertae_Sedis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2:$K$202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0</c:v>
                </c:pt>
                <c:pt idx="3">
                  <c:v>5.0205843960236998E-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7-97D7-40C8-B743-8BEFE0D4F8BA}"/>
            </c:ext>
          </c:extLst>
        </c:ser>
        <c:ser>
          <c:idx val="200"/>
          <c:order val="200"/>
          <c:tx>
            <c:strRef>
              <c:f>ordem_grafico!$A$203</c:f>
              <c:strCache>
                <c:ptCount val="1"/>
                <c:pt idx="0">
                  <c:v>Gammaproteobacteria_unclassified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3:$K$203</c:f>
              <c:numCache>
                <c:formatCode>General</c:formatCode>
                <c:ptCount val="10"/>
                <c:pt idx="0">
                  <c:v>0.26038879971464302</c:v>
                </c:pt>
                <c:pt idx="1">
                  <c:v>0.16066534354030801</c:v>
                </c:pt>
                <c:pt idx="2">
                  <c:v>4.964291935202926</c:v>
                </c:pt>
                <c:pt idx="3">
                  <c:v>0.28115272617732701</c:v>
                </c:pt>
                <c:pt idx="4">
                  <c:v>0</c:v>
                </c:pt>
                <c:pt idx="5">
                  <c:v>4.7016679726855477</c:v>
                </c:pt>
                <c:pt idx="6">
                  <c:v>0.51726686043647496</c:v>
                </c:pt>
                <c:pt idx="7">
                  <c:v>3.1368858565658901E-2</c:v>
                </c:pt>
                <c:pt idx="8">
                  <c:v>1.655562285483545</c:v>
                </c:pt>
                <c:pt idx="9">
                  <c:v>0.648270712418966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8-97D7-40C8-B743-8BEFE0D4F8BA}"/>
            </c:ext>
          </c:extLst>
        </c:ser>
        <c:ser>
          <c:idx val="201"/>
          <c:order val="201"/>
          <c:tx>
            <c:strRef>
              <c:f>ordem_grafico!$A$204</c:f>
              <c:strCache>
                <c:ptCount val="1"/>
                <c:pt idx="0">
                  <c:v>JG36-TzT-191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4:$K$204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9-97D7-40C8-B743-8BEFE0D4F8BA}"/>
            </c:ext>
          </c:extLst>
        </c:ser>
        <c:ser>
          <c:idx val="202"/>
          <c:order val="202"/>
          <c:tx>
            <c:strRef>
              <c:f>ordem_grafico!$A$205</c:f>
              <c:strCache>
                <c:ptCount val="1"/>
                <c:pt idx="0">
                  <c:v>KF-JG30-C25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5:$K$205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A-97D7-40C8-B743-8BEFE0D4F8BA}"/>
            </c:ext>
          </c:extLst>
        </c:ser>
        <c:ser>
          <c:idx val="203"/>
          <c:order val="203"/>
          <c:tx>
            <c:strRef>
              <c:f>ordem_grafico!$A$206</c:f>
              <c:strCache>
                <c:ptCount val="1"/>
                <c:pt idx="0">
                  <c:v>KI89A_clade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6:$K$206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2.3627256402986501E-2</c:v>
                </c:pt>
                <c:pt idx="2">
                  <c:v>0</c:v>
                </c:pt>
                <c:pt idx="3">
                  <c:v>5.5226428356260703E-2</c:v>
                </c:pt>
                <c:pt idx="4">
                  <c:v>0</c:v>
                </c:pt>
                <c:pt idx="5">
                  <c:v>7.2763909101085905E-2</c:v>
                </c:pt>
                <c:pt idx="6">
                  <c:v>3.4484457362431602E-2</c:v>
                </c:pt>
                <c:pt idx="7">
                  <c:v>4.7053287848488397E-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B-97D7-40C8-B743-8BEFE0D4F8BA}"/>
            </c:ext>
          </c:extLst>
        </c:ser>
        <c:ser>
          <c:idx val="204"/>
          <c:order val="204"/>
          <c:tx>
            <c:strRef>
              <c:f>ordem_grafico!$A$207</c:f>
              <c:strCache>
                <c:ptCount val="1"/>
                <c:pt idx="0">
                  <c:v>Legionellales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7:$K$207</c:f>
              <c:numCache>
                <c:formatCode>General</c:formatCode>
                <c:ptCount val="10"/>
                <c:pt idx="0">
                  <c:v>5.5288032816122698E-2</c:v>
                </c:pt>
                <c:pt idx="1">
                  <c:v>1.4176353841791899E-2</c:v>
                </c:pt>
                <c:pt idx="2">
                  <c:v>8.7092840968472397E-3</c:v>
                </c:pt>
                <c:pt idx="3">
                  <c:v>1.00411687920474E-2</c:v>
                </c:pt>
                <c:pt idx="4">
                  <c:v>0</c:v>
                </c:pt>
                <c:pt idx="5">
                  <c:v>5.5972237770066102E-3</c:v>
                </c:pt>
                <c:pt idx="6">
                  <c:v>1.47790531553278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C-97D7-40C8-B743-8BEFE0D4F8BA}"/>
            </c:ext>
          </c:extLst>
        </c:ser>
        <c:ser>
          <c:idx val="205"/>
          <c:order val="205"/>
          <c:tx>
            <c:strRef>
              <c:f>ordem_grafico!$A$208</c:f>
              <c:strCache>
                <c:ptCount val="1"/>
                <c:pt idx="0">
                  <c:v>Nitrococcales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8:$K$208</c:f>
              <c:numCache>
                <c:formatCode>General</c:formatCode>
                <c:ptCount val="10"/>
                <c:pt idx="0">
                  <c:v>3.5669698591046899E-2</c:v>
                </c:pt>
                <c:pt idx="1">
                  <c:v>3.8984973064927702</c:v>
                </c:pt>
                <c:pt idx="2">
                  <c:v>0</c:v>
                </c:pt>
                <c:pt idx="3">
                  <c:v>3.6951501154734401</c:v>
                </c:pt>
                <c:pt idx="4">
                  <c:v>0.10856584518510499</c:v>
                </c:pt>
                <c:pt idx="5">
                  <c:v>0</c:v>
                </c:pt>
                <c:pt idx="6">
                  <c:v>0.15764323365683</c:v>
                </c:pt>
                <c:pt idx="7">
                  <c:v>0.87440693251774304</c:v>
                </c:pt>
                <c:pt idx="8">
                  <c:v>1.00948919846558E-2</c:v>
                </c:pt>
                <c:pt idx="9">
                  <c:v>0.1052167124868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D-97D7-40C8-B743-8BEFE0D4F8BA}"/>
            </c:ext>
          </c:extLst>
        </c:ser>
        <c:ser>
          <c:idx val="206"/>
          <c:order val="206"/>
          <c:tx>
            <c:strRef>
              <c:f>ordem_grafico!$A$209</c:f>
              <c:strCache>
                <c:ptCount val="1"/>
                <c:pt idx="0">
                  <c:v>Nitrosococcales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09:$K$209</c:f>
              <c:numCache>
                <c:formatCode>General</c:formatCode>
                <c:ptCount val="10"/>
                <c:pt idx="0">
                  <c:v>0.171214553237025</c:v>
                </c:pt>
                <c:pt idx="1">
                  <c:v>0</c:v>
                </c:pt>
                <c:pt idx="2">
                  <c:v>2.1773210242118099E-3</c:v>
                </c:pt>
                <c:pt idx="3">
                  <c:v>1.5061753188071099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E-97D7-40C8-B743-8BEFE0D4F8BA}"/>
            </c:ext>
          </c:extLst>
        </c:ser>
        <c:ser>
          <c:idx val="207"/>
          <c:order val="207"/>
          <c:tx>
            <c:strRef>
              <c:f>ordem_grafico!$A$210</c:f>
              <c:strCache>
                <c:ptCount val="1"/>
                <c:pt idx="0">
                  <c:v>Oceanospirillales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0:$K$210</c:f>
              <c:numCache>
                <c:formatCode>General</c:formatCode>
                <c:ptCount val="10"/>
                <c:pt idx="0">
                  <c:v>0</c:v>
                </c:pt>
                <c:pt idx="1">
                  <c:v>2.0839240147434079</c:v>
                </c:pt>
                <c:pt idx="2">
                  <c:v>4.3546420484236199E-3</c:v>
                </c:pt>
                <c:pt idx="3">
                  <c:v>2.2291394718345221</c:v>
                </c:pt>
                <c:pt idx="4">
                  <c:v>0.488546303332972</c:v>
                </c:pt>
                <c:pt idx="5">
                  <c:v>0</c:v>
                </c:pt>
                <c:pt idx="6">
                  <c:v>4.9263510517759498E-2</c:v>
                </c:pt>
                <c:pt idx="7">
                  <c:v>0.337215229580834</c:v>
                </c:pt>
                <c:pt idx="8">
                  <c:v>0</c:v>
                </c:pt>
                <c:pt idx="9">
                  <c:v>1.0793198248650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CF-97D7-40C8-B743-8BEFE0D4F8BA}"/>
            </c:ext>
          </c:extLst>
        </c:ser>
        <c:ser>
          <c:idx val="208"/>
          <c:order val="208"/>
          <c:tx>
            <c:strRef>
              <c:f>ordem_grafico!$A$211</c:f>
              <c:strCache>
                <c:ptCount val="1"/>
                <c:pt idx="0">
                  <c:v>PLTA13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1:$K$211</c:f>
              <c:numCache>
                <c:formatCode>General</c:formatCode>
                <c:ptCount val="10"/>
                <c:pt idx="0">
                  <c:v>2.573568753344034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866114407254</c:v>
                </c:pt>
                <c:pt idx="6">
                  <c:v>0.50248780728114695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0-97D7-40C8-B743-8BEFE0D4F8BA}"/>
            </c:ext>
          </c:extLst>
        </c:ser>
        <c:ser>
          <c:idx val="209"/>
          <c:order val="209"/>
          <c:tx>
            <c:strRef>
              <c:f>ordem_grafico!$A$212</c:f>
              <c:strCache>
                <c:ptCount val="1"/>
                <c:pt idx="0">
                  <c:v>Pseudomonadales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2:$K$212</c:f>
              <c:numCache>
                <c:formatCode>General</c:formatCode>
                <c:ptCount val="10"/>
                <c:pt idx="0">
                  <c:v>2.8535758872837502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583342662039599E-2</c:v>
                </c:pt>
                <c:pt idx="6">
                  <c:v>1.47790531553278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1-97D7-40C8-B743-8BEFE0D4F8BA}"/>
            </c:ext>
          </c:extLst>
        </c:ser>
        <c:ser>
          <c:idx val="210"/>
          <c:order val="210"/>
          <c:tx>
            <c:strRef>
              <c:f>ordem_grafico!$A$213</c:f>
              <c:strCache>
                <c:ptCount val="1"/>
                <c:pt idx="0">
                  <c:v>R7C24</c:v>
                </c:pt>
              </c:strCache>
            </c:strRef>
          </c:tx>
          <c:spPr>
            <a:solidFill>
              <a:schemeClr val="accent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3:$K$213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2-97D7-40C8-B743-8BEFE0D4F8BA}"/>
            </c:ext>
          </c:extLst>
        </c:ser>
        <c:ser>
          <c:idx val="211"/>
          <c:order val="211"/>
          <c:tx>
            <c:strRef>
              <c:f>ordem_grafico!$A$214</c:f>
              <c:strCache>
                <c:ptCount val="1"/>
                <c:pt idx="0">
                  <c:v>Salinisphaerales</c:v>
                </c:pt>
              </c:strCache>
            </c:strRef>
          </c:tx>
          <c:spPr>
            <a:solidFill>
              <a:schemeClr val="accent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4:$K$214</c:f>
              <c:numCache>
                <c:formatCode>General</c:formatCode>
                <c:ptCount val="10"/>
                <c:pt idx="0">
                  <c:v>0.57606563224540797</c:v>
                </c:pt>
                <c:pt idx="1">
                  <c:v>4.2529061525375701E-2</c:v>
                </c:pt>
                <c:pt idx="2">
                  <c:v>0</c:v>
                </c:pt>
                <c:pt idx="3">
                  <c:v>6.0247012752284397E-2</c:v>
                </c:pt>
                <c:pt idx="4">
                  <c:v>0.46140484203669502</c:v>
                </c:pt>
                <c:pt idx="5">
                  <c:v>0</c:v>
                </c:pt>
                <c:pt idx="6">
                  <c:v>1.47790531553278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3-97D7-40C8-B743-8BEFE0D4F8BA}"/>
            </c:ext>
          </c:extLst>
        </c:ser>
        <c:ser>
          <c:idx val="212"/>
          <c:order val="212"/>
          <c:tx>
            <c:strRef>
              <c:f>ordem_grafico!$A$215</c:f>
              <c:strCache>
                <c:ptCount val="1"/>
                <c:pt idx="0">
                  <c:v>Steroidobacterales</c:v>
                </c:pt>
              </c:strCache>
            </c:strRef>
          </c:tx>
          <c:spPr>
            <a:solidFill>
              <a:schemeClr val="accent3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5:$K$215</c:f>
              <c:numCache>
                <c:formatCode>General</c:formatCode>
                <c:ptCount val="10"/>
                <c:pt idx="0">
                  <c:v>1.4160870340645619</c:v>
                </c:pt>
                <c:pt idx="1">
                  <c:v>7.5607220489556801E-2</c:v>
                </c:pt>
                <c:pt idx="2">
                  <c:v>2.1773210242118099E-3</c:v>
                </c:pt>
                <c:pt idx="3">
                  <c:v>0.12551460990059199</c:v>
                </c:pt>
                <c:pt idx="4">
                  <c:v>0</c:v>
                </c:pt>
                <c:pt idx="5">
                  <c:v>0.28545841262733701</c:v>
                </c:pt>
                <c:pt idx="6">
                  <c:v>2.8326518547711701</c:v>
                </c:pt>
                <c:pt idx="7">
                  <c:v>0.34897855154295598</c:v>
                </c:pt>
                <c:pt idx="8">
                  <c:v>6.7299279897705096E-3</c:v>
                </c:pt>
                <c:pt idx="9">
                  <c:v>3.39408749957574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4-97D7-40C8-B743-8BEFE0D4F8BA}"/>
            </c:ext>
          </c:extLst>
        </c:ser>
        <c:ser>
          <c:idx val="213"/>
          <c:order val="213"/>
          <c:tx>
            <c:strRef>
              <c:f>ordem_grafico!$A$216</c:f>
              <c:strCache>
                <c:ptCount val="1"/>
                <c:pt idx="0">
                  <c:v>Tenderiales</c:v>
                </c:pt>
              </c:strCache>
            </c:strRef>
          </c:tx>
          <c:spPr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6:$K$216</c:f>
              <c:numCache>
                <c:formatCode>General</c:formatCode>
                <c:ptCount val="10"/>
                <c:pt idx="0">
                  <c:v>1.248439450686640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5-97D7-40C8-B743-8BEFE0D4F8BA}"/>
            </c:ext>
          </c:extLst>
        </c:ser>
        <c:ser>
          <c:idx val="214"/>
          <c:order val="214"/>
          <c:tx>
            <c:strRef>
              <c:f>ordem_grafico!$A$217</c:f>
              <c:strCache>
                <c:ptCount val="1"/>
                <c:pt idx="0">
                  <c:v>Thiohalorhabdales</c:v>
                </c:pt>
              </c:strCache>
            </c:strRef>
          </c:tx>
          <c:spPr>
            <a:solidFill>
              <a:schemeClr val="accent5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7:$K$217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1.89018051223892E-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4.4337159465983503E-2</c:v>
                </c:pt>
                <c:pt idx="7">
                  <c:v>0.2783986197702230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6-97D7-40C8-B743-8BEFE0D4F8BA}"/>
            </c:ext>
          </c:extLst>
        </c:ser>
        <c:ser>
          <c:idx val="215"/>
          <c:order val="215"/>
          <c:tx>
            <c:strRef>
              <c:f>ordem_grafico!$A$218</c:f>
              <c:strCache>
                <c:ptCount val="1"/>
                <c:pt idx="0">
                  <c:v>Xanthomonadales</c:v>
                </c:pt>
              </c:strCache>
            </c:strRef>
          </c:tx>
          <c:spPr>
            <a:solidFill>
              <a:schemeClr val="accent6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8:$K$218</c:f>
              <c:numCache>
                <c:formatCode>General</c:formatCode>
                <c:ptCount val="10"/>
                <c:pt idx="0">
                  <c:v>3.6579275905118598</c:v>
                </c:pt>
                <c:pt idx="1">
                  <c:v>1.8429259994329461</c:v>
                </c:pt>
                <c:pt idx="2">
                  <c:v>0.59223131858561195</c:v>
                </c:pt>
                <c:pt idx="3">
                  <c:v>2.0333366803895978</c:v>
                </c:pt>
                <c:pt idx="4">
                  <c:v>0</c:v>
                </c:pt>
                <c:pt idx="5">
                  <c:v>2.8433896787193551</c:v>
                </c:pt>
                <c:pt idx="6">
                  <c:v>0.55667766885068204</c:v>
                </c:pt>
                <c:pt idx="7">
                  <c:v>2.6820374073638389</c:v>
                </c:pt>
                <c:pt idx="8">
                  <c:v>0.90517531462413403</c:v>
                </c:pt>
                <c:pt idx="9">
                  <c:v>1.23205376234599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7-97D7-40C8-B743-8BEFE0D4F8BA}"/>
            </c:ext>
          </c:extLst>
        </c:ser>
        <c:ser>
          <c:idx val="216"/>
          <c:order val="216"/>
          <c:tx>
            <c:strRef>
              <c:f>ordem_grafico!$A$219</c:f>
              <c:strCache>
                <c:ptCount val="1"/>
                <c:pt idx="0">
                  <c:v>Proteobacteria_unclassifi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19:$K$219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3.4837136387389001E-2</c:v>
                </c:pt>
                <c:pt idx="3">
                  <c:v>0</c:v>
                </c:pt>
                <c:pt idx="4">
                  <c:v>0</c:v>
                </c:pt>
                <c:pt idx="5">
                  <c:v>2.2388895108026399E-2</c:v>
                </c:pt>
                <c:pt idx="6">
                  <c:v>1.47790531553278E-2</c:v>
                </c:pt>
                <c:pt idx="7">
                  <c:v>0</c:v>
                </c:pt>
                <c:pt idx="8">
                  <c:v>0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8-97D7-40C8-B743-8BEFE0D4F8BA}"/>
            </c:ext>
          </c:extLst>
        </c:ser>
        <c:ser>
          <c:idx val="217"/>
          <c:order val="217"/>
          <c:tx>
            <c:strRef>
              <c:f>ordem_grafico!$A$220</c:f>
              <c:strCache>
                <c:ptCount val="1"/>
                <c:pt idx="0">
                  <c:v>Rokubacterial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0:$K$220</c:f>
              <c:numCache>
                <c:formatCode>General</c:formatCode>
                <c:ptCount val="10"/>
                <c:pt idx="0">
                  <c:v>4.28036383092562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4631755258879801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9-97D7-40C8-B743-8BEFE0D4F8BA}"/>
            </c:ext>
          </c:extLst>
        </c:ser>
        <c:ser>
          <c:idx val="218"/>
          <c:order val="218"/>
          <c:tx>
            <c:strRef>
              <c:f>ordem_grafico!$A$221</c:f>
              <c:strCache>
                <c:ptCount val="1"/>
                <c:pt idx="0">
                  <c:v>Chthoniobacterale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1:$K$221</c:f>
              <c:numCache>
                <c:formatCode>General</c:formatCode>
                <c:ptCount val="10"/>
                <c:pt idx="0">
                  <c:v>9.0957731407169604E-2</c:v>
                </c:pt>
                <c:pt idx="1">
                  <c:v>0.439466969095549</c:v>
                </c:pt>
                <c:pt idx="2">
                  <c:v>0.90794286709632499</c:v>
                </c:pt>
                <c:pt idx="3">
                  <c:v>0.24600863540516099</c:v>
                </c:pt>
                <c:pt idx="4">
                  <c:v>0</c:v>
                </c:pt>
                <c:pt idx="5">
                  <c:v>0.24627784618829099</c:v>
                </c:pt>
                <c:pt idx="6">
                  <c:v>0</c:v>
                </c:pt>
                <c:pt idx="7">
                  <c:v>0</c:v>
                </c:pt>
                <c:pt idx="8">
                  <c:v>0.10767884783632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A-97D7-40C8-B743-8BEFE0D4F8BA}"/>
            </c:ext>
          </c:extLst>
        </c:ser>
        <c:ser>
          <c:idx val="219"/>
          <c:order val="219"/>
          <c:tx>
            <c:strRef>
              <c:f>ordem_grafico!$A$222</c:f>
              <c:strCache>
                <c:ptCount val="1"/>
                <c:pt idx="0">
                  <c:v>Opitutale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2:$K$222</c:f>
              <c:numCache>
                <c:formatCode>General</c:formatCode>
                <c:ptCount val="10"/>
                <c:pt idx="0">
                  <c:v>8.3823791688960203E-2</c:v>
                </c:pt>
                <c:pt idx="1">
                  <c:v>1.4176353841791899E-2</c:v>
                </c:pt>
                <c:pt idx="2">
                  <c:v>5.6610346629507098E-2</c:v>
                </c:pt>
                <c:pt idx="3">
                  <c:v>0</c:v>
                </c:pt>
                <c:pt idx="4">
                  <c:v>0</c:v>
                </c:pt>
                <c:pt idx="5">
                  <c:v>0.42538900705250199</c:v>
                </c:pt>
                <c:pt idx="6">
                  <c:v>1.9705404207103799E-2</c:v>
                </c:pt>
                <c:pt idx="7">
                  <c:v>1.1763321962122099E-2</c:v>
                </c:pt>
                <c:pt idx="8">
                  <c:v>0.57204387913049304</c:v>
                </c:pt>
                <c:pt idx="9">
                  <c:v>2.375861249703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B-97D7-40C8-B743-8BEFE0D4F8BA}"/>
            </c:ext>
          </c:extLst>
        </c:ser>
        <c:ser>
          <c:idx val="220"/>
          <c:order val="220"/>
          <c:tx>
            <c:strRef>
              <c:f>ordem_grafico!$A$223</c:f>
              <c:strCache>
                <c:ptCount val="1"/>
                <c:pt idx="0">
                  <c:v>Pedosphaerale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3:$K$223</c:f>
              <c:numCache>
                <c:formatCode>General</c:formatCode>
                <c:ptCount val="10"/>
                <c:pt idx="0">
                  <c:v>6.7772427322989104E-2</c:v>
                </c:pt>
                <c:pt idx="1">
                  <c:v>1.4176353841791899E-2</c:v>
                </c:pt>
                <c:pt idx="2">
                  <c:v>0.16112175579167401</c:v>
                </c:pt>
                <c:pt idx="3">
                  <c:v>2.0082337584094799E-2</c:v>
                </c:pt>
                <c:pt idx="4">
                  <c:v>0</c:v>
                </c:pt>
                <c:pt idx="5">
                  <c:v>3.9180566439046202E-2</c:v>
                </c:pt>
                <c:pt idx="6">
                  <c:v>5.91162126213113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C-97D7-40C8-B743-8BEFE0D4F8BA}"/>
            </c:ext>
          </c:extLst>
        </c:ser>
        <c:ser>
          <c:idx val="221"/>
          <c:order val="221"/>
          <c:tx>
            <c:strRef>
              <c:f>ordem_grafico!$A$224</c:f>
              <c:strCache>
                <c:ptCount val="1"/>
                <c:pt idx="0">
                  <c:v>S-BQ2-57_soil_group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4:$K$224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D-97D7-40C8-B743-8BEFE0D4F8BA}"/>
            </c:ext>
          </c:extLst>
        </c:ser>
        <c:ser>
          <c:idx val="222"/>
          <c:order val="222"/>
          <c:tx>
            <c:strRef>
              <c:f>ordem_grafico!$A$225</c:f>
              <c:strCache>
                <c:ptCount val="1"/>
                <c:pt idx="0">
                  <c:v>Verrucomicrobiae_unclassified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5:$K$225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E-97D7-40C8-B743-8BEFE0D4F8BA}"/>
            </c:ext>
          </c:extLst>
        </c:ser>
        <c:ser>
          <c:idx val="223"/>
          <c:order val="223"/>
          <c:tx>
            <c:strRef>
              <c:f>ordem_grafico!$A$226</c:f>
              <c:strCache>
                <c:ptCount val="1"/>
                <c:pt idx="0">
                  <c:v>Verrucomicrobiale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6:$K$226</c:f>
              <c:numCache>
                <c:formatCode>General</c:formatCode>
                <c:ptCount val="10"/>
                <c:pt idx="0">
                  <c:v>0.2479044052077760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156722265756185</c:v>
                </c:pt>
                <c:pt idx="6">
                  <c:v>2.95581063106557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DF-97D7-40C8-B743-8BEFE0D4F8BA}"/>
            </c:ext>
          </c:extLst>
        </c:ser>
        <c:ser>
          <c:idx val="224"/>
          <c:order val="224"/>
          <c:tx>
            <c:strRef>
              <c:f>ordem_grafico!$A$227</c:f>
              <c:strCache>
                <c:ptCount val="1"/>
                <c:pt idx="0">
                  <c:v>WPS-2_or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7:$K$227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1.088660512105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E0-97D7-40C8-B743-8BEFE0D4F8BA}"/>
            </c:ext>
          </c:extLst>
        </c:ser>
        <c:ser>
          <c:idx val="225"/>
          <c:order val="225"/>
          <c:tx>
            <c:strRef>
              <c:f>ordem_grafico!$A$228</c:f>
              <c:strCache>
                <c:ptCount val="1"/>
                <c:pt idx="0">
                  <c:v>WS2_or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8:$K$22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16231948953319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E1-97D7-40C8-B743-8BEFE0D4F8BA}"/>
            </c:ext>
          </c:extLst>
        </c:ser>
        <c:ser>
          <c:idx val="226"/>
          <c:order val="226"/>
          <c:tx>
            <c:strRef>
              <c:f>ordem_grafico!$A$229</c:f>
              <c:strCache>
                <c:ptCount val="1"/>
                <c:pt idx="0">
                  <c:v>Zixibacteria_or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29:$K$229</c:f>
              <c:numCache>
                <c:formatCode>General</c:formatCode>
                <c:ptCount val="10"/>
                <c:pt idx="0">
                  <c:v>7.3122882111646206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E2-97D7-40C8-B743-8BEFE0D4F8BA}"/>
            </c:ext>
          </c:extLst>
        </c:ser>
        <c:ser>
          <c:idx val="227"/>
          <c:order val="227"/>
          <c:tx>
            <c:strRef>
              <c:f>ordem_grafico!$A$230</c:f>
              <c:strCache>
                <c:ptCount val="1"/>
                <c:pt idx="0">
                  <c:v>unknown_unclassified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ordem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ordem_grafico!$B$230:$K$230</c:f>
              <c:numCache>
                <c:formatCode>General</c:formatCode>
                <c:ptCount val="10"/>
                <c:pt idx="0">
                  <c:v>7.1339397182093797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E3-97D7-40C8-B743-8BEFE0D4F8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097555808"/>
        <c:axId val="-2097552656"/>
      </c:barChart>
      <c:catAx>
        <c:axId val="-20975558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2097552656"/>
        <c:crosses val="autoZero"/>
        <c:auto val="1"/>
        <c:lblAlgn val="ctr"/>
        <c:lblOffset val="100"/>
        <c:noMultiLvlLbl val="0"/>
      </c:catAx>
      <c:valAx>
        <c:axId val="-209755265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7555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5799881373096036"/>
          <c:y val="2.9463659168565231E-2"/>
          <c:w val="0.34200118626904003"/>
          <c:h val="0.9665028552790150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amily</a:t>
            </a:r>
          </a:p>
        </c:rich>
      </c:tx>
      <c:layout>
        <c:manualLayout>
          <c:xMode val="edge"/>
          <c:yMode val="edge"/>
          <c:x val="0.28858581801869038"/>
          <c:y val="0.119626097799044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4776467489422885E-2"/>
          <c:y val="0.1779434840697296"/>
          <c:w val="0.56322186088688697"/>
          <c:h val="0.62776519711477796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Familia_grafico!$A$3</c:f>
              <c:strCache>
                <c:ptCount val="1"/>
                <c:pt idx="0">
                  <c:v>Rubrobacteriacea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:$K$3</c:f>
              <c:numCache>
                <c:formatCode>General</c:formatCode>
                <c:ptCount val="10"/>
                <c:pt idx="0">
                  <c:v>0.422685928303906</c:v>
                </c:pt>
                <c:pt idx="1">
                  <c:v>12.271996975711181</c:v>
                </c:pt>
                <c:pt idx="2">
                  <c:v>3.8669221390001729</c:v>
                </c:pt>
                <c:pt idx="3">
                  <c:v>13.56059845366001</c:v>
                </c:pt>
                <c:pt idx="4">
                  <c:v>65.326783194007149</c:v>
                </c:pt>
                <c:pt idx="5">
                  <c:v>0.29105563640434301</c:v>
                </c:pt>
                <c:pt idx="6">
                  <c:v>11.315828365929359</c:v>
                </c:pt>
                <c:pt idx="7">
                  <c:v>34.431243383131402</c:v>
                </c:pt>
                <c:pt idx="8">
                  <c:v>24.816609462278759</c:v>
                </c:pt>
                <c:pt idx="9">
                  <c:v>26.531581984183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24-4BB0-950F-03CEDAAFEBEA}"/>
            </c:ext>
          </c:extLst>
        </c:ser>
        <c:ser>
          <c:idx val="1"/>
          <c:order val="1"/>
          <c:tx>
            <c:strRef>
              <c:f>Familia_grafico!$A$4</c:f>
              <c:strCache>
                <c:ptCount val="1"/>
                <c:pt idx="0">
                  <c:v>Pseudonocardiacea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:$K$4</c:f>
              <c:numCache>
                <c:formatCode>General</c:formatCode>
                <c:ptCount val="10"/>
                <c:pt idx="0">
                  <c:v>27.856251114678081</c:v>
                </c:pt>
                <c:pt idx="1">
                  <c:v>10.353463755788679</c:v>
                </c:pt>
                <c:pt idx="2">
                  <c:v>2.7630203797247872</c:v>
                </c:pt>
                <c:pt idx="3">
                  <c:v>9.0019078220704873</c:v>
                </c:pt>
                <c:pt idx="4">
                  <c:v>5.42829225925524E-3</c:v>
                </c:pt>
                <c:pt idx="5">
                  <c:v>0.40300011194447599</c:v>
                </c:pt>
                <c:pt idx="6">
                  <c:v>46.726439726094881</c:v>
                </c:pt>
                <c:pt idx="7">
                  <c:v>5.4660236050660709</c:v>
                </c:pt>
                <c:pt idx="8">
                  <c:v>3.1597011911972541</c:v>
                </c:pt>
                <c:pt idx="9">
                  <c:v>5.62739707429657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C24-4BB0-950F-03CEDAAFEBEA}"/>
            </c:ext>
          </c:extLst>
        </c:ser>
        <c:ser>
          <c:idx val="2"/>
          <c:order val="2"/>
          <c:tx>
            <c:strRef>
              <c:f>Familia_grafico!$A$5</c:f>
              <c:strCache>
                <c:ptCount val="1"/>
                <c:pt idx="0">
                  <c:v>Sphingomonadacea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:$K$5</c:f>
              <c:numCache>
                <c:formatCode>General</c:formatCode>
                <c:ptCount val="10"/>
                <c:pt idx="0">
                  <c:v>1.350098091671126</c:v>
                </c:pt>
                <c:pt idx="1">
                  <c:v>4.5600604857763916</c:v>
                </c:pt>
                <c:pt idx="2">
                  <c:v>7.1089531440515588</c:v>
                </c:pt>
                <c:pt idx="3">
                  <c:v>4.2223114770559276</c:v>
                </c:pt>
                <c:pt idx="4">
                  <c:v>0</c:v>
                </c:pt>
                <c:pt idx="5">
                  <c:v>11.42953095264749</c:v>
                </c:pt>
                <c:pt idx="6">
                  <c:v>0.59608847726489</c:v>
                </c:pt>
                <c:pt idx="7">
                  <c:v>10.563463121985651</c:v>
                </c:pt>
                <c:pt idx="8">
                  <c:v>11.38030823070193</c:v>
                </c:pt>
                <c:pt idx="9">
                  <c:v>16.2882259104639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C24-4BB0-950F-03CEDAAFEBEA}"/>
            </c:ext>
          </c:extLst>
        </c:ser>
        <c:ser>
          <c:idx val="3"/>
          <c:order val="3"/>
          <c:tx>
            <c:strRef>
              <c:f>Familia_grafico!$A$6</c:f>
              <c:strCache>
                <c:ptCount val="1"/>
                <c:pt idx="0">
                  <c:v>Blastocatellacea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:$K$6</c:f>
              <c:numCache>
                <c:formatCode>General</c:formatCode>
                <c:ptCount val="10"/>
                <c:pt idx="0">
                  <c:v>4.5229177813447476</c:v>
                </c:pt>
                <c:pt idx="1">
                  <c:v>5.1460164445704546</c:v>
                </c:pt>
                <c:pt idx="2">
                  <c:v>12.61539801428323</c:v>
                </c:pt>
                <c:pt idx="3">
                  <c:v>4.8448639421628679</c:v>
                </c:pt>
                <c:pt idx="4">
                  <c:v>0</c:v>
                </c:pt>
                <c:pt idx="5">
                  <c:v>6.1905294973693046</c:v>
                </c:pt>
                <c:pt idx="6">
                  <c:v>9.3600669983743001E-2</c:v>
                </c:pt>
                <c:pt idx="7">
                  <c:v>1.1763321962122099E-2</c:v>
                </c:pt>
                <c:pt idx="8">
                  <c:v>9.334410121811695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C24-4BB0-950F-03CEDAAFEBEA}"/>
            </c:ext>
          </c:extLst>
        </c:ser>
        <c:ser>
          <c:idx val="4"/>
          <c:order val="4"/>
          <c:tx>
            <c:strRef>
              <c:f>Familia_grafico!$A$7</c:f>
              <c:strCache>
                <c:ptCount val="1"/>
                <c:pt idx="0">
                  <c:v>Balneolacea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:$K$7</c:f>
              <c:numCache>
                <c:formatCode>General</c:formatCode>
                <c:ptCount val="10"/>
                <c:pt idx="0">
                  <c:v>1.7834849295523501E-2</c:v>
                </c:pt>
                <c:pt idx="1">
                  <c:v>6.8708061619884697</c:v>
                </c:pt>
                <c:pt idx="2">
                  <c:v>0</c:v>
                </c:pt>
                <c:pt idx="3">
                  <c:v>6.8380359473842756</c:v>
                </c:pt>
                <c:pt idx="4">
                  <c:v>28.53110411464554</c:v>
                </c:pt>
                <c:pt idx="5">
                  <c:v>0</c:v>
                </c:pt>
                <c:pt idx="6">
                  <c:v>0.315286467313661</c:v>
                </c:pt>
                <c:pt idx="7">
                  <c:v>3.5289965886366299E-2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C24-4BB0-950F-03CEDAAFEBEA}"/>
            </c:ext>
          </c:extLst>
        </c:ser>
        <c:ser>
          <c:idx val="5"/>
          <c:order val="5"/>
          <c:tx>
            <c:strRef>
              <c:f>Familia_grafico!$A$8</c:f>
              <c:strCache>
                <c:ptCount val="1"/>
                <c:pt idx="0">
                  <c:v>Oxyphotobacteria_unclassifie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:$K$8</c:f>
              <c:numCache>
                <c:formatCode>General</c:formatCode>
                <c:ptCount val="10"/>
                <c:pt idx="0">
                  <c:v>7.9632602104512218</c:v>
                </c:pt>
                <c:pt idx="1">
                  <c:v>8.19865797183631</c:v>
                </c:pt>
                <c:pt idx="2">
                  <c:v>0.21773210242118099</c:v>
                </c:pt>
                <c:pt idx="3">
                  <c:v>7.8873380861532283</c:v>
                </c:pt>
                <c:pt idx="4">
                  <c:v>1.0856584518510499E-2</c:v>
                </c:pt>
                <c:pt idx="5">
                  <c:v>0.12873614687115201</c:v>
                </c:pt>
                <c:pt idx="6">
                  <c:v>0</c:v>
                </c:pt>
                <c:pt idx="7">
                  <c:v>4.2112692624397132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C24-4BB0-950F-03CEDAAFEBEA}"/>
            </c:ext>
          </c:extLst>
        </c:ser>
        <c:ser>
          <c:idx val="6"/>
          <c:order val="6"/>
          <c:tx>
            <c:strRef>
              <c:f>Familia_grafico!$A$9</c:f>
              <c:strCache>
                <c:ptCount val="1"/>
                <c:pt idx="0">
                  <c:v>uncultured_f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:$K$9</c:f>
              <c:numCache>
                <c:formatCode>General</c:formatCode>
                <c:ptCount val="10"/>
                <c:pt idx="0">
                  <c:v>0</c:v>
                </c:pt>
                <c:pt idx="1">
                  <c:v>7.08817692089595E-2</c:v>
                </c:pt>
                <c:pt idx="2">
                  <c:v>25.037014457411601</c:v>
                </c:pt>
                <c:pt idx="3">
                  <c:v>3.0123506376142199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C24-4BB0-950F-03CEDAAFEBEA}"/>
            </c:ext>
          </c:extLst>
        </c:ser>
        <c:ser>
          <c:idx val="7"/>
          <c:order val="7"/>
          <c:tx>
            <c:strRef>
              <c:f>Familia_grafico!$A$10</c:f>
              <c:strCache>
                <c:ptCount val="1"/>
                <c:pt idx="0">
                  <c:v>Burkholderiaceae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0:$K$10</c:f>
              <c:numCache>
                <c:formatCode>General</c:formatCode>
                <c:ptCount val="10"/>
                <c:pt idx="0">
                  <c:v>1.1788835384341001</c:v>
                </c:pt>
                <c:pt idx="1">
                  <c:v>1.096304697098573</c:v>
                </c:pt>
                <c:pt idx="2">
                  <c:v>0.79254485281309905</c:v>
                </c:pt>
                <c:pt idx="3">
                  <c:v>1.0593433075609999</c:v>
                </c:pt>
                <c:pt idx="4">
                  <c:v>0</c:v>
                </c:pt>
                <c:pt idx="5">
                  <c:v>17.312213142281429</c:v>
                </c:pt>
                <c:pt idx="6">
                  <c:v>4.4337159465983503E-2</c:v>
                </c:pt>
                <c:pt idx="7">
                  <c:v>7.8422146414147392E-3</c:v>
                </c:pt>
                <c:pt idx="8">
                  <c:v>2.4194091123224979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3C24-4BB0-950F-03CEDAAFEBEA}"/>
            </c:ext>
          </c:extLst>
        </c:ser>
        <c:ser>
          <c:idx val="8"/>
          <c:order val="8"/>
          <c:tx>
            <c:strRef>
              <c:f>Familia_grafico!$A$11</c:f>
              <c:strCache>
                <c:ptCount val="1"/>
                <c:pt idx="0">
                  <c:v>Rhodothermaceae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1:$K$11</c:f>
              <c:numCache>
                <c:formatCode>General</c:formatCode>
                <c:ptCount val="10"/>
                <c:pt idx="0">
                  <c:v>0.27465667915106101</c:v>
                </c:pt>
                <c:pt idx="1">
                  <c:v>0.42056516397315902</c:v>
                </c:pt>
                <c:pt idx="2">
                  <c:v>0.33530743772861898</c:v>
                </c:pt>
                <c:pt idx="3">
                  <c:v>0.33637915453358802</c:v>
                </c:pt>
                <c:pt idx="4">
                  <c:v>0</c:v>
                </c:pt>
                <c:pt idx="5">
                  <c:v>0.190305608418225</c:v>
                </c:pt>
                <c:pt idx="6">
                  <c:v>0</c:v>
                </c:pt>
                <c:pt idx="7">
                  <c:v>0</c:v>
                </c:pt>
                <c:pt idx="8">
                  <c:v>2.018978396931153</c:v>
                </c:pt>
                <c:pt idx="9">
                  <c:v>17.333604860333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C24-4BB0-950F-03CEDAAFEBEA}"/>
            </c:ext>
          </c:extLst>
        </c:ser>
        <c:ser>
          <c:idx val="9"/>
          <c:order val="9"/>
          <c:tx>
            <c:strRef>
              <c:f>Familia_grafico!$A$12</c:f>
              <c:strCache>
                <c:ptCount val="1"/>
                <c:pt idx="0">
                  <c:v>JG30-KF-CM45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2:$K$12</c:f>
              <c:numCache>
                <c:formatCode>General</c:formatCode>
                <c:ptCount val="10"/>
                <c:pt idx="0">
                  <c:v>0.57428214731585503</c:v>
                </c:pt>
                <c:pt idx="1">
                  <c:v>1.8476514507135431</c:v>
                </c:pt>
                <c:pt idx="2">
                  <c:v>4.1739244034140404</c:v>
                </c:pt>
                <c:pt idx="3">
                  <c:v>1.7069986946480571</c:v>
                </c:pt>
                <c:pt idx="4">
                  <c:v>0</c:v>
                </c:pt>
                <c:pt idx="5">
                  <c:v>0.30225008395835701</c:v>
                </c:pt>
                <c:pt idx="6">
                  <c:v>2.2907532390758161</c:v>
                </c:pt>
                <c:pt idx="7">
                  <c:v>1.615496216131435</c:v>
                </c:pt>
                <c:pt idx="8">
                  <c:v>3.1630661551921402</c:v>
                </c:pt>
                <c:pt idx="9">
                  <c:v>3.89980653701252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3C24-4BB0-950F-03CEDAAFEBEA}"/>
            </c:ext>
          </c:extLst>
        </c:ser>
        <c:ser>
          <c:idx val="10"/>
          <c:order val="10"/>
          <c:tx>
            <c:strRef>
              <c:f>Familia_grafico!$A$13</c:f>
              <c:strCache>
                <c:ptCount val="1"/>
                <c:pt idx="0">
                  <c:v>Rhodobacteraceae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3:$K$13</c:f>
              <c:numCache>
                <c:formatCode>General</c:formatCode>
                <c:ptCount val="10"/>
                <c:pt idx="0">
                  <c:v>0.13554485464597801</c:v>
                </c:pt>
                <c:pt idx="1">
                  <c:v>2.0083167942538509</c:v>
                </c:pt>
                <c:pt idx="2">
                  <c:v>5.8765894443476752</c:v>
                </c:pt>
                <c:pt idx="3">
                  <c:v>1.932924992469123</c:v>
                </c:pt>
                <c:pt idx="4">
                  <c:v>0.165562913907285</c:v>
                </c:pt>
                <c:pt idx="5">
                  <c:v>1.50005597223777</c:v>
                </c:pt>
                <c:pt idx="6">
                  <c:v>0.108379723139071</c:v>
                </c:pt>
                <c:pt idx="7">
                  <c:v>0.57640277614398305</c:v>
                </c:pt>
                <c:pt idx="8">
                  <c:v>4.1288108217242057</c:v>
                </c:pt>
                <c:pt idx="9">
                  <c:v>0.48196042493975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C24-4BB0-950F-03CEDAAFEBEA}"/>
            </c:ext>
          </c:extLst>
        </c:ser>
        <c:ser>
          <c:idx val="11"/>
          <c:order val="11"/>
          <c:tx>
            <c:strRef>
              <c:f>Familia_grafico!$A$14</c:f>
              <c:strCache>
                <c:ptCount val="1"/>
                <c:pt idx="0">
                  <c:v>Rhizobiaceae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4:$K$14</c:f>
              <c:numCache>
                <c:formatCode>General</c:formatCode>
                <c:ptCount val="10"/>
                <c:pt idx="0">
                  <c:v>1.079008382379169</c:v>
                </c:pt>
                <c:pt idx="1">
                  <c:v>1.526320763632927</c:v>
                </c:pt>
                <c:pt idx="2">
                  <c:v>0.87963769378157097</c:v>
                </c:pt>
                <c:pt idx="3">
                  <c:v>1.350537202530375</c:v>
                </c:pt>
                <c:pt idx="4">
                  <c:v>0</c:v>
                </c:pt>
                <c:pt idx="5">
                  <c:v>0.21269450352625099</c:v>
                </c:pt>
                <c:pt idx="6">
                  <c:v>0.88181683826789503</c:v>
                </c:pt>
                <c:pt idx="7">
                  <c:v>6.9560443869348703</c:v>
                </c:pt>
                <c:pt idx="8">
                  <c:v>0.50474459923278803</c:v>
                </c:pt>
                <c:pt idx="9">
                  <c:v>3.00037334962495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3C24-4BB0-950F-03CEDAAFEBEA}"/>
            </c:ext>
          </c:extLst>
        </c:ser>
        <c:ser>
          <c:idx val="12"/>
          <c:order val="12"/>
          <c:tx>
            <c:strRef>
              <c:f>Familia_grafico!$A$15</c:f>
              <c:strCache>
                <c:ptCount val="1"/>
                <c:pt idx="0">
                  <c:v>AKYG1722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5:$K$15</c:f>
              <c:numCache>
                <c:formatCode>General</c:formatCode>
                <c:ptCount val="10"/>
                <c:pt idx="0">
                  <c:v>0.37988228999465001</c:v>
                </c:pt>
                <c:pt idx="1">
                  <c:v>4.158397126925621</c:v>
                </c:pt>
                <c:pt idx="2">
                  <c:v>1.524124716948267</c:v>
                </c:pt>
                <c:pt idx="3">
                  <c:v>4.5637112159855402</c:v>
                </c:pt>
                <c:pt idx="4">
                  <c:v>0</c:v>
                </c:pt>
                <c:pt idx="5">
                  <c:v>0.22948617485727099</c:v>
                </c:pt>
                <c:pt idx="6">
                  <c:v>2.0050248780728119</c:v>
                </c:pt>
                <c:pt idx="7">
                  <c:v>5.4895502489903103E-2</c:v>
                </c:pt>
                <c:pt idx="8">
                  <c:v>1.413284877851807</c:v>
                </c:pt>
                <c:pt idx="9">
                  <c:v>0.85531004989308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3C24-4BB0-950F-03CEDAAFEBEA}"/>
            </c:ext>
          </c:extLst>
        </c:ser>
        <c:ser>
          <c:idx val="13"/>
          <c:order val="13"/>
          <c:tx>
            <c:strRef>
              <c:f>Familia_grafico!$A$16</c:f>
              <c:strCache>
                <c:ptCount val="1"/>
                <c:pt idx="0">
                  <c:v>Intrasporangiaceae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6:$K$16</c:f>
              <c:numCache>
                <c:formatCode>General</c:formatCode>
                <c:ptCount val="10"/>
                <c:pt idx="0">
                  <c:v>2.8535758872837502E-2</c:v>
                </c:pt>
                <c:pt idx="1">
                  <c:v>0.85530668178811098</c:v>
                </c:pt>
                <c:pt idx="2">
                  <c:v>1.74185681936945E-2</c:v>
                </c:pt>
                <c:pt idx="3">
                  <c:v>0.67275830906717604</c:v>
                </c:pt>
                <c:pt idx="4">
                  <c:v>0</c:v>
                </c:pt>
                <c:pt idx="5">
                  <c:v>4.4777790216052799E-2</c:v>
                </c:pt>
                <c:pt idx="6">
                  <c:v>0.48770875412581899</c:v>
                </c:pt>
                <c:pt idx="7">
                  <c:v>10.975179390659919</c:v>
                </c:pt>
                <c:pt idx="8">
                  <c:v>6.7299279897705096E-3</c:v>
                </c:pt>
                <c:pt idx="9">
                  <c:v>0.75688151240539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3C24-4BB0-950F-03CEDAAFEBEA}"/>
            </c:ext>
          </c:extLst>
        </c:ser>
        <c:ser>
          <c:idx val="14"/>
          <c:order val="14"/>
          <c:tx>
            <c:strRef>
              <c:f>Familia_grafico!$A$17</c:f>
              <c:strCache>
                <c:ptCount val="1"/>
                <c:pt idx="0">
                  <c:v>Xanthomonadaceae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7:$K$17</c:f>
              <c:numCache>
                <c:formatCode>General</c:formatCode>
                <c:ptCount val="10"/>
                <c:pt idx="0">
                  <c:v>3.1674692348849649</c:v>
                </c:pt>
                <c:pt idx="1">
                  <c:v>1.8429259994329461</c:v>
                </c:pt>
                <c:pt idx="2">
                  <c:v>0.57481275039191804</c:v>
                </c:pt>
                <c:pt idx="3">
                  <c:v>2.0333366803895978</c:v>
                </c:pt>
                <c:pt idx="4">
                  <c:v>0</c:v>
                </c:pt>
                <c:pt idx="5">
                  <c:v>0.74443076234187799</c:v>
                </c:pt>
                <c:pt idx="6">
                  <c:v>0.42859254150450798</c:v>
                </c:pt>
                <c:pt idx="7">
                  <c:v>2.6820374073638389</c:v>
                </c:pt>
                <c:pt idx="8">
                  <c:v>0.89844538663436302</c:v>
                </c:pt>
                <c:pt idx="9">
                  <c:v>1.23205376234599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3C24-4BB0-950F-03CEDAAFEBEA}"/>
            </c:ext>
          </c:extLst>
        </c:ser>
        <c:ser>
          <c:idx val="15"/>
          <c:order val="15"/>
          <c:tx>
            <c:strRef>
              <c:f>Familia_grafico!$A$18</c:f>
              <c:strCache>
                <c:ptCount val="1"/>
                <c:pt idx="0">
                  <c:v>Nocardioidaceae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8:$K$18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.64266137416123204</c:v>
                </c:pt>
                <c:pt idx="2">
                  <c:v>3.113569064622888</c:v>
                </c:pt>
                <c:pt idx="3">
                  <c:v>0.707902399839341</c:v>
                </c:pt>
                <c:pt idx="4">
                  <c:v>5.42829225925524E-3</c:v>
                </c:pt>
                <c:pt idx="5">
                  <c:v>1.6791671331019799E-2</c:v>
                </c:pt>
                <c:pt idx="6">
                  <c:v>0.374402679934972</c:v>
                </c:pt>
                <c:pt idx="7">
                  <c:v>0.56856056150256795</c:v>
                </c:pt>
                <c:pt idx="8">
                  <c:v>7.325526616865198</c:v>
                </c:pt>
                <c:pt idx="9">
                  <c:v>0.787428299901572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3C24-4BB0-950F-03CEDAAFEBEA}"/>
            </c:ext>
          </c:extLst>
        </c:ser>
        <c:ser>
          <c:idx val="16"/>
          <c:order val="16"/>
          <c:tx>
            <c:strRef>
              <c:f>Familia_grafico!$A$19</c:f>
              <c:strCache>
                <c:ptCount val="1"/>
                <c:pt idx="0">
                  <c:v>Gammaproteobacteria_unclassified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9:$K$19</c:f>
              <c:numCache>
                <c:formatCode>General</c:formatCode>
                <c:ptCount val="10"/>
                <c:pt idx="0">
                  <c:v>0.26038879971464302</c:v>
                </c:pt>
                <c:pt idx="1">
                  <c:v>0.16066534354030801</c:v>
                </c:pt>
                <c:pt idx="2">
                  <c:v>4.964291935202926</c:v>
                </c:pt>
                <c:pt idx="3">
                  <c:v>0.28115272617732701</c:v>
                </c:pt>
                <c:pt idx="4">
                  <c:v>0</c:v>
                </c:pt>
                <c:pt idx="5">
                  <c:v>4.7016679726855477</c:v>
                </c:pt>
                <c:pt idx="6">
                  <c:v>0.51726686043647496</c:v>
                </c:pt>
                <c:pt idx="7">
                  <c:v>3.1368858565658901E-2</c:v>
                </c:pt>
                <c:pt idx="8">
                  <c:v>1.655562285483545</c:v>
                </c:pt>
                <c:pt idx="9">
                  <c:v>0.648270712418966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3C24-4BB0-950F-03CEDAAFEBEA}"/>
            </c:ext>
          </c:extLst>
        </c:ser>
        <c:ser>
          <c:idx val="17"/>
          <c:order val="17"/>
          <c:tx>
            <c:strRef>
              <c:f>Familia_grafico!$A$20</c:f>
              <c:strCache>
                <c:ptCount val="1"/>
                <c:pt idx="0">
                  <c:v>Solibacteraceae_(Subgroup_3)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0:$K$20</c:f>
              <c:numCache>
                <c:formatCode>General</c:formatCode>
                <c:ptCount val="10"/>
                <c:pt idx="0">
                  <c:v>0.74014624576422305</c:v>
                </c:pt>
                <c:pt idx="1">
                  <c:v>1.6208297892448731</c:v>
                </c:pt>
                <c:pt idx="2">
                  <c:v>1.770161992684202</c:v>
                </c:pt>
                <c:pt idx="3">
                  <c:v>1.5563811627673461</c:v>
                </c:pt>
                <c:pt idx="4">
                  <c:v>0</c:v>
                </c:pt>
                <c:pt idx="5">
                  <c:v>3.5542370983991942</c:v>
                </c:pt>
                <c:pt idx="6">
                  <c:v>0.187201339967486</c:v>
                </c:pt>
                <c:pt idx="7">
                  <c:v>0</c:v>
                </c:pt>
                <c:pt idx="8">
                  <c:v>2.85685443165758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3C24-4BB0-950F-03CEDAAFEBEA}"/>
            </c:ext>
          </c:extLst>
        </c:ser>
        <c:ser>
          <c:idx val="18"/>
          <c:order val="18"/>
          <c:tx>
            <c:strRef>
              <c:f>Familia_grafico!$A$21</c:f>
              <c:strCache>
                <c:ptCount val="1"/>
                <c:pt idx="0">
                  <c:v>0319-7L14_fa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1:$K$21</c:f>
              <c:numCache>
                <c:formatCode>General</c:formatCode>
                <c:ptCount val="10"/>
                <c:pt idx="0">
                  <c:v>11.883360085607279</c:v>
                </c:pt>
                <c:pt idx="1">
                  <c:v>0</c:v>
                </c:pt>
                <c:pt idx="2">
                  <c:v>2.395053126632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24139120153702201</c:v>
                </c:pt>
                <c:pt idx="7">
                  <c:v>0</c:v>
                </c:pt>
                <c:pt idx="8">
                  <c:v>8.0759135877246202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3C24-4BB0-950F-03CEDAAFEBEA}"/>
            </c:ext>
          </c:extLst>
        </c:ser>
        <c:ser>
          <c:idx val="19"/>
          <c:order val="19"/>
          <c:tx>
            <c:strRef>
              <c:f>Familia_grafico!$A$22</c:f>
              <c:strCache>
                <c:ptCount val="1"/>
                <c:pt idx="0">
                  <c:v>Cyclobacteriaceae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2:$K$22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.51507418958510498</c:v>
                </c:pt>
                <c:pt idx="2">
                  <c:v>0.11539801428322601</c:v>
                </c:pt>
                <c:pt idx="3">
                  <c:v>0.507079023998394</c:v>
                </c:pt>
                <c:pt idx="4">
                  <c:v>0</c:v>
                </c:pt>
                <c:pt idx="5">
                  <c:v>0.13993059442516501</c:v>
                </c:pt>
                <c:pt idx="6">
                  <c:v>0.49756145622937098</c:v>
                </c:pt>
                <c:pt idx="7">
                  <c:v>0.63129827863388599</c:v>
                </c:pt>
                <c:pt idx="8">
                  <c:v>1.0027592704758059</c:v>
                </c:pt>
                <c:pt idx="9">
                  <c:v>8.3426670739571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3C24-4BB0-950F-03CEDAAFEBEA}"/>
            </c:ext>
          </c:extLst>
        </c:ser>
        <c:ser>
          <c:idx val="20"/>
          <c:order val="20"/>
          <c:tx>
            <c:strRef>
              <c:f>Familia_grafico!$A$23</c:f>
              <c:strCache>
                <c:ptCount val="1"/>
                <c:pt idx="0">
                  <c:v>Nostocales_unclassified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3:$K$23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3.388148568188261</c:v>
                </c:pt>
                <c:pt idx="2">
                  <c:v>1.0015676711374319</c:v>
                </c:pt>
                <c:pt idx="3">
                  <c:v>4.3679084245406168</c:v>
                </c:pt>
                <c:pt idx="4">
                  <c:v>0</c:v>
                </c:pt>
                <c:pt idx="5">
                  <c:v>0.31344453151237001</c:v>
                </c:pt>
                <c:pt idx="6">
                  <c:v>0.18227498891571001</c:v>
                </c:pt>
                <c:pt idx="7">
                  <c:v>7.8422146414147392E-3</c:v>
                </c:pt>
                <c:pt idx="8">
                  <c:v>4.3744531933508302E-2</c:v>
                </c:pt>
                <c:pt idx="9">
                  <c:v>1.72080236228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3C24-4BB0-950F-03CEDAAFEBEA}"/>
            </c:ext>
          </c:extLst>
        </c:ser>
        <c:ser>
          <c:idx val="21"/>
          <c:order val="21"/>
          <c:tx>
            <c:strRef>
              <c:f>Familia_grafico!$A$24</c:f>
              <c:strCache>
                <c:ptCount val="1"/>
                <c:pt idx="0">
                  <c:v>Nitrococcaceae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4:$K$24</c:f>
              <c:numCache>
                <c:formatCode>General</c:formatCode>
                <c:ptCount val="10"/>
                <c:pt idx="0">
                  <c:v>3.5669698591046899E-2</c:v>
                </c:pt>
                <c:pt idx="1">
                  <c:v>3.8984973064927702</c:v>
                </c:pt>
                <c:pt idx="2">
                  <c:v>0</c:v>
                </c:pt>
                <c:pt idx="3">
                  <c:v>3.6851089466813942</c:v>
                </c:pt>
                <c:pt idx="4">
                  <c:v>0.10856584518510499</c:v>
                </c:pt>
                <c:pt idx="5">
                  <c:v>0</c:v>
                </c:pt>
                <c:pt idx="6">
                  <c:v>0.15764323365683</c:v>
                </c:pt>
                <c:pt idx="7">
                  <c:v>0.87440693251774304</c:v>
                </c:pt>
                <c:pt idx="8">
                  <c:v>1.00948919846558E-2</c:v>
                </c:pt>
                <c:pt idx="9">
                  <c:v>0.1052167124868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3C24-4BB0-950F-03CEDAAFEBEA}"/>
            </c:ext>
          </c:extLst>
        </c:ser>
        <c:ser>
          <c:idx val="22"/>
          <c:order val="22"/>
          <c:tx>
            <c:strRef>
              <c:f>Familia_grafico!$A$25</c:f>
              <c:strCache>
                <c:ptCount val="1"/>
                <c:pt idx="0">
                  <c:v>Iamiaceae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5:$K$25</c:f>
              <c:numCache>
                <c:formatCode>General</c:formatCode>
                <c:ptCount val="10"/>
                <c:pt idx="0">
                  <c:v>0.24255395041911901</c:v>
                </c:pt>
                <c:pt idx="1">
                  <c:v>0.88838484075229196</c:v>
                </c:pt>
                <c:pt idx="2">
                  <c:v>1.5197700748998431</c:v>
                </c:pt>
                <c:pt idx="3">
                  <c:v>1.0141580479967871</c:v>
                </c:pt>
                <c:pt idx="4">
                  <c:v>0</c:v>
                </c:pt>
                <c:pt idx="5">
                  <c:v>0.59330572036270002</c:v>
                </c:pt>
                <c:pt idx="6">
                  <c:v>0.91137494457855095</c:v>
                </c:pt>
                <c:pt idx="7">
                  <c:v>1.552758499000118</c:v>
                </c:pt>
                <c:pt idx="8">
                  <c:v>1.5647082576216429</c:v>
                </c:pt>
                <c:pt idx="9">
                  <c:v>0.5430539999321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3C24-4BB0-950F-03CEDAAFEBEA}"/>
            </c:ext>
          </c:extLst>
        </c:ser>
        <c:ser>
          <c:idx val="23"/>
          <c:order val="23"/>
          <c:tx>
            <c:strRef>
              <c:f>Familia_grafico!$A$26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6:$K$26</c:f>
              <c:numCache>
                <c:formatCode>General</c:formatCode>
                <c:ptCount val="10"/>
                <c:pt idx="0">
                  <c:v>0.36026395576957398</c:v>
                </c:pt>
                <c:pt idx="1">
                  <c:v>7.5607220489556801E-2</c:v>
                </c:pt>
                <c:pt idx="2">
                  <c:v>0</c:v>
                </c:pt>
                <c:pt idx="3">
                  <c:v>9.0370519128426502E-2</c:v>
                </c:pt>
                <c:pt idx="4">
                  <c:v>0</c:v>
                </c:pt>
                <c:pt idx="5">
                  <c:v>0.26866674129631701</c:v>
                </c:pt>
                <c:pt idx="6">
                  <c:v>7.8131927681166546</c:v>
                </c:pt>
                <c:pt idx="7">
                  <c:v>7.8422146414147392E-3</c:v>
                </c:pt>
                <c:pt idx="8">
                  <c:v>4.3744531933508302E-2</c:v>
                </c:pt>
                <c:pt idx="9">
                  <c:v>6.44876624919391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3C24-4BB0-950F-03CEDAAFEBEA}"/>
            </c:ext>
          </c:extLst>
        </c:ser>
        <c:ser>
          <c:idx val="24"/>
          <c:order val="24"/>
          <c:tx>
            <c:strRef>
              <c:f>Familia_grafico!$A$27</c:f>
              <c:strCache>
                <c:ptCount val="1"/>
                <c:pt idx="0">
                  <c:v>Chitinophagacea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7:$K$27</c:f>
              <c:numCache>
                <c:formatCode>General</c:formatCode>
                <c:ptCount val="10"/>
                <c:pt idx="0">
                  <c:v>3.5669698591046899E-3</c:v>
                </c:pt>
                <c:pt idx="1">
                  <c:v>0.47727057934032702</c:v>
                </c:pt>
                <c:pt idx="2">
                  <c:v>1.3151018986239329</c:v>
                </c:pt>
                <c:pt idx="3">
                  <c:v>0.466914348830204</c:v>
                </c:pt>
                <c:pt idx="4">
                  <c:v>0</c:v>
                </c:pt>
                <c:pt idx="5">
                  <c:v>1.11944475540132E-2</c:v>
                </c:pt>
                <c:pt idx="6">
                  <c:v>0</c:v>
                </c:pt>
                <c:pt idx="7">
                  <c:v>0</c:v>
                </c:pt>
                <c:pt idx="8">
                  <c:v>5.861767279090114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3C24-4BB0-950F-03CEDAAFEBEA}"/>
            </c:ext>
          </c:extLst>
        </c:ser>
        <c:ser>
          <c:idx val="25"/>
          <c:order val="25"/>
          <c:tx>
            <c:strRef>
              <c:f>Familia_grafico!$A$28</c:f>
              <c:strCache>
                <c:ptCount val="1"/>
                <c:pt idx="0">
                  <c:v>Flavobacteriaceae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8:$K$28</c:f>
              <c:numCache>
                <c:formatCode>General</c:formatCode>
                <c:ptCount val="10"/>
                <c:pt idx="0">
                  <c:v>0</c:v>
                </c:pt>
                <c:pt idx="1">
                  <c:v>0.60013231263585698</c:v>
                </c:pt>
                <c:pt idx="2">
                  <c:v>0</c:v>
                </c:pt>
                <c:pt idx="3">
                  <c:v>0.67777889346319897</c:v>
                </c:pt>
                <c:pt idx="4">
                  <c:v>4.2802084464227557</c:v>
                </c:pt>
                <c:pt idx="5">
                  <c:v>6.1569461547072699E-2</c:v>
                </c:pt>
                <c:pt idx="6">
                  <c:v>0.46800334991871501</c:v>
                </c:pt>
                <c:pt idx="7">
                  <c:v>1.5684429282829499E-2</c:v>
                </c:pt>
                <c:pt idx="8">
                  <c:v>0</c:v>
                </c:pt>
                <c:pt idx="9">
                  <c:v>1.16077792485490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3C24-4BB0-950F-03CEDAAFEBEA}"/>
            </c:ext>
          </c:extLst>
        </c:ser>
        <c:ser>
          <c:idx val="26"/>
          <c:order val="26"/>
          <c:tx>
            <c:strRef>
              <c:f>Familia_grafico!$A$29</c:f>
              <c:strCache>
                <c:ptCount val="1"/>
                <c:pt idx="0">
                  <c:v>Propionibacteriaceae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29:$K$29</c:f>
              <c:numCache>
                <c:formatCode>General</c:formatCode>
                <c:ptCount val="10"/>
                <c:pt idx="0">
                  <c:v>9.4524701266274297E-2</c:v>
                </c:pt>
                <c:pt idx="1">
                  <c:v>3.132974199036008</c:v>
                </c:pt>
                <c:pt idx="2">
                  <c:v>0</c:v>
                </c:pt>
                <c:pt idx="3">
                  <c:v>2.7864243397931521</c:v>
                </c:pt>
                <c:pt idx="4">
                  <c:v>8.14243838888286E-3</c:v>
                </c:pt>
                <c:pt idx="5">
                  <c:v>5.5972237770066102E-3</c:v>
                </c:pt>
                <c:pt idx="6">
                  <c:v>0.83747967880191099</c:v>
                </c:pt>
                <c:pt idx="7">
                  <c:v>2.74477512449516E-2</c:v>
                </c:pt>
                <c:pt idx="8">
                  <c:v>6.7299279897705096E-3</c:v>
                </c:pt>
                <c:pt idx="9">
                  <c:v>5.09113124936360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3C24-4BB0-950F-03CEDAAFEBEA}"/>
            </c:ext>
          </c:extLst>
        </c:ser>
        <c:ser>
          <c:idx val="27"/>
          <c:order val="27"/>
          <c:tx>
            <c:strRef>
              <c:f>Familia_grafico!$A$30</c:f>
              <c:strCache>
                <c:ptCount val="1"/>
                <c:pt idx="0">
                  <c:v>Ilumatobacteraceae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0:$K$30</c:f>
              <c:numCache>
                <c:formatCode>General</c:formatCode>
                <c:ptCount val="10"/>
                <c:pt idx="0">
                  <c:v>1.219903691813804</c:v>
                </c:pt>
                <c:pt idx="1">
                  <c:v>0.47727057934032702</c:v>
                </c:pt>
                <c:pt idx="2">
                  <c:v>1.2911513673576029</c:v>
                </c:pt>
                <c:pt idx="3">
                  <c:v>0.45185259564213298</c:v>
                </c:pt>
                <c:pt idx="4">
                  <c:v>5.42829225925524E-3</c:v>
                </c:pt>
                <c:pt idx="5">
                  <c:v>1.2034031120564199</c:v>
                </c:pt>
                <c:pt idx="6">
                  <c:v>0.20690674417459001</c:v>
                </c:pt>
                <c:pt idx="7">
                  <c:v>0.39603183939144398</c:v>
                </c:pt>
                <c:pt idx="8">
                  <c:v>0.84460596271619903</c:v>
                </c:pt>
                <c:pt idx="9">
                  <c:v>0.519295387435087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3C24-4BB0-950F-03CEDAAFEBEA}"/>
            </c:ext>
          </c:extLst>
        </c:ser>
        <c:ser>
          <c:idx val="28"/>
          <c:order val="28"/>
          <c:tx>
            <c:strRef>
              <c:f>Familia_grafico!$A$31</c:f>
              <c:strCache>
                <c:ptCount val="1"/>
                <c:pt idx="0">
                  <c:v>Gemmatimonadaceae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1:$K$31</c:f>
              <c:numCache>
                <c:formatCode>General</c:formatCode>
                <c:ptCount val="10"/>
                <c:pt idx="0">
                  <c:v>1.970750847155341</c:v>
                </c:pt>
                <c:pt idx="1">
                  <c:v>0.60013231263585698</c:v>
                </c:pt>
                <c:pt idx="2">
                  <c:v>0.58134471346455296</c:v>
                </c:pt>
                <c:pt idx="3">
                  <c:v>0.587408374334773</c:v>
                </c:pt>
                <c:pt idx="4">
                  <c:v>0</c:v>
                </c:pt>
                <c:pt idx="5">
                  <c:v>0.86756968543602397</c:v>
                </c:pt>
                <c:pt idx="6">
                  <c:v>0.44829794571161102</c:v>
                </c:pt>
                <c:pt idx="7">
                  <c:v>1.1763321962122099E-2</c:v>
                </c:pt>
                <c:pt idx="8">
                  <c:v>0.86479574668551096</c:v>
                </c:pt>
                <c:pt idx="9">
                  <c:v>3.7334962495333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3C24-4BB0-950F-03CEDAAFEBEA}"/>
            </c:ext>
          </c:extLst>
        </c:ser>
        <c:ser>
          <c:idx val="29"/>
          <c:order val="29"/>
          <c:tx>
            <c:strRef>
              <c:f>Familia_grafico!$A$32</c:f>
              <c:strCache>
                <c:ptCount val="1"/>
                <c:pt idx="0">
                  <c:v>Nitriliruptoracea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2:$K$32</c:f>
              <c:numCache>
                <c:formatCode>General</c:formatCode>
                <c:ptCount val="10"/>
                <c:pt idx="0">
                  <c:v>6.4205457463884397E-2</c:v>
                </c:pt>
                <c:pt idx="1">
                  <c:v>1.686986107173235</c:v>
                </c:pt>
                <c:pt idx="2">
                  <c:v>1.0886605121059E-2</c:v>
                </c:pt>
                <c:pt idx="3">
                  <c:v>1.646751681895773</c:v>
                </c:pt>
                <c:pt idx="4">
                  <c:v>0.119422429703615</c:v>
                </c:pt>
                <c:pt idx="5">
                  <c:v>2.2388895108026399E-2</c:v>
                </c:pt>
                <c:pt idx="6">
                  <c:v>0.43351889255628401</c:v>
                </c:pt>
                <c:pt idx="7">
                  <c:v>1.278280986550602</c:v>
                </c:pt>
                <c:pt idx="8">
                  <c:v>1.6824819974426301E-2</c:v>
                </c:pt>
                <c:pt idx="9">
                  <c:v>0.26473882496690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3C24-4BB0-950F-03CEDAAFEBEA}"/>
            </c:ext>
          </c:extLst>
        </c:ser>
        <c:ser>
          <c:idx val="30"/>
          <c:order val="30"/>
          <c:tx>
            <c:strRef>
              <c:f>Familia_grafico!$A$33</c:f>
              <c:strCache>
                <c:ptCount val="1"/>
                <c:pt idx="0">
                  <c:v>Halomonadaceae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3:$K$33</c:f>
              <c:numCache>
                <c:formatCode>General</c:formatCode>
                <c:ptCount val="10"/>
                <c:pt idx="0">
                  <c:v>0</c:v>
                </c:pt>
                <c:pt idx="1">
                  <c:v>1.819298743029959</c:v>
                </c:pt>
                <c:pt idx="2">
                  <c:v>4.3546420484236199E-3</c:v>
                </c:pt>
                <c:pt idx="3">
                  <c:v>1.9730896676373131</c:v>
                </c:pt>
                <c:pt idx="4">
                  <c:v>0.488546303332972</c:v>
                </c:pt>
                <c:pt idx="5">
                  <c:v>0</c:v>
                </c:pt>
                <c:pt idx="6">
                  <c:v>0</c:v>
                </c:pt>
                <c:pt idx="7">
                  <c:v>0.192134258714661</c:v>
                </c:pt>
                <c:pt idx="8">
                  <c:v>0</c:v>
                </c:pt>
                <c:pt idx="9">
                  <c:v>8.145809998981770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3C24-4BB0-950F-03CEDAAFEBEA}"/>
            </c:ext>
          </c:extLst>
        </c:ser>
        <c:ser>
          <c:idx val="31"/>
          <c:order val="31"/>
          <c:tx>
            <c:strRef>
              <c:f>Familia_grafico!$A$34</c:f>
              <c:strCache>
                <c:ptCount val="1"/>
                <c:pt idx="0">
                  <c:v>Longimicrobiaceae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4:$K$34</c:f>
              <c:numCache>
                <c:formatCode>General</c:formatCode>
                <c:ptCount val="10"/>
                <c:pt idx="0">
                  <c:v>4.2803638309256299E-2</c:v>
                </c:pt>
                <c:pt idx="1">
                  <c:v>1.4034590303373971</c:v>
                </c:pt>
                <c:pt idx="2">
                  <c:v>0.15894443476746201</c:v>
                </c:pt>
                <c:pt idx="3">
                  <c:v>1.611607591123607</c:v>
                </c:pt>
                <c:pt idx="4">
                  <c:v>0</c:v>
                </c:pt>
                <c:pt idx="5">
                  <c:v>0.31344453151237001</c:v>
                </c:pt>
                <c:pt idx="6">
                  <c:v>0.25124390364057297</c:v>
                </c:pt>
                <c:pt idx="7">
                  <c:v>0</c:v>
                </c:pt>
                <c:pt idx="8">
                  <c:v>0.215357695672656</c:v>
                </c:pt>
                <c:pt idx="9">
                  <c:v>0.556630349930421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3C24-4BB0-950F-03CEDAAFEBEA}"/>
            </c:ext>
          </c:extLst>
        </c:ser>
        <c:ser>
          <c:idx val="32"/>
          <c:order val="32"/>
          <c:tx>
            <c:strRef>
              <c:f>Familia_grafico!$A$35</c:f>
              <c:strCache>
                <c:ptCount val="1"/>
                <c:pt idx="0">
                  <c:v>PLTA13_fa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5:$K$35</c:f>
              <c:numCache>
                <c:formatCode>General</c:formatCode>
                <c:ptCount val="10"/>
                <c:pt idx="0">
                  <c:v>2.573568753344034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866114407254</c:v>
                </c:pt>
                <c:pt idx="6">
                  <c:v>0.50248780728114695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3C24-4BB0-950F-03CEDAAFEBEA}"/>
            </c:ext>
          </c:extLst>
        </c:ser>
        <c:ser>
          <c:idx val="33"/>
          <c:order val="33"/>
          <c:tx>
            <c:strRef>
              <c:f>Familia_grafico!$A$36</c:f>
              <c:strCache>
                <c:ptCount val="1"/>
                <c:pt idx="0">
                  <c:v>Euzebyaceae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6:$K$36</c:f>
              <c:numCache>
                <c:formatCode>General</c:formatCode>
                <c:ptCount val="10"/>
                <c:pt idx="0">
                  <c:v>0.13732833957553101</c:v>
                </c:pt>
                <c:pt idx="1">
                  <c:v>0.43001606653435398</c:v>
                </c:pt>
                <c:pt idx="2">
                  <c:v>0.29176101724438303</c:v>
                </c:pt>
                <c:pt idx="3">
                  <c:v>0.57234662114670098</c:v>
                </c:pt>
                <c:pt idx="4">
                  <c:v>0</c:v>
                </c:pt>
                <c:pt idx="5">
                  <c:v>3.9180566439046202E-2</c:v>
                </c:pt>
                <c:pt idx="6">
                  <c:v>1.0788708803389331</c:v>
                </c:pt>
                <c:pt idx="7">
                  <c:v>1.2351488060228211</c:v>
                </c:pt>
                <c:pt idx="8">
                  <c:v>0.21872265966754201</c:v>
                </c:pt>
                <c:pt idx="9">
                  <c:v>0.224009774971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3C24-4BB0-950F-03CEDAAFEBEA}"/>
            </c:ext>
          </c:extLst>
        </c:ser>
        <c:ser>
          <c:idx val="34"/>
          <c:order val="34"/>
          <c:tx>
            <c:strRef>
              <c:f>Familia_grafico!$A$37</c:f>
              <c:strCache>
                <c:ptCount val="1"/>
                <c:pt idx="0">
                  <c:v>Cytophagales_unclassified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7:$K$37</c:f>
              <c:numCache>
                <c:formatCode>General</c:formatCode>
                <c:ptCount val="10"/>
                <c:pt idx="0">
                  <c:v>0</c:v>
                </c:pt>
                <c:pt idx="1">
                  <c:v>1.32785180984784</c:v>
                </c:pt>
                <c:pt idx="2">
                  <c:v>6.5319630726354298E-3</c:v>
                </c:pt>
                <c:pt idx="3">
                  <c:v>1.6015664223315591</c:v>
                </c:pt>
                <c:pt idx="4">
                  <c:v>0</c:v>
                </c:pt>
                <c:pt idx="5">
                  <c:v>1.11944475540132E-2</c:v>
                </c:pt>
                <c:pt idx="6">
                  <c:v>4.9263510517759498E-2</c:v>
                </c:pt>
                <c:pt idx="7">
                  <c:v>0.13331764890405001</c:v>
                </c:pt>
                <c:pt idx="8">
                  <c:v>3.7014603943737803E-2</c:v>
                </c:pt>
                <c:pt idx="9">
                  <c:v>0.889250924888844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3C24-4BB0-950F-03CEDAAFEBEA}"/>
            </c:ext>
          </c:extLst>
        </c:ser>
        <c:ser>
          <c:idx val="35"/>
          <c:order val="35"/>
          <c:tx>
            <c:strRef>
              <c:f>Familia_grafico!$A$38</c:f>
              <c:strCache>
                <c:ptCount val="1"/>
                <c:pt idx="0">
                  <c:v>Alphaproteobacteria_unclassified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8:$K$38</c:f>
              <c:numCache>
                <c:formatCode>General</c:formatCode>
                <c:ptCount val="10"/>
                <c:pt idx="0">
                  <c:v>0.99875156054931302</c:v>
                </c:pt>
                <c:pt idx="1">
                  <c:v>0.18901805122389201</c:v>
                </c:pt>
                <c:pt idx="2">
                  <c:v>0.69674272774777901</c:v>
                </c:pt>
                <c:pt idx="3">
                  <c:v>0.130535194296616</c:v>
                </c:pt>
                <c:pt idx="4">
                  <c:v>5.42829225925524E-3</c:v>
                </c:pt>
                <c:pt idx="5">
                  <c:v>1.113847531624315</c:v>
                </c:pt>
                <c:pt idx="6">
                  <c:v>0.408887137297404</c:v>
                </c:pt>
                <c:pt idx="7">
                  <c:v>8.6264361055562094E-2</c:v>
                </c:pt>
                <c:pt idx="8">
                  <c:v>0.37351100343226301</c:v>
                </c:pt>
                <c:pt idx="9">
                  <c:v>4.7517224994060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3-3C24-4BB0-950F-03CEDAAFEBEA}"/>
            </c:ext>
          </c:extLst>
        </c:ser>
        <c:ser>
          <c:idx val="36"/>
          <c:order val="36"/>
          <c:tx>
            <c:strRef>
              <c:f>Familia_grafico!$A$39</c:f>
              <c:strCache>
                <c:ptCount val="1"/>
                <c:pt idx="0">
                  <c:v>Woeseiaceae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39:$K$39</c:f>
              <c:numCache>
                <c:formatCode>General</c:formatCode>
                <c:ptCount val="10"/>
                <c:pt idx="0">
                  <c:v>0.46013911182450501</c:v>
                </c:pt>
                <c:pt idx="1">
                  <c:v>7.5607220489556801E-2</c:v>
                </c:pt>
                <c:pt idx="2">
                  <c:v>2.1773210242118099E-3</c:v>
                </c:pt>
                <c:pt idx="3">
                  <c:v>0.12551460990059199</c:v>
                </c:pt>
                <c:pt idx="4">
                  <c:v>0</c:v>
                </c:pt>
                <c:pt idx="5">
                  <c:v>0.195902832195231</c:v>
                </c:pt>
                <c:pt idx="6">
                  <c:v>2.7538302379427559</c:v>
                </c:pt>
                <c:pt idx="7">
                  <c:v>0.34897855154295598</c:v>
                </c:pt>
                <c:pt idx="8">
                  <c:v>6.7299279897705096E-3</c:v>
                </c:pt>
                <c:pt idx="9">
                  <c:v>2.375861249703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3C24-4BB0-950F-03CEDAAFEBEA}"/>
            </c:ext>
          </c:extLst>
        </c:ser>
        <c:ser>
          <c:idx val="37"/>
          <c:order val="37"/>
          <c:tx>
            <c:strRef>
              <c:f>Familia_grafico!$A$40</c:f>
              <c:strCache>
                <c:ptCount val="1"/>
                <c:pt idx="0">
                  <c:v>Actinobacteria_unclassified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0:$K$40</c:f>
              <c:numCache>
                <c:formatCode>General</c:formatCode>
                <c:ptCount val="10"/>
                <c:pt idx="0">
                  <c:v>1.0344212591403601</c:v>
                </c:pt>
                <c:pt idx="1">
                  <c:v>0.37803610244778402</c:v>
                </c:pt>
                <c:pt idx="2">
                  <c:v>7.1851593798989699E-2</c:v>
                </c:pt>
                <c:pt idx="3">
                  <c:v>0.34642032332563499</c:v>
                </c:pt>
                <c:pt idx="4">
                  <c:v>0</c:v>
                </c:pt>
                <c:pt idx="5">
                  <c:v>0.53733348259263403</c:v>
                </c:pt>
                <c:pt idx="6">
                  <c:v>0.95078575299275803</c:v>
                </c:pt>
                <c:pt idx="7">
                  <c:v>0.431321805277811</c:v>
                </c:pt>
                <c:pt idx="8">
                  <c:v>0.13123359580052499</c:v>
                </c:pt>
                <c:pt idx="9">
                  <c:v>6.109357499236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5-3C24-4BB0-950F-03CEDAAFEBEA}"/>
            </c:ext>
          </c:extLst>
        </c:ser>
        <c:ser>
          <c:idx val="38"/>
          <c:order val="38"/>
          <c:tx>
            <c:strRef>
              <c:f>Familia_grafico!$A$41</c:f>
              <c:strCache>
                <c:ptCount val="1"/>
                <c:pt idx="0">
                  <c:v>Leptolyngbyaceae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1:$K$4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1.9595889217906299E-2</c:v>
                </c:pt>
                <c:pt idx="3">
                  <c:v>0</c:v>
                </c:pt>
                <c:pt idx="4">
                  <c:v>0</c:v>
                </c:pt>
                <c:pt idx="5">
                  <c:v>3.873278853688570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3C24-4BB0-950F-03CEDAAFEBEA}"/>
            </c:ext>
          </c:extLst>
        </c:ser>
        <c:ser>
          <c:idx val="39"/>
          <c:order val="39"/>
          <c:tx>
            <c:strRef>
              <c:f>Familia_grafico!$A$42</c:f>
              <c:strCache>
                <c:ptCount val="1"/>
                <c:pt idx="0">
                  <c:v>Saprospiraceae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2:$K$42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862084406134556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3C24-4BB0-950F-03CEDAAFEBEA}"/>
            </c:ext>
          </c:extLst>
        </c:ser>
        <c:ser>
          <c:idx val="40"/>
          <c:order val="40"/>
          <c:tx>
            <c:strRef>
              <c:f>Familia_grafico!$A$43</c:f>
              <c:strCache>
                <c:ptCount val="1"/>
                <c:pt idx="0">
                  <c:v>Gemmataceae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3:$K$43</c:f>
              <c:numCache>
                <c:formatCode>General</c:formatCode>
                <c:ptCount val="10"/>
                <c:pt idx="0">
                  <c:v>0.50115926520420895</c:v>
                </c:pt>
                <c:pt idx="1">
                  <c:v>0.50089783574331403</c:v>
                </c:pt>
                <c:pt idx="2">
                  <c:v>0.618359170876154</c:v>
                </c:pt>
                <c:pt idx="3">
                  <c:v>0.59242895873079604</c:v>
                </c:pt>
                <c:pt idx="4">
                  <c:v>0</c:v>
                </c:pt>
                <c:pt idx="5">
                  <c:v>1.0522780700772421</c:v>
                </c:pt>
                <c:pt idx="6">
                  <c:v>1.9705404207103799E-2</c:v>
                </c:pt>
                <c:pt idx="7">
                  <c:v>0</c:v>
                </c:pt>
                <c:pt idx="8">
                  <c:v>0.52493438320209995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3C24-4BB0-950F-03CEDAAFEBEA}"/>
            </c:ext>
          </c:extLst>
        </c:ser>
        <c:ser>
          <c:idx val="41"/>
          <c:order val="41"/>
          <c:tx>
            <c:strRef>
              <c:f>Familia_grafico!$A$44</c:f>
              <c:strCache>
                <c:ptCount val="1"/>
                <c:pt idx="0">
                  <c:v>Kineosporiaceae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4:$K$44</c:f>
              <c:numCache>
                <c:formatCode>General</c:formatCode>
                <c:ptCount val="10"/>
                <c:pt idx="0">
                  <c:v>9.2741216336721902E-2</c:v>
                </c:pt>
                <c:pt idx="1">
                  <c:v>0.77969946129855405</c:v>
                </c:pt>
                <c:pt idx="2">
                  <c:v>0.93407071938686603</c:v>
                </c:pt>
                <c:pt idx="3">
                  <c:v>0.78321116577969596</c:v>
                </c:pt>
                <c:pt idx="4">
                  <c:v>0</c:v>
                </c:pt>
                <c:pt idx="5">
                  <c:v>2.7986118885032999E-2</c:v>
                </c:pt>
                <c:pt idx="6">
                  <c:v>0.11823242524262299</c:v>
                </c:pt>
                <c:pt idx="7">
                  <c:v>0.529349488295495</c:v>
                </c:pt>
                <c:pt idx="8">
                  <c:v>0.43744531933508302</c:v>
                </c:pt>
                <c:pt idx="9">
                  <c:v>2.03645249974543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9-3C24-4BB0-950F-03CEDAAFEBEA}"/>
            </c:ext>
          </c:extLst>
        </c:ser>
        <c:ser>
          <c:idx val="42"/>
          <c:order val="42"/>
          <c:tx>
            <c:strRef>
              <c:f>Familia_grafico!$A$45</c:f>
              <c:strCache>
                <c:ptCount val="1"/>
                <c:pt idx="0">
                  <c:v>Subgroup_6_fa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5:$K$45</c:f>
              <c:numCache>
                <c:formatCode>General</c:formatCode>
                <c:ptCount val="10"/>
                <c:pt idx="0">
                  <c:v>0.62957018013197796</c:v>
                </c:pt>
                <c:pt idx="1">
                  <c:v>0.36385974860599202</c:v>
                </c:pt>
                <c:pt idx="2">
                  <c:v>0.98197178191952605</c:v>
                </c:pt>
                <c:pt idx="3">
                  <c:v>0.48197610201827501</c:v>
                </c:pt>
                <c:pt idx="4">
                  <c:v>0</c:v>
                </c:pt>
                <c:pt idx="5">
                  <c:v>0.47016679726855498</c:v>
                </c:pt>
                <c:pt idx="6">
                  <c:v>0.40396078624562798</c:v>
                </c:pt>
                <c:pt idx="7">
                  <c:v>0</c:v>
                </c:pt>
                <c:pt idx="8">
                  <c:v>0.37014603943737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A-3C24-4BB0-950F-03CEDAAFEBEA}"/>
            </c:ext>
          </c:extLst>
        </c:ser>
        <c:ser>
          <c:idx val="43"/>
          <c:order val="43"/>
          <c:tx>
            <c:strRef>
              <c:f>Familia_grafico!$A$46</c:f>
              <c:strCache>
                <c:ptCount val="1"/>
                <c:pt idx="0">
                  <c:v>Kiloniellaceae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6:$K$46</c:f>
              <c:numCache>
                <c:formatCode>General</c:formatCode>
                <c:ptCount val="10"/>
                <c:pt idx="0">
                  <c:v>2.31853040841805E-2</c:v>
                </c:pt>
                <c:pt idx="1">
                  <c:v>1.5972025328418871</c:v>
                </c:pt>
                <c:pt idx="2">
                  <c:v>0</c:v>
                </c:pt>
                <c:pt idx="3">
                  <c:v>1.4358871372627771</c:v>
                </c:pt>
                <c:pt idx="4">
                  <c:v>0</c:v>
                </c:pt>
                <c:pt idx="5">
                  <c:v>0</c:v>
                </c:pt>
                <c:pt idx="6">
                  <c:v>7.3895265776639199E-2</c:v>
                </c:pt>
                <c:pt idx="7">
                  <c:v>0.53719170293690899</c:v>
                </c:pt>
                <c:pt idx="8">
                  <c:v>0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B-3C24-4BB0-950F-03CEDAAFEBEA}"/>
            </c:ext>
          </c:extLst>
        </c:ser>
        <c:ser>
          <c:idx val="44"/>
          <c:order val="44"/>
          <c:tx>
            <c:strRef>
              <c:f>Familia_grafico!$A$47</c:f>
              <c:strCache>
                <c:ptCount val="1"/>
                <c:pt idx="0">
                  <c:v>Dongiaceae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7:$K$47</c:f>
              <c:numCache>
                <c:formatCode>General</c:formatCode>
                <c:ptCount val="10"/>
                <c:pt idx="0">
                  <c:v>3.468878187979310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C-3C24-4BB0-950F-03CEDAAFEBEA}"/>
            </c:ext>
          </c:extLst>
        </c:ser>
        <c:ser>
          <c:idx val="45"/>
          <c:order val="45"/>
          <c:tx>
            <c:strRef>
              <c:f>Familia_grafico!$A$48</c:f>
              <c:strCache>
                <c:ptCount val="1"/>
                <c:pt idx="0">
                  <c:v>Solirubrobacteraceae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8:$K$48</c:f>
              <c:numCache>
                <c:formatCode>General</c:formatCode>
                <c:ptCount val="10"/>
                <c:pt idx="0">
                  <c:v>0.35491350098091701</c:v>
                </c:pt>
                <c:pt idx="1">
                  <c:v>0.36385974860599202</c:v>
                </c:pt>
                <c:pt idx="2">
                  <c:v>0.846977878418394</c:v>
                </c:pt>
                <c:pt idx="3">
                  <c:v>0.29119389496937398</c:v>
                </c:pt>
                <c:pt idx="4">
                  <c:v>0</c:v>
                </c:pt>
                <c:pt idx="5">
                  <c:v>0</c:v>
                </c:pt>
                <c:pt idx="6">
                  <c:v>0.36454997783142001</c:v>
                </c:pt>
                <c:pt idx="7">
                  <c:v>0</c:v>
                </c:pt>
                <c:pt idx="8">
                  <c:v>0.67972272696682201</c:v>
                </c:pt>
                <c:pt idx="9">
                  <c:v>0.308861962461392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D-3C24-4BB0-950F-03CEDAAFEBEA}"/>
            </c:ext>
          </c:extLst>
        </c:ser>
        <c:ser>
          <c:idx val="46"/>
          <c:order val="46"/>
          <c:tx>
            <c:strRef>
              <c:f>Familia_grafico!$A$49</c:f>
              <c:strCache>
                <c:ptCount val="1"/>
                <c:pt idx="0">
                  <c:v>Saccharimonadales_fa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49:$K$49</c:f>
              <c:numCache>
                <c:formatCode>General</c:formatCode>
                <c:ptCount val="10"/>
                <c:pt idx="0">
                  <c:v>0.28714107365792801</c:v>
                </c:pt>
                <c:pt idx="1">
                  <c:v>0.283527076835838</c:v>
                </c:pt>
                <c:pt idx="2">
                  <c:v>0.363612611043372</c:v>
                </c:pt>
                <c:pt idx="3">
                  <c:v>0.25604980419720902</c:v>
                </c:pt>
                <c:pt idx="4">
                  <c:v>0</c:v>
                </c:pt>
                <c:pt idx="5">
                  <c:v>1.584014328892869</c:v>
                </c:pt>
                <c:pt idx="6">
                  <c:v>9.8527021035518993E-3</c:v>
                </c:pt>
                <c:pt idx="7">
                  <c:v>5.8816609810610501E-2</c:v>
                </c:pt>
                <c:pt idx="8">
                  <c:v>0.28602193956524702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E-3C24-4BB0-950F-03CEDAAFEBEA}"/>
            </c:ext>
          </c:extLst>
        </c:ser>
        <c:ser>
          <c:idx val="47"/>
          <c:order val="47"/>
          <c:tx>
            <c:strRef>
              <c:f>Familia_grafico!$A$50</c:f>
              <c:strCache>
                <c:ptCount val="1"/>
                <c:pt idx="0">
                  <c:v>uncultured_fa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0:$K$50</c:f>
              <c:numCache>
                <c:formatCode>General</c:formatCode>
                <c:ptCount val="10"/>
                <c:pt idx="0">
                  <c:v>4.6370608168360999E-2</c:v>
                </c:pt>
                <c:pt idx="1">
                  <c:v>0.55760325111048104</c:v>
                </c:pt>
                <c:pt idx="2">
                  <c:v>0.63142309702142496</c:v>
                </c:pt>
                <c:pt idx="3">
                  <c:v>0.55226428356260704</c:v>
                </c:pt>
                <c:pt idx="4">
                  <c:v>0</c:v>
                </c:pt>
                <c:pt idx="5">
                  <c:v>0</c:v>
                </c:pt>
                <c:pt idx="6">
                  <c:v>0.75865806197349595</c:v>
                </c:pt>
                <c:pt idx="7">
                  <c:v>0.384268517429322</c:v>
                </c:pt>
                <c:pt idx="8">
                  <c:v>0.10431388384144299</c:v>
                </c:pt>
                <c:pt idx="9">
                  <c:v>0.1052167124868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F-3C24-4BB0-950F-03CEDAAFEBEA}"/>
            </c:ext>
          </c:extLst>
        </c:ser>
        <c:ser>
          <c:idx val="48"/>
          <c:order val="48"/>
          <c:tx>
            <c:strRef>
              <c:f>Familia_grafico!$A$51</c:f>
              <c:strCache>
                <c:ptCount val="1"/>
                <c:pt idx="0">
                  <c:v>Puniceispirillales_Incertae_Sedis</c:v>
                </c:pt>
              </c:strCache>
            </c:strRef>
          </c:tx>
          <c:spPr>
            <a:solidFill>
              <a:schemeClr val="accent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1:$K$51</c:f>
              <c:numCache>
                <c:formatCode>General</c:formatCode>
                <c:ptCount val="10"/>
                <c:pt idx="0">
                  <c:v>0.12841091492776899</c:v>
                </c:pt>
                <c:pt idx="1">
                  <c:v>1.025422927889613</c:v>
                </c:pt>
                <c:pt idx="2">
                  <c:v>0.13281658247691999</c:v>
                </c:pt>
                <c:pt idx="3">
                  <c:v>1.0141580479967871</c:v>
                </c:pt>
                <c:pt idx="4">
                  <c:v>0</c:v>
                </c:pt>
                <c:pt idx="5">
                  <c:v>0.12313892309414499</c:v>
                </c:pt>
                <c:pt idx="6">
                  <c:v>0.23153849943346999</c:v>
                </c:pt>
                <c:pt idx="7">
                  <c:v>0.10194879033839201</c:v>
                </c:pt>
                <c:pt idx="8">
                  <c:v>0.18843798371357401</c:v>
                </c:pt>
                <c:pt idx="9">
                  <c:v>7.127583749109049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0-3C24-4BB0-950F-03CEDAAFEBEA}"/>
            </c:ext>
          </c:extLst>
        </c:ser>
        <c:ser>
          <c:idx val="49"/>
          <c:order val="49"/>
          <c:tx>
            <c:strRef>
              <c:f>Familia_grafico!$A$52</c:f>
              <c:strCache>
                <c:ptCount val="1"/>
                <c:pt idx="0">
                  <c:v>67-14</c:v>
                </c:pt>
              </c:strCache>
            </c:strRef>
          </c:tx>
          <c:spPr>
            <a:solidFill>
              <a:schemeClr val="accent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2:$K$52</c:f>
              <c:numCache>
                <c:formatCode>General</c:formatCode>
                <c:ptCount val="10"/>
                <c:pt idx="0">
                  <c:v>0.14981273408239701</c:v>
                </c:pt>
                <c:pt idx="1">
                  <c:v>0.26462527171344902</c:v>
                </c:pt>
                <c:pt idx="2">
                  <c:v>0.83826859432154699</c:v>
                </c:pt>
                <c:pt idx="3">
                  <c:v>0.24098805100913701</c:v>
                </c:pt>
                <c:pt idx="4">
                  <c:v>0</c:v>
                </c:pt>
                <c:pt idx="5">
                  <c:v>0.162319489533192</c:v>
                </c:pt>
                <c:pt idx="6">
                  <c:v>7.8821616828415195E-2</c:v>
                </c:pt>
                <c:pt idx="7">
                  <c:v>0</c:v>
                </c:pt>
                <c:pt idx="8">
                  <c:v>1.171007470220069</c:v>
                </c:pt>
                <c:pt idx="9">
                  <c:v>9.1640362488544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1-3C24-4BB0-950F-03CEDAAFEBEA}"/>
            </c:ext>
          </c:extLst>
        </c:ser>
        <c:ser>
          <c:idx val="50"/>
          <c:order val="50"/>
          <c:tx>
            <c:strRef>
              <c:f>Familia_grafico!$A$53</c:f>
              <c:strCache>
                <c:ptCount val="1"/>
                <c:pt idx="0">
                  <c:v>Hyphomonadaceae</c:v>
                </c:pt>
              </c:strCache>
            </c:strRef>
          </c:tx>
          <c:spPr>
            <a:solidFill>
              <a:schemeClr val="accent3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3:$K$53</c:f>
              <c:numCache>
                <c:formatCode>General</c:formatCode>
                <c:ptCount val="10"/>
                <c:pt idx="0">
                  <c:v>0.60103442125913997</c:v>
                </c:pt>
                <c:pt idx="1">
                  <c:v>0.25989982043285098</c:v>
                </c:pt>
                <c:pt idx="2">
                  <c:v>0</c:v>
                </c:pt>
                <c:pt idx="3">
                  <c:v>0.20584396023697199</c:v>
                </c:pt>
                <c:pt idx="4">
                  <c:v>0</c:v>
                </c:pt>
                <c:pt idx="5">
                  <c:v>1.7855143848651069</c:v>
                </c:pt>
                <c:pt idx="6">
                  <c:v>0.1330114783979509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2-3C24-4BB0-950F-03CEDAAFEBEA}"/>
            </c:ext>
          </c:extLst>
        </c:ser>
        <c:ser>
          <c:idx val="51"/>
          <c:order val="51"/>
          <c:tx>
            <c:strRef>
              <c:f>Familia_grafico!$A$54</c:f>
              <c:strCache>
                <c:ptCount val="1"/>
                <c:pt idx="0">
                  <c:v>Microcystaceae</c:v>
                </c:pt>
              </c:strCache>
            </c:strRef>
          </c:tx>
          <c:spPr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4:$K$54</c:f>
              <c:numCache>
                <c:formatCode>General</c:formatCode>
                <c:ptCount val="10"/>
                <c:pt idx="0">
                  <c:v>0</c:v>
                </c:pt>
                <c:pt idx="1">
                  <c:v>1.89018051223892E-2</c:v>
                </c:pt>
                <c:pt idx="2">
                  <c:v>0.25039191778435799</c:v>
                </c:pt>
                <c:pt idx="3">
                  <c:v>1.00411687920474E-2</c:v>
                </c:pt>
                <c:pt idx="4">
                  <c:v>0</c:v>
                </c:pt>
                <c:pt idx="5">
                  <c:v>2.675472965409157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3-3C24-4BB0-950F-03CEDAAFEBEA}"/>
            </c:ext>
          </c:extLst>
        </c:ser>
        <c:ser>
          <c:idx val="52"/>
          <c:order val="52"/>
          <c:tx>
            <c:strRef>
              <c:f>Familia_grafico!$A$55</c:f>
              <c:strCache>
                <c:ptCount val="1"/>
                <c:pt idx="0">
                  <c:v>Ardenticatenaceae</c:v>
                </c:pt>
              </c:strCache>
            </c:strRef>
          </c:tx>
          <c:spPr>
            <a:solidFill>
              <a:schemeClr val="accent5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5:$K$55</c:f>
              <c:numCache>
                <c:formatCode>General</c:formatCode>
                <c:ptCount val="10"/>
                <c:pt idx="0">
                  <c:v>6.2421972534332099E-2</c:v>
                </c:pt>
                <c:pt idx="1">
                  <c:v>0.14648898969851601</c:v>
                </c:pt>
                <c:pt idx="2">
                  <c:v>0.99068106601637296</c:v>
                </c:pt>
                <c:pt idx="3">
                  <c:v>0.160658700672758</c:v>
                </c:pt>
                <c:pt idx="4">
                  <c:v>0</c:v>
                </c:pt>
                <c:pt idx="5">
                  <c:v>0.13433337064815801</c:v>
                </c:pt>
                <c:pt idx="6">
                  <c:v>3.4484457362431602E-2</c:v>
                </c:pt>
                <c:pt idx="7">
                  <c:v>0</c:v>
                </c:pt>
                <c:pt idx="8">
                  <c:v>1.376270273908069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4-3C24-4BB0-950F-03CEDAAFEBEA}"/>
            </c:ext>
          </c:extLst>
        </c:ser>
        <c:ser>
          <c:idx val="53"/>
          <c:order val="53"/>
          <c:tx>
            <c:strRef>
              <c:f>Familia_grafico!$A$56</c:f>
              <c:strCache>
                <c:ptCount val="1"/>
                <c:pt idx="0">
                  <c:v>Acidimicrobiia_unclassified</c:v>
                </c:pt>
              </c:strCache>
            </c:strRef>
          </c:tx>
          <c:spPr>
            <a:solidFill>
              <a:schemeClr val="accent6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6:$K$56</c:f>
              <c:numCache>
                <c:formatCode>General</c:formatCode>
                <c:ptCount val="10"/>
                <c:pt idx="0">
                  <c:v>1.403602639557695</c:v>
                </c:pt>
                <c:pt idx="1">
                  <c:v>0.155939892259711</c:v>
                </c:pt>
                <c:pt idx="2">
                  <c:v>0.13281658247691999</c:v>
                </c:pt>
                <c:pt idx="3">
                  <c:v>0.22592629782106599</c:v>
                </c:pt>
                <c:pt idx="4">
                  <c:v>0</c:v>
                </c:pt>
                <c:pt idx="5">
                  <c:v>2.2388895108026399E-2</c:v>
                </c:pt>
                <c:pt idx="6">
                  <c:v>0.56160401990245801</c:v>
                </c:pt>
                <c:pt idx="7">
                  <c:v>2.3526643924244198E-2</c:v>
                </c:pt>
                <c:pt idx="8">
                  <c:v>0.275927047580591</c:v>
                </c:pt>
                <c:pt idx="9">
                  <c:v>5.09113124936360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5-3C24-4BB0-950F-03CEDAAFEBEA}"/>
            </c:ext>
          </c:extLst>
        </c:ser>
        <c:ser>
          <c:idx val="54"/>
          <c:order val="54"/>
          <c:tx>
            <c:strRef>
              <c:f>Familia_grafico!$A$57</c:f>
              <c:strCache>
                <c:ptCount val="1"/>
                <c:pt idx="0">
                  <c:v>Caldilineacea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7:$K$57</c:f>
              <c:numCache>
                <c:formatCode>General</c:formatCode>
                <c:ptCount val="10"/>
                <c:pt idx="0">
                  <c:v>0.17656500802568201</c:v>
                </c:pt>
                <c:pt idx="1">
                  <c:v>0.91673754843587596</c:v>
                </c:pt>
                <c:pt idx="2">
                  <c:v>0.52908900888346999</c:v>
                </c:pt>
                <c:pt idx="3">
                  <c:v>0.81835525655186303</c:v>
                </c:pt>
                <c:pt idx="4">
                  <c:v>0</c:v>
                </c:pt>
                <c:pt idx="5">
                  <c:v>0.21269450352625099</c:v>
                </c:pt>
                <c:pt idx="6">
                  <c:v>7.3895265776639199E-2</c:v>
                </c:pt>
                <c:pt idx="7">
                  <c:v>0</c:v>
                </c:pt>
                <c:pt idx="8">
                  <c:v>0.114408775826099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6-3C24-4BB0-950F-03CEDAAFEBEA}"/>
            </c:ext>
          </c:extLst>
        </c:ser>
        <c:ser>
          <c:idx val="55"/>
          <c:order val="55"/>
          <c:tx>
            <c:strRef>
              <c:f>Familia_grafico!$A$58</c:f>
              <c:strCache>
                <c:ptCount val="1"/>
                <c:pt idx="0">
                  <c:v>Thermosynechococcales_unclassifi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8:$K$5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2.611457475591107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7-3C24-4BB0-950F-03CEDAAFEBEA}"/>
            </c:ext>
          </c:extLst>
        </c:ser>
        <c:ser>
          <c:idx val="56"/>
          <c:order val="56"/>
          <c:tx>
            <c:strRef>
              <c:f>Familia_grafico!$A$59</c:f>
              <c:strCache>
                <c:ptCount val="1"/>
                <c:pt idx="0">
                  <c:v>Geminicoccacea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59:$K$59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.127587184576127</c:v>
                </c:pt>
                <c:pt idx="2">
                  <c:v>8.7092840968472404E-2</c:v>
                </c:pt>
                <c:pt idx="3">
                  <c:v>0.12551460990059199</c:v>
                </c:pt>
                <c:pt idx="4">
                  <c:v>0</c:v>
                </c:pt>
                <c:pt idx="5">
                  <c:v>0.99630583230717595</c:v>
                </c:pt>
                <c:pt idx="6">
                  <c:v>7.3895265776639199E-2</c:v>
                </c:pt>
                <c:pt idx="7">
                  <c:v>0</c:v>
                </c:pt>
                <c:pt idx="8">
                  <c:v>0.242277407631738</c:v>
                </c:pt>
                <c:pt idx="9">
                  <c:v>0.94695041238163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3C24-4BB0-950F-03CEDAAFEBEA}"/>
            </c:ext>
          </c:extLst>
        </c:ser>
        <c:ser>
          <c:idx val="57"/>
          <c:order val="57"/>
          <c:tx>
            <c:strRef>
              <c:f>Familia_grafico!$A$60</c:f>
              <c:strCache>
                <c:ptCount val="1"/>
                <c:pt idx="0">
                  <c:v>Micrococcacea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0:$K$6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4.3546420484236199E-3</c:v>
                </c:pt>
                <c:pt idx="3">
                  <c:v>0</c:v>
                </c:pt>
                <c:pt idx="4">
                  <c:v>5.1568776462924799E-2</c:v>
                </c:pt>
                <c:pt idx="5">
                  <c:v>0</c:v>
                </c:pt>
                <c:pt idx="6">
                  <c:v>0</c:v>
                </c:pt>
                <c:pt idx="7">
                  <c:v>2.454613182762812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9-3C24-4BB0-950F-03CEDAAFEBEA}"/>
            </c:ext>
          </c:extLst>
        </c:ser>
        <c:ser>
          <c:idx val="58"/>
          <c:order val="58"/>
          <c:tx>
            <c:strRef>
              <c:f>Familia_grafico!$A$61</c:f>
              <c:strCache>
                <c:ptCount val="1"/>
                <c:pt idx="0">
                  <c:v>Chloroplast_f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1:$K$61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.76079765617616502</c:v>
                </c:pt>
                <c:pt idx="2">
                  <c:v>2.1773210242118099E-3</c:v>
                </c:pt>
                <c:pt idx="3">
                  <c:v>0.7781905813836730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94890797161118301</c:v>
                </c:pt>
                <c:pt idx="8">
                  <c:v>1.6824819974426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A-3C24-4BB0-950F-03CEDAAFEBEA}"/>
            </c:ext>
          </c:extLst>
        </c:ser>
        <c:ser>
          <c:idx val="59"/>
          <c:order val="59"/>
          <c:tx>
            <c:strRef>
              <c:f>Familia_grafico!$A$62</c:f>
              <c:strCache>
                <c:ptCount val="1"/>
                <c:pt idx="0">
                  <c:v>Rhodanobacteracea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2:$K$62</c:f>
              <c:numCache>
                <c:formatCode>General</c:formatCode>
                <c:ptCount val="10"/>
                <c:pt idx="0">
                  <c:v>0.49045835562689499</c:v>
                </c:pt>
                <c:pt idx="1">
                  <c:v>0</c:v>
                </c:pt>
                <c:pt idx="2">
                  <c:v>1.74185681936945E-2</c:v>
                </c:pt>
                <c:pt idx="3">
                  <c:v>0</c:v>
                </c:pt>
                <c:pt idx="4">
                  <c:v>0</c:v>
                </c:pt>
                <c:pt idx="5">
                  <c:v>1.8638755177431989</c:v>
                </c:pt>
                <c:pt idx="6">
                  <c:v>0.113306074190847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B-3C24-4BB0-950F-03CEDAAFEBEA}"/>
            </c:ext>
          </c:extLst>
        </c:ser>
        <c:ser>
          <c:idx val="60"/>
          <c:order val="60"/>
          <c:tx>
            <c:strRef>
              <c:f>Familia_grafico!$A$63</c:f>
              <c:strCache>
                <c:ptCount val="1"/>
                <c:pt idx="0">
                  <c:v>Caulobacteraceae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3:$K$63</c:f>
              <c:numCache>
                <c:formatCode>General</c:formatCode>
                <c:ptCount val="10"/>
                <c:pt idx="0">
                  <c:v>2.67522739432852E-2</c:v>
                </c:pt>
                <c:pt idx="1">
                  <c:v>0.27880162555524102</c:v>
                </c:pt>
                <c:pt idx="2">
                  <c:v>0.33966207977704199</c:v>
                </c:pt>
                <c:pt idx="3">
                  <c:v>0.27111155738527998</c:v>
                </c:pt>
                <c:pt idx="4">
                  <c:v>0</c:v>
                </c:pt>
                <c:pt idx="5">
                  <c:v>5.0375013993059402E-2</c:v>
                </c:pt>
                <c:pt idx="6">
                  <c:v>1.9705404207103799E-2</c:v>
                </c:pt>
                <c:pt idx="7">
                  <c:v>0</c:v>
                </c:pt>
                <c:pt idx="8">
                  <c:v>0.72010229490544397</c:v>
                </c:pt>
                <c:pt idx="9">
                  <c:v>0.70257611241217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C-3C24-4BB0-950F-03CEDAAFEBEA}"/>
            </c:ext>
          </c:extLst>
        </c:ser>
        <c:ser>
          <c:idx val="61"/>
          <c:order val="61"/>
          <c:tx>
            <c:strRef>
              <c:f>Familia_grafico!$A$64</c:f>
              <c:strCache>
                <c:ptCount val="1"/>
                <c:pt idx="0">
                  <c:v>Nitrospiraceae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4:$K$64</c:f>
              <c:numCache>
                <c:formatCode>General</c:formatCode>
                <c:ptCount val="10"/>
                <c:pt idx="0">
                  <c:v>1.3429641519529161</c:v>
                </c:pt>
                <c:pt idx="1">
                  <c:v>3.3078158964181099E-2</c:v>
                </c:pt>
                <c:pt idx="2">
                  <c:v>0.137171224525344</c:v>
                </c:pt>
                <c:pt idx="3">
                  <c:v>1.00411687920474E-2</c:v>
                </c:pt>
                <c:pt idx="4">
                  <c:v>0</c:v>
                </c:pt>
                <c:pt idx="5">
                  <c:v>0.64368073435576001</c:v>
                </c:pt>
                <c:pt idx="6">
                  <c:v>0.162569584708606</c:v>
                </c:pt>
                <c:pt idx="7">
                  <c:v>0</c:v>
                </c:pt>
                <c:pt idx="8">
                  <c:v>3.0284675953967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D-3C24-4BB0-950F-03CEDAAFEBEA}"/>
            </c:ext>
          </c:extLst>
        </c:ser>
        <c:ser>
          <c:idx val="62"/>
          <c:order val="62"/>
          <c:tx>
            <c:strRef>
              <c:f>Familia_grafico!$A$65</c:f>
              <c:strCache>
                <c:ptCount val="1"/>
                <c:pt idx="0">
                  <c:v>CCM19a_f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5:$K$65</c:f>
              <c:numCache>
                <c:formatCode>General</c:formatCode>
                <c:ptCount val="10"/>
                <c:pt idx="0">
                  <c:v>0.2193686463349379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97581999328333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E-3C24-4BB0-950F-03CEDAAFEBEA}"/>
            </c:ext>
          </c:extLst>
        </c:ser>
        <c:ser>
          <c:idx val="63"/>
          <c:order val="63"/>
          <c:tx>
            <c:strRef>
              <c:f>Familia_grafico!$A$66</c:f>
              <c:strCache>
                <c:ptCount val="1"/>
                <c:pt idx="0">
                  <c:v>Bacteria_unclassified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6:$K$66</c:f>
              <c:numCache>
                <c:formatCode>General</c:formatCode>
                <c:ptCount val="10"/>
                <c:pt idx="0">
                  <c:v>0.28357410379882297</c:v>
                </c:pt>
                <c:pt idx="1">
                  <c:v>0.18901805122389201</c:v>
                </c:pt>
                <c:pt idx="2">
                  <c:v>0.12410729838007301</c:v>
                </c:pt>
                <c:pt idx="3">
                  <c:v>0.15563811627673499</c:v>
                </c:pt>
                <c:pt idx="4">
                  <c:v>8.1424383888828597E-2</c:v>
                </c:pt>
                <c:pt idx="5">
                  <c:v>0.82838911899697698</c:v>
                </c:pt>
                <c:pt idx="6">
                  <c:v>0.29558106310655702</c:v>
                </c:pt>
                <c:pt idx="7">
                  <c:v>3.1368858565658901E-2</c:v>
                </c:pt>
                <c:pt idx="8">
                  <c:v>0.121138703815869</c:v>
                </c:pt>
                <c:pt idx="9">
                  <c:v>6.109357499236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F-3C24-4BB0-950F-03CEDAAFEBEA}"/>
            </c:ext>
          </c:extLst>
        </c:ser>
        <c:ser>
          <c:idx val="64"/>
          <c:order val="64"/>
          <c:tx>
            <c:strRef>
              <c:f>Familia_grafico!$A$67</c:f>
              <c:strCache>
                <c:ptCount val="1"/>
                <c:pt idx="0">
                  <c:v>Oligoflexaceae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7:$K$67</c:f>
              <c:numCache>
                <c:formatCode>General</c:formatCode>
                <c:ptCount val="10"/>
                <c:pt idx="0">
                  <c:v>0</c:v>
                </c:pt>
                <c:pt idx="1">
                  <c:v>0.538701445988092</c:v>
                </c:pt>
                <c:pt idx="2">
                  <c:v>0.76859432154676899</c:v>
                </c:pt>
                <c:pt idx="3">
                  <c:v>0.45185259564213298</c:v>
                </c:pt>
                <c:pt idx="4">
                  <c:v>0</c:v>
                </c:pt>
                <c:pt idx="5">
                  <c:v>0.184708384641218</c:v>
                </c:pt>
                <c:pt idx="6">
                  <c:v>0</c:v>
                </c:pt>
                <c:pt idx="7">
                  <c:v>0</c:v>
                </c:pt>
                <c:pt idx="8">
                  <c:v>0.20526280368800101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0-3C24-4BB0-950F-03CEDAAFEBEA}"/>
            </c:ext>
          </c:extLst>
        </c:ser>
        <c:ser>
          <c:idx val="65"/>
          <c:order val="65"/>
          <c:tx>
            <c:strRef>
              <c:f>Familia_grafico!$A$68</c:f>
              <c:strCache>
                <c:ptCount val="1"/>
                <c:pt idx="0">
                  <c:v>uncultured_fa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8:$K$68</c:f>
              <c:numCache>
                <c:formatCode>General</c:formatCode>
                <c:ptCount val="10"/>
                <c:pt idx="0">
                  <c:v>0.57963260210451195</c:v>
                </c:pt>
                <c:pt idx="1">
                  <c:v>0</c:v>
                </c:pt>
                <c:pt idx="2">
                  <c:v>8.7092840968472397E-3</c:v>
                </c:pt>
                <c:pt idx="3">
                  <c:v>1.5061753188071099E-2</c:v>
                </c:pt>
                <c:pt idx="4">
                  <c:v>0</c:v>
                </c:pt>
                <c:pt idx="5">
                  <c:v>0.34702787417441</c:v>
                </c:pt>
                <c:pt idx="6">
                  <c:v>1.083797231390708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1-3C24-4BB0-950F-03CEDAAFEBEA}"/>
            </c:ext>
          </c:extLst>
        </c:ser>
        <c:ser>
          <c:idx val="66"/>
          <c:order val="66"/>
          <c:tx>
            <c:strRef>
              <c:f>Familia_grafico!$A$69</c:f>
              <c:strCache>
                <c:ptCount val="1"/>
                <c:pt idx="0">
                  <c:v>Microtrichales_unclassified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69:$K$69</c:f>
              <c:numCache>
                <c:formatCode>General</c:formatCode>
                <c:ptCount val="10"/>
                <c:pt idx="0">
                  <c:v>0.17656500802568201</c:v>
                </c:pt>
                <c:pt idx="1">
                  <c:v>0.31660523580001898</c:v>
                </c:pt>
                <c:pt idx="2">
                  <c:v>0.121929977355861</c:v>
                </c:pt>
                <c:pt idx="3">
                  <c:v>0.170699869464806</c:v>
                </c:pt>
                <c:pt idx="4">
                  <c:v>0</c:v>
                </c:pt>
                <c:pt idx="5">
                  <c:v>0.162319489533192</c:v>
                </c:pt>
                <c:pt idx="6">
                  <c:v>0.216759446278142</c:v>
                </c:pt>
                <c:pt idx="7">
                  <c:v>0.30584637101517498</c:v>
                </c:pt>
                <c:pt idx="8">
                  <c:v>0.32640150750386998</c:v>
                </c:pt>
                <c:pt idx="9">
                  <c:v>0.15273393748090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2-3C24-4BB0-950F-03CEDAAFEBEA}"/>
            </c:ext>
          </c:extLst>
        </c:ser>
        <c:ser>
          <c:idx val="67"/>
          <c:order val="67"/>
          <c:tx>
            <c:strRef>
              <c:f>Familia_grafico!$A$70</c:f>
              <c:strCache>
                <c:ptCount val="1"/>
                <c:pt idx="0">
                  <c:v>RBG-13-54-9_f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0:$K$7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919847755513264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3-3C24-4BB0-950F-03CEDAAFEBEA}"/>
            </c:ext>
          </c:extLst>
        </c:ser>
        <c:ser>
          <c:idx val="68"/>
          <c:order val="68"/>
          <c:tx>
            <c:strRef>
              <c:f>Familia_grafico!$A$71</c:f>
              <c:strCache>
                <c:ptCount val="1"/>
                <c:pt idx="0">
                  <c:v>Pirellulaceae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1:$K$71</c:f>
              <c:numCache>
                <c:formatCode>General</c:formatCode>
                <c:ptCount val="10"/>
                <c:pt idx="0">
                  <c:v>0.75619761013019504</c:v>
                </c:pt>
                <c:pt idx="1">
                  <c:v>5.1979964086570303E-2</c:v>
                </c:pt>
                <c:pt idx="2">
                  <c:v>0.10015676711374299</c:v>
                </c:pt>
                <c:pt idx="3">
                  <c:v>9.5391103524450196E-2</c:v>
                </c:pt>
                <c:pt idx="4">
                  <c:v>0</c:v>
                </c:pt>
                <c:pt idx="5">
                  <c:v>0.363819545505429</c:v>
                </c:pt>
                <c:pt idx="6">
                  <c:v>0.30543376521010901</c:v>
                </c:pt>
                <c:pt idx="7">
                  <c:v>0</c:v>
                </c:pt>
                <c:pt idx="8">
                  <c:v>0.16488323574937799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4-3C24-4BB0-950F-03CEDAAFEBEA}"/>
            </c:ext>
          </c:extLst>
        </c:ser>
        <c:ser>
          <c:idx val="69"/>
          <c:order val="69"/>
          <c:tx>
            <c:strRef>
              <c:f>Familia_grafico!$A$72</c:f>
              <c:strCache>
                <c:ptCount val="1"/>
                <c:pt idx="0">
                  <c:v>Nitrosomonadaceae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2:$K$72</c:f>
              <c:numCache>
                <c:formatCode>General</c:formatCode>
                <c:ptCount val="10"/>
                <c:pt idx="0">
                  <c:v>1.2591403602639559</c:v>
                </c:pt>
                <c:pt idx="1">
                  <c:v>1.89018051223892E-2</c:v>
                </c:pt>
                <c:pt idx="2">
                  <c:v>4.3546420484236199E-3</c:v>
                </c:pt>
                <c:pt idx="3">
                  <c:v>4.51852595642133E-2</c:v>
                </c:pt>
                <c:pt idx="4">
                  <c:v>0</c:v>
                </c:pt>
                <c:pt idx="5">
                  <c:v>3.3583342662039599E-2</c:v>
                </c:pt>
                <c:pt idx="6">
                  <c:v>0.38918173309030002</c:v>
                </c:pt>
                <c:pt idx="7">
                  <c:v>0</c:v>
                </c:pt>
                <c:pt idx="8">
                  <c:v>2.35547479641968E-2</c:v>
                </c:pt>
                <c:pt idx="9">
                  <c:v>1.69704374978787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5-3C24-4BB0-950F-03CEDAAFEBEA}"/>
            </c:ext>
          </c:extLst>
        </c:ser>
        <c:ser>
          <c:idx val="70"/>
          <c:order val="70"/>
          <c:tx>
            <c:strRef>
              <c:f>Familia_grafico!$A$73</c:f>
              <c:strCache>
                <c:ptCount val="1"/>
                <c:pt idx="0">
                  <c:v>Tepidisphaeraceae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3:$K$73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.108685379453738</c:v>
                </c:pt>
                <c:pt idx="2">
                  <c:v>0.16329907681588601</c:v>
                </c:pt>
                <c:pt idx="3">
                  <c:v>0.110452856712521</c:v>
                </c:pt>
                <c:pt idx="4">
                  <c:v>0</c:v>
                </c:pt>
                <c:pt idx="5">
                  <c:v>3.3583342662039599E-2</c:v>
                </c:pt>
                <c:pt idx="6">
                  <c:v>1.9705404207103799E-2</c:v>
                </c:pt>
                <c:pt idx="7">
                  <c:v>0</c:v>
                </c:pt>
                <c:pt idx="8">
                  <c:v>1.164277542230298</c:v>
                </c:pt>
                <c:pt idx="9">
                  <c:v>0.1561280249804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6-3C24-4BB0-950F-03CEDAAFEBEA}"/>
            </c:ext>
          </c:extLst>
        </c:ser>
        <c:ser>
          <c:idx val="71"/>
          <c:order val="71"/>
          <c:tx>
            <c:strRef>
              <c:f>Familia_grafico!$A$74</c:f>
              <c:strCache>
                <c:ptCount val="1"/>
                <c:pt idx="0">
                  <c:v>Acetobacteraceae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4:$K$74</c:f>
              <c:numCache>
                <c:formatCode>General</c:formatCode>
                <c:ptCount val="10"/>
                <c:pt idx="0">
                  <c:v>1.4267879436418799E-2</c:v>
                </c:pt>
                <c:pt idx="1">
                  <c:v>3.3078158964181099E-2</c:v>
                </c:pt>
                <c:pt idx="2">
                  <c:v>0.17854032398536801</c:v>
                </c:pt>
                <c:pt idx="3">
                  <c:v>1.00411687920474E-2</c:v>
                </c:pt>
                <c:pt idx="4">
                  <c:v>0</c:v>
                </c:pt>
                <c:pt idx="5">
                  <c:v>1.511250419791784</c:v>
                </c:pt>
                <c:pt idx="6">
                  <c:v>0</c:v>
                </c:pt>
                <c:pt idx="7">
                  <c:v>0</c:v>
                </c:pt>
                <c:pt idx="8">
                  <c:v>1.0094891984655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7-3C24-4BB0-950F-03CEDAAFEBEA}"/>
            </c:ext>
          </c:extLst>
        </c:ser>
        <c:ser>
          <c:idx val="72"/>
          <c:order val="72"/>
          <c:tx>
            <c:strRef>
              <c:f>Familia_grafico!$A$75</c:f>
              <c:strCache>
                <c:ptCount val="1"/>
                <c:pt idx="0">
                  <c:v>Chthoniobacteraceae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5:$K$75</c:f>
              <c:numCache>
                <c:formatCode>General</c:formatCode>
                <c:ptCount val="10"/>
                <c:pt idx="0">
                  <c:v>1.7834849295523501E-2</c:v>
                </c:pt>
                <c:pt idx="1">
                  <c:v>0.43001606653435398</c:v>
                </c:pt>
                <c:pt idx="2">
                  <c:v>0.90141090402368895</c:v>
                </c:pt>
                <c:pt idx="3">
                  <c:v>0.2309468822170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0767884783632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8-3C24-4BB0-950F-03CEDAAFEBEA}"/>
            </c:ext>
          </c:extLst>
        </c:ser>
        <c:ser>
          <c:idx val="73"/>
          <c:order val="73"/>
          <c:tx>
            <c:strRef>
              <c:f>Familia_grafico!$A$76</c:f>
              <c:strCache>
                <c:ptCount val="1"/>
                <c:pt idx="0">
                  <c:v>Micromonosporaceae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6:$K$76</c:f>
              <c:numCache>
                <c:formatCode>General</c:formatCode>
                <c:ptCount val="10"/>
                <c:pt idx="0">
                  <c:v>2.31853040841805E-2</c:v>
                </c:pt>
                <c:pt idx="1">
                  <c:v>0</c:v>
                </c:pt>
                <c:pt idx="2">
                  <c:v>0</c:v>
                </c:pt>
                <c:pt idx="3">
                  <c:v>2.5102921980118501E-2</c:v>
                </c:pt>
                <c:pt idx="4">
                  <c:v>0</c:v>
                </c:pt>
                <c:pt idx="5">
                  <c:v>0</c:v>
                </c:pt>
                <c:pt idx="6">
                  <c:v>0.83255332775013502</c:v>
                </c:pt>
                <c:pt idx="7">
                  <c:v>0.8038270007450100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9-3C24-4BB0-950F-03CEDAAFEBEA}"/>
            </c:ext>
          </c:extLst>
        </c:ser>
        <c:ser>
          <c:idx val="74"/>
          <c:order val="74"/>
          <c:tx>
            <c:strRef>
              <c:f>Familia_grafico!$A$77</c:f>
              <c:strCache>
                <c:ptCount val="1"/>
                <c:pt idx="0">
                  <c:v>Hyphomicrobiaceae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7:$K$77</c:f>
              <c:numCache>
                <c:formatCode>General</c:formatCode>
                <c:ptCount val="10"/>
                <c:pt idx="0">
                  <c:v>1.143213839843054</c:v>
                </c:pt>
                <c:pt idx="1">
                  <c:v>0</c:v>
                </c:pt>
                <c:pt idx="2">
                  <c:v>4.3546420484236199E-3</c:v>
                </c:pt>
                <c:pt idx="3">
                  <c:v>0</c:v>
                </c:pt>
                <c:pt idx="4">
                  <c:v>0</c:v>
                </c:pt>
                <c:pt idx="5">
                  <c:v>0.43658345460651499</c:v>
                </c:pt>
                <c:pt idx="6">
                  <c:v>3.4484457362431602E-2</c:v>
                </c:pt>
                <c:pt idx="7">
                  <c:v>0</c:v>
                </c:pt>
                <c:pt idx="8">
                  <c:v>1.0094891984655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A-3C24-4BB0-950F-03CEDAAFEBEA}"/>
            </c:ext>
          </c:extLst>
        </c:ser>
        <c:ser>
          <c:idx val="75"/>
          <c:order val="75"/>
          <c:tx>
            <c:strRef>
              <c:f>Familia_grafico!$A$78</c:f>
              <c:strCache>
                <c:ptCount val="1"/>
                <c:pt idx="0">
                  <c:v>Rhizobiales_unclassified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8:$K$78</c:f>
              <c:numCache>
                <c:formatCode>General</c:formatCode>
                <c:ptCount val="10"/>
                <c:pt idx="0">
                  <c:v>0.251471375066881</c:v>
                </c:pt>
                <c:pt idx="1">
                  <c:v>8.9783574331348606E-2</c:v>
                </c:pt>
                <c:pt idx="2">
                  <c:v>2.83051733147535E-2</c:v>
                </c:pt>
                <c:pt idx="3">
                  <c:v>6.0247012752284397E-2</c:v>
                </c:pt>
                <c:pt idx="4">
                  <c:v>0</c:v>
                </c:pt>
                <c:pt idx="5">
                  <c:v>0.30225008395835701</c:v>
                </c:pt>
                <c:pt idx="6">
                  <c:v>0.28572836100300503</c:v>
                </c:pt>
                <c:pt idx="7">
                  <c:v>0.572481668823276</c:v>
                </c:pt>
                <c:pt idx="8">
                  <c:v>6.7299279897705096E-3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B-3C24-4BB0-950F-03CEDAAFEBEA}"/>
            </c:ext>
          </c:extLst>
        </c:ser>
        <c:ser>
          <c:idx val="76"/>
          <c:order val="76"/>
          <c:tx>
            <c:strRef>
              <c:f>Familia_grafico!$A$79</c:f>
              <c:strCache>
                <c:ptCount val="1"/>
                <c:pt idx="0">
                  <c:v>S0134_terrestrial_group_fa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79:$K$79</c:f>
              <c:numCache>
                <c:formatCode>General</c:formatCode>
                <c:ptCount val="10"/>
                <c:pt idx="0">
                  <c:v>0.422685928303906</c:v>
                </c:pt>
                <c:pt idx="1">
                  <c:v>6.6156317928362199E-2</c:v>
                </c:pt>
                <c:pt idx="2">
                  <c:v>8.0560877895837005E-2</c:v>
                </c:pt>
                <c:pt idx="3">
                  <c:v>9.5391103524450196E-2</c:v>
                </c:pt>
                <c:pt idx="4">
                  <c:v>0</c:v>
                </c:pt>
                <c:pt idx="5">
                  <c:v>5.0375013993059402E-2</c:v>
                </c:pt>
                <c:pt idx="6">
                  <c:v>0.85718508300901497</c:v>
                </c:pt>
                <c:pt idx="7">
                  <c:v>0</c:v>
                </c:pt>
                <c:pt idx="8">
                  <c:v>2.3554747964196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C-3C24-4BB0-950F-03CEDAAFEBEA}"/>
            </c:ext>
          </c:extLst>
        </c:ser>
        <c:ser>
          <c:idx val="77"/>
          <c:order val="77"/>
          <c:tx>
            <c:strRef>
              <c:f>Familia_grafico!$A$80</c:f>
              <c:strCache>
                <c:ptCount val="1"/>
                <c:pt idx="0">
                  <c:v>WD2101_soil_group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0:$K$80</c:f>
              <c:numCache>
                <c:formatCode>General</c:formatCode>
                <c:ptCount val="10"/>
                <c:pt idx="0">
                  <c:v>0.31032637774210797</c:v>
                </c:pt>
                <c:pt idx="1">
                  <c:v>2.8352707683583799E-2</c:v>
                </c:pt>
                <c:pt idx="2">
                  <c:v>0.293938338268594</c:v>
                </c:pt>
                <c:pt idx="3">
                  <c:v>1.00411687920474E-2</c:v>
                </c:pt>
                <c:pt idx="4">
                  <c:v>0</c:v>
                </c:pt>
                <c:pt idx="5">
                  <c:v>0.75562520989589199</c:v>
                </c:pt>
                <c:pt idx="6">
                  <c:v>1.47790531553278E-2</c:v>
                </c:pt>
                <c:pt idx="7">
                  <c:v>1.96055366035368E-2</c:v>
                </c:pt>
                <c:pt idx="8">
                  <c:v>6.7299279897705094E-2</c:v>
                </c:pt>
                <c:pt idx="9">
                  <c:v>3.39408749957574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D-3C24-4BB0-950F-03CEDAAFEBEA}"/>
            </c:ext>
          </c:extLst>
        </c:ser>
        <c:ser>
          <c:idx val="78"/>
          <c:order val="78"/>
          <c:tx>
            <c:strRef>
              <c:f>Familia_grafico!$A$81</c:f>
              <c:strCache>
                <c:ptCount val="1"/>
                <c:pt idx="0">
                  <c:v>Microscillacea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1:$K$81</c:f>
              <c:numCache>
                <c:formatCode>General</c:formatCode>
                <c:ptCount val="10"/>
                <c:pt idx="0">
                  <c:v>0.45300517210629598</c:v>
                </c:pt>
                <c:pt idx="1">
                  <c:v>0</c:v>
                </c:pt>
                <c:pt idx="2">
                  <c:v>3.7014457411600803E-2</c:v>
                </c:pt>
                <c:pt idx="3">
                  <c:v>0</c:v>
                </c:pt>
                <c:pt idx="4">
                  <c:v>0</c:v>
                </c:pt>
                <c:pt idx="5">
                  <c:v>0.90115302809806297</c:v>
                </c:pt>
                <c:pt idx="6">
                  <c:v>4.9263510517759498E-2</c:v>
                </c:pt>
                <c:pt idx="7">
                  <c:v>7.8422146414147392E-3</c:v>
                </c:pt>
                <c:pt idx="8">
                  <c:v>7.0664243892590406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E-3C24-4BB0-950F-03CEDAAFEBEA}"/>
            </c:ext>
          </c:extLst>
        </c:ser>
        <c:ser>
          <c:idx val="79"/>
          <c:order val="79"/>
          <c:tx>
            <c:strRef>
              <c:f>Familia_grafico!$A$82</c:f>
              <c:strCache>
                <c:ptCount val="1"/>
                <c:pt idx="0">
                  <c:v>Pyrinomonadaceae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2:$K$82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4.7254512805973E-3</c:v>
                </c:pt>
                <c:pt idx="2">
                  <c:v>0.12410729838007301</c:v>
                </c:pt>
                <c:pt idx="3">
                  <c:v>1.00411687920474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362810417928528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F-3C24-4BB0-950F-03CEDAAFEBEA}"/>
            </c:ext>
          </c:extLst>
        </c:ser>
        <c:ser>
          <c:idx val="80"/>
          <c:order val="80"/>
          <c:tx>
            <c:strRef>
              <c:f>Familia_grafico!$A$83</c:f>
              <c:strCache>
                <c:ptCount val="1"/>
                <c:pt idx="0">
                  <c:v>Devosiaceae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3:$K$83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7.5607220489556801E-2</c:v>
                </c:pt>
                <c:pt idx="2">
                  <c:v>4.3546420484236199E-3</c:v>
                </c:pt>
                <c:pt idx="3">
                  <c:v>0.105432272316498</c:v>
                </c:pt>
                <c:pt idx="4">
                  <c:v>0</c:v>
                </c:pt>
                <c:pt idx="5">
                  <c:v>3.3583342662039599E-2</c:v>
                </c:pt>
                <c:pt idx="6">
                  <c:v>9.8527021035518993E-3</c:v>
                </c:pt>
                <c:pt idx="7">
                  <c:v>1.5684429282829499E-2</c:v>
                </c:pt>
                <c:pt idx="8">
                  <c:v>1.6824819974426301E-2</c:v>
                </c:pt>
                <c:pt idx="9">
                  <c:v>1.14041339985744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0-3C24-4BB0-950F-03CEDAAFEBEA}"/>
            </c:ext>
          </c:extLst>
        </c:ser>
        <c:ser>
          <c:idx val="81"/>
          <c:order val="81"/>
          <c:tx>
            <c:strRef>
              <c:f>Familia_grafico!$A$84</c:f>
              <c:strCache>
                <c:ptCount val="1"/>
                <c:pt idx="0">
                  <c:v>Phycisphaeraceae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4:$K$84</c:f>
              <c:numCache>
                <c:formatCode>General</c:formatCode>
                <c:ptCount val="10"/>
                <c:pt idx="0">
                  <c:v>0.32459425717852702</c:v>
                </c:pt>
                <c:pt idx="1">
                  <c:v>0.15121444097911399</c:v>
                </c:pt>
                <c:pt idx="2">
                  <c:v>4.13690994600244E-2</c:v>
                </c:pt>
                <c:pt idx="3">
                  <c:v>0.25604980419720902</c:v>
                </c:pt>
                <c:pt idx="4">
                  <c:v>0</c:v>
                </c:pt>
                <c:pt idx="5">
                  <c:v>0.48136124482256798</c:v>
                </c:pt>
                <c:pt idx="6">
                  <c:v>3.9410808414207597E-2</c:v>
                </c:pt>
                <c:pt idx="7">
                  <c:v>0</c:v>
                </c:pt>
                <c:pt idx="8">
                  <c:v>1.6824819974426301E-2</c:v>
                </c:pt>
                <c:pt idx="9">
                  <c:v>9.1640362488544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1-3C24-4BB0-950F-03CEDAAFEBEA}"/>
            </c:ext>
          </c:extLst>
        </c:ser>
        <c:ser>
          <c:idx val="82"/>
          <c:order val="82"/>
          <c:tx>
            <c:strRef>
              <c:f>Familia_grafico!$A$85</c:f>
              <c:strCache>
                <c:ptCount val="1"/>
                <c:pt idx="0">
                  <c:v>AKIW781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5:$K$85</c:f>
              <c:numCache>
                <c:formatCode>General</c:formatCode>
                <c:ptCount val="10"/>
                <c:pt idx="0">
                  <c:v>0</c:v>
                </c:pt>
                <c:pt idx="1">
                  <c:v>0.255174369152254</c:v>
                </c:pt>
                <c:pt idx="2">
                  <c:v>0.59440863960982404</c:v>
                </c:pt>
                <c:pt idx="3">
                  <c:v>0.2409880510091370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30621172353455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2-3C24-4BB0-950F-03CEDAAFEBEA}"/>
            </c:ext>
          </c:extLst>
        </c:ser>
        <c:ser>
          <c:idx val="83"/>
          <c:order val="83"/>
          <c:tx>
            <c:strRef>
              <c:f>Familia_grafico!$A$86</c:f>
              <c:strCache>
                <c:ptCount val="1"/>
                <c:pt idx="0">
                  <c:v>A4b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6:$K$86</c:f>
              <c:numCache>
                <c:formatCode>General</c:formatCode>
                <c:ptCount val="10"/>
                <c:pt idx="0">
                  <c:v>0.31210986267166002</c:v>
                </c:pt>
                <c:pt idx="1">
                  <c:v>0.118136282014932</c:v>
                </c:pt>
                <c:pt idx="2">
                  <c:v>4.7901062532659799E-2</c:v>
                </c:pt>
                <c:pt idx="3">
                  <c:v>2.5102921980118501E-2</c:v>
                </c:pt>
                <c:pt idx="4">
                  <c:v>0</c:v>
                </c:pt>
                <c:pt idx="5">
                  <c:v>0.79480577633493799</c:v>
                </c:pt>
                <c:pt idx="6">
                  <c:v>6.4042563673087305E-2</c:v>
                </c:pt>
                <c:pt idx="7">
                  <c:v>0</c:v>
                </c:pt>
                <c:pt idx="8">
                  <c:v>1.0094891984655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3-3C24-4BB0-950F-03CEDAAFEBEA}"/>
            </c:ext>
          </c:extLst>
        </c:ser>
        <c:ser>
          <c:idx val="84"/>
          <c:order val="84"/>
          <c:tx>
            <c:strRef>
              <c:f>Familia_grafico!$A$87</c:f>
              <c:strCache>
                <c:ptCount val="1"/>
                <c:pt idx="0">
                  <c:v>Sporichthyaceae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7:$K$87</c:f>
              <c:numCache>
                <c:formatCode>General</c:formatCode>
                <c:ptCount val="10"/>
                <c:pt idx="0">
                  <c:v>0.131977884786874</c:v>
                </c:pt>
                <c:pt idx="1">
                  <c:v>4.7254512805973002E-2</c:v>
                </c:pt>
                <c:pt idx="2">
                  <c:v>0.27651977007489997</c:v>
                </c:pt>
                <c:pt idx="3">
                  <c:v>9.0370519128426502E-2</c:v>
                </c:pt>
                <c:pt idx="4">
                  <c:v>0</c:v>
                </c:pt>
                <c:pt idx="5">
                  <c:v>0.25187506996529702</c:v>
                </c:pt>
                <c:pt idx="6">
                  <c:v>4.9263510517759498E-2</c:v>
                </c:pt>
                <c:pt idx="7">
                  <c:v>0.38818962475002899</c:v>
                </c:pt>
                <c:pt idx="8">
                  <c:v>0.10094891984655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4-3C24-4BB0-950F-03CEDAAFEBEA}"/>
            </c:ext>
          </c:extLst>
        </c:ser>
        <c:ser>
          <c:idx val="85"/>
          <c:order val="85"/>
          <c:tx>
            <c:strRef>
              <c:f>Familia_grafico!$A$88</c:f>
              <c:strCache>
                <c:ptCount val="1"/>
                <c:pt idx="0">
                  <c:v>Methyloligellaceae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8:$K$88</c:f>
              <c:numCache>
                <c:formatCode>General</c:formatCode>
                <c:ptCount val="10"/>
                <c:pt idx="0">
                  <c:v>0.62957018013197796</c:v>
                </c:pt>
                <c:pt idx="1">
                  <c:v>4.7254512805973002E-2</c:v>
                </c:pt>
                <c:pt idx="2">
                  <c:v>0</c:v>
                </c:pt>
                <c:pt idx="3">
                  <c:v>4.51852595642133E-2</c:v>
                </c:pt>
                <c:pt idx="4">
                  <c:v>0</c:v>
                </c:pt>
                <c:pt idx="5">
                  <c:v>0.28545841262733701</c:v>
                </c:pt>
                <c:pt idx="6">
                  <c:v>0.280802009951229</c:v>
                </c:pt>
                <c:pt idx="7">
                  <c:v>3.1368858565658901E-2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5-3C24-4BB0-950F-03CEDAAFEBEA}"/>
            </c:ext>
          </c:extLst>
        </c:ser>
        <c:ser>
          <c:idx val="86"/>
          <c:order val="86"/>
          <c:tx>
            <c:strRef>
              <c:f>Familia_grafico!$A$89</c:f>
              <c:strCache>
                <c:ptCount val="1"/>
                <c:pt idx="0">
                  <c:v>MWH-CFBk5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89:$K$89</c:f>
              <c:numCache>
                <c:formatCode>General</c:formatCode>
                <c:ptCount val="10"/>
                <c:pt idx="0">
                  <c:v>0</c:v>
                </c:pt>
                <c:pt idx="1">
                  <c:v>4.2529061525375701E-2</c:v>
                </c:pt>
                <c:pt idx="2">
                  <c:v>5.2255704581083397E-2</c:v>
                </c:pt>
                <c:pt idx="3">
                  <c:v>8.0329350336379196E-2</c:v>
                </c:pt>
                <c:pt idx="4">
                  <c:v>0</c:v>
                </c:pt>
                <c:pt idx="5">
                  <c:v>1.11944475540132E-2</c:v>
                </c:pt>
                <c:pt idx="6">
                  <c:v>9.8527021035518993E-3</c:v>
                </c:pt>
                <c:pt idx="7">
                  <c:v>0.482296200447006</c:v>
                </c:pt>
                <c:pt idx="8">
                  <c:v>0</c:v>
                </c:pt>
                <c:pt idx="9">
                  <c:v>0.590571224926178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6-3C24-4BB0-950F-03CEDAAFEBEA}"/>
            </c:ext>
          </c:extLst>
        </c:ser>
        <c:ser>
          <c:idx val="87"/>
          <c:order val="87"/>
          <c:tx>
            <c:strRef>
              <c:f>Familia_grafico!$A$90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0:$K$90</c:f>
              <c:numCache>
                <c:formatCode>General</c:formatCode>
                <c:ptCount val="10"/>
                <c:pt idx="0">
                  <c:v>0.131977884786874</c:v>
                </c:pt>
                <c:pt idx="1">
                  <c:v>0.23627256402986499</c:v>
                </c:pt>
                <c:pt idx="2">
                  <c:v>0.21990942344539299</c:v>
                </c:pt>
                <c:pt idx="3">
                  <c:v>0.210864544632995</c:v>
                </c:pt>
                <c:pt idx="4">
                  <c:v>0</c:v>
                </c:pt>
                <c:pt idx="5">
                  <c:v>0</c:v>
                </c:pt>
                <c:pt idx="6">
                  <c:v>0.20198039312281399</c:v>
                </c:pt>
                <c:pt idx="7">
                  <c:v>0</c:v>
                </c:pt>
                <c:pt idx="8">
                  <c:v>3.0284675953967301E-2</c:v>
                </c:pt>
                <c:pt idx="9">
                  <c:v>0.183280724977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7-3C24-4BB0-950F-03CEDAAFEBEA}"/>
            </c:ext>
          </c:extLst>
        </c:ser>
        <c:ser>
          <c:idx val="88"/>
          <c:order val="88"/>
          <c:tx>
            <c:strRef>
              <c:f>Familia_grafico!$A$91</c:f>
              <c:strCache>
                <c:ptCount val="1"/>
                <c:pt idx="0">
                  <c:v>Micrococcales_unclassified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1:$K$91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9.4509025611946001E-3</c:v>
                </c:pt>
                <c:pt idx="2">
                  <c:v>0</c:v>
                </c:pt>
                <c:pt idx="3">
                  <c:v>5.0205843960236998E-3</c:v>
                </c:pt>
                <c:pt idx="4">
                  <c:v>8.14243838888286E-3</c:v>
                </c:pt>
                <c:pt idx="5">
                  <c:v>0</c:v>
                </c:pt>
                <c:pt idx="6">
                  <c:v>5.4189861569535397E-2</c:v>
                </c:pt>
                <c:pt idx="7">
                  <c:v>0.92146022036623099</c:v>
                </c:pt>
                <c:pt idx="8">
                  <c:v>0</c:v>
                </c:pt>
                <c:pt idx="9">
                  <c:v>0.20703933747412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8-3C24-4BB0-950F-03CEDAAFEBEA}"/>
            </c:ext>
          </c:extLst>
        </c:ser>
        <c:ser>
          <c:idx val="89"/>
          <c:order val="89"/>
          <c:tx>
            <c:strRef>
              <c:f>Familia_grafico!$A$92</c:f>
              <c:strCache>
                <c:ptCount val="1"/>
                <c:pt idx="0">
                  <c:v>Trueperaceae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2:$K$92</c:f>
              <c:numCache>
                <c:formatCode>General</c:formatCode>
                <c:ptCount val="10"/>
                <c:pt idx="0">
                  <c:v>7.8473336900303198E-2</c:v>
                </c:pt>
                <c:pt idx="1">
                  <c:v>2.8352707683583799E-2</c:v>
                </c:pt>
                <c:pt idx="2">
                  <c:v>0.30047030134122998</c:v>
                </c:pt>
                <c:pt idx="3">
                  <c:v>4.51852595642133E-2</c:v>
                </c:pt>
                <c:pt idx="4">
                  <c:v>0</c:v>
                </c:pt>
                <c:pt idx="5">
                  <c:v>2.7986118885032999E-2</c:v>
                </c:pt>
                <c:pt idx="6">
                  <c:v>0.24631755258879701</c:v>
                </c:pt>
                <c:pt idx="7">
                  <c:v>1.1763321962122099E-2</c:v>
                </c:pt>
                <c:pt idx="8">
                  <c:v>0</c:v>
                </c:pt>
                <c:pt idx="9">
                  <c:v>0.45820181244272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9-3C24-4BB0-950F-03CEDAAFEBEA}"/>
            </c:ext>
          </c:extLst>
        </c:ser>
        <c:ser>
          <c:idx val="90"/>
          <c:order val="90"/>
          <c:tx>
            <c:strRef>
              <c:f>Familia_grafico!$A$93</c:f>
              <c:strCache>
                <c:ptCount val="1"/>
                <c:pt idx="0">
                  <c:v>Pseudohongiellaceae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3:$K$93</c:f>
              <c:numCache>
                <c:formatCode>General</c:formatCode>
                <c:ptCount val="10"/>
                <c:pt idx="0">
                  <c:v>0</c:v>
                </c:pt>
                <c:pt idx="1">
                  <c:v>3.78036102447784E-2</c:v>
                </c:pt>
                <c:pt idx="2">
                  <c:v>0</c:v>
                </c:pt>
                <c:pt idx="3">
                  <c:v>1.5061753188071099E-2</c:v>
                </c:pt>
                <c:pt idx="4">
                  <c:v>0</c:v>
                </c:pt>
                <c:pt idx="5">
                  <c:v>0</c:v>
                </c:pt>
                <c:pt idx="6">
                  <c:v>3.4484457362431602E-2</c:v>
                </c:pt>
                <c:pt idx="7">
                  <c:v>0.145080970866173</c:v>
                </c:pt>
                <c:pt idx="8">
                  <c:v>0</c:v>
                </c:pt>
                <c:pt idx="9">
                  <c:v>0.96392084987950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A-3C24-4BB0-950F-03CEDAAFEBEA}"/>
            </c:ext>
          </c:extLst>
        </c:ser>
        <c:ser>
          <c:idx val="91"/>
          <c:order val="91"/>
          <c:tx>
            <c:strRef>
              <c:f>Familia_grafico!$A$94</c:f>
              <c:strCache>
                <c:ptCount val="1"/>
                <c:pt idx="0">
                  <c:v>Opitutaceae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4:$K$94</c:f>
              <c:numCache>
                <c:formatCode>General</c:formatCode>
                <c:ptCount val="10"/>
                <c:pt idx="0">
                  <c:v>8.3823791688960203E-2</c:v>
                </c:pt>
                <c:pt idx="1">
                  <c:v>0</c:v>
                </c:pt>
                <c:pt idx="2">
                  <c:v>5.6610346629507098E-2</c:v>
                </c:pt>
                <c:pt idx="3">
                  <c:v>0</c:v>
                </c:pt>
                <c:pt idx="4">
                  <c:v>0</c:v>
                </c:pt>
                <c:pt idx="5">
                  <c:v>0.42538900705250199</c:v>
                </c:pt>
                <c:pt idx="6">
                  <c:v>1.9705404207103799E-2</c:v>
                </c:pt>
                <c:pt idx="7">
                  <c:v>0</c:v>
                </c:pt>
                <c:pt idx="8">
                  <c:v>0.57204387913049304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B-3C24-4BB0-950F-03CEDAAFEBEA}"/>
            </c:ext>
          </c:extLst>
        </c:ser>
        <c:ser>
          <c:idx val="92"/>
          <c:order val="92"/>
          <c:tx>
            <c:strRef>
              <c:f>Familia_grafico!$A$95</c:f>
              <c:strCache>
                <c:ptCount val="1"/>
                <c:pt idx="0">
                  <c:v>Latescibacteraceae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5:$K$95</c:f>
              <c:numCache>
                <c:formatCode>General</c:formatCode>
                <c:ptCount val="10"/>
                <c:pt idx="0">
                  <c:v>1.15391474942036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C-3C24-4BB0-950F-03CEDAAFEBEA}"/>
            </c:ext>
          </c:extLst>
        </c:ser>
        <c:ser>
          <c:idx val="93"/>
          <c:order val="93"/>
          <c:tx>
            <c:strRef>
              <c:f>Familia_grafico!$A$96</c:f>
              <c:strCache>
                <c:ptCount val="1"/>
                <c:pt idx="0">
                  <c:v>Obscuribacterales_fa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6:$K$9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3623642673234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D-3C24-4BB0-950F-03CEDAAFEBEA}"/>
            </c:ext>
          </c:extLst>
        </c:ser>
        <c:ser>
          <c:idx val="94"/>
          <c:order val="94"/>
          <c:tx>
            <c:strRef>
              <c:f>Familia_grafico!$A$97</c:f>
              <c:strCache>
                <c:ptCount val="1"/>
                <c:pt idx="0">
                  <c:v>Steroidobacteraceae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7:$K$97</c:f>
              <c:numCache>
                <c:formatCode>General</c:formatCode>
                <c:ptCount val="10"/>
                <c:pt idx="0">
                  <c:v>0.95594792224005698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8.9555580432105694E-2</c:v>
                </c:pt>
                <c:pt idx="6">
                  <c:v>7.8821616828415195E-2</c:v>
                </c:pt>
                <c:pt idx="7">
                  <c:v>0</c:v>
                </c:pt>
                <c:pt idx="8">
                  <c:v>0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E-3C24-4BB0-950F-03CEDAAFEBEA}"/>
            </c:ext>
          </c:extLst>
        </c:ser>
        <c:ser>
          <c:idx val="95"/>
          <c:order val="95"/>
          <c:tx>
            <c:strRef>
              <c:f>Familia_grafico!$A$98</c:f>
              <c:strCache>
                <c:ptCount val="1"/>
                <c:pt idx="0">
                  <c:v>JG30-KF-CM66_fa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8:$K$98</c:f>
              <c:numCache>
                <c:formatCode>General</c:formatCode>
                <c:ptCount val="10"/>
                <c:pt idx="0">
                  <c:v>9.8091671125379004E-2</c:v>
                </c:pt>
                <c:pt idx="1">
                  <c:v>0.10395992817314099</c:v>
                </c:pt>
                <c:pt idx="2">
                  <c:v>0.26127852290541698</c:v>
                </c:pt>
                <c:pt idx="3">
                  <c:v>8.0329350336379196E-2</c:v>
                </c:pt>
                <c:pt idx="4">
                  <c:v>0</c:v>
                </c:pt>
                <c:pt idx="5">
                  <c:v>0.21269450352625099</c:v>
                </c:pt>
                <c:pt idx="6">
                  <c:v>0.113306074190847</c:v>
                </c:pt>
                <c:pt idx="7">
                  <c:v>0</c:v>
                </c:pt>
                <c:pt idx="8">
                  <c:v>0.16488323574937799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F-3C24-4BB0-950F-03CEDAAFEBEA}"/>
            </c:ext>
          </c:extLst>
        </c:ser>
        <c:ser>
          <c:idx val="96"/>
          <c:order val="96"/>
          <c:tx>
            <c:strRef>
              <c:f>Familia_grafico!$A$99</c:f>
              <c:strCache>
                <c:ptCount val="1"/>
                <c:pt idx="0">
                  <c:v>Beijerinckiaceae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99:$K$99</c:f>
              <c:numCache>
                <c:formatCode>General</c:formatCode>
                <c:ptCount val="10"/>
                <c:pt idx="0">
                  <c:v>2.31853040841805E-2</c:v>
                </c:pt>
                <c:pt idx="1">
                  <c:v>9.9234476892543194E-2</c:v>
                </c:pt>
                <c:pt idx="2">
                  <c:v>0.24603727573593501</c:v>
                </c:pt>
                <c:pt idx="3">
                  <c:v>0.120494025504569</c:v>
                </c:pt>
                <c:pt idx="4">
                  <c:v>0</c:v>
                </c:pt>
                <c:pt idx="5">
                  <c:v>1.6791671331019799E-2</c:v>
                </c:pt>
                <c:pt idx="6">
                  <c:v>0</c:v>
                </c:pt>
                <c:pt idx="7">
                  <c:v>0</c:v>
                </c:pt>
                <c:pt idx="8">
                  <c:v>0.5081095632276729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0-3C24-4BB0-950F-03CEDAAFEBEA}"/>
            </c:ext>
          </c:extLst>
        </c:ser>
        <c:ser>
          <c:idx val="97"/>
          <c:order val="97"/>
          <c:tx>
            <c:strRef>
              <c:f>Familia_grafico!$A$100</c:f>
              <c:strCache>
                <c:ptCount val="1"/>
                <c:pt idx="0">
                  <c:v>Gemmatimonadetes_unclassified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00:$K$100</c:f>
              <c:numCache>
                <c:formatCode>General</c:formatCode>
                <c:ptCount val="10"/>
                <c:pt idx="0">
                  <c:v>1.6051364365971099E-2</c:v>
                </c:pt>
                <c:pt idx="1">
                  <c:v>0.20791985634628099</c:v>
                </c:pt>
                <c:pt idx="2">
                  <c:v>0</c:v>
                </c:pt>
                <c:pt idx="3">
                  <c:v>0.12551460990059199</c:v>
                </c:pt>
                <c:pt idx="4">
                  <c:v>0</c:v>
                </c:pt>
                <c:pt idx="5">
                  <c:v>0.190305608418225</c:v>
                </c:pt>
                <c:pt idx="6">
                  <c:v>0.30050741415833299</c:v>
                </c:pt>
                <c:pt idx="7">
                  <c:v>0</c:v>
                </c:pt>
                <c:pt idx="8">
                  <c:v>3.3649639948852499E-2</c:v>
                </c:pt>
                <c:pt idx="9">
                  <c:v>0.13576349998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1-3C24-4BB0-950F-03CEDAAFEBEA}"/>
            </c:ext>
          </c:extLst>
        </c:ser>
        <c:ser>
          <c:idx val="98"/>
          <c:order val="98"/>
          <c:tx>
            <c:strRef>
              <c:f>Familia_grafico!$A$101</c:f>
              <c:strCache>
                <c:ptCount val="1"/>
                <c:pt idx="0">
                  <c:v>Remaining families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Familia_grafico!$B$2:$K$2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Familia_grafico!$B$101:$K$101</c:f>
              <c:numCache>
                <c:formatCode>General</c:formatCode>
                <c:ptCount val="10"/>
                <c:pt idx="0">
                  <c:v>9.249152844658445</c:v>
                </c:pt>
                <c:pt idx="1">
                  <c:v>3.2133068708061612</c:v>
                </c:pt>
                <c:pt idx="2">
                  <c:v>4.3785925796899514</c:v>
                </c:pt>
                <c:pt idx="3">
                  <c:v>3.58469725876092</c:v>
                </c:pt>
                <c:pt idx="4">
                  <c:v>0.79795896211051998</c:v>
                </c:pt>
                <c:pt idx="5">
                  <c:v>12.56017015560283</c:v>
                </c:pt>
                <c:pt idx="6">
                  <c:v>6.3155820483767693</c:v>
                </c:pt>
                <c:pt idx="7">
                  <c:v>3.1957024663765048</c:v>
                </c:pt>
                <c:pt idx="8">
                  <c:v>1.6185476815398061</c:v>
                </c:pt>
                <c:pt idx="9">
                  <c:v>1.2829650748396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2-3C24-4BB0-950F-03CEDAAFEB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088182928"/>
        <c:axId val="-2088179712"/>
      </c:barChart>
      <c:catAx>
        <c:axId val="-208818292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2088179712"/>
        <c:crosses val="autoZero"/>
        <c:auto val="1"/>
        <c:lblAlgn val="ctr"/>
        <c:lblOffset val="100"/>
        <c:noMultiLvlLbl val="0"/>
      </c:catAx>
      <c:valAx>
        <c:axId val="-20881797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81829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090805452360498"/>
          <c:y val="4.1847267816963303E-2"/>
          <c:w val="0.373672176328598"/>
          <c:h val="0.933895984166026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dirty="0" err="1"/>
              <a:t>Genera</a:t>
            </a:r>
            <a:endParaRPr lang="pt-PT" dirty="0"/>
          </a:p>
        </c:rich>
      </c:tx>
      <c:layout>
        <c:manualLayout>
          <c:xMode val="edge"/>
          <c:yMode val="edge"/>
          <c:x val="0.29301295931758531"/>
          <c:y val="0.1288639351475847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8932086614173226E-2"/>
          <c:y val="0.19618172887468213"/>
          <c:w val="0.56250803805774297"/>
          <c:h val="0.5686410892882589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Genero_grafico!$A$2</c:f>
              <c:strCache>
                <c:ptCount val="1"/>
                <c:pt idx="0">
                  <c:v>Rubrobacte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:$K$2</c:f>
              <c:numCache>
                <c:formatCode>General</c:formatCode>
                <c:ptCount val="10"/>
                <c:pt idx="0">
                  <c:v>0.422685928303906</c:v>
                </c:pt>
                <c:pt idx="1">
                  <c:v>12.271996975711181</c:v>
                </c:pt>
                <c:pt idx="2">
                  <c:v>3.8669221390001729</c:v>
                </c:pt>
                <c:pt idx="3">
                  <c:v>13.56059845366001</c:v>
                </c:pt>
                <c:pt idx="4">
                  <c:v>65.326783194007149</c:v>
                </c:pt>
                <c:pt idx="5">
                  <c:v>0.29105563640434301</c:v>
                </c:pt>
                <c:pt idx="6">
                  <c:v>11.315828365929359</c:v>
                </c:pt>
                <c:pt idx="7">
                  <c:v>34.431243383131402</c:v>
                </c:pt>
                <c:pt idx="8">
                  <c:v>24.816609462278759</c:v>
                </c:pt>
                <c:pt idx="9">
                  <c:v>26.531581984183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39-43B7-BBB0-971E077EAE9E}"/>
            </c:ext>
          </c:extLst>
        </c:ser>
        <c:ser>
          <c:idx val="1"/>
          <c:order val="1"/>
          <c:tx>
            <c:strRef>
              <c:f>Genero_grafico!$A$3</c:f>
              <c:strCache>
                <c:ptCount val="1"/>
                <c:pt idx="0">
                  <c:v>Crossiell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:$K$3</c:f>
              <c:numCache>
                <c:formatCode>General</c:formatCode>
                <c:ptCount val="10"/>
                <c:pt idx="0">
                  <c:v>26.538255751738902</c:v>
                </c:pt>
                <c:pt idx="1">
                  <c:v>8.3687742179378155</c:v>
                </c:pt>
                <c:pt idx="2">
                  <c:v>4.3546420484236199E-3</c:v>
                </c:pt>
                <c:pt idx="3">
                  <c:v>7.3752384777588107</c:v>
                </c:pt>
                <c:pt idx="4">
                  <c:v>5.42829225925524E-3</c:v>
                </c:pt>
                <c:pt idx="5">
                  <c:v>0.190305608418225</c:v>
                </c:pt>
                <c:pt idx="6">
                  <c:v>40.760628602394213</c:v>
                </c:pt>
                <c:pt idx="7">
                  <c:v>0</c:v>
                </c:pt>
                <c:pt idx="8">
                  <c:v>9.4218991856787102E-2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39-43B7-BBB0-971E077EAE9E}"/>
            </c:ext>
          </c:extLst>
        </c:ser>
        <c:ser>
          <c:idx val="2"/>
          <c:order val="2"/>
          <c:tx>
            <c:strRef>
              <c:f>Genero_grafico!$A$4</c:f>
              <c:strCache>
                <c:ptCount val="1"/>
                <c:pt idx="0">
                  <c:v>Oxyphotobacteria_unclassifie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:$K$4</c:f>
              <c:numCache>
                <c:formatCode>General</c:formatCode>
                <c:ptCount val="10"/>
                <c:pt idx="0">
                  <c:v>7.9632602104512218</c:v>
                </c:pt>
                <c:pt idx="1">
                  <c:v>8.19865797183631</c:v>
                </c:pt>
                <c:pt idx="2">
                  <c:v>0.21773210242118099</c:v>
                </c:pt>
                <c:pt idx="3">
                  <c:v>7.8873380861532283</c:v>
                </c:pt>
                <c:pt idx="4">
                  <c:v>1.0856584518510499E-2</c:v>
                </c:pt>
                <c:pt idx="5">
                  <c:v>0.12873614687115201</c:v>
                </c:pt>
                <c:pt idx="6">
                  <c:v>0</c:v>
                </c:pt>
                <c:pt idx="7">
                  <c:v>4.2112692624397132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B39-43B7-BBB0-971E077EAE9E}"/>
            </c:ext>
          </c:extLst>
        </c:ser>
        <c:ser>
          <c:idx val="3"/>
          <c:order val="3"/>
          <c:tx>
            <c:strRef>
              <c:f>Genero_grafico!$A$5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:$K$5</c:f>
              <c:numCache>
                <c:formatCode>General</c:formatCode>
                <c:ptCount val="10"/>
                <c:pt idx="0">
                  <c:v>1.4267879436418799E-2</c:v>
                </c:pt>
                <c:pt idx="1">
                  <c:v>0.50089783574331403</c:v>
                </c:pt>
                <c:pt idx="2">
                  <c:v>0</c:v>
                </c:pt>
                <c:pt idx="3">
                  <c:v>0.507079023998394</c:v>
                </c:pt>
                <c:pt idx="4">
                  <c:v>26.150797958962109</c:v>
                </c:pt>
                <c:pt idx="5">
                  <c:v>0</c:v>
                </c:pt>
                <c:pt idx="6">
                  <c:v>0.26602295679590099</c:v>
                </c:pt>
                <c:pt idx="7">
                  <c:v>1.1763321962122099E-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B39-43B7-BBB0-971E077EAE9E}"/>
            </c:ext>
          </c:extLst>
        </c:ser>
        <c:ser>
          <c:idx val="4"/>
          <c:order val="4"/>
          <c:tx>
            <c:strRef>
              <c:f>Genero_grafico!$A$6</c:f>
              <c:strCache>
                <c:ptCount val="1"/>
                <c:pt idx="0">
                  <c:v>uncultured_g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:$K$6</c:f>
              <c:numCache>
                <c:formatCode>General</c:formatCode>
                <c:ptCount val="10"/>
                <c:pt idx="0">
                  <c:v>0</c:v>
                </c:pt>
                <c:pt idx="1">
                  <c:v>7.08817692089595E-2</c:v>
                </c:pt>
                <c:pt idx="2">
                  <c:v>25.037014457411601</c:v>
                </c:pt>
                <c:pt idx="3">
                  <c:v>3.0123506376142199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B39-43B7-BBB0-971E077EAE9E}"/>
            </c:ext>
          </c:extLst>
        </c:ser>
        <c:ser>
          <c:idx val="5"/>
          <c:order val="5"/>
          <c:tx>
            <c:strRef>
              <c:f>Genero_grafico!$A$7</c:f>
              <c:strCache>
                <c:ptCount val="1"/>
                <c:pt idx="0">
                  <c:v>Blastocatell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:$K$7</c:f>
              <c:numCache>
                <c:formatCode>General</c:formatCode>
                <c:ptCount val="10"/>
                <c:pt idx="0">
                  <c:v>0.244337435348671</c:v>
                </c:pt>
                <c:pt idx="1">
                  <c:v>4.115868065400246</c:v>
                </c:pt>
                <c:pt idx="2">
                  <c:v>6.9347674621146149</c:v>
                </c:pt>
                <c:pt idx="3">
                  <c:v>3.8658499849382459</c:v>
                </c:pt>
                <c:pt idx="4">
                  <c:v>0</c:v>
                </c:pt>
                <c:pt idx="5">
                  <c:v>0.75562520989589199</c:v>
                </c:pt>
                <c:pt idx="6">
                  <c:v>0</c:v>
                </c:pt>
                <c:pt idx="7">
                  <c:v>1.1763321962122099E-2</c:v>
                </c:pt>
                <c:pt idx="8">
                  <c:v>8.3619355272898606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B39-43B7-BBB0-971E077EAE9E}"/>
            </c:ext>
          </c:extLst>
        </c:ser>
        <c:ser>
          <c:idx val="6"/>
          <c:order val="6"/>
          <c:tx>
            <c:strRef>
              <c:f>Genero_grafico!$A$8</c:f>
              <c:strCache>
                <c:ptCount val="1"/>
                <c:pt idx="0">
                  <c:v>JG30-KF-CM45_ge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:$K$8</c:f>
              <c:numCache>
                <c:formatCode>General</c:formatCode>
                <c:ptCount val="10"/>
                <c:pt idx="0">
                  <c:v>0.57428214731585503</c:v>
                </c:pt>
                <c:pt idx="1">
                  <c:v>1.8476514507135431</c:v>
                </c:pt>
                <c:pt idx="2">
                  <c:v>4.1739244034140404</c:v>
                </c:pt>
                <c:pt idx="3">
                  <c:v>1.7069986946480571</c:v>
                </c:pt>
                <c:pt idx="4">
                  <c:v>0</c:v>
                </c:pt>
                <c:pt idx="5">
                  <c:v>0.30225008395835701</c:v>
                </c:pt>
                <c:pt idx="6">
                  <c:v>2.2907532390758161</c:v>
                </c:pt>
                <c:pt idx="7">
                  <c:v>1.615496216131435</c:v>
                </c:pt>
                <c:pt idx="8">
                  <c:v>3.1630661551921402</c:v>
                </c:pt>
                <c:pt idx="9">
                  <c:v>3.89980653701252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B39-43B7-BBB0-971E077EAE9E}"/>
            </c:ext>
          </c:extLst>
        </c:ser>
        <c:ser>
          <c:idx val="7"/>
          <c:order val="7"/>
          <c:tx>
            <c:strRef>
              <c:f>Genero_grafico!$A$9</c:f>
              <c:strCache>
                <c:ptCount val="1"/>
                <c:pt idx="0">
                  <c:v>Sphingomonadaceae_unclassified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:$K$9</c:f>
              <c:numCache>
                <c:formatCode>General</c:formatCode>
                <c:ptCount val="10"/>
                <c:pt idx="0">
                  <c:v>1.0772248974496159</c:v>
                </c:pt>
                <c:pt idx="1">
                  <c:v>1.9657877327284761</c:v>
                </c:pt>
                <c:pt idx="2">
                  <c:v>1.3063926145270861</c:v>
                </c:pt>
                <c:pt idx="3">
                  <c:v>1.7421427854202229</c:v>
                </c:pt>
                <c:pt idx="4">
                  <c:v>0</c:v>
                </c:pt>
                <c:pt idx="5">
                  <c:v>6.2073211687003251</c:v>
                </c:pt>
                <c:pt idx="6">
                  <c:v>4.9263510517759498E-2</c:v>
                </c:pt>
                <c:pt idx="7">
                  <c:v>3.8348429596518052</c:v>
                </c:pt>
                <c:pt idx="8">
                  <c:v>0.96237970253718297</c:v>
                </c:pt>
                <c:pt idx="9">
                  <c:v>2.28082679971489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4B39-43B7-BBB0-971E077EAE9E}"/>
            </c:ext>
          </c:extLst>
        </c:ser>
        <c:ser>
          <c:idx val="8"/>
          <c:order val="8"/>
          <c:tx>
            <c:strRef>
              <c:f>Genero_grafico!$A$10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:$K$10</c:f>
              <c:numCache>
                <c:formatCode>General</c:formatCode>
                <c:ptCount val="10"/>
                <c:pt idx="0">
                  <c:v>0.37631532013554497</c:v>
                </c:pt>
                <c:pt idx="1">
                  <c:v>0.63793592288063505</c:v>
                </c:pt>
                <c:pt idx="2">
                  <c:v>0.18507228705800399</c:v>
                </c:pt>
                <c:pt idx="3">
                  <c:v>0.63259363389898604</c:v>
                </c:pt>
                <c:pt idx="4">
                  <c:v>0</c:v>
                </c:pt>
                <c:pt idx="5">
                  <c:v>15.280420911228029</c:v>
                </c:pt>
                <c:pt idx="6">
                  <c:v>2.95581063106557E-2</c:v>
                </c:pt>
                <c:pt idx="7">
                  <c:v>0</c:v>
                </c:pt>
                <c:pt idx="8">
                  <c:v>1.88437983713574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B39-43B7-BBB0-971E077EAE9E}"/>
            </c:ext>
          </c:extLst>
        </c:ser>
        <c:ser>
          <c:idx val="9"/>
          <c:order val="9"/>
          <c:tx>
            <c:strRef>
              <c:f>Genero_grafico!$A$11</c:f>
              <c:strCache>
                <c:ptCount val="1"/>
                <c:pt idx="0">
                  <c:v>Rubrivirga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:$K$11</c:f>
              <c:numCache>
                <c:formatCode>General</c:formatCode>
                <c:ptCount val="10"/>
                <c:pt idx="0">
                  <c:v>0</c:v>
                </c:pt>
                <c:pt idx="1">
                  <c:v>8.5058123050751305E-2</c:v>
                </c:pt>
                <c:pt idx="2">
                  <c:v>8.9270161992684199E-2</c:v>
                </c:pt>
                <c:pt idx="3">
                  <c:v>5.0205843960237001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39370078740157499</c:v>
                </c:pt>
                <c:pt idx="9">
                  <c:v>17.333604860333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4B39-43B7-BBB0-971E077EAE9E}"/>
            </c:ext>
          </c:extLst>
        </c:ser>
        <c:ser>
          <c:idx val="10"/>
          <c:order val="10"/>
          <c:tx>
            <c:strRef>
              <c:f>Genero_grafico!$A$12</c:f>
              <c:strCache>
                <c:ptCount val="1"/>
                <c:pt idx="0">
                  <c:v>AKYG1722_ge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2:$K$12</c:f>
              <c:numCache>
                <c:formatCode>General</c:formatCode>
                <c:ptCount val="10"/>
                <c:pt idx="0">
                  <c:v>0.37988228999465001</c:v>
                </c:pt>
                <c:pt idx="1">
                  <c:v>4.158397126925621</c:v>
                </c:pt>
                <c:pt idx="2">
                  <c:v>1.524124716948267</c:v>
                </c:pt>
                <c:pt idx="3">
                  <c:v>4.5637112159855402</c:v>
                </c:pt>
                <c:pt idx="4">
                  <c:v>0</c:v>
                </c:pt>
                <c:pt idx="5">
                  <c:v>0.22948617485727099</c:v>
                </c:pt>
                <c:pt idx="6">
                  <c:v>2.0050248780728119</c:v>
                </c:pt>
                <c:pt idx="7">
                  <c:v>5.4895502489903103E-2</c:v>
                </c:pt>
                <c:pt idx="8">
                  <c:v>1.413284877851807</c:v>
                </c:pt>
                <c:pt idx="9">
                  <c:v>0.85531004989308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B39-43B7-BBB0-971E077EAE9E}"/>
            </c:ext>
          </c:extLst>
        </c:ser>
        <c:ser>
          <c:idx val="11"/>
          <c:order val="11"/>
          <c:tx>
            <c:strRef>
              <c:f>Genero_grafico!$A$13</c:f>
              <c:strCache>
                <c:ptCount val="1"/>
                <c:pt idx="0">
                  <c:v>Balneolaceae_unclassified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3:$K$13</c:f>
              <c:numCache>
                <c:formatCode>General</c:formatCode>
                <c:ptCount val="10"/>
                <c:pt idx="0">
                  <c:v>0</c:v>
                </c:pt>
                <c:pt idx="1">
                  <c:v>5.9965976750779699</c:v>
                </c:pt>
                <c:pt idx="2">
                  <c:v>0</c:v>
                </c:pt>
                <c:pt idx="3">
                  <c:v>6.0096395220403673</c:v>
                </c:pt>
                <c:pt idx="4">
                  <c:v>2.3477364021278908</c:v>
                </c:pt>
                <c:pt idx="5">
                  <c:v>0</c:v>
                </c:pt>
                <c:pt idx="6">
                  <c:v>4.4337159465983503E-2</c:v>
                </c:pt>
                <c:pt idx="7">
                  <c:v>2.3526643924244198E-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4B39-43B7-BBB0-971E077EAE9E}"/>
            </c:ext>
          </c:extLst>
        </c:ser>
        <c:ser>
          <c:idx val="12"/>
          <c:order val="12"/>
          <c:tx>
            <c:strRef>
              <c:f>Genero_grafico!$A$14</c:f>
              <c:strCache>
                <c:ptCount val="1"/>
                <c:pt idx="0">
                  <c:v>Sphingomona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4:$K$14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.82222852282393</c:v>
                </c:pt>
                <c:pt idx="2">
                  <c:v>3.551210590489462</c:v>
                </c:pt>
                <c:pt idx="3">
                  <c:v>0.93884928205643203</c:v>
                </c:pt>
                <c:pt idx="4">
                  <c:v>0</c:v>
                </c:pt>
                <c:pt idx="5">
                  <c:v>0</c:v>
                </c:pt>
                <c:pt idx="6">
                  <c:v>0.10345337208729501</c:v>
                </c:pt>
                <c:pt idx="7">
                  <c:v>6.4776692938085727</c:v>
                </c:pt>
                <c:pt idx="8">
                  <c:v>0.74702200686452702</c:v>
                </c:pt>
                <c:pt idx="9">
                  <c:v>1.3067236873366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B39-43B7-BBB0-971E077EAE9E}"/>
            </c:ext>
          </c:extLst>
        </c:ser>
        <c:ser>
          <c:idx val="13"/>
          <c:order val="13"/>
          <c:tx>
            <c:strRef>
              <c:f>Genero_grafico!$A$15</c:f>
              <c:strCache>
                <c:ptCount val="1"/>
                <c:pt idx="0">
                  <c:v>Gammaproteobacteria_unclassified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5:$K$15</c:f>
              <c:numCache>
                <c:formatCode>General</c:formatCode>
                <c:ptCount val="10"/>
                <c:pt idx="0">
                  <c:v>0.26038879971464302</c:v>
                </c:pt>
                <c:pt idx="1">
                  <c:v>0.16066534354030801</c:v>
                </c:pt>
                <c:pt idx="2">
                  <c:v>4.964291935202926</c:v>
                </c:pt>
                <c:pt idx="3">
                  <c:v>0.28115272617732701</c:v>
                </c:pt>
                <c:pt idx="4">
                  <c:v>0</c:v>
                </c:pt>
                <c:pt idx="5">
                  <c:v>4.7016679726855477</c:v>
                </c:pt>
                <c:pt idx="6">
                  <c:v>0.51726686043647496</c:v>
                </c:pt>
                <c:pt idx="7">
                  <c:v>3.1368858565658901E-2</c:v>
                </c:pt>
                <c:pt idx="8">
                  <c:v>1.655562285483545</c:v>
                </c:pt>
                <c:pt idx="9">
                  <c:v>0.648270712418966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4B39-43B7-BBB0-971E077EAE9E}"/>
            </c:ext>
          </c:extLst>
        </c:ser>
        <c:ser>
          <c:idx val="14"/>
          <c:order val="14"/>
          <c:tx>
            <c:strRef>
              <c:f>Genero_grafico!$A$16</c:f>
              <c:strCache>
                <c:ptCount val="1"/>
                <c:pt idx="0">
                  <c:v>0319-7L14_ge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6:$K$16</c:f>
              <c:numCache>
                <c:formatCode>General</c:formatCode>
                <c:ptCount val="10"/>
                <c:pt idx="0">
                  <c:v>11.883360085607279</c:v>
                </c:pt>
                <c:pt idx="1">
                  <c:v>0</c:v>
                </c:pt>
                <c:pt idx="2">
                  <c:v>2.395053126632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24139120153702201</c:v>
                </c:pt>
                <c:pt idx="7">
                  <c:v>0</c:v>
                </c:pt>
                <c:pt idx="8">
                  <c:v>8.0759135877246202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4B39-43B7-BBB0-971E077EAE9E}"/>
            </c:ext>
          </c:extLst>
        </c:ser>
        <c:ser>
          <c:idx val="15"/>
          <c:order val="15"/>
          <c:tx>
            <c:strRef>
              <c:f>Genero_grafico!$A$17</c:f>
              <c:strCache>
                <c:ptCount val="1"/>
                <c:pt idx="0">
                  <c:v>Pseudonocardi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7:$K$17</c:f>
              <c:numCache>
                <c:formatCode>General</c:formatCode>
                <c:ptCount val="10"/>
                <c:pt idx="0">
                  <c:v>0.58319957196361705</c:v>
                </c:pt>
                <c:pt idx="1">
                  <c:v>1.1860882714299219</c:v>
                </c:pt>
                <c:pt idx="2">
                  <c:v>2.1468385298728441</c:v>
                </c:pt>
                <c:pt idx="3">
                  <c:v>1.0091374636007631</c:v>
                </c:pt>
                <c:pt idx="4">
                  <c:v>0</c:v>
                </c:pt>
                <c:pt idx="5">
                  <c:v>0.12873614687115201</c:v>
                </c:pt>
                <c:pt idx="6">
                  <c:v>0.52711956254002701</c:v>
                </c:pt>
                <c:pt idx="7">
                  <c:v>1.1057522644394779</c:v>
                </c:pt>
                <c:pt idx="8">
                  <c:v>2.4665186082508912</c:v>
                </c:pt>
                <c:pt idx="9">
                  <c:v>2.47768387469028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4B39-43B7-BBB0-971E077EAE9E}"/>
            </c:ext>
          </c:extLst>
        </c:ser>
        <c:ser>
          <c:idx val="16"/>
          <c:order val="16"/>
          <c:tx>
            <c:strRef>
              <c:f>Genero_grafico!$A$18</c:f>
              <c:strCache>
                <c:ptCount val="1"/>
                <c:pt idx="0">
                  <c:v>Novosphingobium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8:$K$18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.17732102421180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1763321962122099E-2</c:v>
                </c:pt>
                <c:pt idx="8">
                  <c:v>6.7299279897705096E-3</c:v>
                </c:pt>
                <c:pt idx="9">
                  <c:v>11.448257136068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4B39-43B7-BBB0-971E077EAE9E}"/>
            </c:ext>
          </c:extLst>
        </c:ser>
        <c:ser>
          <c:idx val="17"/>
          <c:order val="17"/>
          <c:tx>
            <c:strRef>
              <c:f>Genero_grafico!$A$19</c:f>
              <c:strCache>
                <c:ptCount val="1"/>
                <c:pt idx="0">
                  <c:v>Nostocales_unclassified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9:$K$19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3.388148568188261</c:v>
                </c:pt>
                <c:pt idx="2">
                  <c:v>1.0015676711374319</c:v>
                </c:pt>
                <c:pt idx="3">
                  <c:v>4.3679084245406168</c:v>
                </c:pt>
                <c:pt idx="4">
                  <c:v>0</c:v>
                </c:pt>
                <c:pt idx="5">
                  <c:v>0.31344453151237001</c:v>
                </c:pt>
                <c:pt idx="6">
                  <c:v>0.18227498891571001</c:v>
                </c:pt>
                <c:pt idx="7">
                  <c:v>7.8422146414147392E-3</c:v>
                </c:pt>
                <c:pt idx="8">
                  <c:v>4.3744531933508302E-2</c:v>
                </c:pt>
                <c:pt idx="9">
                  <c:v>1.72080236228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4B39-43B7-BBB0-971E077EAE9E}"/>
            </c:ext>
          </c:extLst>
        </c:ser>
        <c:ser>
          <c:idx val="18"/>
          <c:order val="18"/>
          <c:tx>
            <c:strRef>
              <c:f>Genero_grafico!$A$20</c:f>
              <c:strCache>
                <c:ptCount val="1"/>
                <c:pt idx="0">
                  <c:v>Rhodobacteraceae_unclassified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0:$K$20</c:f>
              <c:numCache>
                <c:formatCode>General</c:formatCode>
                <c:ptCount val="10"/>
                <c:pt idx="0">
                  <c:v>0.108792580702693</c:v>
                </c:pt>
                <c:pt idx="1">
                  <c:v>1.365655420092619</c:v>
                </c:pt>
                <c:pt idx="2">
                  <c:v>5.2865354467862726</c:v>
                </c:pt>
                <c:pt idx="3">
                  <c:v>1.4308665528667539</c:v>
                </c:pt>
                <c:pt idx="4">
                  <c:v>0.13299316035175299</c:v>
                </c:pt>
                <c:pt idx="5">
                  <c:v>1.4328892869136911</c:v>
                </c:pt>
                <c:pt idx="6">
                  <c:v>0.10345337208729501</c:v>
                </c:pt>
                <c:pt idx="7">
                  <c:v>7.4501039093439997E-2</c:v>
                </c:pt>
                <c:pt idx="8">
                  <c:v>0.23554747964196801</c:v>
                </c:pt>
                <c:pt idx="9">
                  <c:v>0.37334962495333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4B39-43B7-BBB0-971E077EAE9E}"/>
            </c:ext>
          </c:extLst>
        </c:ser>
        <c:ser>
          <c:idx val="19"/>
          <c:order val="19"/>
          <c:tx>
            <c:strRef>
              <c:f>Genero_grafico!$A$21</c:f>
              <c:strCache>
                <c:ptCount val="1"/>
                <c:pt idx="0">
                  <c:v>Tunicatimonas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1:$K$21</c:f>
              <c:numCache>
                <c:formatCode>General</c:formatCode>
                <c:ptCount val="10"/>
                <c:pt idx="0">
                  <c:v>0</c:v>
                </c:pt>
                <c:pt idx="1">
                  <c:v>0.15121444097911399</c:v>
                </c:pt>
                <c:pt idx="2">
                  <c:v>1.74185681936945E-2</c:v>
                </c:pt>
                <c:pt idx="3">
                  <c:v>7.5308765940355502E-2</c:v>
                </c:pt>
                <c:pt idx="4">
                  <c:v>0</c:v>
                </c:pt>
                <c:pt idx="5">
                  <c:v>0</c:v>
                </c:pt>
                <c:pt idx="6">
                  <c:v>0.31036011626188498</c:v>
                </c:pt>
                <c:pt idx="7">
                  <c:v>0.24702976120456399</c:v>
                </c:pt>
                <c:pt idx="8">
                  <c:v>0.99602934248603503</c:v>
                </c:pt>
                <c:pt idx="9">
                  <c:v>7.89804161151274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4B39-43B7-BBB0-971E077EAE9E}"/>
            </c:ext>
          </c:extLst>
        </c:ser>
        <c:ser>
          <c:idx val="20"/>
          <c:order val="20"/>
          <c:tx>
            <c:strRef>
              <c:f>Genero_grafico!$A$22</c:f>
              <c:strCache>
                <c:ptCount val="1"/>
                <c:pt idx="0">
                  <c:v>Iamia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2:$K$22</c:f>
              <c:numCache>
                <c:formatCode>General</c:formatCode>
                <c:ptCount val="10"/>
                <c:pt idx="0">
                  <c:v>0.24255395041911901</c:v>
                </c:pt>
                <c:pt idx="1">
                  <c:v>0.88838484075229196</c:v>
                </c:pt>
                <c:pt idx="2">
                  <c:v>1.5197700748998431</c:v>
                </c:pt>
                <c:pt idx="3">
                  <c:v>1.0141580479967871</c:v>
                </c:pt>
                <c:pt idx="4">
                  <c:v>0</c:v>
                </c:pt>
                <c:pt idx="5">
                  <c:v>0.59330572036270002</c:v>
                </c:pt>
                <c:pt idx="6">
                  <c:v>0.91137494457855095</c:v>
                </c:pt>
                <c:pt idx="7">
                  <c:v>1.552758499000118</c:v>
                </c:pt>
                <c:pt idx="8">
                  <c:v>1.5647082576216429</c:v>
                </c:pt>
                <c:pt idx="9">
                  <c:v>0.5430539999321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4B39-43B7-BBB0-971E077EAE9E}"/>
            </c:ext>
          </c:extLst>
        </c:ser>
        <c:ser>
          <c:idx val="21"/>
          <c:order val="21"/>
          <c:tx>
            <c:strRef>
              <c:f>Genero_grafico!$A$23</c:f>
              <c:strCache>
                <c:ptCount val="1"/>
                <c:pt idx="0">
                  <c:v>uncultured_ge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3:$K$23</c:f>
              <c:numCache>
                <c:formatCode>General</c:formatCode>
                <c:ptCount val="10"/>
                <c:pt idx="0">
                  <c:v>0.36026395576957398</c:v>
                </c:pt>
                <c:pt idx="1">
                  <c:v>7.5607220489556801E-2</c:v>
                </c:pt>
                <c:pt idx="2">
                  <c:v>0</c:v>
                </c:pt>
                <c:pt idx="3">
                  <c:v>9.0370519128426502E-2</c:v>
                </c:pt>
                <c:pt idx="4">
                  <c:v>0</c:v>
                </c:pt>
                <c:pt idx="5">
                  <c:v>0.26866674129631701</c:v>
                </c:pt>
                <c:pt idx="6">
                  <c:v>7.8131927681166546</c:v>
                </c:pt>
                <c:pt idx="7">
                  <c:v>7.8422146414147392E-3</c:v>
                </c:pt>
                <c:pt idx="8">
                  <c:v>4.3744531933508302E-2</c:v>
                </c:pt>
                <c:pt idx="9">
                  <c:v>6.44876624919391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4B39-43B7-BBB0-971E077EAE9E}"/>
            </c:ext>
          </c:extLst>
        </c:ser>
        <c:ser>
          <c:idx val="22"/>
          <c:order val="22"/>
          <c:tx>
            <c:strRef>
              <c:f>Genero_grafico!$A$24</c:f>
              <c:strCache>
                <c:ptCount val="1"/>
                <c:pt idx="0">
                  <c:v>Blastocatellaceae_unclassified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4:$K$24</c:f>
              <c:numCache>
                <c:formatCode>General</c:formatCode>
                <c:ptCount val="10"/>
                <c:pt idx="0">
                  <c:v>1.144997324772606</c:v>
                </c:pt>
                <c:pt idx="1">
                  <c:v>0.99707022020602898</c:v>
                </c:pt>
                <c:pt idx="2">
                  <c:v>3.3204145619230099</c:v>
                </c:pt>
                <c:pt idx="3">
                  <c:v>0.95391103524450305</c:v>
                </c:pt>
                <c:pt idx="4">
                  <c:v>0</c:v>
                </c:pt>
                <c:pt idx="5">
                  <c:v>1.3769170491436249</c:v>
                </c:pt>
                <c:pt idx="6">
                  <c:v>9.8527021035518993E-3</c:v>
                </c:pt>
                <c:pt idx="7">
                  <c:v>0</c:v>
                </c:pt>
                <c:pt idx="8">
                  <c:v>0.71337236691567396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4B39-43B7-BBB0-971E077EAE9E}"/>
            </c:ext>
          </c:extLst>
        </c:ser>
        <c:ser>
          <c:idx val="23"/>
          <c:order val="23"/>
          <c:tx>
            <c:strRef>
              <c:f>Genero_grafico!$A$25</c:f>
              <c:strCache>
                <c:ptCount val="1"/>
                <c:pt idx="0">
                  <c:v>Ornithinimicrobium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5:$K$25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8.4656707054072093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4B39-43B7-BBB0-971E077EAE9E}"/>
            </c:ext>
          </c:extLst>
        </c:ser>
        <c:ser>
          <c:idx val="24"/>
          <c:order val="24"/>
          <c:tx>
            <c:strRef>
              <c:f>Genero_grafico!$A$26</c:f>
              <c:strCache>
                <c:ptCount val="1"/>
                <c:pt idx="0">
                  <c:v>Qipengyuania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6:$K$26</c:f>
              <c:numCache>
                <c:formatCode>General</c:formatCode>
                <c:ptCount val="10"/>
                <c:pt idx="0">
                  <c:v>0</c:v>
                </c:pt>
                <c:pt idx="1">
                  <c:v>1.242793686797089</c:v>
                </c:pt>
                <c:pt idx="2">
                  <c:v>1.236718341752308</c:v>
                </c:pt>
                <c:pt idx="3">
                  <c:v>0.97399337282859699</c:v>
                </c:pt>
                <c:pt idx="4">
                  <c:v>0</c:v>
                </c:pt>
                <c:pt idx="5">
                  <c:v>1.11944475540132E-2</c:v>
                </c:pt>
                <c:pt idx="6">
                  <c:v>4.4337159465983503E-2</c:v>
                </c:pt>
                <c:pt idx="7">
                  <c:v>1.5684429282829499E-2</c:v>
                </c:pt>
                <c:pt idx="8">
                  <c:v>4.7345043408035528</c:v>
                </c:pt>
                <c:pt idx="9">
                  <c:v>4.41231374944845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4B39-43B7-BBB0-971E077EAE9E}"/>
            </c:ext>
          </c:extLst>
        </c:ser>
        <c:ser>
          <c:idx val="25"/>
          <c:order val="25"/>
          <c:tx>
            <c:strRef>
              <c:f>Genero_grafico!$A$27</c:f>
              <c:strCache>
                <c:ptCount val="1"/>
                <c:pt idx="0">
                  <c:v>Bryobacter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7:$K$27</c:f>
              <c:numCache>
                <c:formatCode>General</c:formatCode>
                <c:ptCount val="10"/>
                <c:pt idx="0">
                  <c:v>0.146245764223292</c:v>
                </c:pt>
                <c:pt idx="1">
                  <c:v>1.583026179000095</c:v>
                </c:pt>
                <c:pt idx="2">
                  <c:v>1.5894443476746209</c:v>
                </c:pt>
                <c:pt idx="3">
                  <c:v>1.511195903203133</c:v>
                </c:pt>
                <c:pt idx="4">
                  <c:v>0</c:v>
                </c:pt>
                <c:pt idx="5">
                  <c:v>2.9889174969215269</c:v>
                </c:pt>
                <c:pt idx="6">
                  <c:v>0</c:v>
                </c:pt>
                <c:pt idx="7">
                  <c:v>0</c:v>
                </c:pt>
                <c:pt idx="8">
                  <c:v>0.16824819974426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4B39-43B7-BBB0-971E077EAE9E}"/>
            </c:ext>
          </c:extLst>
        </c:ser>
        <c:ser>
          <c:idx val="26"/>
          <c:order val="26"/>
          <c:tx>
            <c:strRef>
              <c:f>Genero_grafico!$A$28</c:f>
              <c:strCache>
                <c:ptCount val="1"/>
                <c:pt idx="0">
                  <c:v>Luteimonas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8:$K$28</c:f>
              <c:numCache>
                <c:formatCode>General</c:formatCode>
                <c:ptCount val="10"/>
                <c:pt idx="0">
                  <c:v>2.9266987693953981</c:v>
                </c:pt>
                <c:pt idx="1">
                  <c:v>0.16066534354030801</c:v>
                </c:pt>
                <c:pt idx="2">
                  <c:v>0.11539801428322601</c:v>
                </c:pt>
                <c:pt idx="3">
                  <c:v>0.110452856712521</c:v>
                </c:pt>
                <c:pt idx="4">
                  <c:v>0</c:v>
                </c:pt>
                <c:pt idx="5">
                  <c:v>0.45337512593753498</c:v>
                </c:pt>
                <c:pt idx="6">
                  <c:v>0.280802009951229</c:v>
                </c:pt>
                <c:pt idx="7">
                  <c:v>1.976238089636513</c:v>
                </c:pt>
                <c:pt idx="8">
                  <c:v>0.612423447069116</c:v>
                </c:pt>
                <c:pt idx="9">
                  <c:v>0.970709024878660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4B39-43B7-BBB0-971E077EAE9E}"/>
            </c:ext>
          </c:extLst>
        </c:ser>
        <c:ser>
          <c:idx val="27"/>
          <c:order val="27"/>
          <c:tx>
            <c:strRef>
              <c:f>Genero_grafico!$A$29</c:f>
              <c:strCache>
                <c:ptCount val="1"/>
                <c:pt idx="0">
                  <c:v>Actinomycetospora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29:$K$29</c:f>
              <c:numCache>
                <c:formatCode>General</c:formatCode>
                <c:ptCount val="10"/>
                <c:pt idx="0">
                  <c:v>3.3886213661494601E-2</c:v>
                </c:pt>
                <c:pt idx="1">
                  <c:v>0.39221245628957602</c:v>
                </c:pt>
                <c:pt idx="2">
                  <c:v>0.37014457411600798</c:v>
                </c:pt>
                <c:pt idx="3">
                  <c:v>0.31629681694949302</c:v>
                </c:pt>
                <c:pt idx="4">
                  <c:v>0</c:v>
                </c:pt>
                <c:pt idx="5">
                  <c:v>5.5972237770066102E-2</c:v>
                </c:pt>
                <c:pt idx="6">
                  <c:v>0.36947632888319598</c:v>
                </c:pt>
                <c:pt idx="7">
                  <c:v>2.3840332509900799</c:v>
                </c:pt>
                <c:pt idx="8">
                  <c:v>0.42398546335554199</c:v>
                </c:pt>
                <c:pt idx="9">
                  <c:v>2.8883684621389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4B39-43B7-BBB0-971E077EAE9E}"/>
            </c:ext>
          </c:extLst>
        </c:ser>
        <c:ser>
          <c:idx val="28"/>
          <c:order val="28"/>
          <c:tx>
            <c:strRef>
              <c:f>Genero_grafico!$A$30</c:f>
              <c:strCache>
                <c:ptCount val="1"/>
                <c:pt idx="0">
                  <c:v>Rhizobiaceae_unclassified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0:$K$30</c:f>
              <c:numCache>
                <c:formatCode>General</c:formatCode>
                <c:ptCount val="10"/>
                <c:pt idx="0">
                  <c:v>0.766898519707508</c:v>
                </c:pt>
                <c:pt idx="1">
                  <c:v>0.81277762026273503</c:v>
                </c:pt>
                <c:pt idx="2">
                  <c:v>0.57916739244034099</c:v>
                </c:pt>
                <c:pt idx="3">
                  <c:v>0.73802590621548403</c:v>
                </c:pt>
                <c:pt idx="4">
                  <c:v>0</c:v>
                </c:pt>
                <c:pt idx="5">
                  <c:v>0.12313892309414499</c:v>
                </c:pt>
                <c:pt idx="6">
                  <c:v>0.384255382038524</c:v>
                </c:pt>
                <c:pt idx="7">
                  <c:v>1.301807630474846</c:v>
                </c:pt>
                <c:pt idx="8">
                  <c:v>0.32640150750386998</c:v>
                </c:pt>
                <c:pt idx="9">
                  <c:v>1.87014221226623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4B39-43B7-BBB0-971E077EAE9E}"/>
            </c:ext>
          </c:extLst>
        </c:ser>
        <c:ser>
          <c:idx val="29"/>
          <c:order val="29"/>
          <c:tx>
            <c:strRef>
              <c:f>Genero_grafico!$A$31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1:$K$31</c:f>
              <c:numCache>
                <c:formatCode>General</c:formatCode>
                <c:ptCount val="10"/>
                <c:pt idx="0">
                  <c:v>2.5771357232031389</c:v>
                </c:pt>
                <c:pt idx="1">
                  <c:v>0</c:v>
                </c:pt>
                <c:pt idx="2">
                  <c:v>0.96019857167740796</c:v>
                </c:pt>
                <c:pt idx="3">
                  <c:v>0</c:v>
                </c:pt>
                <c:pt idx="4">
                  <c:v>0</c:v>
                </c:pt>
                <c:pt idx="5">
                  <c:v>2.9833202731445212</c:v>
                </c:pt>
                <c:pt idx="6">
                  <c:v>6.4042563673087305E-2</c:v>
                </c:pt>
                <c:pt idx="7">
                  <c:v>0</c:v>
                </c:pt>
                <c:pt idx="8">
                  <c:v>0.19516791170334499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4B39-43B7-BBB0-971E077EAE9E}"/>
            </c:ext>
          </c:extLst>
        </c:ser>
        <c:ser>
          <c:idx val="30"/>
          <c:order val="30"/>
          <c:tx>
            <c:strRef>
              <c:f>Genero_grafico!$A$32</c:f>
              <c:strCache>
                <c:ptCount val="1"/>
                <c:pt idx="0">
                  <c:v>Pseudonocardiaceae_unclassified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2:$K$32</c:f>
              <c:numCache>
                <c:formatCode>General</c:formatCode>
                <c:ptCount val="10"/>
                <c:pt idx="0">
                  <c:v>0.356696985910469</c:v>
                </c:pt>
                <c:pt idx="1">
                  <c:v>0.311879784519422</c:v>
                </c:pt>
                <c:pt idx="2">
                  <c:v>0.113220693259014</c:v>
                </c:pt>
                <c:pt idx="3">
                  <c:v>0.24600863540516099</c:v>
                </c:pt>
                <c:pt idx="4">
                  <c:v>0</c:v>
                </c:pt>
                <c:pt idx="5">
                  <c:v>2.7986118885032999E-2</c:v>
                </c:pt>
                <c:pt idx="6">
                  <c:v>4.9854672643972613</c:v>
                </c:pt>
                <c:pt idx="7">
                  <c:v>0.239187546563149</c:v>
                </c:pt>
                <c:pt idx="8">
                  <c:v>0.17497812773403301</c:v>
                </c:pt>
                <c:pt idx="9">
                  <c:v>0.257950649967756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4B39-43B7-BBB0-971E077EAE9E}"/>
            </c:ext>
          </c:extLst>
        </c:ser>
        <c:ser>
          <c:idx val="31"/>
          <c:order val="31"/>
          <c:tx>
            <c:strRef>
              <c:f>Genero_grafico!$A$33</c:f>
              <c:strCache>
                <c:ptCount val="1"/>
                <c:pt idx="0">
                  <c:v>Arhodomona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3:$K$33</c:f>
              <c:numCache>
                <c:formatCode>General</c:formatCode>
                <c:ptCount val="10"/>
                <c:pt idx="0">
                  <c:v>3.03192438023899E-2</c:v>
                </c:pt>
                <c:pt idx="1">
                  <c:v>2.7171344863434461</c:v>
                </c:pt>
                <c:pt idx="2">
                  <c:v>0</c:v>
                </c:pt>
                <c:pt idx="3">
                  <c:v>2.6759714830806312</c:v>
                </c:pt>
                <c:pt idx="4">
                  <c:v>0.100423406796222</c:v>
                </c:pt>
                <c:pt idx="5">
                  <c:v>0</c:v>
                </c:pt>
                <c:pt idx="6">
                  <c:v>6.8968914724863301E-2</c:v>
                </c:pt>
                <c:pt idx="7">
                  <c:v>0.81559032270713205</c:v>
                </c:pt>
                <c:pt idx="8">
                  <c:v>0</c:v>
                </c:pt>
                <c:pt idx="9">
                  <c:v>0.1018226249872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4B39-43B7-BBB0-971E077EAE9E}"/>
            </c:ext>
          </c:extLst>
        </c:ser>
        <c:ser>
          <c:idx val="32"/>
          <c:order val="32"/>
          <c:tx>
            <c:strRef>
              <c:f>Genero_grafico!$A$34</c:f>
              <c:strCache>
                <c:ptCount val="1"/>
                <c:pt idx="0">
                  <c:v>Nocardioidaceae_unclassified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4:$K$34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0.21737075890747601</c:v>
                </c:pt>
                <c:pt idx="2">
                  <c:v>0.24821459676014601</c:v>
                </c:pt>
                <c:pt idx="3">
                  <c:v>0.23094688221709</c:v>
                </c:pt>
                <c:pt idx="4">
                  <c:v>2.71414612962762E-3</c:v>
                </c:pt>
                <c:pt idx="5">
                  <c:v>0</c:v>
                </c:pt>
                <c:pt idx="6">
                  <c:v>0.29558106310655702</c:v>
                </c:pt>
                <c:pt idx="7">
                  <c:v>4.7053287848488397E-2</c:v>
                </c:pt>
                <c:pt idx="8">
                  <c:v>5.2796285079749659</c:v>
                </c:pt>
                <c:pt idx="9">
                  <c:v>0.183280724977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4B39-43B7-BBB0-971E077EAE9E}"/>
            </c:ext>
          </c:extLst>
        </c:ser>
        <c:ser>
          <c:idx val="33"/>
          <c:order val="33"/>
          <c:tx>
            <c:strRef>
              <c:f>Genero_grafico!$A$35</c:f>
              <c:strCache>
                <c:ptCount val="1"/>
                <c:pt idx="0">
                  <c:v>Flavobacteriaceae_unclassified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5:$K$35</c:f>
              <c:numCache>
                <c:formatCode>General</c:formatCode>
                <c:ptCount val="10"/>
                <c:pt idx="0">
                  <c:v>0</c:v>
                </c:pt>
                <c:pt idx="1">
                  <c:v>0.50089783574331403</c:v>
                </c:pt>
                <c:pt idx="2">
                  <c:v>0</c:v>
                </c:pt>
                <c:pt idx="3">
                  <c:v>0.59242895873079604</c:v>
                </c:pt>
                <c:pt idx="4">
                  <c:v>4.2802084464227557</c:v>
                </c:pt>
                <c:pt idx="5">
                  <c:v>0</c:v>
                </c:pt>
                <c:pt idx="6">
                  <c:v>0.46800334991871501</c:v>
                </c:pt>
                <c:pt idx="7">
                  <c:v>0</c:v>
                </c:pt>
                <c:pt idx="8">
                  <c:v>0</c:v>
                </c:pt>
                <c:pt idx="9">
                  <c:v>0.485354512439330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4B39-43B7-BBB0-971E077EAE9E}"/>
            </c:ext>
          </c:extLst>
        </c:ser>
        <c:ser>
          <c:idx val="34"/>
          <c:order val="34"/>
          <c:tx>
            <c:strRef>
              <c:f>Genero_grafico!$A$36</c:f>
              <c:strCache>
                <c:ptCount val="1"/>
                <c:pt idx="0">
                  <c:v>Ellin6055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6:$K$36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.21737075890747601</c:v>
                </c:pt>
                <c:pt idx="2">
                  <c:v>0.80560877895837002</c:v>
                </c:pt>
                <c:pt idx="3">
                  <c:v>0.220905713425043</c:v>
                </c:pt>
                <c:pt idx="4">
                  <c:v>0</c:v>
                </c:pt>
                <c:pt idx="5">
                  <c:v>5.5972237770066102E-2</c:v>
                </c:pt>
                <c:pt idx="6">
                  <c:v>4.9263510517759497E-3</c:v>
                </c:pt>
                <c:pt idx="7">
                  <c:v>7.0579931772732599E-2</c:v>
                </c:pt>
                <c:pt idx="8">
                  <c:v>4.88592772057339</c:v>
                </c:pt>
                <c:pt idx="9">
                  <c:v>5.09113124936360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4B39-43B7-BBB0-971E077EAE9E}"/>
            </c:ext>
          </c:extLst>
        </c:ser>
        <c:ser>
          <c:idx val="35"/>
          <c:order val="35"/>
          <c:tx>
            <c:strRef>
              <c:f>Genero_grafico!$A$37</c:f>
              <c:strCache>
                <c:ptCount val="1"/>
                <c:pt idx="0">
                  <c:v>Flavisolibacter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7:$K$37</c:f>
              <c:numCache>
                <c:formatCode>General</c:formatCode>
                <c:ptCount val="10"/>
                <c:pt idx="0">
                  <c:v>0</c:v>
                </c:pt>
                <c:pt idx="1">
                  <c:v>0.127587184576127</c:v>
                </c:pt>
                <c:pt idx="2">
                  <c:v>0.618359170876154</c:v>
                </c:pt>
                <c:pt idx="3">
                  <c:v>9.5391103524450196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4546066357089966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3-4B39-43B7-BBB0-971E077EAE9E}"/>
            </c:ext>
          </c:extLst>
        </c:ser>
        <c:ser>
          <c:idx val="36"/>
          <c:order val="36"/>
          <c:tx>
            <c:strRef>
              <c:f>Genero_grafico!$A$38</c:f>
              <c:strCache>
                <c:ptCount val="1"/>
                <c:pt idx="0">
                  <c:v>Nocardioides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8:$K$38</c:f>
              <c:numCache>
                <c:formatCode>General</c:formatCode>
                <c:ptCount val="10"/>
                <c:pt idx="0">
                  <c:v>0</c:v>
                </c:pt>
                <c:pt idx="1">
                  <c:v>0.38748700500897798</c:v>
                </c:pt>
                <c:pt idx="2">
                  <c:v>2.8109214422574458</c:v>
                </c:pt>
                <c:pt idx="3">
                  <c:v>0.446832011246109</c:v>
                </c:pt>
                <c:pt idx="4">
                  <c:v>2.71414612962762E-3</c:v>
                </c:pt>
                <c:pt idx="5">
                  <c:v>1.6791671331019799E-2</c:v>
                </c:pt>
                <c:pt idx="6">
                  <c:v>5.9116212621311399E-2</c:v>
                </c:pt>
                <c:pt idx="7">
                  <c:v>0.188213151393954</c:v>
                </c:pt>
                <c:pt idx="8">
                  <c:v>1.7565112053301031</c:v>
                </c:pt>
                <c:pt idx="9">
                  <c:v>0.580388962427450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4B39-43B7-BBB0-971E077EAE9E}"/>
            </c:ext>
          </c:extLst>
        </c:ser>
        <c:ser>
          <c:idx val="37"/>
          <c:order val="37"/>
          <c:tx>
            <c:strRef>
              <c:f>Genero_grafico!$A$39</c:f>
              <c:strCache>
                <c:ptCount val="1"/>
                <c:pt idx="0">
                  <c:v>Propionibacteriaceae_unclassified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39:$K$39</c:f>
              <c:numCache>
                <c:formatCode>General</c:formatCode>
                <c:ptCount val="10"/>
                <c:pt idx="0">
                  <c:v>4.6370608168360999E-2</c:v>
                </c:pt>
                <c:pt idx="1">
                  <c:v>2.5611945940837351</c:v>
                </c:pt>
                <c:pt idx="2">
                  <c:v>0</c:v>
                </c:pt>
                <c:pt idx="3">
                  <c:v>2.2341600562305461</c:v>
                </c:pt>
                <c:pt idx="4">
                  <c:v>0</c:v>
                </c:pt>
                <c:pt idx="5">
                  <c:v>0</c:v>
                </c:pt>
                <c:pt idx="6">
                  <c:v>0.38918173309030002</c:v>
                </c:pt>
                <c:pt idx="7">
                  <c:v>1.96055366035368E-2</c:v>
                </c:pt>
                <c:pt idx="8">
                  <c:v>0</c:v>
                </c:pt>
                <c:pt idx="9">
                  <c:v>5.09113124936360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5-4B39-43B7-BBB0-971E077EAE9E}"/>
            </c:ext>
          </c:extLst>
        </c:ser>
        <c:ser>
          <c:idx val="38"/>
          <c:order val="38"/>
          <c:tx>
            <c:strRef>
              <c:f>Genero_grafico!$A$40</c:f>
              <c:strCache>
                <c:ptCount val="1"/>
                <c:pt idx="0">
                  <c:v>Mesorhizobium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0:$K$40</c:f>
              <c:numCache>
                <c:formatCode>General</c:formatCode>
                <c:ptCount val="10"/>
                <c:pt idx="0">
                  <c:v>0.13019439985732101</c:v>
                </c:pt>
                <c:pt idx="1">
                  <c:v>0.38748700500897798</c:v>
                </c:pt>
                <c:pt idx="2">
                  <c:v>4.3546420484236199E-3</c:v>
                </c:pt>
                <c:pt idx="3">
                  <c:v>0.31629681694949302</c:v>
                </c:pt>
                <c:pt idx="4">
                  <c:v>0</c:v>
                </c:pt>
                <c:pt idx="5">
                  <c:v>5.5972237770066102E-3</c:v>
                </c:pt>
                <c:pt idx="6">
                  <c:v>0.18227498891571001</c:v>
                </c:pt>
                <c:pt idx="7">
                  <c:v>4.2112692624397132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4B39-43B7-BBB0-971E077EAE9E}"/>
            </c:ext>
          </c:extLst>
        </c:ser>
        <c:ser>
          <c:idx val="39"/>
          <c:order val="39"/>
          <c:tx>
            <c:strRef>
              <c:f>Genero_grafico!$A$41</c:f>
              <c:strCache>
                <c:ptCount val="1"/>
                <c:pt idx="0">
                  <c:v>Rubellimicrobium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1:$K$41</c:f>
              <c:numCache>
                <c:formatCode>General</c:formatCode>
                <c:ptCount val="10"/>
                <c:pt idx="0">
                  <c:v>0</c:v>
                </c:pt>
                <c:pt idx="1">
                  <c:v>0.50089783574331403</c:v>
                </c:pt>
                <c:pt idx="2">
                  <c:v>0.209022818324334</c:v>
                </c:pt>
                <c:pt idx="3">
                  <c:v>0.4568731800381560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7.8422146414147392E-3</c:v>
                </c:pt>
                <c:pt idx="8">
                  <c:v>3.8326939901743038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4B39-43B7-BBB0-971E077EAE9E}"/>
            </c:ext>
          </c:extLst>
        </c:ser>
        <c:ser>
          <c:idx val="40"/>
          <c:order val="40"/>
          <c:tx>
            <c:strRef>
              <c:f>Genero_grafico!$A$42</c:f>
              <c:strCache>
                <c:ptCount val="1"/>
                <c:pt idx="0">
                  <c:v>Longimicrobiaceae_ge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2:$K$42</c:f>
              <c:numCache>
                <c:formatCode>General</c:formatCode>
                <c:ptCount val="10"/>
                <c:pt idx="0">
                  <c:v>4.1020153379703897E-2</c:v>
                </c:pt>
                <c:pt idx="1">
                  <c:v>1.3751063226538141</c:v>
                </c:pt>
                <c:pt idx="2">
                  <c:v>0.13063926145270899</c:v>
                </c:pt>
                <c:pt idx="3">
                  <c:v>1.5865046691434881</c:v>
                </c:pt>
                <c:pt idx="4">
                  <c:v>0</c:v>
                </c:pt>
                <c:pt idx="5">
                  <c:v>0.31344453151237001</c:v>
                </c:pt>
                <c:pt idx="6">
                  <c:v>0.25124390364057297</c:v>
                </c:pt>
                <c:pt idx="7">
                  <c:v>0</c:v>
                </c:pt>
                <c:pt idx="8">
                  <c:v>0.215357695672656</c:v>
                </c:pt>
                <c:pt idx="9">
                  <c:v>0.556630349930421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4B39-43B7-BBB0-971E077EAE9E}"/>
            </c:ext>
          </c:extLst>
        </c:ser>
        <c:ser>
          <c:idx val="41"/>
          <c:order val="41"/>
          <c:tx>
            <c:strRef>
              <c:f>Genero_grafico!$A$43</c:f>
              <c:strCache>
                <c:ptCount val="1"/>
                <c:pt idx="0">
                  <c:v>Lysobacter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3:$K$43</c:f>
              <c:numCache>
                <c:formatCode>General</c:formatCode>
                <c:ptCount val="10"/>
                <c:pt idx="0">
                  <c:v>3.3886213661494601E-2</c:v>
                </c:pt>
                <c:pt idx="1">
                  <c:v>1.3703808713732171</c:v>
                </c:pt>
                <c:pt idx="2">
                  <c:v>0.37014457411600798</c:v>
                </c:pt>
                <c:pt idx="3">
                  <c:v>1.541319409579275</c:v>
                </c:pt>
                <c:pt idx="4">
                  <c:v>0</c:v>
                </c:pt>
                <c:pt idx="5">
                  <c:v>0.207097279749244</c:v>
                </c:pt>
                <c:pt idx="6">
                  <c:v>0.108379723139071</c:v>
                </c:pt>
                <c:pt idx="7">
                  <c:v>0.45484844920205503</c:v>
                </c:pt>
                <c:pt idx="8">
                  <c:v>0.17497812773403301</c:v>
                </c:pt>
                <c:pt idx="9">
                  <c:v>0.149339849981333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9-4B39-43B7-BBB0-971E077EAE9E}"/>
            </c:ext>
          </c:extLst>
        </c:ser>
        <c:ser>
          <c:idx val="42"/>
          <c:order val="42"/>
          <c:tx>
            <c:strRef>
              <c:f>Genero_grafico!$A$44</c:f>
              <c:strCache>
                <c:ptCount val="1"/>
                <c:pt idx="0">
                  <c:v>PLTA13_ge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4:$K$44</c:f>
              <c:numCache>
                <c:formatCode>General</c:formatCode>
                <c:ptCount val="10"/>
                <c:pt idx="0">
                  <c:v>2.573568753344034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866114407254</c:v>
                </c:pt>
                <c:pt idx="6">
                  <c:v>0.50248780728114695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A-4B39-43B7-BBB0-971E077EAE9E}"/>
            </c:ext>
          </c:extLst>
        </c:ser>
        <c:ser>
          <c:idx val="43"/>
          <c:order val="43"/>
          <c:tx>
            <c:strRef>
              <c:f>Genero_grafico!$A$45</c:f>
              <c:strCache>
                <c:ptCount val="1"/>
                <c:pt idx="0">
                  <c:v>Cytophagales_unclassified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5:$K$45</c:f>
              <c:numCache>
                <c:formatCode>General</c:formatCode>
                <c:ptCount val="10"/>
                <c:pt idx="0">
                  <c:v>0</c:v>
                </c:pt>
                <c:pt idx="1">
                  <c:v>1.32785180984784</c:v>
                </c:pt>
                <c:pt idx="2">
                  <c:v>6.5319630726354298E-3</c:v>
                </c:pt>
                <c:pt idx="3">
                  <c:v>1.6015664223315591</c:v>
                </c:pt>
                <c:pt idx="4">
                  <c:v>0</c:v>
                </c:pt>
                <c:pt idx="5">
                  <c:v>1.11944475540132E-2</c:v>
                </c:pt>
                <c:pt idx="6">
                  <c:v>4.9263510517759498E-2</c:v>
                </c:pt>
                <c:pt idx="7">
                  <c:v>0.13331764890405001</c:v>
                </c:pt>
                <c:pt idx="8">
                  <c:v>3.7014603943737803E-2</c:v>
                </c:pt>
                <c:pt idx="9">
                  <c:v>0.889250924888844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B-4B39-43B7-BBB0-971E077EAE9E}"/>
            </c:ext>
          </c:extLst>
        </c:ser>
        <c:ser>
          <c:idx val="44"/>
          <c:order val="44"/>
          <c:tx>
            <c:strRef>
              <c:f>Genero_grafico!$A$46</c:f>
              <c:strCache>
                <c:ptCount val="1"/>
                <c:pt idx="0">
                  <c:v>Alphaproteobacteria_unclassified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6:$K$46</c:f>
              <c:numCache>
                <c:formatCode>General</c:formatCode>
                <c:ptCount val="10"/>
                <c:pt idx="0">
                  <c:v>0.99875156054931302</c:v>
                </c:pt>
                <c:pt idx="1">
                  <c:v>0.18901805122389201</c:v>
                </c:pt>
                <c:pt idx="2">
                  <c:v>0.69674272774777901</c:v>
                </c:pt>
                <c:pt idx="3">
                  <c:v>0.130535194296616</c:v>
                </c:pt>
                <c:pt idx="4">
                  <c:v>5.42829225925524E-3</c:v>
                </c:pt>
                <c:pt idx="5">
                  <c:v>1.113847531624315</c:v>
                </c:pt>
                <c:pt idx="6">
                  <c:v>0.408887137297404</c:v>
                </c:pt>
                <c:pt idx="7">
                  <c:v>8.6264361055562094E-2</c:v>
                </c:pt>
                <c:pt idx="8">
                  <c:v>0.37351100343226301</c:v>
                </c:pt>
                <c:pt idx="9">
                  <c:v>4.7517224994060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C-4B39-43B7-BBB0-971E077EAE9E}"/>
            </c:ext>
          </c:extLst>
        </c:ser>
        <c:ser>
          <c:idx val="45"/>
          <c:order val="45"/>
          <c:tx>
            <c:strRef>
              <c:f>Genero_grafico!$A$47</c:f>
              <c:strCache>
                <c:ptCount val="1"/>
                <c:pt idx="0">
                  <c:v>Nitriliruptoraceae_ge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7:$K$47</c:f>
              <c:numCache>
                <c:formatCode>General</c:formatCode>
                <c:ptCount val="10"/>
                <c:pt idx="0">
                  <c:v>5.5288032816122698E-2</c:v>
                </c:pt>
                <c:pt idx="1">
                  <c:v>1.549948020035913</c:v>
                </c:pt>
                <c:pt idx="2">
                  <c:v>8.7092840968472397E-3</c:v>
                </c:pt>
                <c:pt idx="3">
                  <c:v>1.5162164875991559</c:v>
                </c:pt>
                <c:pt idx="4">
                  <c:v>0.11670828357398801</c:v>
                </c:pt>
                <c:pt idx="5">
                  <c:v>2.2388895108026399E-2</c:v>
                </c:pt>
                <c:pt idx="6">
                  <c:v>0.32021281836543702</c:v>
                </c:pt>
                <c:pt idx="7">
                  <c:v>0.26663529780810102</c:v>
                </c:pt>
                <c:pt idx="8">
                  <c:v>1.6824819974426301E-2</c:v>
                </c:pt>
                <c:pt idx="9">
                  <c:v>0.1561280249804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D-4B39-43B7-BBB0-971E077EAE9E}"/>
            </c:ext>
          </c:extLst>
        </c:ser>
        <c:ser>
          <c:idx val="46"/>
          <c:order val="46"/>
          <c:tx>
            <c:strRef>
              <c:f>Genero_grafico!$A$48</c:f>
              <c:strCache>
                <c:ptCount val="1"/>
                <c:pt idx="0">
                  <c:v>Altererythrobacter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8:$K$48</c:f>
              <c:numCache>
                <c:formatCode>General</c:formatCode>
                <c:ptCount val="10"/>
                <c:pt idx="0">
                  <c:v>3.2102728731942198E-2</c:v>
                </c:pt>
                <c:pt idx="1">
                  <c:v>0.25044891787165702</c:v>
                </c:pt>
                <c:pt idx="2">
                  <c:v>0</c:v>
                </c:pt>
                <c:pt idx="3">
                  <c:v>0.19580279144492399</c:v>
                </c:pt>
                <c:pt idx="4">
                  <c:v>0</c:v>
                </c:pt>
                <c:pt idx="5">
                  <c:v>3.2799731333258699</c:v>
                </c:pt>
                <c:pt idx="6">
                  <c:v>0</c:v>
                </c:pt>
                <c:pt idx="7">
                  <c:v>4.3132180527781103E-2</c:v>
                </c:pt>
                <c:pt idx="8">
                  <c:v>0</c:v>
                </c:pt>
                <c:pt idx="9">
                  <c:v>0.196857074975393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E-4B39-43B7-BBB0-971E077EAE9E}"/>
            </c:ext>
          </c:extLst>
        </c:ser>
        <c:ser>
          <c:idx val="47"/>
          <c:order val="47"/>
          <c:tx>
            <c:strRef>
              <c:f>Genero_grafico!$A$49</c:f>
              <c:strCache>
                <c:ptCount val="1"/>
                <c:pt idx="0">
                  <c:v>Woeseia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49:$K$49</c:f>
              <c:numCache>
                <c:formatCode>General</c:formatCode>
                <c:ptCount val="10"/>
                <c:pt idx="0">
                  <c:v>0.45835562689495302</c:v>
                </c:pt>
                <c:pt idx="1">
                  <c:v>7.5607220489556801E-2</c:v>
                </c:pt>
                <c:pt idx="2">
                  <c:v>2.1773210242118099E-3</c:v>
                </c:pt>
                <c:pt idx="3">
                  <c:v>0.12551460990059199</c:v>
                </c:pt>
                <c:pt idx="4">
                  <c:v>0</c:v>
                </c:pt>
                <c:pt idx="5">
                  <c:v>0.195902832195231</c:v>
                </c:pt>
                <c:pt idx="6">
                  <c:v>2.7538302379427559</c:v>
                </c:pt>
                <c:pt idx="7">
                  <c:v>0.34897855154295598</c:v>
                </c:pt>
                <c:pt idx="8">
                  <c:v>6.7299279897705096E-3</c:v>
                </c:pt>
                <c:pt idx="9">
                  <c:v>2.375861249703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F-4B39-43B7-BBB0-971E077EAE9E}"/>
            </c:ext>
          </c:extLst>
        </c:ser>
        <c:ser>
          <c:idx val="48"/>
          <c:order val="48"/>
          <c:tx>
            <c:strRef>
              <c:f>Genero_grafico!$A$50</c:f>
              <c:strCache>
                <c:ptCount val="1"/>
                <c:pt idx="0">
                  <c:v>Actinobacteria_unclassified</c:v>
                </c:pt>
              </c:strCache>
            </c:strRef>
          </c:tx>
          <c:spPr>
            <a:solidFill>
              <a:schemeClr val="accent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0:$K$50</c:f>
              <c:numCache>
                <c:formatCode>General</c:formatCode>
                <c:ptCount val="10"/>
                <c:pt idx="0">
                  <c:v>1.0344212591403601</c:v>
                </c:pt>
                <c:pt idx="1">
                  <c:v>0.37803610244778402</c:v>
                </c:pt>
                <c:pt idx="2">
                  <c:v>7.1851593798989699E-2</c:v>
                </c:pt>
                <c:pt idx="3">
                  <c:v>0.34642032332563499</c:v>
                </c:pt>
                <c:pt idx="4">
                  <c:v>0</c:v>
                </c:pt>
                <c:pt idx="5">
                  <c:v>0.53733348259263403</c:v>
                </c:pt>
                <c:pt idx="6">
                  <c:v>0.95078575299275803</c:v>
                </c:pt>
                <c:pt idx="7">
                  <c:v>0.431321805277811</c:v>
                </c:pt>
                <c:pt idx="8">
                  <c:v>0.13123359580052499</c:v>
                </c:pt>
                <c:pt idx="9">
                  <c:v>6.109357499236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0-4B39-43B7-BBB0-971E077EAE9E}"/>
            </c:ext>
          </c:extLst>
        </c:ser>
        <c:ser>
          <c:idx val="49"/>
          <c:order val="49"/>
          <c:tx>
            <c:strRef>
              <c:f>Genero_grafico!$A$51</c:f>
              <c:strCache>
                <c:ptCount val="1"/>
                <c:pt idx="0">
                  <c:v>Burkholderiaceae_unclassified</c:v>
                </c:pt>
              </c:strCache>
            </c:strRef>
          </c:tx>
          <c:spPr>
            <a:solidFill>
              <a:schemeClr val="accent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1:$K$51</c:f>
              <c:numCache>
                <c:formatCode>General</c:formatCode>
                <c:ptCount val="10"/>
                <c:pt idx="0">
                  <c:v>0.63313714999108195</c:v>
                </c:pt>
                <c:pt idx="1">
                  <c:v>0.37331065116718598</c:v>
                </c:pt>
                <c:pt idx="2">
                  <c:v>0.28522905417174699</c:v>
                </c:pt>
                <c:pt idx="3">
                  <c:v>0.33135857013756398</c:v>
                </c:pt>
                <c:pt idx="4">
                  <c:v>0</c:v>
                </c:pt>
                <c:pt idx="5">
                  <c:v>1.886264412851226</c:v>
                </c:pt>
                <c:pt idx="6">
                  <c:v>4.9263510517759497E-3</c:v>
                </c:pt>
                <c:pt idx="7">
                  <c:v>0</c:v>
                </c:pt>
                <c:pt idx="8">
                  <c:v>0.400430715391345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1-4B39-43B7-BBB0-971E077EAE9E}"/>
            </c:ext>
          </c:extLst>
        </c:ser>
        <c:ser>
          <c:idx val="50"/>
          <c:order val="50"/>
          <c:tx>
            <c:strRef>
              <c:f>Genero_grafico!$A$52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3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2:$K$52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834098287249524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2-4B39-43B7-BBB0-971E077EAE9E}"/>
            </c:ext>
          </c:extLst>
        </c:ser>
        <c:ser>
          <c:idx val="51"/>
          <c:order val="51"/>
          <c:tx>
            <c:strRef>
              <c:f>Genero_grafico!$A$53</c:f>
              <c:strCache>
                <c:ptCount val="1"/>
                <c:pt idx="0">
                  <c:v>Halomonas</c:v>
                </c:pt>
              </c:strCache>
            </c:strRef>
          </c:tx>
          <c:spPr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3:$K$53</c:f>
              <c:numCache>
                <c:formatCode>General</c:formatCode>
                <c:ptCount val="10"/>
                <c:pt idx="0">
                  <c:v>0</c:v>
                </c:pt>
                <c:pt idx="1">
                  <c:v>1.4837917021075511</c:v>
                </c:pt>
                <c:pt idx="2">
                  <c:v>4.3546420484236199E-3</c:v>
                </c:pt>
                <c:pt idx="3">
                  <c:v>1.6919369414599861</c:v>
                </c:pt>
                <c:pt idx="4">
                  <c:v>0.38812289653674997</c:v>
                </c:pt>
                <c:pt idx="5">
                  <c:v>0</c:v>
                </c:pt>
                <c:pt idx="6">
                  <c:v>0</c:v>
                </c:pt>
                <c:pt idx="7">
                  <c:v>0.16076540014900201</c:v>
                </c:pt>
                <c:pt idx="8">
                  <c:v>0</c:v>
                </c:pt>
                <c:pt idx="9">
                  <c:v>6.788174999151480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3-4B39-43B7-BBB0-971E077EAE9E}"/>
            </c:ext>
          </c:extLst>
        </c:ser>
        <c:ser>
          <c:idx val="52"/>
          <c:order val="52"/>
          <c:tx>
            <c:strRef>
              <c:f>Genero_grafico!$A$54</c:f>
              <c:strCache>
                <c:ptCount val="1"/>
                <c:pt idx="0">
                  <c:v>Ornithinicoccus</c:v>
                </c:pt>
              </c:strCache>
            </c:strRef>
          </c:tx>
          <c:spPr>
            <a:solidFill>
              <a:schemeClr val="accent5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4:$K$54</c:f>
              <c:numCache>
                <c:formatCode>General</c:formatCode>
                <c:ptCount val="10"/>
                <c:pt idx="0">
                  <c:v>2.8535758872837502E-2</c:v>
                </c:pt>
                <c:pt idx="1">
                  <c:v>0.84113032794631903</c:v>
                </c:pt>
                <c:pt idx="2">
                  <c:v>6.5319630726354298E-3</c:v>
                </c:pt>
                <c:pt idx="3">
                  <c:v>0.67275830906717604</c:v>
                </c:pt>
                <c:pt idx="4">
                  <c:v>0</c:v>
                </c:pt>
                <c:pt idx="5">
                  <c:v>3.3583342662039599E-2</c:v>
                </c:pt>
                <c:pt idx="6">
                  <c:v>0.48278240307404302</c:v>
                </c:pt>
                <c:pt idx="7">
                  <c:v>0.93322354232835403</c:v>
                </c:pt>
                <c:pt idx="8">
                  <c:v>6.7299279897705096E-3</c:v>
                </c:pt>
                <c:pt idx="9">
                  <c:v>0.74330516240708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4-4B39-43B7-BBB0-971E077EAE9E}"/>
            </c:ext>
          </c:extLst>
        </c:ser>
        <c:ser>
          <c:idx val="53"/>
          <c:order val="53"/>
          <c:tx>
            <c:strRef>
              <c:f>Genero_grafico!$A$55</c:f>
              <c:strCache>
                <c:ptCount val="1"/>
                <c:pt idx="0">
                  <c:v>Subgroup_6_ge</c:v>
                </c:pt>
              </c:strCache>
            </c:strRef>
          </c:tx>
          <c:spPr>
            <a:solidFill>
              <a:schemeClr val="accent6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5:$K$55</c:f>
              <c:numCache>
                <c:formatCode>General</c:formatCode>
                <c:ptCount val="10"/>
                <c:pt idx="0">
                  <c:v>0.62957018013197796</c:v>
                </c:pt>
                <c:pt idx="1">
                  <c:v>0.36385974860599202</c:v>
                </c:pt>
                <c:pt idx="2">
                  <c:v>0.98197178191952605</c:v>
                </c:pt>
                <c:pt idx="3">
                  <c:v>0.48197610201827501</c:v>
                </c:pt>
                <c:pt idx="4">
                  <c:v>0</c:v>
                </c:pt>
                <c:pt idx="5">
                  <c:v>0.47016679726855498</c:v>
                </c:pt>
                <c:pt idx="6">
                  <c:v>0.40396078624562798</c:v>
                </c:pt>
                <c:pt idx="7">
                  <c:v>0</c:v>
                </c:pt>
                <c:pt idx="8">
                  <c:v>0.37014603943737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5-4B39-43B7-BBB0-971E077EAE9E}"/>
            </c:ext>
          </c:extLst>
        </c:ser>
        <c:ser>
          <c:idx val="54"/>
          <c:order val="54"/>
          <c:tx>
            <c:strRef>
              <c:f>Genero_grafico!$A$56</c:f>
              <c:strCache>
                <c:ptCount val="1"/>
                <c:pt idx="0">
                  <c:v>Dongi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6:$K$56</c:f>
              <c:numCache>
                <c:formatCode>General</c:formatCode>
                <c:ptCount val="10"/>
                <c:pt idx="0">
                  <c:v>3.468878187979310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6-4B39-43B7-BBB0-971E077EAE9E}"/>
            </c:ext>
          </c:extLst>
        </c:ser>
        <c:ser>
          <c:idx val="55"/>
          <c:order val="55"/>
          <c:tx>
            <c:strRef>
              <c:f>Genero_grafico!$A$57</c:f>
              <c:strCache>
                <c:ptCount val="1"/>
                <c:pt idx="0">
                  <c:v>Solibacteraceae_(Subgroup_3)_unclassifi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7:$K$57</c:f>
              <c:numCache>
                <c:formatCode>General</c:formatCode>
                <c:ptCount val="10"/>
                <c:pt idx="0">
                  <c:v>0.13732833957553101</c:v>
                </c:pt>
                <c:pt idx="1">
                  <c:v>3.78036102447784E-2</c:v>
                </c:pt>
                <c:pt idx="2">
                  <c:v>0.17636300296115701</c:v>
                </c:pt>
                <c:pt idx="3">
                  <c:v>4.51852595642133E-2</c:v>
                </c:pt>
                <c:pt idx="4">
                  <c:v>0</c:v>
                </c:pt>
                <c:pt idx="5">
                  <c:v>0.335833426620396</c:v>
                </c:pt>
                <c:pt idx="6">
                  <c:v>1.47790531553278E-2</c:v>
                </c:pt>
                <c:pt idx="7">
                  <c:v>0</c:v>
                </c:pt>
                <c:pt idx="8">
                  <c:v>2.6785113399286629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7-4B39-43B7-BBB0-971E077EAE9E}"/>
            </c:ext>
          </c:extLst>
        </c:ser>
        <c:ser>
          <c:idx val="56"/>
          <c:order val="56"/>
          <c:tx>
            <c:strRef>
              <c:f>Genero_grafico!$A$58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8:$K$58</c:f>
              <c:numCache>
                <c:formatCode>General</c:formatCode>
                <c:ptCount val="10"/>
                <c:pt idx="0">
                  <c:v>0.52434456928839002</c:v>
                </c:pt>
                <c:pt idx="1">
                  <c:v>1.89018051223892E-2</c:v>
                </c:pt>
                <c:pt idx="2">
                  <c:v>1.073419264936422</c:v>
                </c:pt>
                <c:pt idx="3">
                  <c:v>2.0082337584094799E-2</c:v>
                </c:pt>
                <c:pt idx="4">
                  <c:v>5.42829225925524E-3</c:v>
                </c:pt>
                <c:pt idx="5">
                  <c:v>0.96831971342214296</c:v>
                </c:pt>
                <c:pt idx="6">
                  <c:v>5.4189861569535397E-2</c:v>
                </c:pt>
                <c:pt idx="7">
                  <c:v>7.8422146414147392E-3</c:v>
                </c:pt>
                <c:pt idx="8">
                  <c:v>0.57540884312537899</c:v>
                </c:pt>
                <c:pt idx="9">
                  <c:v>2.375861249703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4B39-43B7-BBB0-971E077EAE9E}"/>
            </c:ext>
          </c:extLst>
        </c:ser>
        <c:ser>
          <c:idx val="57"/>
          <c:order val="57"/>
          <c:tx>
            <c:strRef>
              <c:f>Genero_grafico!$A$59</c:f>
              <c:strCache>
                <c:ptCount val="1"/>
                <c:pt idx="0">
                  <c:v>Saccharimonadales_g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59:$K$59</c:f>
              <c:numCache>
                <c:formatCode>General</c:formatCode>
                <c:ptCount val="10"/>
                <c:pt idx="0">
                  <c:v>0.28714107365792801</c:v>
                </c:pt>
                <c:pt idx="1">
                  <c:v>0.283527076835838</c:v>
                </c:pt>
                <c:pt idx="2">
                  <c:v>0.363612611043372</c:v>
                </c:pt>
                <c:pt idx="3">
                  <c:v>0.25604980419720902</c:v>
                </c:pt>
                <c:pt idx="4">
                  <c:v>0</c:v>
                </c:pt>
                <c:pt idx="5">
                  <c:v>1.584014328892869</c:v>
                </c:pt>
                <c:pt idx="6">
                  <c:v>9.8527021035518993E-3</c:v>
                </c:pt>
                <c:pt idx="7">
                  <c:v>5.8816609810610501E-2</c:v>
                </c:pt>
                <c:pt idx="8">
                  <c:v>0.28602193956524702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9-4B39-43B7-BBB0-971E077EAE9E}"/>
            </c:ext>
          </c:extLst>
        </c:ser>
        <c:ser>
          <c:idx val="58"/>
          <c:order val="58"/>
          <c:tx>
            <c:strRef>
              <c:f>Genero_grafico!$A$60</c:f>
              <c:strCache>
                <c:ptCount val="1"/>
                <c:pt idx="0">
                  <c:v>uncultured_g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0:$K$60</c:f>
              <c:numCache>
                <c:formatCode>General</c:formatCode>
                <c:ptCount val="10"/>
                <c:pt idx="0">
                  <c:v>4.6370608168360999E-2</c:v>
                </c:pt>
                <c:pt idx="1">
                  <c:v>0.55760325111048104</c:v>
                </c:pt>
                <c:pt idx="2">
                  <c:v>0.63142309702142496</c:v>
                </c:pt>
                <c:pt idx="3">
                  <c:v>0.55226428356260704</c:v>
                </c:pt>
                <c:pt idx="4">
                  <c:v>0</c:v>
                </c:pt>
                <c:pt idx="5">
                  <c:v>0</c:v>
                </c:pt>
                <c:pt idx="6">
                  <c:v>0.75865806197349595</c:v>
                </c:pt>
                <c:pt idx="7">
                  <c:v>0.384268517429322</c:v>
                </c:pt>
                <c:pt idx="8">
                  <c:v>0.10431388384144299</c:v>
                </c:pt>
                <c:pt idx="9">
                  <c:v>0.1052167124868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A-4B39-43B7-BBB0-971E077EAE9E}"/>
            </c:ext>
          </c:extLst>
        </c:ser>
        <c:ser>
          <c:idx val="59"/>
          <c:order val="59"/>
          <c:tx>
            <c:strRef>
              <c:f>Genero_grafico!$A$61</c:f>
              <c:strCache>
                <c:ptCount val="1"/>
                <c:pt idx="0">
                  <c:v>Aliihoefle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1:$K$61</c:f>
              <c:numCache>
                <c:formatCode>General</c:formatCode>
                <c:ptCount val="10"/>
                <c:pt idx="0">
                  <c:v>8.9174246477617305E-2</c:v>
                </c:pt>
                <c:pt idx="1">
                  <c:v>0.255174369152254</c:v>
                </c:pt>
                <c:pt idx="2">
                  <c:v>0.27651977007489997</c:v>
                </c:pt>
                <c:pt idx="3">
                  <c:v>0.25604980419720902</c:v>
                </c:pt>
                <c:pt idx="4">
                  <c:v>0</c:v>
                </c:pt>
                <c:pt idx="5">
                  <c:v>6.7166685324079295E-2</c:v>
                </c:pt>
                <c:pt idx="6">
                  <c:v>0.216759446278142</c:v>
                </c:pt>
                <c:pt idx="7">
                  <c:v>1.297886523154139</c:v>
                </c:pt>
                <c:pt idx="8">
                  <c:v>4.0379567938623101E-2</c:v>
                </c:pt>
                <c:pt idx="9">
                  <c:v>0.631300274921086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B-4B39-43B7-BBB0-971E077EAE9E}"/>
            </c:ext>
          </c:extLst>
        </c:ser>
        <c:ser>
          <c:idx val="60"/>
          <c:order val="60"/>
          <c:tx>
            <c:strRef>
              <c:f>Genero_grafico!$A$62</c:f>
              <c:strCache>
                <c:ptCount val="1"/>
                <c:pt idx="0">
                  <c:v>Constrictibacter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2:$K$62</c:f>
              <c:numCache>
                <c:formatCode>General</c:formatCode>
                <c:ptCount val="10"/>
                <c:pt idx="0">
                  <c:v>0.12841091492776899</c:v>
                </c:pt>
                <c:pt idx="1">
                  <c:v>1.025422927889613</c:v>
                </c:pt>
                <c:pt idx="2">
                  <c:v>0.13281658247691999</c:v>
                </c:pt>
                <c:pt idx="3">
                  <c:v>1.0141580479967871</c:v>
                </c:pt>
                <c:pt idx="4">
                  <c:v>0</c:v>
                </c:pt>
                <c:pt idx="5">
                  <c:v>0.12313892309414499</c:v>
                </c:pt>
                <c:pt idx="6">
                  <c:v>0.23153849943346999</c:v>
                </c:pt>
                <c:pt idx="7">
                  <c:v>0.10194879033839201</c:v>
                </c:pt>
                <c:pt idx="8">
                  <c:v>0.18843798371357401</c:v>
                </c:pt>
                <c:pt idx="9">
                  <c:v>7.127583749109049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C-4B39-43B7-BBB0-971E077EAE9E}"/>
            </c:ext>
          </c:extLst>
        </c:ser>
        <c:ser>
          <c:idx val="61"/>
          <c:order val="61"/>
          <c:tx>
            <c:strRef>
              <c:f>Genero_grafico!$A$63</c:f>
              <c:strCache>
                <c:ptCount val="1"/>
                <c:pt idx="0">
                  <c:v>67-14_ge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3:$K$63</c:f>
              <c:numCache>
                <c:formatCode>General</c:formatCode>
                <c:ptCount val="10"/>
                <c:pt idx="0">
                  <c:v>0.14981273408239701</c:v>
                </c:pt>
                <c:pt idx="1">
                  <c:v>0.26462527171344902</c:v>
                </c:pt>
                <c:pt idx="2">
                  <c:v>0.83826859432154699</c:v>
                </c:pt>
                <c:pt idx="3">
                  <c:v>0.24098805100913701</c:v>
                </c:pt>
                <c:pt idx="4">
                  <c:v>0</c:v>
                </c:pt>
                <c:pt idx="5">
                  <c:v>0.162319489533192</c:v>
                </c:pt>
                <c:pt idx="6">
                  <c:v>7.8821616828415195E-2</c:v>
                </c:pt>
                <c:pt idx="7">
                  <c:v>0</c:v>
                </c:pt>
                <c:pt idx="8">
                  <c:v>1.171007470220069</c:v>
                </c:pt>
                <c:pt idx="9">
                  <c:v>9.1640362488544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D-4B39-43B7-BBB0-971E077EAE9E}"/>
            </c:ext>
          </c:extLst>
        </c:ser>
        <c:ser>
          <c:idx val="62"/>
          <c:order val="62"/>
          <c:tx>
            <c:strRef>
              <c:f>Genero_grafico!$A$64</c:f>
              <c:strCache>
                <c:ptCount val="1"/>
                <c:pt idx="0">
                  <c:v>Ilumatobacter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4:$K$64</c:f>
              <c:numCache>
                <c:formatCode>General</c:formatCode>
                <c:ptCount val="10"/>
                <c:pt idx="0">
                  <c:v>0.634920634920635</c:v>
                </c:pt>
                <c:pt idx="1">
                  <c:v>0.43474151781495102</c:v>
                </c:pt>
                <c:pt idx="2">
                  <c:v>0.10886605121059099</c:v>
                </c:pt>
                <c:pt idx="3">
                  <c:v>0.39662616728587202</c:v>
                </c:pt>
                <c:pt idx="4">
                  <c:v>0</c:v>
                </c:pt>
                <c:pt idx="5">
                  <c:v>0.13433337064815801</c:v>
                </c:pt>
                <c:pt idx="6">
                  <c:v>0.14286418050150301</c:v>
                </c:pt>
                <c:pt idx="7">
                  <c:v>0.37250519546720001</c:v>
                </c:pt>
                <c:pt idx="8">
                  <c:v>0.211992731677771</c:v>
                </c:pt>
                <c:pt idx="9">
                  <c:v>0.48874859993890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E-4B39-43B7-BBB0-971E077EAE9E}"/>
            </c:ext>
          </c:extLst>
        </c:ser>
        <c:ser>
          <c:idx val="63"/>
          <c:order val="63"/>
          <c:tx>
            <c:strRef>
              <c:f>Genero_grafico!$A$65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5:$K$65</c:f>
              <c:numCache>
                <c:formatCode>General</c:formatCode>
                <c:ptCount val="10"/>
                <c:pt idx="0">
                  <c:v>6.2421972534332099E-2</c:v>
                </c:pt>
                <c:pt idx="1">
                  <c:v>0.14648898969851601</c:v>
                </c:pt>
                <c:pt idx="2">
                  <c:v>0.99068106601637296</c:v>
                </c:pt>
                <c:pt idx="3">
                  <c:v>0.160658700672758</c:v>
                </c:pt>
                <c:pt idx="4">
                  <c:v>0</c:v>
                </c:pt>
                <c:pt idx="5">
                  <c:v>0.13433337064815801</c:v>
                </c:pt>
                <c:pt idx="6">
                  <c:v>3.4484457362431602E-2</c:v>
                </c:pt>
                <c:pt idx="7">
                  <c:v>0</c:v>
                </c:pt>
                <c:pt idx="8">
                  <c:v>1.376270273908069</c:v>
                </c:pt>
                <c:pt idx="9">
                  <c:v>1.0182262498727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F-4B39-43B7-BBB0-971E077EAE9E}"/>
            </c:ext>
          </c:extLst>
        </c:ser>
        <c:ser>
          <c:idx val="64"/>
          <c:order val="64"/>
          <c:tx>
            <c:strRef>
              <c:f>Genero_grafico!$A$66</c:f>
              <c:strCache>
                <c:ptCount val="1"/>
                <c:pt idx="0">
                  <c:v>Acidimicrobiia_unclassified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6:$K$66</c:f>
              <c:numCache>
                <c:formatCode>General</c:formatCode>
                <c:ptCount val="10"/>
                <c:pt idx="0">
                  <c:v>1.403602639557695</c:v>
                </c:pt>
                <c:pt idx="1">
                  <c:v>0.155939892259711</c:v>
                </c:pt>
                <c:pt idx="2">
                  <c:v>0.13281658247691999</c:v>
                </c:pt>
                <c:pt idx="3">
                  <c:v>0.22592629782106599</c:v>
                </c:pt>
                <c:pt idx="4">
                  <c:v>0</c:v>
                </c:pt>
                <c:pt idx="5">
                  <c:v>2.2388895108026399E-2</c:v>
                </c:pt>
                <c:pt idx="6">
                  <c:v>0.56160401990245801</c:v>
                </c:pt>
                <c:pt idx="7">
                  <c:v>2.3526643924244198E-2</c:v>
                </c:pt>
                <c:pt idx="8">
                  <c:v>0.275927047580591</c:v>
                </c:pt>
                <c:pt idx="9">
                  <c:v>5.09113124936360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0-4B39-43B7-BBB0-971E077EAE9E}"/>
            </c:ext>
          </c:extLst>
        </c:ser>
        <c:ser>
          <c:idx val="65"/>
          <c:order val="65"/>
          <c:tx>
            <c:strRef>
              <c:f>Genero_grafico!$A$67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7:$K$67</c:f>
              <c:numCache>
                <c:formatCode>General</c:formatCode>
                <c:ptCount val="10"/>
                <c:pt idx="0">
                  <c:v>1.844123417157125</c:v>
                </c:pt>
                <c:pt idx="1">
                  <c:v>9.4509025611946001E-3</c:v>
                </c:pt>
                <c:pt idx="2">
                  <c:v>2.1773210242118099E-3</c:v>
                </c:pt>
                <c:pt idx="3">
                  <c:v>5.0205843960236998E-3</c:v>
                </c:pt>
                <c:pt idx="4">
                  <c:v>0</c:v>
                </c:pt>
                <c:pt idx="5">
                  <c:v>0.722041867233852</c:v>
                </c:pt>
                <c:pt idx="6">
                  <c:v>0.25124390364057297</c:v>
                </c:pt>
                <c:pt idx="7">
                  <c:v>0</c:v>
                </c:pt>
                <c:pt idx="8">
                  <c:v>1.0094891984655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1-4B39-43B7-BBB0-971E077EAE9E}"/>
            </c:ext>
          </c:extLst>
        </c:ser>
        <c:ser>
          <c:idx val="66"/>
          <c:order val="66"/>
          <c:tx>
            <c:strRef>
              <c:f>Genero_grafico!$A$68</c:f>
              <c:strCache>
                <c:ptCount val="1"/>
                <c:pt idx="0">
                  <c:v>Microcystaceae_unclassified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8:$K$68</c:f>
              <c:numCache>
                <c:formatCode>General</c:formatCode>
                <c:ptCount val="10"/>
                <c:pt idx="0">
                  <c:v>0</c:v>
                </c:pt>
                <c:pt idx="1">
                  <c:v>9.4509025611946001E-3</c:v>
                </c:pt>
                <c:pt idx="2">
                  <c:v>0.172008360912733</c:v>
                </c:pt>
                <c:pt idx="3">
                  <c:v>0</c:v>
                </c:pt>
                <c:pt idx="4">
                  <c:v>0</c:v>
                </c:pt>
                <c:pt idx="5">
                  <c:v>2.597111832531064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2-4B39-43B7-BBB0-971E077EAE9E}"/>
            </c:ext>
          </c:extLst>
        </c:ser>
        <c:ser>
          <c:idx val="67"/>
          <c:order val="67"/>
          <c:tx>
            <c:strRef>
              <c:f>Genero_grafico!$A$69</c:f>
              <c:strCache>
                <c:ptCount val="1"/>
                <c:pt idx="0">
                  <c:v>Tistli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69:$K$69</c:f>
              <c:numCache>
                <c:formatCode>General</c:formatCode>
                <c:ptCount val="10"/>
                <c:pt idx="0">
                  <c:v>0</c:v>
                </c:pt>
                <c:pt idx="1">
                  <c:v>1.384557225215008</c:v>
                </c:pt>
                <c:pt idx="2">
                  <c:v>0</c:v>
                </c:pt>
                <c:pt idx="3">
                  <c:v>1.28526960538206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3-4B39-43B7-BBB0-971E077EAE9E}"/>
            </c:ext>
          </c:extLst>
        </c:ser>
        <c:ser>
          <c:idx val="68"/>
          <c:order val="68"/>
          <c:tx>
            <c:strRef>
              <c:f>Genero_grafico!$A$70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0:$K$70</c:f>
              <c:numCache>
                <c:formatCode>General</c:formatCode>
                <c:ptCount val="10"/>
                <c:pt idx="0">
                  <c:v>0.14089530943463499</c:v>
                </c:pt>
                <c:pt idx="1">
                  <c:v>0.91673754843587596</c:v>
                </c:pt>
                <c:pt idx="2">
                  <c:v>0.52908900888346999</c:v>
                </c:pt>
                <c:pt idx="3">
                  <c:v>0.81835525655186303</c:v>
                </c:pt>
                <c:pt idx="4">
                  <c:v>0</c:v>
                </c:pt>
                <c:pt idx="5">
                  <c:v>8.3958356655099098E-2</c:v>
                </c:pt>
                <c:pt idx="6">
                  <c:v>3.4484457362431602E-2</c:v>
                </c:pt>
                <c:pt idx="7">
                  <c:v>0</c:v>
                </c:pt>
                <c:pt idx="8">
                  <c:v>0.10767884783632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4-4B39-43B7-BBB0-971E077EAE9E}"/>
            </c:ext>
          </c:extLst>
        </c:ser>
        <c:ser>
          <c:idx val="69"/>
          <c:order val="69"/>
          <c:tx>
            <c:strRef>
              <c:f>Genero_grafico!$A$71</c:f>
              <c:strCache>
                <c:ptCount val="1"/>
                <c:pt idx="0">
                  <c:v>Thermosynechococcales_unclassified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1:$K$7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2.611457475591107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5-4B39-43B7-BBB0-971E077EAE9E}"/>
            </c:ext>
          </c:extLst>
        </c:ser>
        <c:ser>
          <c:idx val="70"/>
          <c:order val="70"/>
          <c:tx>
            <c:strRef>
              <c:f>Genero_grafico!$A$72</c:f>
              <c:strCache>
                <c:ptCount val="1"/>
                <c:pt idx="0">
                  <c:v>Chloroplast_ge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2:$K$72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.76079765617616502</c:v>
                </c:pt>
                <c:pt idx="2">
                  <c:v>2.1773210242118099E-3</c:v>
                </c:pt>
                <c:pt idx="3">
                  <c:v>0.7781905813836730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94890797161118301</c:v>
                </c:pt>
                <c:pt idx="8">
                  <c:v>1.6824819974426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6-4B39-43B7-BBB0-971E077EAE9E}"/>
            </c:ext>
          </c:extLst>
        </c:ser>
        <c:ser>
          <c:idx val="71"/>
          <c:order val="71"/>
          <c:tx>
            <c:strRef>
              <c:f>Genero_grafico!$A$73</c:f>
              <c:strCache>
                <c:ptCount val="1"/>
                <c:pt idx="0">
                  <c:v>YB-42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3:$K$7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41240344788984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7-4B39-43B7-BBB0-971E077EAE9E}"/>
            </c:ext>
          </c:extLst>
        </c:ser>
        <c:ser>
          <c:idx val="72"/>
          <c:order val="72"/>
          <c:tx>
            <c:strRef>
              <c:f>Genero_grafico!$A$74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4:$K$74</c:f>
              <c:numCache>
                <c:formatCode>General</c:formatCode>
                <c:ptCount val="10"/>
                <c:pt idx="0">
                  <c:v>2.1401819154628101E-2</c:v>
                </c:pt>
                <c:pt idx="1">
                  <c:v>0.30242888195822698</c:v>
                </c:pt>
                <c:pt idx="2">
                  <c:v>5.6610346629507098E-2</c:v>
                </c:pt>
                <c:pt idx="3">
                  <c:v>0.35144090772165898</c:v>
                </c:pt>
                <c:pt idx="4">
                  <c:v>0</c:v>
                </c:pt>
                <c:pt idx="5">
                  <c:v>3.9180566439046202E-2</c:v>
                </c:pt>
                <c:pt idx="6">
                  <c:v>0.79806887038770402</c:v>
                </c:pt>
                <c:pt idx="7">
                  <c:v>0.52542838097478695</c:v>
                </c:pt>
                <c:pt idx="8">
                  <c:v>0.185073019718689</c:v>
                </c:pt>
                <c:pt idx="9">
                  <c:v>9.50344499881207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8-4B39-43B7-BBB0-971E077EAE9E}"/>
            </c:ext>
          </c:extLst>
        </c:ser>
        <c:ser>
          <c:idx val="73"/>
          <c:order val="73"/>
          <c:tx>
            <c:strRef>
              <c:f>Genero_grafico!$A$75</c:f>
              <c:strCache>
                <c:ptCount val="1"/>
                <c:pt idx="0">
                  <c:v>Nitrospira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5:$K$75</c:f>
              <c:numCache>
                <c:formatCode>General</c:formatCode>
                <c:ptCount val="10"/>
                <c:pt idx="0">
                  <c:v>1.3429641519529161</c:v>
                </c:pt>
                <c:pt idx="1">
                  <c:v>3.3078158964181099E-2</c:v>
                </c:pt>
                <c:pt idx="2">
                  <c:v>0.137171224525344</c:v>
                </c:pt>
                <c:pt idx="3">
                  <c:v>1.00411687920474E-2</c:v>
                </c:pt>
                <c:pt idx="4">
                  <c:v>0</c:v>
                </c:pt>
                <c:pt idx="5">
                  <c:v>0.64368073435576001</c:v>
                </c:pt>
                <c:pt idx="6">
                  <c:v>0.162569584708606</c:v>
                </c:pt>
                <c:pt idx="7">
                  <c:v>0</c:v>
                </c:pt>
                <c:pt idx="8">
                  <c:v>3.0284675953967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9-4B39-43B7-BBB0-971E077EAE9E}"/>
            </c:ext>
          </c:extLst>
        </c:ser>
        <c:ser>
          <c:idx val="74"/>
          <c:order val="74"/>
          <c:tx>
            <c:strRef>
              <c:f>Genero_grafico!$A$76</c:f>
              <c:strCache>
                <c:ptCount val="1"/>
                <c:pt idx="0">
                  <c:v>Nitrococcaceae_unclassified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6:$K$76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1.153010112465741</c:v>
                </c:pt>
                <c:pt idx="2">
                  <c:v>0</c:v>
                </c:pt>
                <c:pt idx="3">
                  <c:v>0.93382869766040799</c:v>
                </c:pt>
                <c:pt idx="4">
                  <c:v>8.14243838888286E-3</c:v>
                </c:pt>
                <c:pt idx="5">
                  <c:v>0</c:v>
                </c:pt>
                <c:pt idx="6">
                  <c:v>7.3895265776639199E-2</c:v>
                </c:pt>
                <c:pt idx="7">
                  <c:v>5.8816609810610501E-2</c:v>
                </c:pt>
                <c:pt idx="8">
                  <c:v>1.00948919846558E-2</c:v>
                </c:pt>
                <c:pt idx="9">
                  <c:v>3.39408749957574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A-4B39-43B7-BBB0-971E077EAE9E}"/>
            </c:ext>
          </c:extLst>
        </c:ser>
        <c:ser>
          <c:idx val="75"/>
          <c:order val="75"/>
          <c:tx>
            <c:strRef>
              <c:f>Genero_grafico!$A$77</c:f>
              <c:strCache>
                <c:ptCount val="1"/>
                <c:pt idx="0">
                  <c:v>CCM19a_ge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7:$K$77</c:f>
              <c:numCache>
                <c:formatCode>General</c:formatCode>
                <c:ptCount val="10"/>
                <c:pt idx="0">
                  <c:v>0.2193686463349379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97581999328333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B-4B39-43B7-BBB0-971E077EAE9E}"/>
            </c:ext>
          </c:extLst>
        </c:ser>
        <c:ser>
          <c:idx val="76"/>
          <c:order val="76"/>
          <c:tx>
            <c:strRef>
              <c:f>Genero_grafico!$A$78</c:f>
              <c:strCache>
                <c:ptCount val="1"/>
                <c:pt idx="0">
                  <c:v>Gemmatimonadaceae_unclassified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8:$K$78</c:f>
              <c:numCache>
                <c:formatCode>General</c:formatCode>
                <c:ptCount val="10"/>
                <c:pt idx="0">
                  <c:v>0.123060460139112</c:v>
                </c:pt>
                <c:pt idx="1">
                  <c:v>0.50562328702391102</c:v>
                </c:pt>
                <c:pt idx="2">
                  <c:v>0.206845497300122</c:v>
                </c:pt>
                <c:pt idx="3">
                  <c:v>0.51712019279044097</c:v>
                </c:pt>
                <c:pt idx="4">
                  <c:v>0</c:v>
                </c:pt>
                <c:pt idx="5">
                  <c:v>0.106347251763125</c:v>
                </c:pt>
                <c:pt idx="6">
                  <c:v>0.187201339967486</c:v>
                </c:pt>
                <c:pt idx="7">
                  <c:v>1.1763321962122099E-2</c:v>
                </c:pt>
                <c:pt idx="8">
                  <c:v>0.50137963523790297</c:v>
                </c:pt>
                <c:pt idx="9">
                  <c:v>3.39408749957574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C-4B39-43B7-BBB0-971E077EAE9E}"/>
            </c:ext>
          </c:extLst>
        </c:ser>
        <c:ser>
          <c:idx val="77"/>
          <c:order val="77"/>
          <c:tx>
            <c:strRef>
              <c:f>Genero_grafico!$A$79</c:f>
              <c:strCache>
                <c:ptCount val="1"/>
                <c:pt idx="0">
                  <c:v>Bacteria_unclassified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79:$K$79</c:f>
              <c:numCache>
                <c:formatCode>General</c:formatCode>
                <c:ptCount val="10"/>
                <c:pt idx="0">
                  <c:v>0.28357410379882297</c:v>
                </c:pt>
                <c:pt idx="1">
                  <c:v>0.18901805122389201</c:v>
                </c:pt>
                <c:pt idx="2">
                  <c:v>0.12410729838007301</c:v>
                </c:pt>
                <c:pt idx="3">
                  <c:v>0.15563811627673499</c:v>
                </c:pt>
                <c:pt idx="4">
                  <c:v>8.1424383888828597E-2</c:v>
                </c:pt>
                <c:pt idx="5">
                  <c:v>0.82838911899697698</c:v>
                </c:pt>
                <c:pt idx="6">
                  <c:v>0.29558106310655702</c:v>
                </c:pt>
                <c:pt idx="7">
                  <c:v>3.1368858565658901E-2</c:v>
                </c:pt>
                <c:pt idx="8">
                  <c:v>0.121138703815869</c:v>
                </c:pt>
                <c:pt idx="9">
                  <c:v>6.109357499236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D-4B39-43B7-BBB0-971E077EAE9E}"/>
            </c:ext>
          </c:extLst>
        </c:ser>
        <c:ser>
          <c:idx val="78"/>
          <c:order val="78"/>
          <c:tx>
            <c:strRef>
              <c:f>Genero_grafico!$A$80</c:f>
              <c:strCache>
                <c:ptCount val="1"/>
                <c:pt idx="0">
                  <c:v>Quadrisphaera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0:$K$80</c:f>
              <c:numCache>
                <c:formatCode>General</c:formatCode>
                <c:ptCount val="10"/>
                <c:pt idx="0">
                  <c:v>9.0957731407169604E-2</c:v>
                </c:pt>
                <c:pt idx="1">
                  <c:v>0.127587184576127</c:v>
                </c:pt>
                <c:pt idx="2">
                  <c:v>0.71851593798989699</c:v>
                </c:pt>
                <c:pt idx="3">
                  <c:v>0.17572045386082899</c:v>
                </c:pt>
                <c:pt idx="4">
                  <c:v>0</c:v>
                </c:pt>
                <c:pt idx="5">
                  <c:v>2.7986118885032999E-2</c:v>
                </c:pt>
                <c:pt idx="6">
                  <c:v>9.3600669983743001E-2</c:v>
                </c:pt>
                <c:pt idx="7">
                  <c:v>0.46661177116417701</c:v>
                </c:pt>
                <c:pt idx="8">
                  <c:v>0.33313143549363999</c:v>
                </c:pt>
                <c:pt idx="9">
                  <c:v>2.03645249974543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E-4B39-43B7-BBB0-971E077EAE9E}"/>
            </c:ext>
          </c:extLst>
        </c:ser>
        <c:ser>
          <c:idx val="79"/>
          <c:order val="79"/>
          <c:tx>
            <c:strRef>
              <c:f>Genero_grafico!$A$81</c:f>
              <c:strCache>
                <c:ptCount val="1"/>
                <c:pt idx="0">
                  <c:v>uncultured_ge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1:$K$81</c:f>
              <c:numCache>
                <c:formatCode>General</c:formatCode>
                <c:ptCount val="10"/>
                <c:pt idx="0">
                  <c:v>0.57963260210451195</c:v>
                </c:pt>
                <c:pt idx="1">
                  <c:v>0</c:v>
                </c:pt>
                <c:pt idx="2">
                  <c:v>8.7092840968472397E-3</c:v>
                </c:pt>
                <c:pt idx="3">
                  <c:v>1.5061753188071099E-2</c:v>
                </c:pt>
                <c:pt idx="4">
                  <c:v>0</c:v>
                </c:pt>
                <c:pt idx="5">
                  <c:v>0.34702787417441</c:v>
                </c:pt>
                <c:pt idx="6">
                  <c:v>1.083797231390708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F-4B39-43B7-BBB0-971E077EAE9E}"/>
            </c:ext>
          </c:extLst>
        </c:ser>
        <c:ser>
          <c:idx val="80"/>
          <c:order val="80"/>
          <c:tx>
            <c:strRef>
              <c:f>Genero_grafico!$A$82</c:f>
              <c:strCache>
                <c:ptCount val="1"/>
                <c:pt idx="0">
                  <c:v>Actinokineospora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2:$K$82</c:f>
              <c:numCache>
                <c:formatCode>General</c:formatCode>
                <c:ptCount val="10"/>
                <c:pt idx="0">
                  <c:v>6.5988942393436806E-2</c:v>
                </c:pt>
                <c:pt idx="1">
                  <c:v>0</c:v>
                </c:pt>
                <c:pt idx="2">
                  <c:v>0.1284619404284970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3.9410808414207597E-2</c:v>
                </c:pt>
                <c:pt idx="7">
                  <c:v>1.737050543073364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0-4B39-43B7-BBB0-971E077EAE9E}"/>
            </c:ext>
          </c:extLst>
        </c:ser>
        <c:ser>
          <c:idx val="81"/>
          <c:order val="81"/>
          <c:tx>
            <c:strRef>
              <c:f>Genero_grafico!$A$83</c:f>
              <c:strCache>
                <c:ptCount val="1"/>
                <c:pt idx="0">
                  <c:v>Microtrichales_unclassified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3:$K$83</c:f>
              <c:numCache>
                <c:formatCode>General</c:formatCode>
                <c:ptCount val="10"/>
                <c:pt idx="0">
                  <c:v>0.17656500802568201</c:v>
                </c:pt>
                <c:pt idx="1">
                  <c:v>0.31660523580001898</c:v>
                </c:pt>
                <c:pt idx="2">
                  <c:v>0.121929977355861</c:v>
                </c:pt>
                <c:pt idx="3">
                  <c:v>0.170699869464806</c:v>
                </c:pt>
                <c:pt idx="4">
                  <c:v>0</c:v>
                </c:pt>
                <c:pt idx="5">
                  <c:v>0.162319489533192</c:v>
                </c:pt>
                <c:pt idx="6">
                  <c:v>0.216759446278142</c:v>
                </c:pt>
                <c:pt idx="7">
                  <c:v>0.30584637101517498</c:v>
                </c:pt>
                <c:pt idx="8">
                  <c:v>0.32640150750386998</c:v>
                </c:pt>
                <c:pt idx="9">
                  <c:v>0.15273393748090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1-4B39-43B7-BBB0-971E077EAE9E}"/>
            </c:ext>
          </c:extLst>
        </c:ser>
        <c:ser>
          <c:idx val="82"/>
          <c:order val="82"/>
          <c:tx>
            <c:strRef>
              <c:f>Genero_grafico!$A$84</c:f>
              <c:strCache>
                <c:ptCount val="1"/>
                <c:pt idx="0">
                  <c:v>RBG-13-54-9_ge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4:$K$84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919847755513264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2-4B39-43B7-BBB0-971E077EAE9E}"/>
            </c:ext>
          </c:extLst>
        </c:ser>
        <c:ser>
          <c:idx val="83"/>
          <c:order val="83"/>
          <c:tx>
            <c:strRef>
              <c:f>Genero_grafico!$A$85</c:f>
              <c:strCache>
                <c:ptCount val="1"/>
                <c:pt idx="0">
                  <c:v>Oligoflexus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5:$K$85</c:f>
              <c:numCache>
                <c:formatCode>General</c:formatCode>
                <c:ptCount val="10"/>
                <c:pt idx="0">
                  <c:v>0</c:v>
                </c:pt>
                <c:pt idx="1">
                  <c:v>0.48672148190152198</c:v>
                </c:pt>
                <c:pt idx="2">
                  <c:v>0.64884166521511899</c:v>
                </c:pt>
                <c:pt idx="3">
                  <c:v>0.42172908926599101</c:v>
                </c:pt>
                <c:pt idx="4">
                  <c:v>0</c:v>
                </c:pt>
                <c:pt idx="5">
                  <c:v>0.156722265756185</c:v>
                </c:pt>
                <c:pt idx="6">
                  <c:v>0</c:v>
                </c:pt>
                <c:pt idx="7">
                  <c:v>0</c:v>
                </c:pt>
                <c:pt idx="8">
                  <c:v>0.19180294770845899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3-4B39-43B7-BBB0-971E077EAE9E}"/>
            </c:ext>
          </c:extLst>
        </c:ser>
        <c:ser>
          <c:idx val="84"/>
          <c:order val="84"/>
          <c:tx>
            <c:strRef>
              <c:f>Genero_grafico!$A$86</c:f>
              <c:strCache>
                <c:ptCount val="1"/>
                <c:pt idx="0">
                  <c:v>Rhodothermaceae_unclassified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6:$K$86</c:f>
              <c:numCache>
                <c:formatCode>General</c:formatCode>
                <c:ptCount val="10"/>
                <c:pt idx="0">
                  <c:v>4.8154093097913298E-2</c:v>
                </c:pt>
                <c:pt idx="1">
                  <c:v>9.4509025611945893E-2</c:v>
                </c:pt>
                <c:pt idx="2">
                  <c:v>0.10015676711374299</c:v>
                </c:pt>
                <c:pt idx="3">
                  <c:v>9.0370519128426502E-2</c:v>
                </c:pt>
                <c:pt idx="4">
                  <c:v>0</c:v>
                </c:pt>
                <c:pt idx="5">
                  <c:v>5.0375013993059402E-2</c:v>
                </c:pt>
                <c:pt idx="6">
                  <c:v>0</c:v>
                </c:pt>
                <c:pt idx="7">
                  <c:v>0</c:v>
                </c:pt>
                <c:pt idx="8">
                  <c:v>1.514233797698364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4-4B39-43B7-BBB0-971E077EAE9E}"/>
            </c:ext>
          </c:extLst>
        </c:ser>
        <c:ser>
          <c:idx val="85"/>
          <c:order val="85"/>
          <c:tx>
            <c:strRef>
              <c:f>Genero_grafico!$A$87</c:f>
              <c:strCache>
                <c:ptCount val="1"/>
                <c:pt idx="0">
                  <c:v>Gemmata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7:$K$87</c:f>
              <c:numCache>
                <c:formatCode>General</c:formatCode>
                <c:ptCount val="10"/>
                <c:pt idx="0">
                  <c:v>5.7071517745675003E-2</c:v>
                </c:pt>
                <c:pt idx="1">
                  <c:v>0.30715433323882402</c:v>
                </c:pt>
                <c:pt idx="2">
                  <c:v>0.398449747430761</c:v>
                </c:pt>
                <c:pt idx="3">
                  <c:v>0.41168792047394298</c:v>
                </c:pt>
                <c:pt idx="4">
                  <c:v>0</c:v>
                </c:pt>
                <c:pt idx="5">
                  <c:v>0.22388895108026399</c:v>
                </c:pt>
                <c:pt idx="6">
                  <c:v>0</c:v>
                </c:pt>
                <c:pt idx="7">
                  <c:v>0</c:v>
                </c:pt>
                <c:pt idx="8">
                  <c:v>0.3768759674271490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5-4B39-43B7-BBB0-971E077EAE9E}"/>
            </c:ext>
          </c:extLst>
        </c:ser>
        <c:ser>
          <c:idx val="86"/>
          <c:order val="86"/>
          <c:tx>
            <c:strRef>
              <c:f>Genero_grafico!$A$88</c:f>
              <c:strCache>
                <c:ptCount val="1"/>
                <c:pt idx="0">
                  <c:v>Conexibacter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8:$K$88</c:f>
              <c:numCache>
                <c:formatCode>General</c:formatCode>
                <c:ptCount val="10"/>
                <c:pt idx="0">
                  <c:v>1.0700909577314101E-2</c:v>
                </c:pt>
                <c:pt idx="1">
                  <c:v>0.25989982043285098</c:v>
                </c:pt>
                <c:pt idx="2">
                  <c:v>0.169831039888521</c:v>
                </c:pt>
                <c:pt idx="3">
                  <c:v>0.210864544632995</c:v>
                </c:pt>
                <c:pt idx="4">
                  <c:v>0</c:v>
                </c:pt>
                <c:pt idx="5">
                  <c:v>0</c:v>
                </c:pt>
                <c:pt idx="6">
                  <c:v>0.24139120153702201</c:v>
                </c:pt>
                <c:pt idx="7">
                  <c:v>0</c:v>
                </c:pt>
                <c:pt idx="8">
                  <c:v>0.57540884312537899</c:v>
                </c:pt>
                <c:pt idx="9">
                  <c:v>0.29528561246308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6-4B39-43B7-BBB0-971E077EAE9E}"/>
            </c:ext>
          </c:extLst>
        </c:ser>
        <c:ser>
          <c:idx val="87"/>
          <c:order val="87"/>
          <c:tx>
            <c:strRef>
              <c:f>Genero_grafico!$A$89</c:f>
              <c:strCache>
                <c:ptCount val="1"/>
                <c:pt idx="0">
                  <c:v>Arthrobacter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89:$K$8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5283899685159097E-2</c:v>
                </c:pt>
                <c:pt idx="5">
                  <c:v>0</c:v>
                </c:pt>
                <c:pt idx="6">
                  <c:v>0</c:v>
                </c:pt>
                <c:pt idx="7">
                  <c:v>1.63902286005568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7-4B39-43B7-BBB0-971E077EAE9E}"/>
            </c:ext>
          </c:extLst>
        </c:ser>
        <c:ser>
          <c:idx val="88"/>
          <c:order val="88"/>
          <c:tx>
            <c:strRef>
              <c:f>Genero_grafico!$A$90</c:f>
              <c:strCache>
                <c:ptCount val="1"/>
                <c:pt idx="0">
                  <c:v>Kineosporiaceae_unclassified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0:$K$90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0.652112276722427</c:v>
                </c:pt>
                <c:pt idx="2">
                  <c:v>0.209022818324334</c:v>
                </c:pt>
                <c:pt idx="3">
                  <c:v>0.60749071191886705</c:v>
                </c:pt>
                <c:pt idx="4">
                  <c:v>0</c:v>
                </c:pt>
                <c:pt idx="5">
                  <c:v>0</c:v>
                </c:pt>
                <c:pt idx="6">
                  <c:v>2.4631755258879801E-2</c:v>
                </c:pt>
                <c:pt idx="7">
                  <c:v>6.2737717131317899E-2</c:v>
                </c:pt>
                <c:pt idx="8">
                  <c:v>0.10431388384144299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8-4B39-43B7-BBB0-971E077EAE9E}"/>
            </c:ext>
          </c:extLst>
        </c:ser>
        <c:ser>
          <c:idx val="89"/>
          <c:order val="89"/>
          <c:tx>
            <c:strRef>
              <c:f>Genero_grafico!$A$91</c:f>
              <c:strCache>
                <c:ptCount val="1"/>
                <c:pt idx="0">
                  <c:v>Cyclobacteriaceae_unclassified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1:$K$91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.27407617427464298</c:v>
                </c:pt>
                <c:pt idx="2">
                  <c:v>6.9674272774777904E-2</c:v>
                </c:pt>
                <c:pt idx="3">
                  <c:v>0.33637915453358802</c:v>
                </c:pt>
                <c:pt idx="4">
                  <c:v>0</c:v>
                </c:pt>
                <c:pt idx="5">
                  <c:v>0.111944475540132</c:v>
                </c:pt>
                <c:pt idx="6">
                  <c:v>0.14779053155327801</c:v>
                </c:pt>
                <c:pt idx="7">
                  <c:v>0.25879308316668598</c:v>
                </c:pt>
                <c:pt idx="8">
                  <c:v>0</c:v>
                </c:pt>
                <c:pt idx="9">
                  <c:v>0.420866849947391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9-4B39-43B7-BBB0-971E077EAE9E}"/>
            </c:ext>
          </c:extLst>
        </c:ser>
        <c:ser>
          <c:idx val="90"/>
          <c:order val="90"/>
          <c:tx>
            <c:strRef>
              <c:f>Genero_grafico!$A$92</c:f>
              <c:strCache>
                <c:ptCount val="1"/>
                <c:pt idx="0">
                  <c:v>Rhizobiales_unclassified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2:$K$92</c:f>
              <c:numCache>
                <c:formatCode>General</c:formatCode>
                <c:ptCount val="10"/>
                <c:pt idx="0">
                  <c:v>0.251471375066881</c:v>
                </c:pt>
                <c:pt idx="1">
                  <c:v>8.9783574331348606E-2</c:v>
                </c:pt>
                <c:pt idx="2">
                  <c:v>2.83051733147535E-2</c:v>
                </c:pt>
                <c:pt idx="3">
                  <c:v>6.0247012752284397E-2</c:v>
                </c:pt>
                <c:pt idx="4">
                  <c:v>0</c:v>
                </c:pt>
                <c:pt idx="5">
                  <c:v>0.30225008395835701</c:v>
                </c:pt>
                <c:pt idx="6">
                  <c:v>0.28572836100300503</c:v>
                </c:pt>
                <c:pt idx="7">
                  <c:v>0.572481668823276</c:v>
                </c:pt>
                <c:pt idx="8">
                  <c:v>6.7299279897705096E-3</c:v>
                </c:pt>
                <c:pt idx="9">
                  <c:v>1.3576349998303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A-4B39-43B7-BBB0-971E077EAE9E}"/>
            </c:ext>
          </c:extLst>
        </c:ser>
        <c:ser>
          <c:idx val="91"/>
          <c:order val="91"/>
          <c:tx>
            <c:strRef>
              <c:f>Genero_grafico!$A$93</c:f>
              <c:strCache>
                <c:ptCount val="1"/>
                <c:pt idx="0">
                  <c:v>S0134_terrestrial_group_ge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3:$K$93</c:f>
              <c:numCache>
                <c:formatCode>General</c:formatCode>
                <c:ptCount val="10"/>
                <c:pt idx="0">
                  <c:v>0.422685928303906</c:v>
                </c:pt>
                <c:pt idx="1">
                  <c:v>6.6156317928362199E-2</c:v>
                </c:pt>
                <c:pt idx="2">
                  <c:v>8.0560877895837005E-2</c:v>
                </c:pt>
                <c:pt idx="3">
                  <c:v>9.5391103524450196E-2</c:v>
                </c:pt>
                <c:pt idx="4">
                  <c:v>0</c:v>
                </c:pt>
                <c:pt idx="5">
                  <c:v>5.0375013993059402E-2</c:v>
                </c:pt>
                <c:pt idx="6">
                  <c:v>0.85718508300901497</c:v>
                </c:pt>
                <c:pt idx="7">
                  <c:v>0</c:v>
                </c:pt>
                <c:pt idx="8">
                  <c:v>2.3554747964196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B-4B39-43B7-BBB0-971E077EAE9E}"/>
            </c:ext>
          </c:extLst>
        </c:ser>
        <c:ser>
          <c:idx val="92"/>
          <c:order val="92"/>
          <c:tx>
            <c:strRef>
              <c:f>Genero_grafico!$A$94</c:f>
              <c:strCache>
                <c:ptCount val="1"/>
                <c:pt idx="0">
                  <c:v>Blastocatellaceae_ge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4:$K$94</c:f>
              <c:numCache>
                <c:formatCode>General</c:formatCode>
                <c:ptCount val="10"/>
                <c:pt idx="0">
                  <c:v>0.461922596754058</c:v>
                </c:pt>
                <c:pt idx="1">
                  <c:v>1.4176353841791899E-2</c:v>
                </c:pt>
                <c:pt idx="2">
                  <c:v>0.26563316495384098</c:v>
                </c:pt>
                <c:pt idx="3">
                  <c:v>0</c:v>
                </c:pt>
                <c:pt idx="4">
                  <c:v>0</c:v>
                </c:pt>
                <c:pt idx="5">
                  <c:v>0.79480577633493799</c:v>
                </c:pt>
                <c:pt idx="6">
                  <c:v>1.9705404207103799E-2</c:v>
                </c:pt>
                <c:pt idx="7">
                  <c:v>0</c:v>
                </c:pt>
                <c:pt idx="8">
                  <c:v>1.6824819974426301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C-4B39-43B7-BBB0-971E077EAE9E}"/>
            </c:ext>
          </c:extLst>
        </c:ser>
        <c:ser>
          <c:idx val="93"/>
          <c:order val="93"/>
          <c:tx>
            <c:strRef>
              <c:f>Genero_grafico!$A$95</c:f>
              <c:strCache>
                <c:ptCount val="1"/>
                <c:pt idx="0">
                  <c:v>WD2101_soil_group_ge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5:$K$95</c:f>
              <c:numCache>
                <c:formatCode>General</c:formatCode>
                <c:ptCount val="10"/>
                <c:pt idx="0">
                  <c:v>0.31032637774210797</c:v>
                </c:pt>
                <c:pt idx="1">
                  <c:v>2.8352707683583799E-2</c:v>
                </c:pt>
                <c:pt idx="2">
                  <c:v>0.293938338268594</c:v>
                </c:pt>
                <c:pt idx="3">
                  <c:v>1.00411687920474E-2</c:v>
                </c:pt>
                <c:pt idx="4">
                  <c:v>0</c:v>
                </c:pt>
                <c:pt idx="5">
                  <c:v>0.75562520989589199</c:v>
                </c:pt>
                <c:pt idx="6">
                  <c:v>1.47790531553278E-2</c:v>
                </c:pt>
                <c:pt idx="7">
                  <c:v>1.96055366035368E-2</c:v>
                </c:pt>
                <c:pt idx="8">
                  <c:v>6.7299279897705094E-2</c:v>
                </c:pt>
                <c:pt idx="9">
                  <c:v>3.39408749957574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D-4B39-43B7-BBB0-971E077EAE9E}"/>
            </c:ext>
          </c:extLst>
        </c:ser>
        <c:ser>
          <c:idx val="94"/>
          <c:order val="94"/>
          <c:tx>
            <c:strRef>
              <c:f>Genero_grafico!$A$96</c:f>
              <c:strCache>
                <c:ptCount val="1"/>
                <c:pt idx="0">
                  <c:v>SWB02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6:$K$96</c:f>
              <c:numCache>
                <c:formatCode>General</c:formatCode>
                <c:ptCount val="10"/>
                <c:pt idx="0">
                  <c:v>0.5243445692883900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96831971342214296</c:v>
                </c:pt>
                <c:pt idx="6">
                  <c:v>9.8527021035518993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E-4B39-43B7-BBB0-971E077EAE9E}"/>
            </c:ext>
          </c:extLst>
        </c:ser>
        <c:ser>
          <c:idx val="95"/>
          <c:order val="95"/>
          <c:tx>
            <c:strRef>
              <c:f>Genero_grafico!$A$97</c:f>
              <c:strCache>
                <c:ptCount val="1"/>
                <c:pt idx="0">
                  <c:v>Intrasporangiaceae_unclassified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7:$K$97</c:f>
              <c:numCache>
                <c:formatCode>General</c:formatCode>
                <c:ptCount val="10"/>
                <c:pt idx="0">
                  <c:v>0</c:v>
                </c:pt>
                <c:pt idx="1">
                  <c:v>1.4176353841791899E-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1944475540132E-2</c:v>
                </c:pt>
                <c:pt idx="6">
                  <c:v>4.9263510517759497E-3</c:v>
                </c:pt>
                <c:pt idx="7">
                  <c:v>1.462573030623848</c:v>
                </c:pt>
                <c:pt idx="8">
                  <c:v>0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F-4B39-43B7-BBB0-971E077EAE9E}"/>
            </c:ext>
          </c:extLst>
        </c:ser>
        <c:ser>
          <c:idx val="96"/>
          <c:order val="96"/>
          <c:tx>
            <c:strRef>
              <c:f>Genero_grafico!$A$98</c:f>
              <c:strCache>
                <c:ptCount val="1"/>
                <c:pt idx="0">
                  <c:v>RB41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8:$K$98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4.7254512805973E-3</c:v>
                </c:pt>
                <c:pt idx="2">
                  <c:v>0.11757533530743799</c:v>
                </c:pt>
                <c:pt idx="3">
                  <c:v>1.00411687920474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339255669964332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0-4B39-43B7-BBB0-971E077EAE9E}"/>
            </c:ext>
          </c:extLst>
        </c:ser>
        <c:ser>
          <c:idx val="97"/>
          <c:order val="97"/>
          <c:tx>
            <c:strRef>
              <c:f>Genero_grafico!$A$99</c:f>
              <c:strCache>
                <c:ptCount val="1"/>
                <c:pt idx="0">
                  <c:v>Rhodanobacteraceae_unclassified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99:$K$99</c:f>
              <c:numCache>
                <c:formatCode>General</c:formatCode>
                <c:ptCount val="10"/>
                <c:pt idx="0">
                  <c:v>3.2102728731942198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4328892869136911</c:v>
                </c:pt>
                <c:pt idx="6">
                  <c:v>1.47790531553278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1-4B39-43B7-BBB0-971E077EAE9E}"/>
            </c:ext>
          </c:extLst>
        </c:ser>
        <c:ser>
          <c:idx val="98"/>
          <c:order val="98"/>
          <c:tx>
            <c:strRef>
              <c:f>Genero_grafico!$A$100</c:f>
              <c:strCache>
                <c:ptCount val="1"/>
                <c:pt idx="0">
                  <c:v>Acetobacteraceae_unclassified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0:$K$100</c:f>
              <c:numCache>
                <c:formatCode>General</c:formatCode>
                <c:ptCount val="10"/>
                <c:pt idx="0">
                  <c:v>1.4267879436418799E-2</c:v>
                </c:pt>
                <c:pt idx="1">
                  <c:v>1.4176353841791899E-2</c:v>
                </c:pt>
                <c:pt idx="2">
                  <c:v>8.7092840968472404E-2</c:v>
                </c:pt>
                <c:pt idx="3">
                  <c:v>1.00411687920474E-2</c:v>
                </c:pt>
                <c:pt idx="4">
                  <c:v>0</c:v>
                </c:pt>
                <c:pt idx="5">
                  <c:v>1.3433337064815849</c:v>
                </c:pt>
                <c:pt idx="6">
                  <c:v>0</c:v>
                </c:pt>
                <c:pt idx="7">
                  <c:v>0</c:v>
                </c:pt>
                <c:pt idx="8">
                  <c:v>6.7299279897705096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2-4B39-43B7-BBB0-971E077EAE9E}"/>
            </c:ext>
          </c:extLst>
        </c:ser>
        <c:ser>
          <c:idx val="99"/>
          <c:order val="99"/>
          <c:tx>
            <c:strRef>
              <c:f>Genero_grafico!$A$101</c:f>
              <c:strCache>
                <c:ptCount val="1"/>
                <c:pt idx="0">
                  <c:v>Leptolyngbya_Es-Yyy1000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1:$K$10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1.9595889217906299E-2</c:v>
                </c:pt>
                <c:pt idx="3">
                  <c:v>0</c:v>
                </c:pt>
                <c:pt idx="4">
                  <c:v>0</c:v>
                </c:pt>
                <c:pt idx="5">
                  <c:v>1.438486510690697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3-4B39-43B7-BBB0-971E077EAE9E}"/>
            </c:ext>
          </c:extLst>
        </c:ser>
        <c:ser>
          <c:idx val="100"/>
          <c:order val="100"/>
          <c:tx>
            <c:strRef>
              <c:f>Genero_grafico!$A$102</c:f>
              <c:strCache>
                <c:ptCount val="1"/>
                <c:pt idx="0">
                  <c:v>Nitriliruptoraceae_unclassified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2:$K$102</c:f>
              <c:numCache>
                <c:formatCode>General</c:formatCode>
                <c:ptCount val="10"/>
                <c:pt idx="0">
                  <c:v>8.9174246477617299E-3</c:v>
                </c:pt>
                <c:pt idx="1">
                  <c:v>0.13231263585672401</c:v>
                </c:pt>
                <c:pt idx="2">
                  <c:v>2.1773210242118099E-3</c:v>
                </c:pt>
                <c:pt idx="3">
                  <c:v>0.115473441108545</c:v>
                </c:pt>
                <c:pt idx="4">
                  <c:v>2.71414612962762E-3</c:v>
                </c:pt>
                <c:pt idx="5">
                  <c:v>0</c:v>
                </c:pt>
                <c:pt idx="6">
                  <c:v>0.10345337208729501</c:v>
                </c:pt>
                <c:pt idx="7">
                  <c:v>0.98419793749754902</c:v>
                </c:pt>
                <c:pt idx="8">
                  <c:v>0</c:v>
                </c:pt>
                <c:pt idx="9">
                  <c:v>9.842853748769650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4-4B39-43B7-BBB0-971E077EAE9E}"/>
            </c:ext>
          </c:extLst>
        </c:ser>
        <c:ser>
          <c:idx val="101"/>
          <c:order val="101"/>
          <c:tx>
            <c:strRef>
              <c:f>Genero_grafico!$A$103</c:f>
              <c:strCache>
                <c:ptCount val="1"/>
                <c:pt idx="0">
                  <c:v>AKIW781_ge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3:$K$103</c:f>
              <c:numCache>
                <c:formatCode>General</c:formatCode>
                <c:ptCount val="10"/>
                <c:pt idx="0">
                  <c:v>0</c:v>
                </c:pt>
                <c:pt idx="1">
                  <c:v>0.255174369152254</c:v>
                </c:pt>
                <c:pt idx="2">
                  <c:v>0.59440863960982404</c:v>
                </c:pt>
                <c:pt idx="3">
                  <c:v>0.2409880510091370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30621172353455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5-4B39-43B7-BBB0-971E077EAE9E}"/>
            </c:ext>
          </c:extLst>
        </c:ser>
        <c:ser>
          <c:idx val="102"/>
          <c:order val="102"/>
          <c:tx>
            <c:strRef>
              <c:f>Genero_grafico!$A$104</c:f>
              <c:strCache>
                <c:ptCount val="1"/>
                <c:pt idx="0">
                  <c:v>MWH-CFBk5_ge</c:v>
                </c:pt>
              </c:strCache>
            </c:strRef>
          </c:tx>
          <c:spPr>
            <a:solidFill>
              <a:schemeClr val="accent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4:$K$104</c:f>
              <c:numCache>
                <c:formatCode>General</c:formatCode>
                <c:ptCount val="10"/>
                <c:pt idx="0">
                  <c:v>0</c:v>
                </c:pt>
                <c:pt idx="1">
                  <c:v>4.2529061525375701E-2</c:v>
                </c:pt>
                <c:pt idx="2">
                  <c:v>5.2255704581083397E-2</c:v>
                </c:pt>
                <c:pt idx="3">
                  <c:v>8.0329350336379196E-2</c:v>
                </c:pt>
                <c:pt idx="4">
                  <c:v>0</c:v>
                </c:pt>
                <c:pt idx="5">
                  <c:v>1.11944475540132E-2</c:v>
                </c:pt>
                <c:pt idx="6">
                  <c:v>9.8527021035518993E-3</c:v>
                </c:pt>
                <c:pt idx="7">
                  <c:v>0.482296200447006</c:v>
                </c:pt>
                <c:pt idx="8">
                  <c:v>0</c:v>
                </c:pt>
                <c:pt idx="9">
                  <c:v>0.590571224926178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6-4B39-43B7-BBB0-971E077EAE9E}"/>
            </c:ext>
          </c:extLst>
        </c:ser>
        <c:ser>
          <c:idx val="103"/>
          <c:order val="103"/>
          <c:tx>
            <c:strRef>
              <c:f>Genero_grafico!$A$105</c:f>
              <c:strCache>
                <c:ptCount val="1"/>
                <c:pt idx="0">
                  <c:v>Tepidisphaera</c:v>
                </c:pt>
              </c:strCache>
            </c:strRef>
          </c:tx>
          <c:spPr>
            <a:solidFill>
              <a:schemeClr val="accent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5:$K$105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4.7254512805973002E-2</c:v>
                </c:pt>
                <c:pt idx="2">
                  <c:v>4.7901062532659799E-2</c:v>
                </c:pt>
                <c:pt idx="3">
                  <c:v>7.5308765940355502E-2</c:v>
                </c:pt>
                <c:pt idx="4">
                  <c:v>0</c:v>
                </c:pt>
                <c:pt idx="5">
                  <c:v>5.5972237770066102E-3</c:v>
                </c:pt>
                <c:pt idx="6">
                  <c:v>1.9705404207103799E-2</c:v>
                </c:pt>
                <c:pt idx="7">
                  <c:v>0</c:v>
                </c:pt>
                <c:pt idx="8">
                  <c:v>0.89171545864459301</c:v>
                </c:pt>
                <c:pt idx="9">
                  <c:v>0.15273393748090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7-4B39-43B7-BBB0-971E077EAE9E}"/>
            </c:ext>
          </c:extLst>
        </c:ser>
        <c:ser>
          <c:idx val="104"/>
          <c:order val="104"/>
          <c:tx>
            <c:strRef>
              <c:f>Genero_grafico!$A$106</c:f>
              <c:strCache>
                <c:ptCount val="1"/>
                <c:pt idx="0">
                  <c:v>uncultured_ge</c:v>
                </c:pt>
              </c:strCache>
            </c:strRef>
          </c:tx>
          <c:spPr>
            <a:solidFill>
              <a:schemeClr val="accent3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6:$K$106</c:f>
              <c:numCache>
                <c:formatCode>General</c:formatCode>
                <c:ptCount val="10"/>
                <c:pt idx="0">
                  <c:v>0.131977884786874</c:v>
                </c:pt>
                <c:pt idx="1">
                  <c:v>0.23627256402986499</c:v>
                </c:pt>
                <c:pt idx="2">
                  <c:v>0.21990942344539299</c:v>
                </c:pt>
                <c:pt idx="3">
                  <c:v>0.210864544632995</c:v>
                </c:pt>
                <c:pt idx="4">
                  <c:v>0</c:v>
                </c:pt>
                <c:pt idx="5">
                  <c:v>0</c:v>
                </c:pt>
                <c:pt idx="6">
                  <c:v>0.20198039312281399</c:v>
                </c:pt>
                <c:pt idx="7">
                  <c:v>0</c:v>
                </c:pt>
                <c:pt idx="8">
                  <c:v>3.0284675953967301E-2</c:v>
                </c:pt>
                <c:pt idx="9">
                  <c:v>0.183280724977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8-4B39-43B7-BBB0-971E077EAE9E}"/>
            </c:ext>
          </c:extLst>
        </c:ser>
        <c:ser>
          <c:idx val="105"/>
          <c:order val="105"/>
          <c:tx>
            <c:strRef>
              <c:f>Genero_grafico!$A$107</c:f>
              <c:strCache>
                <c:ptCount val="1"/>
                <c:pt idx="0">
                  <c:v>PMMR1</c:v>
                </c:pt>
              </c:strCache>
            </c:strRef>
          </c:tx>
          <c:spPr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7:$K$107</c:f>
              <c:numCache>
                <c:formatCode>General</c:formatCode>
                <c:ptCount val="10"/>
                <c:pt idx="0">
                  <c:v>0</c:v>
                </c:pt>
                <c:pt idx="1">
                  <c:v>0.25044891787165702</c:v>
                </c:pt>
                <c:pt idx="2">
                  <c:v>0.12846194042849701</c:v>
                </c:pt>
                <c:pt idx="3">
                  <c:v>0.2359674666131139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5989635910895749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9-4B39-43B7-BBB0-971E077EAE9E}"/>
            </c:ext>
          </c:extLst>
        </c:ser>
        <c:ser>
          <c:idx val="106"/>
          <c:order val="106"/>
          <c:tx>
            <c:strRef>
              <c:f>Genero_grafico!$A$108</c:f>
              <c:strCache>
                <c:ptCount val="1"/>
                <c:pt idx="0">
                  <c:v>Micrococcales_unclassified</c:v>
                </c:pt>
              </c:strCache>
            </c:strRef>
          </c:tx>
          <c:spPr>
            <a:solidFill>
              <a:schemeClr val="accent5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8:$K$108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9.4509025611946001E-3</c:v>
                </c:pt>
                <c:pt idx="2">
                  <c:v>0</c:v>
                </c:pt>
                <c:pt idx="3">
                  <c:v>5.0205843960236998E-3</c:v>
                </c:pt>
                <c:pt idx="4">
                  <c:v>8.14243838888286E-3</c:v>
                </c:pt>
                <c:pt idx="5">
                  <c:v>0</c:v>
                </c:pt>
                <c:pt idx="6">
                  <c:v>5.4189861569535397E-2</c:v>
                </c:pt>
                <c:pt idx="7">
                  <c:v>0.92146022036623099</c:v>
                </c:pt>
                <c:pt idx="8">
                  <c:v>0</c:v>
                </c:pt>
                <c:pt idx="9">
                  <c:v>0.20703933747412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A-4B39-43B7-BBB0-971E077EAE9E}"/>
            </c:ext>
          </c:extLst>
        </c:ser>
        <c:ser>
          <c:idx val="107"/>
          <c:order val="107"/>
          <c:tx>
            <c:strRef>
              <c:f>Genero_grafico!$A$109</c:f>
              <c:strCache>
                <c:ptCount val="1"/>
                <c:pt idx="0">
                  <c:v>Truepera</c:v>
                </c:pt>
              </c:strCache>
            </c:strRef>
          </c:tx>
          <c:spPr>
            <a:solidFill>
              <a:schemeClr val="accent6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09:$K$109</c:f>
              <c:numCache>
                <c:formatCode>General</c:formatCode>
                <c:ptCount val="10"/>
                <c:pt idx="0">
                  <c:v>7.8473336900303198E-2</c:v>
                </c:pt>
                <c:pt idx="1">
                  <c:v>2.8352707683583799E-2</c:v>
                </c:pt>
                <c:pt idx="2">
                  <c:v>0.30047030134122998</c:v>
                </c:pt>
                <c:pt idx="3">
                  <c:v>4.51852595642133E-2</c:v>
                </c:pt>
                <c:pt idx="4">
                  <c:v>0</c:v>
                </c:pt>
                <c:pt idx="5">
                  <c:v>2.7986118885032999E-2</c:v>
                </c:pt>
                <c:pt idx="6">
                  <c:v>0.24631755258879701</c:v>
                </c:pt>
                <c:pt idx="7">
                  <c:v>1.1763321962122099E-2</c:v>
                </c:pt>
                <c:pt idx="8">
                  <c:v>0</c:v>
                </c:pt>
                <c:pt idx="9">
                  <c:v>0.45820181244272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B-4B39-43B7-BBB0-971E077EAE9E}"/>
            </c:ext>
          </c:extLst>
        </c:ser>
        <c:ser>
          <c:idx val="108"/>
          <c:order val="108"/>
          <c:tx>
            <c:strRef>
              <c:f>Genero_grafico!$A$110</c:f>
              <c:strCache>
                <c:ptCount val="1"/>
                <c:pt idx="0">
                  <c:v>Pseudohongiel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0:$K$110</c:f>
              <c:numCache>
                <c:formatCode>General</c:formatCode>
                <c:ptCount val="10"/>
                <c:pt idx="0">
                  <c:v>0</c:v>
                </c:pt>
                <c:pt idx="1">
                  <c:v>3.78036102447784E-2</c:v>
                </c:pt>
                <c:pt idx="2">
                  <c:v>0</c:v>
                </c:pt>
                <c:pt idx="3">
                  <c:v>1.5061753188071099E-2</c:v>
                </c:pt>
                <c:pt idx="4">
                  <c:v>0</c:v>
                </c:pt>
                <c:pt idx="5">
                  <c:v>0</c:v>
                </c:pt>
                <c:pt idx="6">
                  <c:v>3.4484457362431602E-2</c:v>
                </c:pt>
                <c:pt idx="7">
                  <c:v>0.145080970866173</c:v>
                </c:pt>
                <c:pt idx="8">
                  <c:v>0</c:v>
                </c:pt>
                <c:pt idx="9">
                  <c:v>0.96392084987950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C-4B39-43B7-BBB0-971E077EAE9E}"/>
            </c:ext>
          </c:extLst>
        </c:ser>
        <c:ser>
          <c:idx val="109"/>
          <c:order val="109"/>
          <c:tx>
            <c:strRef>
              <c:f>Genero_grafico!$A$111</c:f>
              <c:strCache>
                <c:ptCount val="1"/>
                <c:pt idx="0">
                  <c:v>Euzebyaceae_unclassifi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1:$K$111</c:f>
              <c:numCache>
                <c:formatCode>General</c:formatCode>
                <c:ptCount val="10"/>
                <c:pt idx="0">
                  <c:v>1.7834849295523499E-3</c:v>
                </c:pt>
                <c:pt idx="1">
                  <c:v>4.7254512805973002E-2</c:v>
                </c:pt>
                <c:pt idx="2">
                  <c:v>3.7014457411600803E-2</c:v>
                </c:pt>
                <c:pt idx="3">
                  <c:v>8.5349934732402793E-2</c:v>
                </c:pt>
                <c:pt idx="4">
                  <c:v>0</c:v>
                </c:pt>
                <c:pt idx="5">
                  <c:v>0</c:v>
                </c:pt>
                <c:pt idx="6">
                  <c:v>0.23646485048524599</c:v>
                </c:pt>
                <c:pt idx="7">
                  <c:v>0.66266713719954495</c:v>
                </c:pt>
                <c:pt idx="8">
                  <c:v>2.6919711959082E-2</c:v>
                </c:pt>
                <c:pt idx="9">
                  <c:v>9.842853748769650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D-4B39-43B7-BBB0-971E077EAE9E}"/>
            </c:ext>
          </c:extLst>
        </c:ser>
        <c:ser>
          <c:idx val="110"/>
          <c:order val="110"/>
          <c:tx>
            <c:strRef>
              <c:f>Genero_grafico!$A$112</c:f>
              <c:strCache>
                <c:ptCount val="1"/>
                <c:pt idx="0">
                  <c:v>unculture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2:$K$112</c:f>
              <c:numCache>
                <c:formatCode>General</c:formatCode>
                <c:ptCount val="10"/>
                <c:pt idx="0">
                  <c:v>7.1339397182093797E-2</c:v>
                </c:pt>
                <c:pt idx="1">
                  <c:v>3.3078158964181099E-2</c:v>
                </c:pt>
                <c:pt idx="2">
                  <c:v>0.26781048597805301</c:v>
                </c:pt>
                <c:pt idx="3">
                  <c:v>5.0205843960237001E-2</c:v>
                </c:pt>
                <c:pt idx="4">
                  <c:v>0</c:v>
                </c:pt>
                <c:pt idx="5">
                  <c:v>0.24627784618829099</c:v>
                </c:pt>
                <c:pt idx="6">
                  <c:v>1.9705404207103799E-2</c:v>
                </c:pt>
                <c:pt idx="7">
                  <c:v>0.384268517429322</c:v>
                </c:pt>
                <c:pt idx="8">
                  <c:v>9.7583955851672399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E-4B39-43B7-BBB0-971E077EAE9E}"/>
            </c:ext>
          </c:extLst>
        </c:ser>
        <c:ser>
          <c:idx val="111"/>
          <c:order val="111"/>
          <c:tx>
            <c:strRef>
              <c:f>Genero_grafico!$A$113</c:f>
              <c:strCache>
                <c:ptCount val="1"/>
                <c:pt idx="0">
                  <c:v>JGI_0001001-H0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3:$K$113</c:f>
              <c:numCache>
                <c:formatCode>General</c:formatCode>
                <c:ptCount val="10"/>
                <c:pt idx="0">
                  <c:v>7.1339397182093797E-2</c:v>
                </c:pt>
                <c:pt idx="1">
                  <c:v>4.7254512805973E-3</c:v>
                </c:pt>
                <c:pt idx="2">
                  <c:v>0.94931196655634897</c:v>
                </c:pt>
                <c:pt idx="3">
                  <c:v>0</c:v>
                </c:pt>
                <c:pt idx="4">
                  <c:v>0</c:v>
                </c:pt>
                <c:pt idx="5">
                  <c:v>0.12873614687115201</c:v>
                </c:pt>
                <c:pt idx="6">
                  <c:v>0</c:v>
                </c:pt>
                <c:pt idx="7">
                  <c:v>0</c:v>
                </c:pt>
                <c:pt idx="8">
                  <c:v>3.36496399488525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F-4B39-43B7-BBB0-971E077EAE9E}"/>
            </c:ext>
          </c:extLst>
        </c:ser>
        <c:ser>
          <c:idx val="112"/>
          <c:order val="112"/>
          <c:tx>
            <c:strRef>
              <c:f>Genero_grafico!$A$114</c:f>
              <c:strCache>
                <c:ptCount val="1"/>
                <c:pt idx="0">
                  <c:v>Latescibacteraceae_g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4:$K$114</c:f>
              <c:numCache>
                <c:formatCode>General</c:formatCode>
                <c:ptCount val="10"/>
                <c:pt idx="0">
                  <c:v>1.15391474942036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0-4B39-43B7-BBB0-971E077EAE9E}"/>
            </c:ext>
          </c:extLst>
        </c:ser>
        <c:ser>
          <c:idx val="113"/>
          <c:order val="113"/>
          <c:tx>
            <c:strRef>
              <c:f>Genero_grafico!$A$115</c:f>
              <c:strCache>
                <c:ptCount val="1"/>
                <c:pt idx="0">
                  <c:v>A4b_g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5:$K$115</c:f>
              <c:numCache>
                <c:formatCode>General</c:formatCode>
                <c:ptCount val="10"/>
                <c:pt idx="0">
                  <c:v>0.29427501337613698</c:v>
                </c:pt>
                <c:pt idx="1">
                  <c:v>0.118136282014932</c:v>
                </c:pt>
                <c:pt idx="2">
                  <c:v>3.4837136387389001E-2</c:v>
                </c:pt>
                <c:pt idx="3">
                  <c:v>2.5102921980118501E-2</c:v>
                </c:pt>
                <c:pt idx="4">
                  <c:v>0</c:v>
                </c:pt>
                <c:pt idx="5">
                  <c:v>0.62688906302474001</c:v>
                </c:pt>
                <c:pt idx="6">
                  <c:v>2.95581063106557E-2</c:v>
                </c:pt>
                <c:pt idx="7">
                  <c:v>0</c:v>
                </c:pt>
                <c:pt idx="8">
                  <c:v>1.00948919846558E-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1-4B39-43B7-BBB0-971E077EAE9E}"/>
            </c:ext>
          </c:extLst>
        </c:ser>
        <c:ser>
          <c:idx val="114"/>
          <c:order val="114"/>
          <c:tx>
            <c:strRef>
              <c:f>Genero_grafico!$A$116</c:f>
              <c:strCache>
                <c:ptCount val="1"/>
                <c:pt idx="0">
                  <c:v>Obscuribacterales_ge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6:$K$11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13623642673234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2-4B39-43B7-BBB0-971E077EAE9E}"/>
            </c:ext>
          </c:extLst>
        </c:ser>
        <c:ser>
          <c:idx val="115"/>
          <c:order val="115"/>
          <c:tx>
            <c:strRef>
              <c:f>Genero_grafico!$A$117</c:f>
              <c:strCache>
                <c:ptCount val="1"/>
                <c:pt idx="0">
                  <c:v>Geminicoccaceae_unclassified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7:$K$117</c:f>
              <c:numCache>
                <c:formatCode>General</c:formatCode>
                <c:ptCount val="10"/>
                <c:pt idx="0">
                  <c:v>0</c:v>
                </c:pt>
                <c:pt idx="1">
                  <c:v>9.4509025611946001E-3</c:v>
                </c:pt>
                <c:pt idx="2">
                  <c:v>1.9595889217906299E-2</c:v>
                </c:pt>
                <c:pt idx="3">
                  <c:v>2.0082337584094799E-2</c:v>
                </c:pt>
                <c:pt idx="4">
                  <c:v>0</c:v>
                </c:pt>
                <c:pt idx="5">
                  <c:v>5.5972237770066102E-3</c:v>
                </c:pt>
                <c:pt idx="6">
                  <c:v>4.4337159465983503E-2</c:v>
                </c:pt>
                <c:pt idx="7">
                  <c:v>0</c:v>
                </c:pt>
                <c:pt idx="8">
                  <c:v>0.16488323574937799</c:v>
                </c:pt>
                <c:pt idx="9">
                  <c:v>0.872280487390964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3-4B39-43B7-BBB0-971E077EAE9E}"/>
            </c:ext>
          </c:extLst>
        </c:ser>
        <c:ser>
          <c:idx val="116"/>
          <c:order val="116"/>
          <c:tx>
            <c:strRef>
              <c:f>Genero_grafico!$A$118</c:f>
              <c:strCache>
                <c:ptCount val="1"/>
                <c:pt idx="0">
                  <c:v>MND1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8:$K$118</c:f>
              <c:numCache>
                <c:formatCode>General</c:formatCode>
                <c:ptCount val="10"/>
                <c:pt idx="0">
                  <c:v>0.9167112537899060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2069067441745900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4-4B39-43B7-BBB0-971E077EAE9E}"/>
            </c:ext>
          </c:extLst>
        </c:ser>
        <c:ser>
          <c:idx val="117"/>
          <c:order val="117"/>
          <c:tx>
            <c:strRef>
              <c:f>Genero_grafico!$A$119</c:f>
              <c:strCache>
                <c:ptCount val="1"/>
                <c:pt idx="0">
                  <c:v>Hyphomicrobium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19:$K$119</c:f>
              <c:numCache>
                <c:formatCode>General</c:formatCode>
                <c:ptCount val="10"/>
                <c:pt idx="0">
                  <c:v>0.82040306759407899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2854584126273370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5-4B39-43B7-BBB0-971E077EAE9E}"/>
            </c:ext>
          </c:extLst>
        </c:ser>
        <c:ser>
          <c:idx val="118"/>
          <c:order val="118"/>
          <c:tx>
            <c:strRef>
              <c:f>Genero_grafico!$A$120</c:f>
              <c:strCache>
                <c:ptCount val="1"/>
                <c:pt idx="0">
                  <c:v>Xanthomonadaceae_unclassified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20:$K$120</c:f>
              <c:numCache>
                <c:formatCode>General</c:formatCode>
                <c:ptCount val="10"/>
                <c:pt idx="0">
                  <c:v>0.15516318887105399</c:v>
                </c:pt>
                <c:pt idx="1">
                  <c:v>0.240998015310462</c:v>
                </c:pt>
                <c:pt idx="2">
                  <c:v>6.7496951750566095E-2</c:v>
                </c:pt>
                <c:pt idx="3">
                  <c:v>0.24600863540516099</c:v>
                </c:pt>
                <c:pt idx="4">
                  <c:v>0</c:v>
                </c:pt>
                <c:pt idx="5">
                  <c:v>3.9180566439046202E-2</c:v>
                </c:pt>
                <c:pt idx="6">
                  <c:v>1.47790531553278E-2</c:v>
                </c:pt>
                <c:pt idx="7">
                  <c:v>0.164686507469709</c:v>
                </c:pt>
                <c:pt idx="8">
                  <c:v>9.0854027861901901E-2</c:v>
                </c:pt>
                <c:pt idx="9">
                  <c:v>7.46699249906662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6-4B39-43B7-BBB0-971E077EAE9E}"/>
            </c:ext>
          </c:extLst>
        </c:ser>
        <c:ser>
          <c:idx val="119"/>
          <c:order val="119"/>
          <c:tx>
            <c:strRef>
              <c:f>Genero_grafico!$A$121</c:f>
              <c:strCache>
                <c:ptCount val="1"/>
                <c:pt idx="0">
                  <c:v>Haloactinopolyspora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21:$K$121</c:f>
              <c:numCache>
                <c:formatCode>General</c:formatCode>
                <c:ptCount val="10"/>
                <c:pt idx="0">
                  <c:v>1.4267879436418799E-2</c:v>
                </c:pt>
                <c:pt idx="1">
                  <c:v>0.52452509214630005</c:v>
                </c:pt>
                <c:pt idx="2">
                  <c:v>0</c:v>
                </c:pt>
                <c:pt idx="3">
                  <c:v>0.50205843960236995</c:v>
                </c:pt>
                <c:pt idx="4">
                  <c:v>0</c:v>
                </c:pt>
                <c:pt idx="5">
                  <c:v>0</c:v>
                </c:pt>
                <c:pt idx="6">
                  <c:v>4.9263510517759498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7-4B39-43B7-BBB0-971E077EAE9E}"/>
            </c:ext>
          </c:extLst>
        </c:ser>
        <c:ser>
          <c:idx val="120"/>
          <c:order val="120"/>
          <c:tx>
            <c:strRef>
              <c:f>Genero_grafico!$A$122</c:f>
              <c:strCache>
                <c:ptCount val="1"/>
                <c:pt idx="0">
                  <c:v>Brevundimona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22:$K$122</c:f>
              <c:numCache>
                <c:formatCode>General</c:formatCode>
                <c:ptCount val="10"/>
                <c:pt idx="0">
                  <c:v>2.67522739432852E-2</c:v>
                </c:pt>
                <c:pt idx="1">
                  <c:v>2.8352707683583799E-2</c:v>
                </c:pt>
                <c:pt idx="2">
                  <c:v>0.169831039888521</c:v>
                </c:pt>
                <c:pt idx="3">
                  <c:v>2.5102921980118501E-2</c:v>
                </c:pt>
                <c:pt idx="4">
                  <c:v>0</c:v>
                </c:pt>
                <c:pt idx="5">
                  <c:v>5.0375013993059402E-2</c:v>
                </c:pt>
                <c:pt idx="6">
                  <c:v>1.9705404207103799E-2</c:v>
                </c:pt>
                <c:pt idx="7">
                  <c:v>0</c:v>
                </c:pt>
                <c:pt idx="8">
                  <c:v>0.114408775826099</c:v>
                </c:pt>
                <c:pt idx="9">
                  <c:v>0.631300274921086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8-4B39-43B7-BBB0-971E077EAE9E}"/>
            </c:ext>
          </c:extLst>
        </c:ser>
        <c:ser>
          <c:idx val="121"/>
          <c:order val="121"/>
          <c:tx>
            <c:strRef>
              <c:f>Genero_grafico!$A$123</c:f>
              <c:strCache>
                <c:ptCount val="1"/>
                <c:pt idx="0">
                  <c:v>Candidatus_Alysiosphaer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23:$K$123</c:f>
              <c:numCache>
                <c:formatCode>General</c:formatCode>
                <c:ptCount val="10"/>
                <c:pt idx="0">
                  <c:v>5.35045478865704E-3</c:v>
                </c:pt>
                <c:pt idx="1">
                  <c:v>1.4176353841791899E-2</c:v>
                </c:pt>
                <c:pt idx="2">
                  <c:v>5.2255704581083397E-2</c:v>
                </c:pt>
                <c:pt idx="3">
                  <c:v>1.5061753188071099E-2</c:v>
                </c:pt>
                <c:pt idx="4">
                  <c:v>0</c:v>
                </c:pt>
                <c:pt idx="5">
                  <c:v>0.96272248964513596</c:v>
                </c:pt>
                <c:pt idx="6">
                  <c:v>1.47790531553278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9-4B39-43B7-BBB0-971E077EAE9E}"/>
            </c:ext>
          </c:extLst>
        </c:ser>
        <c:ser>
          <c:idx val="122"/>
          <c:order val="122"/>
          <c:tx>
            <c:strRef>
              <c:f>Genero_grafico!$A$124</c:f>
              <c:strCache>
                <c:ptCount val="1"/>
                <c:pt idx="0">
                  <c:v>JG30-KF-CM66_ge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24:$K$124</c:f>
              <c:numCache>
                <c:formatCode>General</c:formatCode>
                <c:ptCount val="10"/>
                <c:pt idx="0">
                  <c:v>9.8091671125379004E-2</c:v>
                </c:pt>
                <c:pt idx="1">
                  <c:v>0.10395992817314099</c:v>
                </c:pt>
                <c:pt idx="2">
                  <c:v>0.26127852290541698</c:v>
                </c:pt>
                <c:pt idx="3">
                  <c:v>8.0329350336379196E-2</c:v>
                </c:pt>
                <c:pt idx="4">
                  <c:v>0</c:v>
                </c:pt>
                <c:pt idx="5">
                  <c:v>0.21269450352625099</c:v>
                </c:pt>
                <c:pt idx="6">
                  <c:v>0.113306074190847</c:v>
                </c:pt>
                <c:pt idx="7">
                  <c:v>0</c:v>
                </c:pt>
                <c:pt idx="8">
                  <c:v>0.16488323574937799</c:v>
                </c:pt>
                <c:pt idx="9">
                  <c:v>6.78817499915148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A-4B39-43B7-BBB0-971E077EAE9E}"/>
            </c:ext>
          </c:extLst>
        </c:ser>
        <c:ser>
          <c:idx val="123"/>
          <c:order val="123"/>
          <c:tx>
            <c:strRef>
              <c:f>Genero_grafico!$A$125</c:f>
              <c:strCache>
                <c:ptCount val="1"/>
                <c:pt idx="0">
                  <c:v>Gemmatimonadetes_unclassified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25:$K$125</c:f>
              <c:numCache>
                <c:formatCode>General</c:formatCode>
                <c:ptCount val="10"/>
                <c:pt idx="0">
                  <c:v>1.6051364365971099E-2</c:v>
                </c:pt>
                <c:pt idx="1">
                  <c:v>0.20791985634628099</c:v>
                </c:pt>
                <c:pt idx="2">
                  <c:v>0</c:v>
                </c:pt>
                <c:pt idx="3">
                  <c:v>0.12551460990059199</c:v>
                </c:pt>
                <c:pt idx="4">
                  <c:v>0</c:v>
                </c:pt>
                <c:pt idx="5">
                  <c:v>0.190305608418225</c:v>
                </c:pt>
                <c:pt idx="6">
                  <c:v>0.30050741415833299</c:v>
                </c:pt>
                <c:pt idx="7">
                  <c:v>0</c:v>
                </c:pt>
                <c:pt idx="8">
                  <c:v>3.3649639948852499E-2</c:v>
                </c:pt>
                <c:pt idx="9">
                  <c:v>0.13576349998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B-4B39-43B7-BBB0-971E077EAE9E}"/>
            </c:ext>
          </c:extLst>
        </c:ser>
        <c:ser>
          <c:idx val="124"/>
          <c:order val="124"/>
          <c:tx>
            <c:strRef>
              <c:f>Genero_grafico!$A$126</c:f>
              <c:strCache>
                <c:ptCount val="1"/>
                <c:pt idx="0">
                  <c:v>Remaining genera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o_grafico!$B$1:$K$1</c:f>
              <c:strCache>
                <c:ptCount val="10"/>
                <c:pt idx="0">
                  <c:v>Sample_2.1</c:v>
                </c:pt>
                <c:pt idx="1">
                  <c:v>Sample_3.1</c:v>
                </c:pt>
                <c:pt idx="2">
                  <c:v>Sample_3.2</c:v>
                </c:pt>
                <c:pt idx="3">
                  <c:v>Sample_3.3</c:v>
                </c:pt>
                <c:pt idx="4">
                  <c:v>Sample_3.6</c:v>
                </c:pt>
                <c:pt idx="5">
                  <c:v>Sample_4.2</c:v>
                </c:pt>
                <c:pt idx="6">
                  <c:v>Sample_4.5</c:v>
                </c:pt>
                <c:pt idx="7">
                  <c:v>Sample_4.6</c:v>
                </c:pt>
                <c:pt idx="8">
                  <c:v>Sample_4.7</c:v>
                </c:pt>
                <c:pt idx="9">
                  <c:v>Sample_4.8</c:v>
                </c:pt>
              </c:strCache>
            </c:strRef>
          </c:cat>
          <c:val>
            <c:numRef>
              <c:f>Genero_grafico!$B$126:$K$126</c:f>
              <c:numCache>
                <c:formatCode>General</c:formatCode>
                <c:ptCount val="10"/>
                <c:pt idx="0">
                  <c:v>16.418762261458919</c:v>
                </c:pt>
                <c:pt idx="1">
                  <c:v>7.4803893771855341</c:v>
                </c:pt>
                <c:pt idx="2">
                  <c:v>9.9743076119143126</c:v>
                </c:pt>
                <c:pt idx="3">
                  <c:v>7.6714529571242149</c:v>
                </c:pt>
                <c:pt idx="4">
                  <c:v>0.98794919118445301</c:v>
                </c:pt>
                <c:pt idx="5">
                  <c:v>21.017575282659859</c:v>
                </c:pt>
                <c:pt idx="6">
                  <c:v>10.00541898615695</c:v>
                </c:pt>
                <c:pt idx="7">
                  <c:v>6.971728816217694</c:v>
                </c:pt>
                <c:pt idx="8">
                  <c:v>5.4613365636987572</c:v>
                </c:pt>
                <c:pt idx="9">
                  <c:v>5.1114957743610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C-4B39-43B7-BBB0-971E077EAE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087670704"/>
        <c:axId val="-2087673872"/>
      </c:barChart>
      <c:catAx>
        <c:axId val="-208767070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2087673872"/>
        <c:crosses val="autoZero"/>
        <c:auto val="1"/>
        <c:lblAlgn val="ctr"/>
        <c:lblOffset val="100"/>
        <c:noMultiLvlLbl val="0"/>
      </c:catAx>
      <c:valAx>
        <c:axId val="-208767387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76707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1192142388451498"/>
          <c:y val="4.2818640267543097E-2"/>
          <c:w val="0.38628182414698198"/>
          <c:h val="0.915436704684647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6337</cdr:x>
      <cdr:y>0.83262</cdr:y>
    </cdr:from>
    <cdr:to>
      <cdr:x>0.73789</cdr:x>
      <cdr:y>0.88245</cdr:y>
    </cdr:to>
    <cdr:grpSp>
      <cdr:nvGrpSpPr>
        <cdr:cNvPr id="2" name="Group 1">
          <a:extLst xmlns:a="http://schemas.openxmlformats.org/drawingml/2006/main">
            <a:ext uri="{FF2B5EF4-FFF2-40B4-BE49-F238E27FC236}">
              <a16:creationId xmlns:a16="http://schemas.microsoft.com/office/drawing/2014/main" id="{471451D8-884F-4574-9342-3CD2C88E4AFD}"/>
            </a:ext>
          </a:extLst>
        </cdr:cNvPr>
        <cdr:cNvGrpSpPr/>
      </cdr:nvGrpSpPr>
      <cdr:grpSpPr>
        <a:xfrm xmlns:a="http://schemas.openxmlformats.org/drawingml/2006/main">
          <a:off x="657080" y="5142689"/>
          <a:ext cx="6994065" cy="307776"/>
          <a:chOff x="1799924" y="5086881"/>
          <a:chExt cx="6994002" cy="307777"/>
        </a:xfrm>
      </cdr:grpSpPr>
      <cdr:sp macro="" textlink="">
        <cdr:nvSpPr>
          <cdr:cNvPr id="3" name="TextBox 1">
            <a:extLst xmlns:a="http://schemas.openxmlformats.org/drawingml/2006/main">
              <a:ext uri="{FF2B5EF4-FFF2-40B4-BE49-F238E27FC236}">
                <a16:creationId xmlns:a16="http://schemas.microsoft.com/office/drawing/2014/main" id="{B024B5A5-AB15-4E3C-A423-9632FE7A2DAA}"/>
              </a:ext>
            </a:extLst>
          </cdr:cNvPr>
          <cdr:cNvSpPr txBox="1"/>
        </cdr:nvSpPr>
        <cdr:spPr>
          <a:xfrm xmlns:a="http://schemas.openxmlformats.org/drawingml/2006/main">
            <a:off x="1799924" y="5086881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1</a:t>
            </a:r>
          </a:p>
        </cdr:txBody>
      </cdr:sp>
      <cdr:sp macro="" textlink="">
        <cdr:nvSpPr>
          <cdr:cNvPr id="4" name="TextBox 4">
            <a:extLst xmlns:a="http://schemas.openxmlformats.org/drawingml/2006/main">
              <a:ext uri="{FF2B5EF4-FFF2-40B4-BE49-F238E27FC236}">
                <a16:creationId xmlns:a16="http://schemas.microsoft.com/office/drawing/2014/main" id="{471E26E3-2C5C-4E36-B302-882770ACF8D3}"/>
              </a:ext>
            </a:extLst>
          </cdr:cNvPr>
          <cdr:cNvSpPr txBox="1"/>
        </cdr:nvSpPr>
        <cdr:spPr>
          <a:xfrm xmlns:a="http://schemas.openxmlformats.org/drawingml/2006/main">
            <a:off x="2532415" y="5086881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2</a:t>
            </a:r>
          </a:p>
        </cdr:txBody>
      </cdr:sp>
      <cdr:sp macro="" textlink="">
        <cdr:nvSpPr>
          <cdr:cNvPr id="5" name="TextBox 5">
            <a:extLst xmlns:a="http://schemas.openxmlformats.org/drawingml/2006/main">
              <a:ext uri="{FF2B5EF4-FFF2-40B4-BE49-F238E27FC236}">
                <a16:creationId xmlns:a16="http://schemas.microsoft.com/office/drawing/2014/main" id="{D81FC63B-0A3F-438E-BE7E-BE5D272B4C22}"/>
              </a:ext>
            </a:extLst>
          </cdr:cNvPr>
          <cdr:cNvSpPr txBox="1"/>
        </cdr:nvSpPr>
        <cdr:spPr>
          <a:xfrm xmlns:a="http://schemas.openxmlformats.org/drawingml/2006/main">
            <a:off x="3264906" y="5086881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3</a:t>
            </a:r>
          </a:p>
        </cdr:txBody>
      </cdr:sp>
      <cdr:sp macro="" textlink="">
        <cdr:nvSpPr>
          <cdr:cNvPr id="6" name="TextBox 6">
            <a:extLst xmlns:a="http://schemas.openxmlformats.org/drawingml/2006/main">
              <a:ext uri="{FF2B5EF4-FFF2-40B4-BE49-F238E27FC236}">
                <a16:creationId xmlns:a16="http://schemas.microsoft.com/office/drawing/2014/main" id="{90AC07B0-71EA-4058-8BE3-333AED0C0B2E}"/>
              </a:ext>
            </a:extLst>
          </cdr:cNvPr>
          <cdr:cNvSpPr txBox="1"/>
        </cdr:nvSpPr>
        <cdr:spPr>
          <a:xfrm xmlns:a="http://schemas.openxmlformats.org/drawingml/2006/main">
            <a:off x="3997397" y="5086881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4</a:t>
            </a:r>
          </a:p>
        </cdr:txBody>
      </cdr:sp>
      <cdr:sp macro="" textlink="">
        <cdr:nvSpPr>
          <cdr:cNvPr id="7" name="TextBox 7">
            <a:extLst xmlns:a="http://schemas.openxmlformats.org/drawingml/2006/main">
              <a:ext uri="{FF2B5EF4-FFF2-40B4-BE49-F238E27FC236}">
                <a16:creationId xmlns:a16="http://schemas.microsoft.com/office/drawing/2014/main" id="{DBDACC23-6E7F-4788-990C-9E3CFD593C96}"/>
              </a:ext>
            </a:extLst>
          </cdr:cNvPr>
          <cdr:cNvSpPr txBox="1"/>
        </cdr:nvSpPr>
        <cdr:spPr>
          <a:xfrm xmlns:a="http://schemas.openxmlformats.org/drawingml/2006/main">
            <a:off x="4692650" y="5086881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5</a:t>
            </a:r>
          </a:p>
        </cdr:txBody>
      </cdr:sp>
      <cdr:sp macro="" textlink="">
        <cdr:nvSpPr>
          <cdr:cNvPr id="8" name="TextBox 8">
            <a:extLst xmlns:a="http://schemas.openxmlformats.org/drawingml/2006/main">
              <a:ext uri="{FF2B5EF4-FFF2-40B4-BE49-F238E27FC236}">
                <a16:creationId xmlns:a16="http://schemas.microsoft.com/office/drawing/2014/main" id="{1F0F91DC-25E4-47B6-AB2E-EA0D0AF6F719}"/>
              </a:ext>
            </a:extLst>
          </cdr:cNvPr>
          <cdr:cNvSpPr txBox="1"/>
        </cdr:nvSpPr>
        <cdr:spPr>
          <a:xfrm xmlns:a="http://schemas.openxmlformats.org/drawingml/2006/main">
            <a:off x="5425141" y="5086881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6</a:t>
            </a:r>
          </a:p>
        </cdr:txBody>
      </cdr:sp>
      <cdr:sp macro="" textlink="">
        <cdr:nvSpPr>
          <cdr:cNvPr id="9" name="TextBox 9">
            <a:extLst xmlns:a="http://schemas.openxmlformats.org/drawingml/2006/main">
              <a:ext uri="{FF2B5EF4-FFF2-40B4-BE49-F238E27FC236}">
                <a16:creationId xmlns:a16="http://schemas.microsoft.com/office/drawing/2014/main" id="{8099EACB-DBCE-4119-8FF4-53D14B604085}"/>
              </a:ext>
            </a:extLst>
          </cdr:cNvPr>
          <cdr:cNvSpPr txBox="1"/>
        </cdr:nvSpPr>
        <cdr:spPr>
          <a:xfrm xmlns:a="http://schemas.openxmlformats.org/drawingml/2006/main">
            <a:off x="6120394" y="5086881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7</a:t>
            </a:r>
          </a:p>
        </cdr:txBody>
      </cdr:sp>
      <cdr:sp macro="" textlink="">
        <cdr:nvSpPr>
          <cdr:cNvPr id="10" name="TextBox 10">
            <a:extLst xmlns:a="http://schemas.openxmlformats.org/drawingml/2006/main">
              <a:ext uri="{FF2B5EF4-FFF2-40B4-BE49-F238E27FC236}">
                <a16:creationId xmlns:a16="http://schemas.microsoft.com/office/drawing/2014/main" id="{656AC2C5-3293-4786-993E-03864A71719E}"/>
              </a:ext>
            </a:extLst>
          </cdr:cNvPr>
          <cdr:cNvSpPr txBox="1"/>
        </cdr:nvSpPr>
        <cdr:spPr>
          <a:xfrm xmlns:a="http://schemas.openxmlformats.org/drawingml/2006/main">
            <a:off x="6815647" y="5086881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8</a:t>
            </a:r>
          </a:p>
        </cdr:txBody>
      </cdr:sp>
      <cdr:sp macro="" textlink="">
        <cdr:nvSpPr>
          <cdr:cNvPr id="11" name="TextBox 11">
            <a:extLst xmlns:a="http://schemas.openxmlformats.org/drawingml/2006/main">
              <a:ext uri="{FF2B5EF4-FFF2-40B4-BE49-F238E27FC236}">
                <a16:creationId xmlns:a16="http://schemas.microsoft.com/office/drawing/2014/main" id="{2F214927-7EE6-4F74-A579-8BBDF871A0C9}"/>
              </a:ext>
            </a:extLst>
          </cdr:cNvPr>
          <cdr:cNvSpPr txBox="1"/>
        </cdr:nvSpPr>
        <cdr:spPr>
          <a:xfrm xmlns:a="http://schemas.openxmlformats.org/drawingml/2006/main">
            <a:off x="7548138" y="5086881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9</a:t>
            </a:r>
          </a:p>
        </cdr:txBody>
      </cdr:sp>
      <cdr:sp macro="" textlink="">
        <cdr:nvSpPr>
          <cdr:cNvPr id="12" name="TextBox 12">
            <a:extLst xmlns:a="http://schemas.openxmlformats.org/drawingml/2006/main">
              <a:ext uri="{FF2B5EF4-FFF2-40B4-BE49-F238E27FC236}">
                <a16:creationId xmlns:a16="http://schemas.microsoft.com/office/drawing/2014/main" id="{90802D8C-DEBE-4BD2-B5FB-E398438C8E42}"/>
              </a:ext>
            </a:extLst>
          </cdr:cNvPr>
          <cdr:cNvSpPr txBox="1"/>
        </cdr:nvSpPr>
        <cdr:spPr>
          <a:xfrm xmlns:a="http://schemas.openxmlformats.org/drawingml/2006/main">
            <a:off x="8243391" y="5086881"/>
            <a:ext cx="55053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10</a:t>
            </a:r>
          </a:p>
        </cdr:txBody>
      </cdr:sp>
    </cdr:grp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5859</cdr:x>
      <cdr:y>0.84257</cdr:y>
    </cdr:from>
    <cdr:to>
      <cdr:x>0.68941</cdr:x>
      <cdr:y>0.89144</cdr:y>
    </cdr:to>
    <cdr:grpSp>
      <cdr:nvGrpSpPr>
        <cdr:cNvPr id="4" name="Group 3">
          <a:extLst xmlns:a="http://schemas.openxmlformats.org/drawingml/2006/main">
            <a:ext uri="{FF2B5EF4-FFF2-40B4-BE49-F238E27FC236}">
              <a16:creationId xmlns:a16="http://schemas.microsoft.com/office/drawing/2014/main" id="{C09BCBE6-2C32-4185-A835-49175294313F}"/>
            </a:ext>
          </a:extLst>
        </cdr:cNvPr>
        <cdr:cNvGrpSpPr/>
      </cdr:nvGrpSpPr>
      <cdr:grpSpPr>
        <a:xfrm xmlns:a="http://schemas.openxmlformats.org/drawingml/2006/main">
          <a:off x="592978" y="5305902"/>
          <a:ext cx="6384408" cy="307748"/>
          <a:chOff x="2942750" y="5510044"/>
          <a:chExt cx="6384402" cy="307777"/>
        </a:xfrm>
      </cdr:grpSpPr>
      <cdr:sp macro="" textlink="">
        <cdr:nvSpPr>
          <cdr:cNvPr id="5" name="TextBox 1">
            <a:extLst xmlns:a="http://schemas.openxmlformats.org/drawingml/2006/main">
              <a:ext uri="{FF2B5EF4-FFF2-40B4-BE49-F238E27FC236}">
                <a16:creationId xmlns:a16="http://schemas.microsoft.com/office/drawing/2014/main" id="{817DEA40-A337-453E-898C-E7B0344A100B}"/>
              </a:ext>
            </a:extLst>
          </cdr:cNvPr>
          <cdr:cNvSpPr txBox="1"/>
        </cdr:nvSpPr>
        <cdr:spPr>
          <a:xfrm xmlns:a="http://schemas.openxmlformats.org/drawingml/2006/main">
            <a:off x="2942750" y="5510044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1</a:t>
            </a:r>
          </a:p>
        </cdr:txBody>
      </cdr:sp>
      <cdr:sp macro="" textlink="">
        <cdr:nvSpPr>
          <cdr:cNvPr id="6" name="TextBox 4">
            <a:extLst xmlns:a="http://schemas.openxmlformats.org/drawingml/2006/main">
              <a:ext uri="{FF2B5EF4-FFF2-40B4-BE49-F238E27FC236}">
                <a16:creationId xmlns:a16="http://schemas.microsoft.com/office/drawing/2014/main" id="{CF409BE4-04CD-4860-8942-1CF82C97B20E}"/>
              </a:ext>
            </a:extLst>
          </cdr:cNvPr>
          <cdr:cNvSpPr txBox="1"/>
        </cdr:nvSpPr>
        <cdr:spPr>
          <a:xfrm xmlns:a="http://schemas.openxmlformats.org/drawingml/2006/main">
            <a:off x="3598239" y="5510044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2</a:t>
            </a:r>
          </a:p>
        </cdr:txBody>
      </cdr:sp>
      <cdr:sp macro="" textlink="">
        <cdr:nvSpPr>
          <cdr:cNvPr id="7" name="TextBox 5">
            <a:extLst xmlns:a="http://schemas.openxmlformats.org/drawingml/2006/main">
              <a:ext uri="{FF2B5EF4-FFF2-40B4-BE49-F238E27FC236}">
                <a16:creationId xmlns:a16="http://schemas.microsoft.com/office/drawing/2014/main" id="{D63C264F-5186-4F11-B699-ADBE06951875}"/>
              </a:ext>
            </a:extLst>
          </cdr:cNvPr>
          <cdr:cNvSpPr txBox="1"/>
        </cdr:nvSpPr>
        <cdr:spPr>
          <a:xfrm xmlns:a="http://schemas.openxmlformats.org/drawingml/2006/main">
            <a:off x="4234478" y="5510044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3</a:t>
            </a:r>
          </a:p>
        </cdr:txBody>
      </cdr:sp>
      <cdr:sp macro="" textlink="">
        <cdr:nvSpPr>
          <cdr:cNvPr id="8" name="TextBox 6">
            <a:extLst xmlns:a="http://schemas.openxmlformats.org/drawingml/2006/main">
              <a:ext uri="{FF2B5EF4-FFF2-40B4-BE49-F238E27FC236}">
                <a16:creationId xmlns:a16="http://schemas.microsoft.com/office/drawing/2014/main" id="{5D794494-D14B-487D-9776-B913498BB6E0}"/>
              </a:ext>
            </a:extLst>
          </cdr:cNvPr>
          <cdr:cNvSpPr txBox="1"/>
        </cdr:nvSpPr>
        <cdr:spPr>
          <a:xfrm xmlns:a="http://schemas.openxmlformats.org/drawingml/2006/main">
            <a:off x="4911623" y="5510044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4</a:t>
            </a:r>
          </a:p>
        </cdr:txBody>
      </cdr:sp>
      <cdr:sp macro="" textlink="">
        <cdr:nvSpPr>
          <cdr:cNvPr id="9" name="TextBox 7">
            <a:extLst xmlns:a="http://schemas.openxmlformats.org/drawingml/2006/main">
              <a:ext uri="{FF2B5EF4-FFF2-40B4-BE49-F238E27FC236}">
                <a16:creationId xmlns:a16="http://schemas.microsoft.com/office/drawing/2014/main" id="{607BB078-4C53-43C3-AC4D-D68ECEA027A3}"/>
              </a:ext>
            </a:extLst>
          </cdr:cNvPr>
          <cdr:cNvSpPr txBox="1"/>
        </cdr:nvSpPr>
        <cdr:spPr>
          <a:xfrm xmlns:a="http://schemas.openxmlformats.org/drawingml/2006/main">
            <a:off x="5544963" y="5510044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5</a:t>
            </a:r>
          </a:p>
        </cdr:txBody>
      </cdr:sp>
      <cdr:sp macro="" textlink="">
        <cdr:nvSpPr>
          <cdr:cNvPr id="10" name="TextBox 8">
            <a:extLst xmlns:a="http://schemas.openxmlformats.org/drawingml/2006/main">
              <a:ext uri="{FF2B5EF4-FFF2-40B4-BE49-F238E27FC236}">
                <a16:creationId xmlns:a16="http://schemas.microsoft.com/office/drawing/2014/main" id="{4B191F4B-4EB4-40AF-9F4F-67D6A286C060}"/>
              </a:ext>
            </a:extLst>
          </cdr:cNvPr>
          <cdr:cNvSpPr txBox="1"/>
        </cdr:nvSpPr>
        <cdr:spPr>
          <a:xfrm xmlns:a="http://schemas.openxmlformats.org/drawingml/2006/main">
            <a:off x="6191729" y="5510044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6</a:t>
            </a:r>
          </a:p>
        </cdr:txBody>
      </cdr:sp>
      <cdr:sp macro="" textlink="">
        <cdr:nvSpPr>
          <cdr:cNvPr id="11" name="TextBox 9">
            <a:extLst xmlns:a="http://schemas.openxmlformats.org/drawingml/2006/main">
              <a:ext uri="{FF2B5EF4-FFF2-40B4-BE49-F238E27FC236}">
                <a16:creationId xmlns:a16="http://schemas.microsoft.com/office/drawing/2014/main" id="{9CC340C1-1641-43E2-BB66-4C5A92423CD5}"/>
              </a:ext>
            </a:extLst>
          </cdr:cNvPr>
          <cdr:cNvSpPr txBox="1"/>
        </cdr:nvSpPr>
        <cdr:spPr>
          <a:xfrm xmlns:a="http://schemas.openxmlformats.org/drawingml/2006/main">
            <a:off x="6834595" y="5510044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7</a:t>
            </a:r>
          </a:p>
        </cdr:txBody>
      </cdr:sp>
      <cdr:sp macro="" textlink="">
        <cdr:nvSpPr>
          <cdr:cNvPr id="12" name="TextBox 10">
            <a:extLst xmlns:a="http://schemas.openxmlformats.org/drawingml/2006/main">
              <a:ext uri="{FF2B5EF4-FFF2-40B4-BE49-F238E27FC236}">
                <a16:creationId xmlns:a16="http://schemas.microsoft.com/office/drawing/2014/main" id="{CB9F73DF-15FF-49D4-9099-0EABADAB9B54}"/>
              </a:ext>
            </a:extLst>
          </cdr:cNvPr>
          <cdr:cNvSpPr txBox="1"/>
        </cdr:nvSpPr>
        <cdr:spPr>
          <a:xfrm xmlns:a="http://schemas.openxmlformats.org/drawingml/2006/main">
            <a:off x="7471090" y="5510044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8</a:t>
            </a:r>
          </a:p>
        </cdr:txBody>
      </cdr:sp>
      <cdr:sp macro="" textlink="">
        <cdr:nvSpPr>
          <cdr:cNvPr id="13" name="TextBox 11">
            <a:extLst xmlns:a="http://schemas.openxmlformats.org/drawingml/2006/main">
              <a:ext uri="{FF2B5EF4-FFF2-40B4-BE49-F238E27FC236}">
                <a16:creationId xmlns:a16="http://schemas.microsoft.com/office/drawing/2014/main" id="{3AA3031D-22E9-4BB6-9D6B-1432A5BFD232}"/>
              </a:ext>
            </a:extLst>
          </cdr:cNvPr>
          <cdr:cNvSpPr txBox="1"/>
        </cdr:nvSpPr>
        <cdr:spPr>
          <a:xfrm xmlns:a="http://schemas.openxmlformats.org/drawingml/2006/main">
            <a:off x="8143276" y="5510044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9</a:t>
            </a:r>
          </a:p>
        </cdr:txBody>
      </cdr:sp>
      <cdr:sp macro="" textlink="">
        <cdr:nvSpPr>
          <cdr:cNvPr id="14" name="TextBox 12">
            <a:extLst xmlns:a="http://schemas.openxmlformats.org/drawingml/2006/main">
              <a:ext uri="{FF2B5EF4-FFF2-40B4-BE49-F238E27FC236}">
                <a16:creationId xmlns:a16="http://schemas.microsoft.com/office/drawing/2014/main" id="{6D605426-9DFA-42F9-A318-055DEA5E9D25}"/>
              </a:ext>
            </a:extLst>
          </cdr:cNvPr>
          <cdr:cNvSpPr txBox="1"/>
        </cdr:nvSpPr>
        <cdr:spPr>
          <a:xfrm xmlns:a="http://schemas.openxmlformats.org/drawingml/2006/main">
            <a:off x="8776617" y="5510044"/>
            <a:ext cx="55053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10</a:t>
            </a:r>
          </a:p>
        </cdr:txBody>
      </cdr:sp>
    </cdr:grp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4332</cdr:x>
      <cdr:y>0.80922</cdr:y>
    </cdr:from>
    <cdr:to>
      <cdr:x>0.59393</cdr:x>
      <cdr:y>0.8532</cdr:y>
    </cdr:to>
    <cdr:grpSp>
      <cdr:nvGrpSpPr>
        <cdr:cNvPr id="4" name="Group 3">
          <a:extLst xmlns:a="http://schemas.openxmlformats.org/drawingml/2006/main">
            <a:ext uri="{FF2B5EF4-FFF2-40B4-BE49-F238E27FC236}">
              <a16:creationId xmlns:a16="http://schemas.microsoft.com/office/drawing/2014/main" id="{D5A5E8E7-CF2E-416B-A5F8-56519ED90747}"/>
            </a:ext>
          </a:extLst>
        </cdr:cNvPr>
        <cdr:cNvGrpSpPr/>
      </cdr:nvGrpSpPr>
      <cdr:grpSpPr>
        <a:xfrm xmlns:a="http://schemas.openxmlformats.org/drawingml/2006/main">
          <a:off x="528157" y="5662358"/>
          <a:ext cx="6713038" cy="307741"/>
          <a:chOff x="4981951" y="6506726"/>
          <a:chExt cx="6713014" cy="307777"/>
        </a:xfrm>
      </cdr:grpSpPr>
      <cdr:sp macro="" textlink="">
        <cdr:nvSpPr>
          <cdr:cNvPr id="5" name="TextBox 1">
            <a:extLst xmlns:a="http://schemas.openxmlformats.org/drawingml/2006/main">
              <a:ext uri="{FF2B5EF4-FFF2-40B4-BE49-F238E27FC236}">
                <a16:creationId xmlns:a16="http://schemas.microsoft.com/office/drawing/2014/main" id="{6F8EAE64-BB27-4BB5-A3B3-D502C542AB5A}"/>
              </a:ext>
            </a:extLst>
          </cdr:cNvPr>
          <cdr:cNvSpPr txBox="1"/>
        </cdr:nvSpPr>
        <cdr:spPr>
          <a:xfrm xmlns:a="http://schemas.openxmlformats.org/drawingml/2006/main">
            <a:off x="4981951" y="6506726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1</a:t>
            </a:r>
          </a:p>
        </cdr:txBody>
      </cdr:sp>
      <cdr:sp macro="" textlink="">
        <cdr:nvSpPr>
          <cdr:cNvPr id="6" name="TextBox 4">
            <a:extLst xmlns:a="http://schemas.openxmlformats.org/drawingml/2006/main">
              <a:ext uri="{FF2B5EF4-FFF2-40B4-BE49-F238E27FC236}">
                <a16:creationId xmlns:a16="http://schemas.microsoft.com/office/drawing/2014/main" id="{9D8F6FBF-3E71-4F2F-9FBE-47BAD7234EA8}"/>
              </a:ext>
            </a:extLst>
          </cdr:cNvPr>
          <cdr:cNvSpPr txBox="1"/>
        </cdr:nvSpPr>
        <cdr:spPr>
          <a:xfrm xmlns:a="http://schemas.openxmlformats.org/drawingml/2006/main">
            <a:off x="5637440" y="6506726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2</a:t>
            </a:r>
          </a:p>
        </cdr:txBody>
      </cdr:sp>
      <cdr:sp macro="" textlink="">
        <cdr:nvSpPr>
          <cdr:cNvPr id="7" name="TextBox 5">
            <a:extLst xmlns:a="http://schemas.openxmlformats.org/drawingml/2006/main">
              <a:ext uri="{FF2B5EF4-FFF2-40B4-BE49-F238E27FC236}">
                <a16:creationId xmlns:a16="http://schemas.microsoft.com/office/drawing/2014/main" id="{09B6F75D-FD84-46CA-ADD6-2395A328110C}"/>
              </a:ext>
            </a:extLst>
          </cdr:cNvPr>
          <cdr:cNvSpPr txBox="1"/>
        </cdr:nvSpPr>
        <cdr:spPr>
          <a:xfrm xmlns:a="http://schemas.openxmlformats.org/drawingml/2006/main">
            <a:off x="6349879" y="6506726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3</a:t>
            </a:r>
          </a:p>
        </cdr:txBody>
      </cdr:sp>
      <cdr:sp macro="" textlink="">
        <cdr:nvSpPr>
          <cdr:cNvPr id="8" name="TextBox 6">
            <a:extLst xmlns:a="http://schemas.openxmlformats.org/drawingml/2006/main">
              <a:ext uri="{FF2B5EF4-FFF2-40B4-BE49-F238E27FC236}">
                <a16:creationId xmlns:a16="http://schemas.microsoft.com/office/drawing/2014/main" id="{F8276CD4-441A-4D06-9905-9D1E8A945703}"/>
              </a:ext>
            </a:extLst>
          </cdr:cNvPr>
          <cdr:cNvSpPr txBox="1"/>
        </cdr:nvSpPr>
        <cdr:spPr>
          <a:xfrm xmlns:a="http://schemas.openxmlformats.org/drawingml/2006/main">
            <a:off x="7060361" y="6506726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4</a:t>
            </a:r>
          </a:p>
        </cdr:txBody>
      </cdr:sp>
      <cdr:sp macro="" textlink="">
        <cdr:nvSpPr>
          <cdr:cNvPr id="9" name="TextBox 7">
            <a:extLst xmlns:a="http://schemas.openxmlformats.org/drawingml/2006/main">
              <a:ext uri="{FF2B5EF4-FFF2-40B4-BE49-F238E27FC236}">
                <a16:creationId xmlns:a16="http://schemas.microsoft.com/office/drawing/2014/main" id="{3A299CB9-A2DF-43DA-9160-25DD65E2F3B5}"/>
              </a:ext>
            </a:extLst>
          </cdr:cNvPr>
          <cdr:cNvSpPr txBox="1"/>
        </cdr:nvSpPr>
        <cdr:spPr>
          <a:xfrm xmlns:a="http://schemas.openxmlformats.org/drawingml/2006/main">
            <a:off x="7717514" y="6506726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5</a:t>
            </a:r>
          </a:p>
        </cdr:txBody>
      </cdr:sp>
      <cdr:sp macro="" textlink="">
        <cdr:nvSpPr>
          <cdr:cNvPr id="10" name="TextBox 8">
            <a:extLst xmlns:a="http://schemas.openxmlformats.org/drawingml/2006/main">
              <a:ext uri="{FF2B5EF4-FFF2-40B4-BE49-F238E27FC236}">
                <a16:creationId xmlns:a16="http://schemas.microsoft.com/office/drawing/2014/main" id="{1EAD1067-234A-4E14-9E64-798CACB295B3}"/>
              </a:ext>
            </a:extLst>
          </cdr:cNvPr>
          <cdr:cNvSpPr txBox="1"/>
        </cdr:nvSpPr>
        <cdr:spPr>
          <a:xfrm xmlns:a="http://schemas.openxmlformats.org/drawingml/2006/main">
            <a:off x="8440480" y="6506726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6</a:t>
            </a:r>
          </a:p>
        </cdr:txBody>
      </cdr:sp>
      <cdr:sp macro="" textlink="">
        <cdr:nvSpPr>
          <cdr:cNvPr id="11" name="TextBox 9">
            <a:extLst xmlns:a="http://schemas.openxmlformats.org/drawingml/2006/main">
              <a:ext uri="{FF2B5EF4-FFF2-40B4-BE49-F238E27FC236}">
                <a16:creationId xmlns:a16="http://schemas.microsoft.com/office/drawing/2014/main" id="{49EAC58F-D000-42FE-9E95-177449B11076}"/>
              </a:ext>
            </a:extLst>
          </cdr:cNvPr>
          <cdr:cNvSpPr txBox="1"/>
        </cdr:nvSpPr>
        <cdr:spPr>
          <a:xfrm xmlns:a="http://schemas.openxmlformats.org/drawingml/2006/main">
            <a:off x="9092871" y="6506726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7</a:t>
            </a:r>
          </a:p>
        </cdr:txBody>
      </cdr:sp>
      <cdr:sp macro="" textlink="">
        <cdr:nvSpPr>
          <cdr:cNvPr id="12" name="TextBox 10">
            <a:extLst xmlns:a="http://schemas.openxmlformats.org/drawingml/2006/main">
              <a:ext uri="{FF2B5EF4-FFF2-40B4-BE49-F238E27FC236}">
                <a16:creationId xmlns:a16="http://schemas.microsoft.com/office/drawing/2014/main" id="{4221446A-B718-409E-84A7-D4AF1D1B0221}"/>
              </a:ext>
            </a:extLst>
          </cdr:cNvPr>
          <cdr:cNvSpPr txBox="1"/>
        </cdr:nvSpPr>
        <cdr:spPr>
          <a:xfrm xmlns:a="http://schemas.openxmlformats.org/drawingml/2006/main">
            <a:off x="9786516" y="6506726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8</a:t>
            </a:r>
          </a:p>
        </cdr:txBody>
      </cdr:sp>
      <cdr:sp macro="" textlink="">
        <cdr:nvSpPr>
          <cdr:cNvPr id="13" name="TextBox 11">
            <a:extLst xmlns:a="http://schemas.openxmlformats.org/drawingml/2006/main">
              <a:ext uri="{FF2B5EF4-FFF2-40B4-BE49-F238E27FC236}">
                <a16:creationId xmlns:a16="http://schemas.microsoft.com/office/drawing/2014/main" id="{B87A698B-E9FF-4F2B-A278-ED9D6F80AFA7}"/>
              </a:ext>
            </a:extLst>
          </cdr:cNvPr>
          <cdr:cNvSpPr txBox="1"/>
        </cdr:nvSpPr>
        <cdr:spPr>
          <a:xfrm xmlns:a="http://schemas.openxmlformats.org/drawingml/2006/main">
            <a:off x="10463465" y="6506726"/>
            <a:ext cx="45916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9</a:t>
            </a:r>
          </a:p>
        </cdr:txBody>
      </cdr:sp>
      <cdr:sp macro="" textlink="">
        <cdr:nvSpPr>
          <cdr:cNvPr id="14" name="TextBox 12">
            <a:extLst xmlns:a="http://schemas.openxmlformats.org/drawingml/2006/main">
              <a:ext uri="{FF2B5EF4-FFF2-40B4-BE49-F238E27FC236}">
                <a16:creationId xmlns:a16="http://schemas.microsoft.com/office/drawing/2014/main" id="{082CE3EF-62EB-44C2-BD2D-19011FFE5654}"/>
              </a:ext>
            </a:extLst>
          </cdr:cNvPr>
          <cdr:cNvSpPr txBox="1"/>
        </cdr:nvSpPr>
        <cdr:spPr>
          <a:xfrm xmlns:a="http://schemas.openxmlformats.org/drawingml/2006/main">
            <a:off x="11144430" y="6506726"/>
            <a:ext cx="550535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pt-PT" sz="1400" dirty="0">
                <a:solidFill>
                  <a:schemeClr val="bg1">
                    <a:lumMod val="50000"/>
                  </a:schemeClr>
                </a:solidFill>
              </a:rPr>
              <a:t>SV10</a:t>
            </a:r>
          </a:p>
        </cdr:txBody>
      </cdr:sp>
    </cdr:grpSp>
  </cdr:relSizeAnchor>
  <cdr:relSizeAnchor xmlns:cdr="http://schemas.openxmlformats.org/drawingml/2006/chartDrawing">
    <cdr:from>
      <cdr:x>8.2021E-8</cdr:x>
      <cdr:y>0.17395</cdr:y>
    </cdr:from>
    <cdr:to>
      <cdr:x>0.02272</cdr:x>
      <cdr:y>0.56822</cdr:y>
    </cdr:to>
    <cdr:sp macro="" textlink="">
      <cdr:nvSpPr>
        <cdr:cNvPr id="15" name="CaixaDeTexto 14">
          <a:extLst xmlns:a="http://schemas.openxmlformats.org/drawingml/2006/main">
            <a:ext uri="{FF2B5EF4-FFF2-40B4-BE49-F238E27FC236}">
              <a16:creationId xmlns:a16="http://schemas.microsoft.com/office/drawing/2014/main" id="{5D1D2043-DD59-4E77-8AC5-0956584A661C}"/>
            </a:ext>
          </a:extLst>
        </cdr:cNvPr>
        <cdr:cNvSpPr txBox="1"/>
      </cdr:nvSpPr>
      <cdr:spPr>
        <a:xfrm xmlns:a="http://schemas.openxmlformats.org/drawingml/2006/main" rot="16200000">
          <a:off x="-1240934" y="2458098"/>
          <a:ext cx="2758869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pt-PT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200" dirty="0"/>
            <a:t>Relative abundance (%)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FE34AD9-86F4-4BDF-BA35-29051B71DF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D2286C7-5EDB-4A6F-B3C7-0F590931B3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0D898844-BC86-4DD6-968C-C7B4F98FC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F289EE90-3A6D-4FF3-BA05-F78570BA0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7291F854-F28D-4AFA-9390-B9DC1C8B8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1907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945A244-3479-4879-BC0E-88B836D176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ACC5C7BF-9F51-4F02-8111-1C641BC749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BF60D1A5-6716-47F2-B3F4-FEEB00781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3468F232-2705-4E8E-B5F2-573D4AA7D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A7193A63-12DC-441D-B96B-D426CCAC4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86840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DEE70D3-67AA-4F57-AF01-9FA4D79B80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62DF277A-BCE2-441E-A2D6-546181BC22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986C0AA6-5D00-4682-9941-41543E385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58A46A94-CCE5-48D6-8D25-57F35285C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6CC523D3-084A-4497-AD88-0A16E2301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516177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31674B3-E1B3-49D1-911C-5CD090E687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B0C29A70-F6A6-4649-A28F-5D045D3D08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96C75AA6-C7C9-4E32-87C0-9B2D07D99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15DCF0FD-0CE0-4A64-919D-5DCFDAA9B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6787473-A1ED-4BF7-B06D-6FB25770E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995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FBD42A-C931-449F-A8EB-25D5CDF814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2A6D8439-4F57-4816-A769-286E62FDA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79E4BB22-19A8-48BB-9A4A-2F55ED2FB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2842790F-2AB8-4B57-A84E-F998C0340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1C8BF10-CDD6-4C25-B384-202C008C1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55277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03BA9B0-8358-4A02-9CA4-03EE58E54E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769B386F-711A-4042-81ED-D06C218C29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FCFDC524-1AEB-4A21-9A21-8308023E4F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7C3F331C-321E-48CA-BB76-A50529111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A803C75A-5501-4179-8A3A-F85DF4487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F6630738-BA31-4086-809C-B1A06E59A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25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F2385D3-D0A7-4F91-96DF-5E510F842A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76B81BDF-191B-4A5F-B9AE-0EA1DB410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998A189C-6305-443A-9B50-1593994F68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4307DA94-79ED-4B02-A151-EA3D6ACEA5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88F1EBC6-E2A9-4D8C-BBD5-38C3EAB38E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E52CDDEC-5BE5-431C-98C0-4DB1FA350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7D895CFE-8C5A-4103-AD2F-C62098475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F34D2EBC-22C5-4D95-B041-86D4CE225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62857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85167BE-20A4-492F-8EB0-2B5FC7E31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A0BE9BDE-0CE4-464C-94AB-DBF3383AC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D01C06DB-0CDC-47BC-B27D-659995394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745636DE-A0D3-49D8-A86F-B34AB39CA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77192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054372EE-7DE1-4941-9C14-B44E9EC46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72EA14E0-F5A0-4642-AA02-710EE293D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55FF32AB-EBE1-4631-B90C-8D80EA307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17255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1FF1D8-8A69-4681-A5BC-1B2DBE5EA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E1FFB355-0522-4604-B42C-8BB2A58ED7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CF73A014-82D1-4E7D-8FC9-C87A737544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EDA0BB98-FEDA-49FF-AB77-8F5A54ACD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9F24D740-6EBA-4ECC-84D7-08DDE80E4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66D68353-1704-4450-BCC1-4110E2925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70790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2401CD7-27B3-4CA3-B5A5-35846F5C22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E38E036F-060A-4510-8AE6-3B29E1F275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86F8F16F-AF3C-4371-BE8A-22823A4370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FE37E8B6-1E90-4280-807A-06DA3E061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FE99A417-DC34-40D7-AC08-2342EE266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FDC38AD5-2829-4C31-AFF4-DABBEAB95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22455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AD2E377C-0FB6-44A8-A88F-D192A9772E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A8DB050C-9C1C-4095-B5E8-94EBF90FFB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CD17255F-5607-4506-97F3-256E0E9485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23B52-1BEA-457D-88B7-AA88EAA094C2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FB8068D8-C5CD-43D2-916F-BCC1D03538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7F6797D3-3677-48B2-AB2C-5E6CF797B8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C8C69-C2A1-4737-988E-0029F567899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58165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61451C4E-C5C0-456B-9AAE-EB10B763E0C0}"/>
              </a:ext>
            </a:extLst>
          </p:cNvPr>
          <p:cNvSpPr txBox="1"/>
          <p:nvPr/>
        </p:nvSpPr>
        <p:spPr>
          <a:xfrm>
            <a:off x="145904" y="6125383"/>
            <a:ext cx="119001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b="1" dirty="0" err="1"/>
              <a:t>Supplementary</a:t>
            </a:r>
            <a:r>
              <a:rPr lang="pt-PT" b="1" dirty="0"/>
              <a:t> Figure S2 (a). </a:t>
            </a:r>
            <a:r>
              <a:rPr lang="en-GB" dirty="0"/>
              <a:t>Relative abundances of bacterial 16S rRNA genes at (a)phylum, (b) class, (c) order (d) family, (e) genus taxonomic ranks.</a:t>
            </a:r>
            <a:endParaRPr lang="pt-PT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400A958-933D-4955-8FED-8F1912F5C1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3723" y="-1628"/>
            <a:ext cx="9565453" cy="61270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83110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B85087AF-B3C1-48B4-A156-E6BB77B726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5872569"/>
              </p:ext>
            </p:extLst>
          </p:nvPr>
        </p:nvGraphicFramePr>
        <p:xfrm>
          <a:off x="979640" y="181858"/>
          <a:ext cx="10368951" cy="61765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92F2942-0E7F-4BB1-A52A-068C712CDE44}"/>
              </a:ext>
            </a:extLst>
          </p:cNvPr>
          <p:cNvSpPr txBox="1"/>
          <p:nvPr/>
        </p:nvSpPr>
        <p:spPr>
          <a:xfrm>
            <a:off x="291809" y="6426926"/>
            <a:ext cx="9880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b="1" dirty="0" err="1"/>
              <a:t>Supplementary</a:t>
            </a:r>
            <a:r>
              <a:rPr lang="pt-PT" b="1" dirty="0"/>
              <a:t> Figure S2(b). </a:t>
            </a:r>
            <a:r>
              <a:rPr lang="pt-PT" b="1" dirty="0" err="1"/>
              <a:t>Relative</a:t>
            </a:r>
            <a:r>
              <a:rPr lang="pt-PT" b="1" dirty="0"/>
              <a:t> </a:t>
            </a:r>
            <a:r>
              <a:rPr lang="pt-PT" b="1" dirty="0" err="1"/>
              <a:t>abundance</a:t>
            </a:r>
            <a:r>
              <a:rPr lang="pt-PT" b="1" dirty="0"/>
              <a:t> </a:t>
            </a:r>
            <a:r>
              <a:rPr lang="pt-PT" b="1" dirty="0" err="1"/>
              <a:t>of</a:t>
            </a:r>
            <a:r>
              <a:rPr lang="pt-PT" b="1" dirty="0"/>
              <a:t> bacterial 16S rRNA genes </a:t>
            </a:r>
            <a:r>
              <a:rPr lang="pt-PT" b="1" dirty="0" err="1"/>
              <a:t>at</a:t>
            </a:r>
            <a:r>
              <a:rPr lang="pt-PT" b="1" dirty="0"/>
              <a:t> </a:t>
            </a:r>
            <a:r>
              <a:rPr lang="pt-PT" b="1" dirty="0" err="1"/>
              <a:t>class</a:t>
            </a:r>
            <a:r>
              <a:rPr lang="pt-PT" b="1" dirty="0"/>
              <a:t> </a:t>
            </a:r>
            <a:r>
              <a:rPr lang="pt-PT" b="1" dirty="0" err="1"/>
              <a:t>taxonomic</a:t>
            </a:r>
            <a:r>
              <a:rPr lang="pt-PT" b="1" dirty="0"/>
              <a:t> </a:t>
            </a:r>
            <a:r>
              <a:rPr lang="pt-PT" b="1" dirty="0" err="1"/>
              <a:t>rank</a:t>
            </a:r>
            <a:r>
              <a:rPr lang="pt-PT" b="1" dirty="0"/>
              <a:t>. </a:t>
            </a:r>
            <a:endParaRPr lang="pt-PT" dirty="0"/>
          </a:p>
        </p:txBody>
      </p:sp>
      <p:sp>
        <p:nvSpPr>
          <p:cNvPr id="5" name="CaixaDeTexto 4">
            <a:extLst>
              <a:ext uri="{FF2B5EF4-FFF2-40B4-BE49-F238E27FC236}">
                <a16:creationId xmlns:a16="http://schemas.microsoft.com/office/drawing/2014/main" id="{94BD1583-E9E3-45D3-B4B8-C9FC94F3CAA4}"/>
              </a:ext>
            </a:extLst>
          </p:cNvPr>
          <p:cNvSpPr txBox="1"/>
          <p:nvPr/>
        </p:nvSpPr>
        <p:spPr>
          <a:xfrm rot="16200000">
            <a:off x="-307910" y="2332653"/>
            <a:ext cx="2758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elative abundance (%)</a:t>
            </a:r>
          </a:p>
        </p:txBody>
      </p:sp>
    </p:spTree>
    <p:extLst>
      <p:ext uri="{BB962C8B-B14F-4D97-AF65-F5344CB8AC3E}">
        <p14:creationId xmlns:p14="http://schemas.microsoft.com/office/powerpoint/2010/main" val="31523253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áfico 4">
            <a:extLst>
              <a:ext uri="{FF2B5EF4-FFF2-40B4-BE49-F238E27FC236}">
                <a16:creationId xmlns:a16="http://schemas.microsoft.com/office/drawing/2014/main" id="{D87A06A4-DCB9-4181-87BA-AE3B2BAB42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9392466"/>
              </p:ext>
            </p:extLst>
          </p:nvPr>
        </p:nvGraphicFramePr>
        <p:xfrm>
          <a:off x="440742" y="129643"/>
          <a:ext cx="10120807" cy="62972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9F1B8F8-C5B0-4B54-B76E-BC5668630CC9}"/>
              </a:ext>
            </a:extLst>
          </p:cNvPr>
          <p:cNvSpPr txBox="1"/>
          <p:nvPr/>
        </p:nvSpPr>
        <p:spPr>
          <a:xfrm>
            <a:off x="291809" y="6426926"/>
            <a:ext cx="9927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b="1" dirty="0" err="1"/>
              <a:t>Supplementary</a:t>
            </a:r>
            <a:r>
              <a:rPr lang="pt-PT" b="1" dirty="0"/>
              <a:t> Figure S2(c). </a:t>
            </a:r>
            <a:r>
              <a:rPr lang="pt-PT" b="1" dirty="0" err="1"/>
              <a:t>Relative</a:t>
            </a:r>
            <a:r>
              <a:rPr lang="pt-PT" b="1" dirty="0"/>
              <a:t> </a:t>
            </a:r>
            <a:r>
              <a:rPr lang="pt-PT" b="1" dirty="0" err="1"/>
              <a:t>abundance</a:t>
            </a:r>
            <a:r>
              <a:rPr lang="pt-PT" b="1" dirty="0"/>
              <a:t> </a:t>
            </a:r>
            <a:r>
              <a:rPr lang="pt-PT" b="1" dirty="0" err="1"/>
              <a:t>of</a:t>
            </a:r>
            <a:r>
              <a:rPr lang="pt-PT" b="1" dirty="0"/>
              <a:t> bacterial 16S rRNA genes </a:t>
            </a:r>
            <a:r>
              <a:rPr lang="pt-PT" b="1" dirty="0" err="1"/>
              <a:t>at</a:t>
            </a:r>
            <a:r>
              <a:rPr lang="pt-PT" b="1" dirty="0"/>
              <a:t> </a:t>
            </a:r>
            <a:r>
              <a:rPr lang="pt-PT" b="1" dirty="0" err="1"/>
              <a:t>order</a:t>
            </a:r>
            <a:r>
              <a:rPr lang="pt-PT" b="1" dirty="0"/>
              <a:t> </a:t>
            </a:r>
            <a:r>
              <a:rPr lang="pt-PT" b="1" dirty="0" err="1"/>
              <a:t>taxonomic</a:t>
            </a:r>
            <a:r>
              <a:rPr lang="pt-PT" b="1" dirty="0"/>
              <a:t> </a:t>
            </a:r>
            <a:r>
              <a:rPr lang="pt-PT" b="1" dirty="0" err="1"/>
              <a:t>rank</a:t>
            </a:r>
            <a:r>
              <a:rPr lang="pt-PT" b="1" dirty="0"/>
              <a:t>. </a:t>
            </a:r>
            <a:endParaRPr lang="pt-PT" dirty="0"/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3FAC482B-AE66-4648-8BDE-D858BCA0DB86}"/>
              </a:ext>
            </a:extLst>
          </p:cNvPr>
          <p:cNvSpPr txBox="1"/>
          <p:nvPr/>
        </p:nvSpPr>
        <p:spPr>
          <a:xfrm rot="16200000">
            <a:off x="-867747" y="2276669"/>
            <a:ext cx="2758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elative abundance (%)</a:t>
            </a:r>
          </a:p>
        </p:txBody>
      </p:sp>
    </p:spTree>
    <p:extLst>
      <p:ext uri="{BB962C8B-B14F-4D97-AF65-F5344CB8AC3E}">
        <p14:creationId xmlns:p14="http://schemas.microsoft.com/office/powerpoint/2010/main" val="18715637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áfico 4">
            <a:extLst>
              <a:ext uri="{FF2B5EF4-FFF2-40B4-BE49-F238E27FC236}">
                <a16:creationId xmlns:a16="http://schemas.microsoft.com/office/drawing/2014/main" id="{F3F4D467-2DAB-4805-B013-9DA3303DE3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2755203"/>
              </p:ext>
            </p:extLst>
          </p:nvPr>
        </p:nvGraphicFramePr>
        <p:xfrm>
          <a:off x="264544" y="155277"/>
          <a:ext cx="11662912" cy="59451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5" name="Group 14">
            <a:extLst>
              <a:ext uri="{FF2B5EF4-FFF2-40B4-BE49-F238E27FC236}">
                <a16:creationId xmlns:a16="http://schemas.microsoft.com/office/drawing/2014/main" id="{D5A5E8E7-CF2E-416B-A5F8-56519ED90747}"/>
              </a:ext>
            </a:extLst>
          </p:cNvPr>
          <p:cNvGrpSpPr/>
          <p:nvPr/>
        </p:nvGrpSpPr>
        <p:grpSpPr>
          <a:xfrm>
            <a:off x="964509" y="4973284"/>
            <a:ext cx="6384402" cy="307777"/>
            <a:chOff x="2942750" y="5510044"/>
            <a:chExt cx="6384402" cy="307777"/>
          </a:xfrm>
        </p:grpSpPr>
        <p:sp>
          <p:nvSpPr>
            <p:cNvPr id="16" name="TextBox 1">
              <a:extLst>
                <a:ext uri="{FF2B5EF4-FFF2-40B4-BE49-F238E27FC236}">
                  <a16:creationId xmlns:a16="http://schemas.microsoft.com/office/drawing/2014/main" id="{6F8EAE64-BB27-4BB5-A3B3-D502C542AB5A}"/>
                </a:ext>
              </a:extLst>
            </p:cNvPr>
            <p:cNvSpPr txBox="1"/>
            <p:nvPr/>
          </p:nvSpPr>
          <p:spPr>
            <a:xfrm>
              <a:off x="2942750" y="5510044"/>
              <a:ext cx="459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1</a:t>
              </a:r>
            </a:p>
          </p:txBody>
        </p:sp>
        <p:sp>
          <p:nvSpPr>
            <p:cNvPr id="17" name="TextBox 4">
              <a:extLst>
                <a:ext uri="{FF2B5EF4-FFF2-40B4-BE49-F238E27FC236}">
                  <a16:creationId xmlns:a16="http://schemas.microsoft.com/office/drawing/2014/main" id="{9D8F6FBF-3E71-4F2F-9FBE-47BAD7234EA8}"/>
                </a:ext>
              </a:extLst>
            </p:cNvPr>
            <p:cNvSpPr txBox="1"/>
            <p:nvPr/>
          </p:nvSpPr>
          <p:spPr>
            <a:xfrm>
              <a:off x="3598239" y="5510044"/>
              <a:ext cx="459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2</a:t>
              </a:r>
            </a:p>
          </p:txBody>
        </p:sp>
        <p:sp>
          <p:nvSpPr>
            <p:cNvPr id="18" name="TextBox 5">
              <a:extLst>
                <a:ext uri="{FF2B5EF4-FFF2-40B4-BE49-F238E27FC236}">
                  <a16:creationId xmlns:a16="http://schemas.microsoft.com/office/drawing/2014/main" id="{09B6F75D-FD84-46CA-ADD6-2395A328110C}"/>
                </a:ext>
              </a:extLst>
            </p:cNvPr>
            <p:cNvSpPr txBox="1"/>
            <p:nvPr/>
          </p:nvSpPr>
          <p:spPr>
            <a:xfrm>
              <a:off x="4234478" y="5510044"/>
              <a:ext cx="459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3</a:t>
              </a:r>
            </a:p>
          </p:txBody>
        </p:sp>
        <p:sp>
          <p:nvSpPr>
            <p:cNvPr id="19" name="TextBox 6">
              <a:extLst>
                <a:ext uri="{FF2B5EF4-FFF2-40B4-BE49-F238E27FC236}">
                  <a16:creationId xmlns:a16="http://schemas.microsoft.com/office/drawing/2014/main" id="{F8276CD4-441A-4D06-9905-9D1E8A945703}"/>
                </a:ext>
              </a:extLst>
            </p:cNvPr>
            <p:cNvSpPr txBox="1"/>
            <p:nvPr/>
          </p:nvSpPr>
          <p:spPr>
            <a:xfrm>
              <a:off x="4911623" y="5510044"/>
              <a:ext cx="459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4</a:t>
              </a:r>
            </a:p>
          </p:txBody>
        </p:sp>
        <p:sp>
          <p:nvSpPr>
            <p:cNvPr id="20" name="TextBox 7">
              <a:extLst>
                <a:ext uri="{FF2B5EF4-FFF2-40B4-BE49-F238E27FC236}">
                  <a16:creationId xmlns:a16="http://schemas.microsoft.com/office/drawing/2014/main" id="{3A299CB9-A2DF-43DA-9160-25DD65E2F3B5}"/>
                </a:ext>
              </a:extLst>
            </p:cNvPr>
            <p:cNvSpPr txBox="1"/>
            <p:nvPr/>
          </p:nvSpPr>
          <p:spPr>
            <a:xfrm>
              <a:off x="5544963" y="5510044"/>
              <a:ext cx="459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5</a:t>
              </a:r>
            </a:p>
          </p:txBody>
        </p:sp>
        <p:sp>
          <p:nvSpPr>
            <p:cNvPr id="21" name="TextBox 8">
              <a:extLst>
                <a:ext uri="{FF2B5EF4-FFF2-40B4-BE49-F238E27FC236}">
                  <a16:creationId xmlns:a16="http://schemas.microsoft.com/office/drawing/2014/main" id="{1EAD1067-234A-4E14-9E64-798CACB295B3}"/>
                </a:ext>
              </a:extLst>
            </p:cNvPr>
            <p:cNvSpPr txBox="1"/>
            <p:nvPr/>
          </p:nvSpPr>
          <p:spPr>
            <a:xfrm>
              <a:off x="6191729" y="5510044"/>
              <a:ext cx="459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6</a:t>
              </a:r>
            </a:p>
          </p:txBody>
        </p:sp>
        <p:sp>
          <p:nvSpPr>
            <p:cNvPr id="22" name="TextBox 9">
              <a:extLst>
                <a:ext uri="{FF2B5EF4-FFF2-40B4-BE49-F238E27FC236}">
                  <a16:creationId xmlns:a16="http://schemas.microsoft.com/office/drawing/2014/main" id="{49EAC58F-D000-42FE-9E95-177449B11076}"/>
                </a:ext>
              </a:extLst>
            </p:cNvPr>
            <p:cNvSpPr txBox="1"/>
            <p:nvPr/>
          </p:nvSpPr>
          <p:spPr>
            <a:xfrm>
              <a:off x="6834595" y="5510044"/>
              <a:ext cx="459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7</a:t>
              </a:r>
            </a:p>
          </p:txBody>
        </p:sp>
        <p:sp>
          <p:nvSpPr>
            <p:cNvPr id="23" name="TextBox 10">
              <a:extLst>
                <a:ext uri="{FF2B5EF4-FFF2-40B4-BE49-F238E27FC236}">
                  <a16:creationId xmlns:a16="http://schemas.microsoft.com/office/drawing/2014/main" id="{4221446A-B718-409E-84A7-D4AF1D1B0221}"/>
                </a:ext>
              </a:extLst>
            </p:cNvPr>
            <p:cNvSpPr txBox="1"/>
            <p:nvPr/>
          </p:nvSpPr>
          <p:spPr>
            <a:xfrm>
              <a:off x="7471090" y="5510044"/>
              <a:ext cx="459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8</a:t>
              </a:r>
            </a:p>
          </p:txBody>
        </p:sp>
        <p:sp>
          <p:nvSpPr>
            <p:cNvPr id="24" name="TextBox 11">
              <a:extLst>
                <a:ext uri="{FF2B5EF4-FFF2-40B4-BE49-F238E27FC236}">
                  <a16:creationId xmlns:a16="http://schemas.microsoft.com/office/drawing/2014/main" id="{B87A698B-E9FF-4F2B-A278-ED9D6F80AFA7}"/>
                </a:ext>
              </a:extLst>
            </p:cNvPr>
            <p:cNvSpPr txBox="1"/>
            <p:nvPr/>
          </p:nvSpPr>
          <p:spPr>
            <a:xfrm>
              <a:off x="8143276" y="5510044"/>
              <a:ext cx="459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9</a:t>
              </a:r>
            </a:p>
          </p:txBody>
        </p:sp>
        <p:sp>
          <p:nvSpPr>
            <p:cNvPr id="25" name="TextBox 12">
              <a:extLst>
                <a:ext uri="{FF2B5EF4-FFF2-40B4-BE49-F238E27FC236}">
                  <a16:creationId xmlns:a16="http://schemas.microsoft.com/office/drawing/2014/main" id="{082CE3EF-62EB-44C2-BD2D-19011FFE5654}"/>
                </a:ext>
              </a:extLst>
            </p:cNvPr>
            <p:cNvSpPr txBox="1"/>
            <p:nvPr/>
          </p:nvSpPr>
          <p:spPr>
            <a:xfrm>
              <a:off x="8776617" y="5510044"/>
              <a:ext cx="5505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1400" dirty="0">
                  <a:solidFill>
                    <a:schemeClr val="bg1">
                      <a:lumMod val="50000"/>
                    </a:schemeClr>
                  </a:solidFill>
                </a:rPr>
                <a:t>SV10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527AF73C-0740-4C55-895D-29A1C56BC9C6}"/>
              </a:ext>
            </a:extLst>
          </p:cNvPr>
          <p:cNvSpPr txBox="1"/>
          <p:nvPr/>
        </p:nvSpPr>
        <p:spPr>
          <a:xfrm>
            <a:off x="291809" y="6426926"/>
            <a:ext cx="10130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b="1" dirty="0" err="1"/>
              <a:t>Supplementary</a:t>
            </a:r>
            <a:r>
              <a:rPr lang="pt-PT" b="1" dirty="0"/>
              <a:t> Figure S2 (d). </a:t>
            </a:r>
            <a:r>
              <a:rPr lang="pt-PT" b="1" dirty="0" err="1"/>
              <a:t>Relative</a:t>
            </a:r>
            <a:r>
              <a:rPr lang="pt-PT" b="1" dirty="0"/>
              <a:t> </a:t>
            </a:r>
            <a:r>
              <a:rPr lang="pt-PT" b="1" dirty="0" err="1"/>
              <a:t>abundance</a:t>
            </a:r>
            <a:r>
              <a:rPr lang="pt-PT" b="1" dirty="0"/>
              <a:t> </a:t>
            </a:r>
            <a:r>
              <a:rPr lang="pt-PT" b="1" dirty="0" err="1"/>
              <a:t>of</a:t>
            </a:r>
            <a:r>
              <a:rPr lang="pt-PT" b="1" dirty="0"/>
              <a:t> bacterial 16S rRNA genes </a:t>
            </a:r>
            <a:r>
              <a:rPr lang="pt-PT" b="1" dirty="0" err="1"/>
              <a:t>at</a:t>
            </a:r>
            <a:r>
              <a:rPr lang="pt-PT" b="1" dirty="0"/>
              <a:t> </a:t>
            </a:r>
            <a:r>
              <a:rPr lang="pt-PT" b="1" dirty="0" err="1"/>
              <a:t>family</a:t>
            </a:r>
            <a:r>
              <a:rPr lang="pt-PT" b="1" dirty="0"/>
              <a:t> </a:t>
            </a:r>
            <a:r>
              <a:rPr lang="pt-PT" b="1" dirty="0" err="1"/>
              <a:t>taxonomic</a:t>
            </a:r>
            <a:r>
              <a:rPr lang="pt-PT" b="1" dirty="0"/>
              <a:t> </a:t>
            </a:r>
            <a:r>
              <a:rPr lang="pt-PT" b="1" dirty="0" err="1"/>
              <a:t>rank</a:t>
            </a:r>
            <a:r>
              <a:rPr lang="pt-PT" b="1" dirty="0"/>
              <a:t>. </a:t>
            </a:r>
            <a:endParaRPr lang="pt-PT" dirty="0"/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A469D15D-CE60-4E46-B222-B03D00CE85EE}"/>
              </a:ext>
            </a:extLst>
          </p:cNvPr>
          <p:cNvSpPr txBox="1"/>
          <p:nvPr/>
        </p:nvSpPr>
        <p:spPr>
          <a:xfrm rot="16200000">
            <a:off x="-1087626" y="2267339"/>
            <a:ext cx="2758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Relative abundance (%)</a:t>
            </a:r>
          </a:p>
        </p:txBody>
      </p:sp>
    </p:spTree>
    <p:extLst>
      <p:ext uri="{BB962C8B-B14F-4D97-AF65-F5344CB8AC3E}">
        <p14:creationId xmlns:p14="http://schemas.microsoft.com/office/powerpoint/2010/main" val="35231552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C9600BE8-0A2C-45C3-A008-C43E8FE326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6156770"/>
              </p:ext>
            </p:extLst>
          </p:nvPr>
        </p:nvGraphicFramePr>
        <p:xfrm>
          <a:off x="0" y="-69652"/>
          <a:ext cx="12192000" cy="69973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CC1C38D-D43C-4BA7-A1AD-AD83419EDA70}"/>
              </a:ext>
            </a:extLst>
          </p:cNvPr>
          <p:cNvSpPr txBox="1"/>
          <p:nvPr/>
        </p:nvSpPr>
        <p:spPr>
          <a:xfrm>
            <a:off x="0" y="6211669"/>
            <a:ext cx="74545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b="1" dirty="0" err="1"/>
              <a:t>Supplementary</a:t>
            </a:r>
            <a:r>
              <a:rPr lang="pt-PT" b="1" dirty="0"/>
              <a:t> Figure S2 (e). </a:t>
            </a:r>
            <a:r>
              <a:rPr lang="pt-PT" b="1" dirty="0" err="1"/>
              <a:t>Relative</a:t>
            </a:r>
            <a:r>
              <a:rPr lang="pt-PT" b="1" dirty="0"/>
              <a:t> </a:t>
            </a:r>
            <a:r>
              <a:rPr lang="pt-PT" b="1" dirty="0" err="1"/>
              <a:t>abundance</a:t>
            </a:r>
            <a:r>
              <a:rPr lang="pt-PT" b="1" dirty="0"/>
              <a:t> </a:t>
            </a:r>
            <a:r>
              <a:rPr lang="pt-PT" b="1" dirty="0" err="1"/>
              <a:t>of</a:t>
            </a:r>
            <a:r>
              <a:rPr lang="pt-PT" b="1" dirty="0"/>
              <a:t> bacterial 16S rRNA genes </a:t>
            </a:r>
            <a:r>
              <a:rPr lang="pt-PT" b="1" dirty="0" err="1"/>
              <a:t>at</a:t>
            </a:r>
            <a:r>
              <a:rPr lang="pt-PT" b="1" dirty="0"/>
              <a:t> </a:t>
            </a:r>
            <a:r>
              <a:rPr lang="pt-PT" b="1" dirty="0" err="1"/>
              <a:t>genus</a:t>
            </a:r>
            <a:r>
              <a:rPr lang="pt-PT" b="1" dirty="0"/>
              <a:t> </a:t>
            </a:r>
            <a:r>
              <a:rPr lang="pt-PT" b="1" dirty="0" err="1"/>
              <a:t>taxonomic</a:t>
            </a:r>
            <a:r>
              <a:rPr lang="pt-PT" b="1" dirty="0"/>
              <a:t> </a:t>
            </a:r>
            <a:r>
              <a:rPr lang="pt-PT" b="1" dirty="0" err="1"/>
              <a:t>rank</a:t>
            </a:r>
            <a:r>
              <a:rPr lang="pt-PT" b="1" dirty="0"/>
              <a:t>. 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28527344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1</TotalTime>
  <Words>168</Words>
  <Application>Microsoft Office PowerPoint</Application>
  <PresentationFormat>Widescreen</PresentationFormat>
  <Paragraphs>5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ema do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tarina fernandes</dc:creator>
  <cp:lastModifiedBy>I T</cp:lastModifiedBy>
  <cp:revision>19</cp:revision>
  <dcterms:created xsi:type="dcterms:W3CDTF">2019-02-02T17:55:28Z</dcterms:created>
  <dcterms:modified xsi:type="dcterms:W3CDTF">2021-02-22T00:29:16Z</dcterms:modified>
</cp:coreProperties>
</file>